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</p:sldIdLst>
  <p:sldSz cx="12192000" cy="162179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58" y="-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lexa\Downloads\RNQ-G%20condensate%20surface%20amyloid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lexa\Downloads\Rnq%20+%20RNAse%20stats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lexa\OneDrive\&#1044;&#1086;&#1082;&#1091;&#1084;&#1077;&#1085;&#1090;&#1099;\Work\LLPS\Pictures%20in%20paper%20draft\QN%20calculations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lexa\OneDrive\&#1044;&#1086;&#1082;&#1091;&#1084;&#1077;&#1085;&#1090;&#1099;\Work\LLPS\Pictures%20in%20paper%20draft\Mot+Ure+Rnq+Sap\Mot3,%20Ure,%20Sap%20aggregate%20timelapse%20quantif%20fin.xls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lexa\Downloads\RNQ-G%20condensate%20surface%20amyloid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&#1050;&#1085;&#1080;&#1075;&#1072;1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_____Microsoft_Excel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_____Microsoft_Excel1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&#1050;&#1085;&#1080;&#1075;&#1072;1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&#1050;&#1085;&#1080;&#1075;&#1072;1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lexa\Downloads\Rnq1%20hollow%20bodies%20calc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G:\Sup35%20Liquid%20Droplets\RNAse%20experiment\Mot%206h%20expr.xls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439748698103881"/>
          <c:y val="8.3204212038040987E-2"/>
          <c:w val="0.87119685039370076"/>
          <c:h val="0.73577136191309422"/>
        </c:manualLayout>
      </c:layout>
      <c:scatterChart>
        <c:scatterStyle val="smoothMarker"/>
        <c:varyColors val="0"/>
        <c:ser>
          <c:idx val="0"/>
          <c:order val="0"/>
          <c:tx>
            <c:strRef>
              <c:f>Лист1!$D$2</c:f>
              <c:strCache>
                <c:ptCount val="1"/>
                <c:pt idx="0">
                  <c:v>GFP-Rnq1</c:v>
                </c:pt>
              </c:strCache>
            </c:strRef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xVal>
            <c:numRef>
              <c:f>Лист1!$C$3:$C$102</c:f>
              <c:numCache>
                <c:formatCode>General</c:formatCode>
                <c:ptCount val="10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</c:numCache>
            </c:numRef>
          </c:xVal>
          <c:yVal>
            <c:numRef>
              <c:f>Лист1!$D$3:$D$102</c:f>
              <c:numCache>
                <c:formatCode>General</c:formatCode>
                <c:ptCount val="100"/>
                <c:pt idx="0">
                  <c:v>12</c:v>
                </c:pt>
                <c:pt idx="1">
                  <c:v>13</c:v>
                </c:pt>
                <c:pt idx="2">
                  <c:v>13</c:v>
                </c:pt>
                <c:pt idx="3">
                  <c:v>14</c:v>
                </c:pt>
                <c:pt idx="4">
                  <c:v>14</c:v>
                </c:pt>
                <c:pt idx="5">
                  <c:v>14</c:v>
                </c:pt>
                <c:pt idx="6">
                  <c:v>14</c:v>
                </c:pt>
                <c:pt idx="7">
                  <c:v>14</c:v>
                </c:pt>
                <c:pt idx="8">
                  <c:v>15</c:v>
                </c:pt>
                <c:pt idx="9">
                  <c:v>16</c:v>
                </c:pt>
                <c:pt idx="10">
                  <c:v>15</c:v>
                </c:pt>
                <c:pt idx="11">
                  <c:v>17</c:v>
                </c:pt>
                <c:pt idx="12">
                  <c:v>17</c:v>
                </c:pt>
                <c:pt idx="13">
                  <c:v>19</c:v>
                </c:pt>
                <c:pt idx="14">
                  <c:v>20</c:v>
                </c:pt>
                <c:pt idx="15">
                  <c:v>21</c:v>
                </c:pt>
                <c:pt idx="16">
                  <c:v>22</c:v>
                </c:pt>
                <c:pt idx="17">
                  <c:v>23</c:v>
                </c:pt>
                <c:pt idx="18">
                  <c:v>24</c:v>
                </c:pt>
                <c:pt idx="19">
                  <c:v>26</c:v>
                </c:pt>
                <c:pt idx="20">
                  <c:v>26</c:v>
                </c:pt>
                <c:pt idx="21">
                  <c:v>27</c:v>
                </c:pt>
                <c:pt idx="22">
                  <c:v>27</c:v>
                </c:pt>
                <c:pt idx="23">
                  <c:v>29</c:v>
                </c:pt>
                <c:pt idx="24">
                  <c:v>31</c:v>
                </c:pt>
                <c:pt idx="25">
                  <c:v>35</c:v>
                </c:pt>
                <c:pt idx="26">
                  <c:v>36</c:v>
                </c:pt>
                <c:pt idx="27">
                  <c:v>37</c:v>
                </c:pt>
                <c:pt idx="28">
                  <c:v>39</c:v>
                </c:pt>
                <c:pt idx="29">
                  <c:v>48</c:v>
                </c:pt>
                <c:pt idx="30">
                  <c:v>57</c:v>
                </c:pt>
                <c:pt idx="31">
                  <c:v>63</c:v>
                </c:pt>
                <c:pt idx="32">
                  <c:v>67</c:v>
                </c:pt>
                <c:pt idx="33">
                  <c:v>72</c:v>
                </c:pt>
                <c:pt idx="34">
                  <c:v>77</c:v>
                </c:pt>
                <c:pt idx="35">
                  <c:v>81</c:v>
                </c:pt>
                <c:pt idx="36">
                  <c:v>82</c:v>
                </c:pt>
                <c:pt idx="37">
                  <c:v>86</c:v>
                </c:pt>
                <c:pt idx="38">
                  <c:v>87</c:v>
                </c:pt>
                <c:pt idx="39">
                  <c:v>89</c:v>
                </c:pt>
                <c:pt idx="40">
                  <c:v>91</c:v>
                </c:pt>
                <c:pt idx="41">
                  <c:v>93</c:v>
                </c:pt>
                <c:pt idx="42">
                  <c:v>95</c:v>
                </c:pt>
                <c:pt idx="43">
                  <c:v>96</c:v>
                </c:pt>
                <c:pt idx="44">
                  <c:v>97</c:v>
                </c:pt>
                <c:pt idx="45">
                  <c:v>97</c:v>
                </c:pt>
                <c:pt idx="46">
                  <c:v>98</c:v>
                </c:pt>
                <c:pt idx="47">
                  <c:v>98</c:v>
                </c:pt>
                <c:pt idx="48">
                  <c:v>97</c:v>
                </c:pt>
                <c:pt idx="49">
                  <c:v>97</c:v>
                </c:pt>
                <c:pt idx="50">
                  <c:v>96</c:v>
                </c:pt>
                <c:pt idx="51">
                  <c:v>96</c:v>
                </c:pt>
                <c:pt idx="52">
                  <c:v>95</c:v>
                </c:pt>
                <c:pt idx="53">
                  <c:v>93</c:v>
                </c:pt>
                <c:pt idx="54">
                  <c:v>92</c:v>
                </c:pt>
                <c:pt idx="55">
                  <c:v>91</c:v>
                </c:pt>
                <c:pt idx="56">
                  <c:v>88</c:v>
                </c:pt>
                <c:pt idx="57">
                  <c:v>86</c:v>
                </c:pt>
                <c:pt idx="58">
                  <c:v>84</c:v>
                </c:pt>
                <c:pt idx="59">
                  <c:v>81</c:v>
                </c:pt>
                <c:pt idx="60">
                  <c:v>78</c:v>
                </c:pt>
                <c:pt idx="61">
                  <c:v>75</c:v>
                </c:pt>
                <c:pt idx="62">
                  <c:v>71</c:v>
                </c:pt>
                <c:pt idx="63">
                  <c:v>69</c:v>
                </c:pt>
                <c:pt idx="64">
                  <c:v>62</c:v>
                </c:pt>
                <c:pt idx="65">
                  <c:v>56</c:v>
                </c:pt>
                <c:pt idx="66">
                  <c:v>50</c:v>
                </c:pt>
                <c:pt idx="67">
                  <c:v>42</c:v>
                </c:pt>
                <c:pt idx="68">
                  <c:v>36</c:v>
                </c:pt>
                <c:pt idx="69">
                  <c:v>28</c:v>
                </c:pt>
                <c:pt idx="70">
                  <c:v>25</c:v>
                </c:pt>
                <c:pt idx="71">
                  <c:v>26</c:v>
                </c:pt>
                <c:pt idx="72">
                  <c:v>23</c:v>
                </c:pt>
                <c:pt idx="73">
                  <c:v>19</c:v>
                </c:pt>
                <c:pt idx="74">
                  <c:v>17</c:v>
                </c:pt>
                <c:pt idx="75">
                  <c:v>18</c:v>
                </c:pt>
                <c:pt idx="76">
                  <c:v>16</c:v>
                </c:pt>
                <c:pt idx="77">
                  <c:v>15</c:v>
                </c:pt>
                <c:pt idx="78">
                  <c:v>13</c:v>
                </c:pt>
                <c:pt idx="79">
                  <c:v>13</c:v>
                </c:pt>
                <c:pt idx="80">
                  <c:v>12</c:v>
                </c:pt>
                <c:pt idx="81">
                  <c:v>12</c:v>
                </c:pt>
                <c:pt idx="82">
                  <c:v>10</c:v>
                </c:pt>
                <c:pt idx="83">
                  <c:v>10</c:v>
                </c:pt>
                <c:pt idx="84">
                  <c:v>9</c:v>
                </c:pt>
                <c:pt idx="85">
                  <c:v>10</c:v>
                </c:pt>
                <c:pt idx="86">
                  <c:v>9</c:v>
                </c:pt>
                <c:pt idx="87">
                  <c:v>8</c:v>
                </c:pt>
                <c:pt idx="88">
                  <c:v>7</c:v>
                </c:pt>
                <c:pt idx="89">
                  <c:v>7</c:v>
                </c:pt>
                <c:pt idx="90">
                  <c:v>6</c:v>
                </c:pt>
                <c:pt idx="91">
                  <c:v>7</c:v>
                </c:pt>
                <c:pt idx="92">
                  <c:v>7</c:v>
                </c:pt>
                <c:pt idx="93">
                  <c:v>7</c:v>
                </c:pt>
                <c:pt idx="94">
                  <c:v>6</c:v>
                </c:pt>
                <c:pt idx="95">
                  <c:v>6</c:v>
                </c:pt>
                <c:pt idx="96">
                  <c:v>5</c:v>
                </c:pt>
                <c:pt idx="97">
                  <c:v>5</c:v>
                </c:pt>
                <c:pt idx="98">
                  <c:v>4</c:v>
                </c:pt>
                <c:pt idx="99">
                  <c:v>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7668-4317-9E3B-8515A7E89E99}"/>
            </c:ext>
          </c:extLst>
        </c:ser>
        <c:ser>
          <c:idx val="1"/>
          <c:order val="1"/>
          <c:tx>
            <c:strRef>
              <c:f>Лист1!$E$2</c:f>
              <c:strCache>
                <c:ptCount val="1"/>
                <c:pt idx="0">
                  <c:v>Proteostat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Лист1!$C$3:$C$102</c:f>
              <c:numCache>
                <c:formatCode>General</c:formatCode>
                <c:ptCount val="10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</c:numCache>
            </c:numRef>
          </c:xVal>
          <c:yVal>
            <c:numRef>
              <c:f>Лист1!$E$3:$E$102</c:f>
              <c:numCache>
                <c:formatCode>General</c:formatCode>
                <c:ptCount val="100"/>
                <c:pt idx="0">
                  <c:v>15</c:v>
                </c:pt>
                <c:pt idx="1">
                  <c:v>15</c:v>
                </c:pt>
                <c:pt idx="2">
                  <c:v>15</c:v>
                </c:pt>
                <c:pt idx="3">
                  <c:v>17</c:v>
                </c:pt>
                <c:pt idx="4">
                  <c:v>17</c:v>
                </c:pt>
                <c:pt idx="5">
                  <c:v>17</c:v>
                </c:pt>
                <c:pt idx="6">
                  <c:v>18</c:v>
                </c:pt>
                <c:pt idx="7">
                  <c:v>19</c:v>
                </c:pt>
                <c:pt idx="8">
                  <c:v>19</c:v>
                </c:pt>
                <c:pt idx="9">
                  <c:v>20</c:v>
                </c:pt>
                <c:pt idx="10">
                  <c:v>20</c:v>
                </c:pt>
                <c:pt idx="11">
                  <c:v>20</c:v>
                </c:pt>
                <c:pt idx="12">
                  <c:v>20</c:v>
                </c:pt>
                <c:pt idx="13">
                  <c:v>22</c:v>
                </c:pt>
                <c:pt idx="14">
                  <c:v>23</c:v>
                </c:pt>
                <c:pt idx="15">
                  <c:v>25</c:v>
                </c:pt>
                <c:pt idx="16">
                  <c:v>27</c:v>
                </c:pt>
                <c:pt idx="17">
                  <c:v>28</c:v>
                </c:pt>
                <c:pt idx="18">
                  <c:v>29</c:v>
                </c:pt>
                <c:pt idx="19">
                  <c:v>31</c:v>
                </c:pt>
                <c:pt idx="20">
                  <c:v>30</c:v>
                </c:pt>
                <c:pt idx="21">
                  <c:v>30</c:v>
                </c:pt>
                <c:pt idx="22">
                  <c:v>32</c:v>
                </c:pt>
                <c:pt idx="23">
                  <c:v>34</c:v>
                </c:pt>
                <c:pt idx="24">
                  <c:v>35</c:v>
                </c:pt>
                <c:pt idx="25">
                  <c:v>38</c:v>
                </c:pt>
                <c:pt idx="26">
                  <c:v>43</c:v>
                </c:pt>
                <c:pt idx="27">
                  <c:v>50</c:v>
                </c:pt>
                <c:pt idx="28">
                  <c:v>57</c:v>
                </c:pt>
                <c:pt idx="29">
                  <c:v>63</c:v>
                </c:pt>
                <c:pt idx="30">
                  <c:v>65</c:v>
                </c:pt>
                <c:pt idx="31">
                  <c:v>64</c:v>
                </c:pt>
                <c:pt idx="32">
                  <c:v>64</c:v>
                </c:pt>
                <c:pt idx="33">
                  <c:v>63</c:v>
                </c:pt>
                <c:pt idx="34">
                  <c:v>60</c:v>
                </c:pt>
                <c:pt idx="35">
                  <c:v>58</c:v>
                </c:pt>
                <c:pt idx="36">
                  <c:v>57</c:v>
                </c:pt>
                <c:pt idx="37">
                  <c:v>55</c:v>
                </c:pt>
                <c:pt idx="38">
                  <c:v>52</c:v>
                </c:pt>
                <c:pt idx="39">
                  <c:v>50</c:v>
                </c:pt>
                <c:pt idx="40">
                  <c:v>49</c:v>
                </c:pt>
                <c:pt idx="41">
                  <c:v>48</c:v>
                </c:pt>
                <c:pt idx="42">
                  <c:v>47</c:v>
                </c:pt>
                <c:pt idx="43">
                  <c:v>48</c:v>
                </c:pt>
                <c:pt idx="44">
                  <c:v>48</c:v>
                </c:pt>
                <c:pt idx="45">
                  <c:v>48</c:v>
                </c:pt>
                <c:pt idx="46">
                  <c:v>49</c:v>
                </c:pt>
                <c:pt idx="47">
                  <c:v>49</c:v>
                </c:pt>
                <c:pt idx="48">
                  <c:v>49</c:v>
                </c:pt>
                <c:pt idx="49">
                  <c:v>49</c:v>
                </c:pt>
                <c:pt idx="50">
                  <c:v>49</c:v>
                </c:pt>
                <c:pt idx="51">
                  <c:v>50</c:v>
                </c:pt>
                <c:pt idx="52">
                  <c:v>50</c:v>
                </c:pt>
                <c:pt idx="53">
                  <c:v>51</c:v>
                </c:pt>
                <c:pt idx="54">
                  <c:v>51</c:v>
                </c:pt>
                <c:pt idx="55">
                  <c:v>50</c:v>
                </c:pt>
                <c:pt idx="56">
                  <c:v>50</c:v>
                </c:pt>
                <c:pt idx="57">
                  <c:v>49</c:v>
                </c:pt>
                <c:pt idx="58">
                  <c:v>48</c:v>
                </c:pt>
                <c:pt idx="59">
                  <c:v>51</c:v>
                </c:pt>
                <c:pt idx="60">
                  <c:v>51</c:v>
                </c:pt>
                <c:pt idx="61">
                  <c:v>51</c:v>
                </c:pt>
                <c:pt idx="62">
                  <c:v>53</c:v>
                </c:pt>
                <c:pt idx="63">
                  <c:v>55</c:v>
                </c:pt>
                <c:pt idx="64">
                  <c:v>59</c:v>
                </c:pt>
                <c:pt idx="65">
                  <c:v>61</c:v>
                </c:pt>
                <c:pt idx="66">
                  <c:v>63</c:v>
                </c:pt>
                <c:pt idx="67">
                  <c:v>63</c:v>
                </c:pt>
                <c:pt idx="68">
                  <c:v>59</c:v>
                </c:pt>
                <c:pt idx="69">
                  <c:v>53</c:v>
                </c:pt>
                <c:pt idx="70">
                  <c:v>44</c:v>
                </c:pt>
                <c:pt idx="71">
                  <c:v>38</c:v>
                </c:pt>
                <c:pt idx="72">
                  <c:v>34</c:v>
                </c:pt>
                <c:pt idx="73">
                  <c:v>31</c:v>
                </c:pt>
                <c:pt idx="74">
                  <c:v>31</c:v>
                </c:pt>
                <c:pt idx="75">
                  <c:v>29</c:v>
                </c:pt>
                <c:pt idx="76">
                  <c:v>27</c:v>
                </c:pt>
                <c:pt idx="77">
                  <c:v>25</c:v>
                </c:pt>
                <c:pt idx="78">
                  <c:v>23</c:v>
                </c:pt>
                <c:pt idx="79">
                  <c:v>22</c:v>
                </c:pt>
                <c:pt idx="80">
                  <c:v>22</c:v>
                </c:pt>
                <c:pt idx="81">
                  <c:v>22</c:v>
                </c:pt>
                <c:pt idx="82">
                  <c:v>22</c:v>
                </c:pt>
                <c:pt idx="83">
                  <c:v>20</c:v>
                </c:pt>
                <c:pt idx="84">
                  <c:v>19</c:v>
                </c:pt>
                <c:pt idx="85">
                  <c:v>18</c:v>
                </c:pt>
                <c:pt idx="86">
                  <c:v>17</c:v>
                </c:pt>
                <c:pt idx="87">
                  <c:v>17</c:v>
                </c:pt>
                <c:pt idx="88">
                  <c:v>18</c:v>
                </c:pt>
                <c:pt idx="89">
                  <c:v>18</c:v>
                </c:pt>
                <c:pt idx="90">
                  <c:v>19</c:v>
                </c:pt>
                <c:pt idx="91">
                  <c:v>19</c:v>
                </c:pt>
                <c:pt idx="92">
                  <c:v>17</c:v>
                </c:pt>
                <c:pt idx="93">
                  <c:v>15</c:v>
                </c:pt>
                <c:pt idx="94">
                  <c:v>13</c:v>
                </c:pt>
                <c:pt idx="95">
                  <c:v>12</c:v>
                </c:pt>
                <c:pt idx="96">
                  <c:v>11</c:v>
                </c:pt>
                <c:pt idx="97">
                  <c:v>12</c:v>
                </c:pt>
                <c:pt idx="98">
                  <c:v>11</c:v>
                </c:pt>
                <c:pt idx="99">
                  <c:v>1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7668-4317-9E3B-8515A7E89E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44772447"/>
        <c:axId val="1144790751"/>
      </c:scatterChart>
      <c:valAx>
        <c:axId val="1144772447"/>
        <c:scaling>
          <c:orientation val="minMax"/>
          <c:max val="10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144790751"/>
        <c:crosses val="autoZero"/>
        <c:crossBetween val="midCat"/>
        <c:majorUnit val="25"/>
      </c:valAx>
      <c:valAx>
        <c:axId val="1144790751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144772447"/>
        <c:crosses val="autoZero"/>
        <c:crossBetween val="midCat"/>
        <c:majorUnit val="2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ru-RU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2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0-0F8B-4938-A40C-D4D732DCA56D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F8B-4938-A40C-D4D732DCA56D}"/>
              </c:ext>
            </c:extLst>
          </c:dPt>
          <c:errBars>
            <c:errBarType val="plus"/>
            <c:errValType val="cust"/>
            <c:noEndCap val="0"/>
            <c:plus>
              <c:numRef>
                <c:f>Лист1!$K$4:$N$4</c:f>
                <c:numCache>
                  <c:formatCode>General</c:formatCode>
                  <c:ptCount val="4"/>
                  <c:pt idx="0">
                    <c:v>5.307594749920427</c:v>
                  </c:pt>
                  <c:pt idx="1">
                    <c:v>0</c:v>
                  </c:pt>
                  <c:pt idx="2">
                    <c:v>5.3180832557396274</c:v>
                  </c:pt>
                  <c:pt idx="3">
                    <c:v>2.31865599166395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Лист1!$K$2:$N$2</c:f>
              <c:strCache>
                <c:ptCount val="4"/>
                <c:pt idx="0">
                  <c:v>contr</c:v>
                </c:pt>
                <c:pt idx="1">
                  <c:v>RNAse</c:v>
                </c:pt>
                <c:pt idx="2">
                  <c:v>contr</c:v>
                </c:pt>
                <c:pt idx="3">
                  <c:v>RNAse</c:v>
                </c:pt>
              </c:strCache>
            </c:strRef>
          </c:cat>
          <c:val>
            <c:numRef>
              <c:f>Лист1!$K$3:$N$3</c:f>
              <c:numCache>
                <c:formatCode>General</c:formatCode>
                <c:ptCount val="4"/>
                <c:pt idx="0">
                  <c:v>20.0598544442643</c:v>
                </c:pt>
                <c:pt idx="1">
                  <c:v>0</c:v>
                </c:pt>
                <c:pt idx="2">
                  <c:v>58.313924541994709</c:v>
                </c:pt>
                <c:pt idx="3">
                  <c:v>54.4831314326887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E2A-42A4-8140-D036DB8201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188160768"/>
        <c:axId val="1188162848"/>
      </c:barChart>
      <c:catAx>
        <c:axId val="11881607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188162848"/>
        <c:crosses val="autoZero"/>
        <c:auto val="1"/>
        <c:lblAlgn val="ctr"/>
        <c:lblOffset val="100"/>
        <c:noMultiLvlLbl val="0"/>
      </c:catAx>
      <c:valAx>
        <c:axId val="11881628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18816076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ru-RU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0776369587267727"/>
          <c:y val="0.21689497716894976"/>
          <c:w val="0.5756360385230731"/>
          <c:h val="0.67423866537230792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Лист1!$D$18</c:f>
              <c:strCache>
                <c:ptCount val="1"/>
                <c:pt idx="0">
                  <c:v>N%</c:v>
                </c:pt>
              </c:strCache>
            </c:strRef>
          </c:tx>
          <c:spPr>
            <a:solidFill>
              <a:schemeClr val="accent4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Лист1!$C$19:$C$23</c:f>
              <c:strCache>
                <c:ptCount val="5"/>
                <c:pt idx="0">
                  <c:v>Sap30PD</c:v>
                </c:pt>
                <c:pt idx="1">
                  <c:v>Ure2PD</c:v>
                </c:pt>
                <c:pt idx="2">
                  <c:v>Mot3PD</c:v>
                </c:pt>
                <c:pt idx="3">
                  <c:v>Rnq1 FL</c:v>
                </c:pt>
                <c:pt idx="4">
                  <c:v>Sup35PD</c:v>
                </c:pt>
              </c:strCache>
            </c:strRef>
          </c:cat>
          <c:val>
            <c:numRef>
              <c:f>Лист1!$D$19:$D$22</c:f>
              <c:numCache>
                <c:formatCode>General</c:formatCode>
                <c:ptCount val="4"/>
                <c:pt idx="0">
                  <c:v>31.958762886597935</c:v>
                </c:pt>
                <c:pt idx="1">
                  <c:v>33.333333333333329</c:v>
                </c:pt>
                <c:pt idx="2">
                  <c:v>23.232323232323232</c:v>
                </c:pt>
                <c:pt idx="3">
                  <c:v>12.3456790123456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F48-42AE-9B9C-BE0BD34A6D29}"/>
            </c:ext>
          </c:extLst>
        </c:ser>
        <c:ser>
          <c:idx val="1"/>
          <c:order val="1"/>
          <c:tx>
            <c:strRef>
              <c:f>Лист1!$E$18</c:f>
              <c:strCache>
                <c:ptCount val="1"/>
                <c:pt idx="0">
                  <c:v>Q%</c:v>
                </c:pt>
              </c:strCache>
            </c:strRef>
          </c:tx>
          <c:spPr>
            <a:solidFill>
              <a:srgbClr val="7030A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Лист1!$C$19:$C$23</c:f>
              <c:strCache>
                <c:ptCount val="5"/>
                <c:pt idx="0">
                  <c:v>Sap30PD</c:v>
                </c:pt>
                <c:pt idx="1">
                  <c:v>Ure2PD</c:v>
                </c:pt>
                <c:pt idx="2">
                  <c:v>Mot3PD</c:v>
                </c:pt>
                <c:pt idx="3">
                  <c:v>Rnq1 FL</c:v>
                </c:pt>
                <c:pt idx="4">
                  <c:v>Sup35PD</c:v>
                </c:pt>
              </c:strCache>
            </c:strRef>
          </c:cat>
          <c:val>
            <c:numRef>
              <c:f>Лист1!$E$19:$E$22</c:f>
              <c:numCache>
                <c:formatCode>General</c:formatCode>
                <c:ptCount val="4"/>
                <c:pt idx="0">
                  <c:v>5.1546391752577314</c:v>
                </c:pt>
                <c:pt idx="1">
                  <c:v>10.1010101010101</c:v>
                </c:pt>
                <c:pt idx="2">
                  <c:v>13.468013468013467</c:v>
                </c:pt>
                <c:pt idx="3">
                  <c:v>19.0123456790123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F48-42AE-9B9C-BE0BD34A6D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873712559"/>
        <c:axId val="1873714223"/>
      </c:barChart>
      <c:catAx>
        <c:axId val="1873712559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873714223"/>
        <c:crosses val="autoZero"/>
        <c:auto val="1"/>
        <c:lblAlgn val="ctr"/>
        <c:lblOffset val="100"/>
        <c:noMultiLvlLbl val="0"/>
      </c:catAx>
      <c:valAx>
        <c:axId val="187371422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873712559"/>
        <c:crosses val="autoZero"/>
        <c:crossBetween val="between"/>
        <c:majorUnit val="10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28947621587142247"/>
          <c:y val="0.11600959982741889"/>
          <c:w val="0.58041011805795195"/>
          <c:h val="9.631916729586885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ru-RU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ru-RU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287449380307335"/>
          <c:y val="3.8039147064457587E-2"/>
          <c:w val="0.75696572549371077"/>
          <c:h val="0.74734950382555643"/>
        </c:manualLayout>
      </c:layout>
      <c:scatterChart>
        <c:scatterStyle val="lineMarker"/>
        <c:varyColors val="0"/>
        <c:ser>
          <c:idx val="0"/>
          <c:order val="0"/>
          <c:tx>
            <c:strRef>
              <c:f>'Mot3 + Ure + Sap time-lapse'!$B$54</c:f>
              <c:strCache>
                <c:ptCount val="1"/>
                <c:pt idx="0">
                  <c:v>Ure2PD Solid-like</c:v>
                </c:pt>
              </c:strCache>
            </c:strRef>
          </c:tx>
          <c:spPr>
            <a:ln w="22225">
              <a:solidFill>
                <a:srgbClr val="003300"/>
              </a:solidFill>
              <a:prstDash val="solid"/>
            </a:ln>
          </c:spPr>
          <c:marker>
            <c:symbol val="circle"/>
            <c:size val="4"/>
            <c:spPr>
              <a:solidFill>
                <a:schemeClr val="bg1"/>
              </a:solidFill>
              <a:ln>
                <a:solidFill>
                  <a:srgbClr val="003300"/>
                </a:solidFill>
                <a:prstDash val="solid"/>
              </a:ln>
            </c:spPr>
          </c:marker>
          <c:xVal>
            <c:numRef>
              <c:f>'Mot3 + Ure + Sap time-lapse'!$E$44:$J$44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24</c:v>
                </c:pt>
                <c:pt idx="4">
                  <c:v>72</c:v>
                </c:pt>
                <c:pt idx="5">
                  <c:v>168</c:v>
                </c:pt>
              </c:numCache>
            </c:numRef>
          </c:xVal>
          <c:yVal>
            <c:numRef>
              <c:f>'Mot3 + Ure + Sap time-lapse'!$E$54:$J$54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24206274565404001</c:v>
                </c:pt>
                <c:pt idx="5">
                  <c:v>0.51616631849078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041E-4C69-B2FF-297C27C24A64}"/>
            </c:ext>
          </c:extLst>
        </c:ser>
        <c:ser>
          <c:idx val="1"/>
          <c:order val="1"/>
          <c:tx>
            <c:strRef>
              <c:f>'Mot3 + Ure + Sap time-lapse'!$B$55</c:f>
              <c:strCache>
                <c:ptCount val="1"/>
                <c:pt idx="0">
                  <c:v>Ure2PD Liquid-like</c:v>
                </c:pt>
              </c:strCache>
            </c:strRef>
          </c:tx>
          <c:spPr>
            <a:ln w="22225">
              <a:solidFill>
                <a:srgbClr val="00CC00"/>
              </a:solidFill>
              <a:prstDash val="solid"/>
            </a:ln>
          </c:spPr>
          <c:marker>
            <c:symbol val="circle"/>
            <c:size val="4"/>
            <c:spPr>
              <a:solidFill>
                <a:schemeClr val="bg1"/>
              </a:solidFill>
              <a:ln>
                <a:solidFill>
                  <a:srgbClr val="00CC00"/>
                </a:solidFill>
                <a:prstDash val="solid"/>
              </a:ln>
            </c:spPr>
          </c:marker>
          <c:xVal>
            <c:numRef>
              <c:f>'Mot3 + Ure + Sap time-lapse'!$E$44:$J$44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24</c:v>
                </c:pt>
                <c:pt idx="4">
                  <c:v>72</c:v>
                </c:pt>
                <c:pt idx="5">
                  <c:v>168</c:v>
                </c:pt>
              </c:numCache>
            </c:numRef>
          </c:xVal>
          <c:yVal>
            <c:numRef>
              <c:f>'Mot3 + Ure + Sap time-lapse'!$E$55:$J$55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3.0788128751436401E-2</c:v>
                </c:pt>
                <c:pt idx="5">
                  <c:v>0.143972808629469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041E-4C69-B2FF-297C27C24A64}"/>
            </c:ext>
          </c:extLst>
        </c:ser>
        <c:ser>
          <c:idx val="2"/>
          <c:order val="2"/>
          <c:tx>
            <c:strRef>
              <c:f>'Mot3 + Ure + Sap time-lapse'!$B$62</c:f>
              <c:strCache>
                <c:ptCount val="1"/>
                <c:pt idx="0">
                  <c:v>Sap30PD Solid-like</c:v>
                </c:pt>
              </c:strCache>
            </c:strRef>
          </c:tx>
          <c:spPr>
            <a:ln w="22225">
              <a:solidFill>
                <a:srgbClr val="FF0000"/>
              </a:solidFill>
              <a:prstDash val="solid"/>
            </a:ln>
          </c:spPr>
          <c:marker>
            <c:symbol val="circle"/>
            <c:size val="4"/>
            <c:spPr>
              <a:solidFill>
                <a:schemeClr val="bg1"/>
              </a:solidFill>
              <a:ln>
                <a:solidFill>
                  <a:srgbClr val="FF0000"/>
                </a:solidFill>
                <a:prstDash val="solid"/>
              </a:ln>
            </c:spPr>
          </c:marker>
          <c:xVal>
            <c:numRef>
              <c:f>'Mot3 + Ure + Sap time-lapse'!$E$44:$J$44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24</c:v>
                </c:pt>
                <c:pt idx="4">
                  <c:v>72</c:v>
                </c:pt>
                <c:pt idx="5">
                  <c:v>168</c:v>
                </c:pt>
              </c:numCache>
            </c:numRef>
          </c:xVal>
          <c:yVal>
            <c:numRef>
              <c:f>'Mot3 + Ure + Sap time-lapse'!$E$62:$J$62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041E-4C69-B2FF-297C27C24A64}"/>
            </c:ext>
          </c:extLst>
        </c:ser>
        <c:ser>
          <c:idx val="3"/>
          <c:order val="3"/>
          <c:tx>
            <c:strRef>
              <c:f>'Mot3 + Ure + Sap time-lapse'!$B$63</c:f>
              <c:strCache>
                <c:ptCount val="1"/>
                <c:pt idx="0">
                  <c:v>Sap30PD Liquid-like</c:v>
                </c:pt>
              </c:strCache>
            </c:strRef>
          </c:tx>
          <c:spPr>
            <a:ln w="22225">
              <a:solidFill>
                <a:srgbClr val="7030A0"/>
              </a:solidFill>
              <a:prstDash val="solid"/>
            </a:ln>
          </c:spPr>
          <c:marker>
            <c:symbol val="circle"/>
            <c:size val="4"/>
            <c:spPr>
              <a:solidFill>
                <a:schemeClr val="bg1"/>
              </a:solidFill>
              <a:ln>
                <a:solidFill>
                  <a:srgbClr val="7030A0"/>
                </a:solidFill>
                <a:prstDash val="solid"/>
              </a:ln>
            </c:spPr>
          </c:marker>
          <c:xVal>
            <c:numRef>
              <c:f>'Mot3 + Ure + Sap time-lapse'!$E$44:$J$44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24</c:v>
                </c:pt>
                <c:pt idx="4">
                  <c:v>72</c:v>
                </c:pt>
                <c:pt idx="5">
                  <c:v>168</c:v>
                </c:pt>
              </c:numCache>
            </c:numRef>
          </c:xVal>
          <c:yVal>
            <c:numRef>
              <c:f>'Mot3 + Ure + Sap time-lapse'!$E$63:$J$63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041E-4C69-B2FF-297C27C24A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11907232"/>
        <c:axId val="1"/>
      </c:scatterChart>
      <c:valAx>
        <c:axId val="11119072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  <a:prstDash val="solid"/>
          </a:ln>
        </c:spPr>
        <c:txPr>
          <a:bodyPr rot="0" vert="horz"/>
          <a:lstStyle/>
          <a:p>
            <a:pPr>
              <a:defRPr sz="1100" b="0" i="0" u="none" strike="noStrike" baseline="0">
                <a:solidFill>
                  <a:srgbClr val="000000"/>
                </a:solidFill>
                <a:latin typeface="+mn-lt"/>
                <a:ea typeface="Arial"/>
                <a:cs typeface="Arial"/>
              </a:defRPr>
            </a:pPr>
            <a:endParaRPr lang="ru-RU"/>
          </a:p>
        </c:txPr>
        <c:crossAx val="1"/>
        <c:crossesAt val="-1"/>
        <c:crossBetween val="midCat"/>
        <c:majorUnit val="50"/>
      </c:valAx>
      <c:valAx>
        <c:axId val="1"/>
        <c:scaling>
          <c:orientation val="minMax"/>
          <c:max val="5"/>
          <c:min val="-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  <a:prstDash val="solid"/>
          </a:ln>
        </c:spPr>
        <c:txPr>
          <a:bodyPr rot="0" vert="horz"/>
          <a:lstStyle/>
          <a:p>
            <a:pPr>
              <a:defRPr sz="1100" b="0" i="0" u="none" strike="noStrike" baseline="0">
                <a:solidFill>
                  <a:srgbClr val="000000"/>
                </a:solidFill>
                <a:latin typeface="+mn-lt"/>
                <a:ea typeface="Arial"/>
                <a:cs typeface="Arial"/>
              </a:defRPr>
            </a:pPr>
            <a:endParaRPr lang="ru-RU"/>
          </a:p>
        </c:txPr>
        <c:crossAx val="1111907232"/>
        <c:crossesAt val="0"/>
        <c:crossBetween val="midCat"/>
        <c:majorUnit val="1"/>
        <c:minorUnit val="1"/>
      </c:valAx>
      <c:spPr>
        <a:noFill/>
        <a:ln w="12700"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11415552444939606"/>
          <c:y val="9.5099696126541691E-2"/>
          <c:w val="0.73313059957270543"/>
          <c:h val="0.41556990601641214"/>
        </c:manualLayout>
      </c:layout>
      <c:overlay val="0"/>
      <c:spPr>
        <a:noFill/>
        <a:ln w="25400">
          <a:noFill/>
        </a:ln>
      </c:spPr>
      <c:txPr>
        <a:bodyPr/>
        <a:lstStyle/>
        <a:p>
          <a:pPr>
            <a:defRPr sz="1100" b="1" i="0" u="none" strike="noStrike" baseline="0">
              <a:solidFill>
                <a:srgbClr val="000000"/>
              </a:solidFill>
              <a:latin typeface="+mn-lt"/>
              <a:ea typeface="Arial"/>
              <a:cs typeface="Arial"/>
            </a:defRPr>
          </a:pPr>
          <a:endParaRPr lang="ru-RU"/>
        </a:p>
      </c:txPr>
    </c:legend>
    <c:plotVisOnly val="1"/>
    <c:dispBlanksAs val="span"/>
    <c:showDLblsOverMax val="0"/>
  </c:chart>
  <c:spPr>
    <a:solidFill>
      <a:srgbClr val="FFFFFF"/>
    </a:solidFill>
    <a:ln w="6350">
      <a:noFill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ru-RU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784576071522677"/>
          <c:y val="0.12532823527617518"/>
          <c:w val="0.69021074086667189"/>
          <c:h val="0.5420020041752154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Лист1!$H$2</c:f>
              <c:strCache>
                <c:ptCount val="1"/>
                <c:pt idx="0">
                  <c:v>GFP-Rnq1</c:v>
                </c:pt>
              </c:strCache>
            </c:strRef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xVal>
            <c:numRef>
              <c:f>Лист1!$G$3:$G$90</c:f>
              <c:numCache>
                <c:formatCode>General</c:formatCode>
                <c:ptCount val="88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</c:numCache>
            </c:numRef>
          </c:xVal>
          <c:yVal>
            <c:numRef>
              <c:f>Лист1!$H$3:$H$90</c:f>
              <c:numCache>
                <c:formatCode>General</c:formatCode>
                <c:ptCount val="88"/>
                <c:pt idx="0">
                  <c:v>7</c:v>
                </c:pt>
                <c:pt idx="1">
                  <c:v>7</c:v>
                </c:pt>
                <c:pt idx="2">
                  <c:v>8</c:v>
                </c:pt>
                <c:pt idx="3">
                  <c:v>8</c:v>
                </c:pt>
                <c:pt idx="4">
                  <c:v>9</c:v>
                </c:pt>
                <c:pt idx="5">
                  <c:v>9</c:v>
                </c:pt>
                <c:pt idx="6">
                  <c:v>9</c:v>
                </c:pt>
                <c:pt idx="7">
                  <c:v>9</c:v>
                </c:pt>
                <c:pt idx="8">
                  <c:v>9</c:v>
                </c:pt>
                <c:pt idx="9">
                  <c:v>9</c:v>
                </c:pt>
                <c:pt idx="10">
                  <c:v>10</c:v>
                </c:pt>
                <c:pt idx="11">
                  <c:v>10</c:v>
                </c:pt>
                <c:pt idx="12">
                  <c:v>10</c:v>
                </c:pt>
                <c:pt idx="13">
                  <c:v>11</c:v>
                </c:pt>
                <c:pt idx="14">
                  <c:v>11</c:v>
                </c:pt>
                <c:pt idx="15">
                  <c:v>12</c:v>
                </c:pt>
                <c:pt idx="16">
                  <c:v>13</c:v>
                </c:pt>
                <c:pt idx="17">
                  <c:v>14</c:v>
                </c:pt>
                <c:pt idx="18">
                  <c:v>15</c:v>
                </c:pt>
                <c:pt idx="19">
                  <c:v>15</c:v>
                </c:pt>
                <c:pt idx="20">
                  <c:v>16</c:v>
                </c:pt>
                <c:pt idx="21">
                  <c:v>17</c:v>
                </c:pt>
                <c:pt idx="22">
                  <c:v>18</c:v>
                </c:pt>
                <c:pt idx="23">
                  <c:v>18</c:v>
                </c:pt>
                <c:pt idx="24">
                  <c:v>19</c:v>
                </c:pt>
                <c:pt idx="25">
                  <c:v>20</c:v>
                </c:pt>
                <c:pt idx="26">
                  <c:v>22</c:v>
                </c:pt>
                <c:pt idx="27">
                  <c:v>24</c:v>
                </c:pt>
                <c:pt idx="28">
                  <c:v>25</c:v>
                </c:pt>
                <c:pt idx="29">
                  <c:v>26</c:v>
                </c:pt>
                <c:pt idx="30">
                  <c:v>28</c:v>
                </c:pt>
                <c:pt idx="31">
                  <c:v>30</c:v>
                </c:pt>
                <c:pt idx="32">
                  <c:v>31</c:v>
                </c:pt>
                <c:pt idx="33">
                  <c:v>33</c:v>
                </c:pt>
                <c:pt idx="34">
                  <c:v>36</c:v>
                </c:pt>
                <c:pt idx="35">
                  <c:v>40</c:v>
                </c:pt>
                <c:pt idx="36">
                  <c:v>44</c:v>
                </c:pt>
                <c:pt idx="37">
                  <c:v>49</c:v>
                </c:pt>
                <c:pt idx="38">
                  <c:v>54</c:v>
                </c:pt>
                <c:pt idx="39">
                  <c:v>61</c:v>
                </c:pt>
                <c:pt idx="40">
                  <c:v>65</c:v>
                </c:pt>
                <c:pt idx="41">
                  <c:v>66</c:v>
                </c:pt>
                <c:pt idx="42">
                  <c:v>68</c:v>
                </c:pt>
                <c:pt idx="43">
                  <c:v>69</c:v>
                </c:pt>
                <c:pt idx="44">
                  <c:v>70</c:v>
                </c:pt>
                <c:pt idx="45">
                  <c:v>70</c:v>
                </c:pt>
                <c:pt idx="46">
                  <c:v>70</c:v>
                </c:pt>
                <c:pt idx="47">
                  <c:v>70</c:v>
                </c:pt>
                <c:pt idx="48">
                  <c:v>70</c:v>
                </c:pt>
                <c:pt idx="49">
                  <c:v>71</c:v>
                </c:pt>
                <c:pt idx="50">
                  <c:v>70</c:v>
                </c:pt>
                <c:pt idx="51">
                  <c:v>69</c:v>
                </c:pt>
                <c:pt idx="52">
                  <c:v>66</c:v>
                </c:pt>
                <c:pt idx="53">
                  <c:v>64</c:v>
                </c:pt>
                <c:pt idx="54">
                  <c:v>62</c:v>
                </c:pt>
                <c:pt idx="55">
                  <c:v>60</c:v>
                </c:pt>
                <c:pt idx="56">
                  <c:v>57</c:v>
                </c:pt>
                <c:pt idx="57">
                  <c:v>54</c:v>
                </c:pt>
                <c:pt idx="58">
                  <c:v>48</c:v>
                </c:pt>
                <c:pt idx="59">
                  <c:v>43</c:v>
                </c:pt>
                <c:pt idx="60">
                  <c:v>39</c:v>
                </c:pt>
                <c:pt idx="61">
                  <c:v>35</c:v>
                </c:pt>
                <c:pt idx="62">
                  <c:v>31</c:v>
                </c:pt>
                <c:pt idx="63">
                  <c:v>29</c:v>
                </c:pt>
                <c:pt idx="64">
                  <c:v>26</c:v>
                </c:pt>
                <c:pt idx="65">
                  <c:v>23</c:v>
                </c:pt>
                <c:pt idx="66">
                  <c:v>20</c:v>
                </c:pt>
                <c:pt idx="67">
                  <c:v>16</c:v>
                </c:pt>
                <c:pt idx="68">
                  <c:v>14</c:v>
                </c:pt>
                <c:pt idx="69">
                  <c:v>13</c:v>
                </c:pt>
                <c:pt idx="70">
                  <c:v>13</c:v>
                </c:pt>
                <c:pt idx="71">
                  <c:v>12</c:v>
                </c:pt>
                <c:pt idx="72">
                  <c:v>12</c:v>
                </c:pt>
                <c:pt idx="73">
                  <c:v>11</c:v>
                </c:pt>
                <c:pt idx="74">
                  <c:v>10</c:v>
                </c:pt>
                <c:pt idx="75">
                  <c:v>9</c:v>
                </c:pt>
                <c:pt idx="76">
                  <c:v>9</c:v>
                </c:pt>
                <c:pt idx="77">
                  <c:v>9</c:v>
                </c:pt>
                <c:pt idx="78">
                  <c:v>8</c:v>
                </c:pt>
                <c:pt idx="79">
                  <c:v>7</c:v>
                </c:pt>
                <c:pt idx="80">
                  <c:v>7</c:v>
                </c:pt>
                <c:pt idx="81">
                  <c:v>7</c:v>
                </c:pt>
                <c:pt idx="82">
                  <c:v>7</c:v>
                </c:pt>
                <c:pt idx="83">
                  <c:v>7</c:v>
                </c:pt>
                <c:pt idx="84">
                  <c:v>7</c:v>
                </c:pt>
                <c:pt idx="85">
                  <c:v>7</c:v>
                </c:pt>
                <c:pt idx="86">
                  <c:v>5</c:v>
                </c:pt>
                <c:pt idx="87">
                  <c:v>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77A6-44FE-8C27-7DC46AC30B23}"/>
            </c:ext>
          </c:extLst>
        </c:ser>
        <c:ser>
          <c:idx val="1"/>
          <c:order val="1"/>
          <c:tx>
            <c:strRef>
              <c:f>Лист1!$I$2</c:f>
              <c:strCache>
                <c:ptCount val="1"/>
                <c:pt idx="0">
                  <c:v>Proteostat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Лист1!$G$3:$G$90</c:f>
              <c:numCache>
                <c:formatCode>General</c:formatCode>
                <c:ptCount val="88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</c:numCache>
            </c:numRef>
          </c:xVal>
          <c:yVal>
            <c:numRef>
              <c:f>Лист1!$I$3:$I$90</c:f>
              <c:numCache>
                <c:formatCode>General</c:formatCode>
                <c:ptCount val="88"/>
                <c:pt idx="0">
                  <c:v>9</c:v>
                </c:pt>
                <c:pt idx="1">
                  <c:v>9</c:v>
                </c:pt>
                <c:pt idx="2">
                  <c:v>9</c:v>
                </c:pt>
                <c:pt idx="3">
                  <c:v>9</c:v>
                </c:pt>
                <c:pt idx="4">
                  <c:v>9</c:v>
                </c:pt>
                <c:pt idx="5">
                  <c:v>10</c:v>
                </c:pt>
                <c:pt idx="6">
                  <c:v>10</c:v>
                </c:pt>
                <c:pt idx="7">
                  <c:v>11</c:v>
                </c:pt>
                <c:pt idx="8">
                  <c:v>11</c:v>
                </c:pt>
                <c:pt idx="9">
                  <c:v>11</c:v>
                </c:pt>
                <c:pt idx="10">
                  <c:v>12</c:v>
                </c:pt>
                <c:pt idx="11">
                  <c:v>13</c:v>
                </c:pt>
                <c:pt idx="12">
                  <c:v>14</c:v>
                </c:pt>
                <c:pt idx="13">
                  <c:v>15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8</c:v>
                </c:pt>
                <c:pt idx="19">
                  <c:v>21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5</c:v>
                </c:pt>
                <c:pt idx="27">
                  <c:v>26</c:v>
                </c:pt>
                <c:pt idx="28">
                  <c:v>28</c:v>
                </c:pt>
                <c:pt idx="29">
                  <c:v>28</c:v>
                </c:pt>
                <c:pt idx="30">
                  <c:v>28</c:v>
                </c:pt>
                <c:pt idx="31">
                  <c:v>29</c:v>
                </c:pt>
                <c:pt idx="32">
                  <c:v>30</c:v>
                </c:pt>
                <c:pt idx="33">
                  <c:v>32</c:v>
                </c:pt>
                <c:pt idx="34">
                  <c:v>35</c:v>
                </c:pt>
                <c:pt idx="35">
                  <c:v>37</c:v>
                </c:pt>
                <c:pt idx="36">
                  <c:v>38</c:v>
                </c:pt>
                <c:pt idx="37">
                  <c:v>36</c:v>
                </c:pt>
                <c:pt idx="38">
                  <c:v>36</c:v>
                </c:pt>
                <c:pt idx="39">
                  <c:v>35</c:v>
                </c:pt>
                <c:pt idx="40">
                  <c:v>34</c:v>
                </c:pt>
                <c:pt idx="41">
                  <c:v>33</c:v>
                </c:pt>
                <c:pt idx="42">
                  <c:v>32</c:v>
                </c:pt>
                <c:pt idx="43">
                  <c:v>31</c:v>
                </c:pt>
                <c:pt idx="44">
                  <c:v>31</c:v>
                </c:pt>
                <c:pt idx="45">
                  <c:v>30</c:v>
                </c:pt>
                <c:pt idx="46">
                  <c:v>30</c:v>
                </c:pt>
                <c:pt idx="47">
                  <c:v>29</c:v>
                </c:pt>
                <c:pt idx="48">
                  <c:v>29</c:v>
                </c:pt>
                <c:pt idx="49">
                  <c:v>28</c:v>
                </c:pt>
                <c:pt idx="50">
                  <c:v>28</c:v>
                </c:pt>
                <c:pt idx="51">
                  <c:v>29</c:v>
                </c:pt>
                <c:pt idx="52">
                  <c:v>29</c:v>
                </c:pt>
                <c:pt idx="53">
                  <c:v>30</c:v>
                </c:pt>
                <c:pt idx="54">
                  <c:v>30</c:v>
                </c:pt>
                <c:pt idx="55">
                  <c:v>31</c:v>
                </c:pt>
                <c:pt idx="56">
                  <c:v>32</c:v>
                </c:pt>
                <c:pt idx="57">
                  <c:v>33</c:v>
                </c:pt>
                <c:pt idx="58">
                  <c:v>35</c:v>
                </c:pt>
                <c:pt idx="59">
                  <c:v>37</c:v>
                </c:pt>
                <c:pt idx="60">
                  <c:v>40</c:v>
                </c:pt>
                <c:pt idx="61">
                  <c:v>40</c:v>
                </c:pt>
                <c:pt idx="62">
                  <c:v>39</c:v>
                </c:pt>
                <c:pt idx="63">
                  <c:v>37</c:v>
                </c:pt>
                <c:pt idx="64">
                  <c:v>35</c:v>
                </c:pt>
                <c:pt idx="65">
                  <c:v>32</c:v>
                </c:pt>
                <c:pt idx="66">
                  <c:v>29</c:v>
                </c:pt>
                <c:pt idx="67">
                  <c:v>26</c:v>
                </c:pt>
                <c:pt idx="68">
                  <c:v>24</c:v>
                </c:pt>
                <c:pt idx="69">
                  <c:v>22</c:v>
                </c:pt>
                <c:pt idx="70">
                  <c:v>20</c:v>
                </c:pt>
                <c:pt idx="71">
                  <c:v>17</c:v>
                </c:pt>
                <c:pt idx="72">
                  <c:v>15</c:v>
                </c:pt>
                <c:pt idx="73">
                  <c:v>14</c:v>
                </c:pt>
                <c:pt idx="74">
                  <c:v>14</c:v>
                </c:pt>
                <c:pt idx="75">
                  <c:v>14</c:v>
                </c:pt>
                <c:pt idx="76">
                  <c:v>13</c:v>
                </c:pt>
                <c:pt idx="77">
                  <c:v>13</c:v>
                </c:pt>
                <c:pt idx="78">
                  <c:v>13</c:v>
                </c:pt>
                <c:pt idx="79">
                  <c:v>13</c:v>
                </c:pt>
                <c:pt idx="80">
                  <c:v>12</c:v>
                </c:pt>
                <c:pt idx="81">
                  <c:v>12</c:v>
                </c:pt>
                <c:pt idx="82">
                  <c:v>12</c:v>
                </c:pt>
                <c:pt idx="83">
                  <c:v>11</c:v>
                </c:pt>
                <c:pt idx="84">
                  <c:v>11</c:v>
                </c:pt>
                <c:pt idx="85">
                  <c:v>10</c:v>
                </c:pt>
                <c:pt idx="86">
                  <c:v>11</c:v>
                </c:pt>
                <c:pt idx="87">
                  <c:v>1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77A6-44FE-8C27-7DC46AC30B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31750559"/>
        <c:axId val="1131757215"/>
      </c:scatterChart>
      <c:valAx>
        <c:axId val="1131750559"/>
        <c:scaling>
          <c:orientation val="minMax"/>
          <c:max val="8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131757215"/>
        <c:crosses val="autoZero"/>
        <c:crossBetween val="midCat"/>
        <c:majorUnit val="20"/>
      </c:valAx>
      <c:valAx>
        <c:axId val="113175721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131750559"/>
        <c:crosses val="autoZero"/>
        <c:crossBetween val="midCat"/>
        <c:majorUnit val="2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ru-RU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299128096014742"/>
          <c:y val="0.17447037562959827"/>
          <c:w val="0.55022872709413295"/>
          <c:h val="0.48702961999927563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xVal>
            <c:numRef>
              <c:f>Лист1!$E$2:$E$93</c:f>
              <c:numCache>
                <c:formatCode>General</c:formatCode>
                <c:ptCount val="92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</c:numCache>
            </c:numRef>
          </c:xVal>
          <c:yVal>
            <c:numRef>
              <c:f>Лист1!$F$2:$F$93</c:f>
              <c:numCache>
                <c:formatCode>General</c:formatCode>
                <c:ptCount val="92"/>
                <c:pt idx="0">
                  <c:v>12</c:v>
                </c:pt>
                <c:pt idx="1">
                  <c:v>11.8132</c:v>
                </c:pt>
                <c:pt idx="2">
                  <c:v>11.811999999999999</c:v>
                </c:pt>
                <c:pt idx="3">
                  <c:v>11.875500000000001</c:v>
                </c:pt>
                <c:pt idx="4">
                  <c:v>12.299200000000001</c:v>
                </c:pt>
                <c:pt idx="5">
                  <c:v>12.63</c:v>
                </c:pt>
                <c:pt idx="6">
                  <c:v>13.1723</c:v>
                </c:pt>
                <c:pt idx="7">
                  <c:v>13.3314</c:v>
                </c:pt>
                <c:pt idx="8">
                  <c:v>13.678699999999999</c:v>
                </c:pt>
                <c:pt idx="9">
                  <c:v>13.942</c:v>
                </c:pt>
                <c:pt idx="10">
                  <c:v>14.520099999999999</c:v>
                </c:pt>
                <c:pt idx="11">
                  <c:v>14.8444</c:v>
                </c:pt>
                <c:pt idx="12">
                  <c:v>15.201000000000001</c:v>
                </c:pt>
                <c:pt idx="13">
                  <c:v>15.6395</c:v>
                </c:pt>
                <c:pt idx="14">
                  <c:v>16.366900000000001</c:v>
                </c:pt>
                <c:pt idx="15">
                  <c:v>17.351500000000001</c:v>
                </c:pt>
                <c:pt idx="16">
                  <c:v>18.0989</c:v>
                </c:pt>
                <c:pt idx="17">
                  <c:v>18.9391</c:v>
                </c:pt>
                <c:pt idx="18">
                  <c:v>19.869599999999998</c:v>
                </c:pt>
                <c:pt idx="19">
                  <c:v>20.728000000000002</c:v>
                </c:pt>
                <c:pt idx="20">
                  <c:v>21.651900000000001</c:v>
                </c:pt>
                <c:pt idx="21">
                  <c:v>23.1953</c:v>
                </c:pt>
                <c:pt idx="22">
                  <c:v>24.860800000000001</c:v>
                </c:pt>
                <c:pt idx="23">
                  <c:v>26.6557</c:v>
                </c:pt>
                <c:pt idx="24">
                  <c:v>28.611499999999999</c:v>
                </c:pt>
                <c:pt idx="25">
                  <c:v>31.007400000000001</c:v>
                </c:pt>
                <c:pt idx="26">
                  <c:v>34.680300000000003</c:v>
                </c:pt>
                <c:pt idx="27">
                  <c:v>40.042400000000001</c:v>
                </c:pt>
                <c:pt idx="28">
                  <c:v>46.216999999999999</c:v>
                </c:pt>
                <c:pt idx="29">
                  <c:v>51.129600000000003</c:v>
                </c:pt>
                <c:pt idx="30">
                  <c:v>53.822899999999997</c:v>
                </c:pt>
                <c:pt idx="31">
                  <c:v>55.438499999999998</c:v>
                </c:pt>
                <c:pt idx="32">
                  <c:v>56.233699999999999</c:v>
                </c:pt>
                <c:pt idx="33">
                  <c:v>56.3874</c:v>
                </c:pt>
                <c:pt idx="34">
                  <c:v>54.707599999999999</c:v>
                </c:pt>
                <c:pt idx="35">
                  <c:v>52.865900000000003</c:v>
                </c:pt>
                <c:pt idx="36">
                  <c:v>49.572099999999999</c:v>
                </c:pt>
                <c:pt idx="37">
                  <c:v>48.338200000000001</c:v>
                </c:pt>
                <c:pt idx="38">
                  <c:v>47.743600000000001</c:v>
                </c:pt>
                <c:pt idx="39">
                  <c:v>47.1905</c:v>
                </c:pt>
                <c:pt idx="40">
                  <c:v>47.494500000000002</c:v>
                </c:pt>
                <c:pt idx="41">
                  <c:v>47.751100000000001</c:v>
                </c:pt>
                <c:pt idx="42">
                  <c:v>47.666699999999999</c:v>
                </c:pt>
                <c:pt idx="43">
                  <c:v>47.768799999999999</c:v>
                </c:pt>
                <c:pt idx="44">
                  <c:v>48.824199999999998</c:v>
                </c:pt>
                <c:pt idx="45">
                  <c:v>48.9377</c:v>
                </c:pt>
                <c:pt idx="46">
                  <c:v>48.728900000000003</c:v>
                </c:pt>
                <c:pt idx="47">
                  <c:v>48.580399999999997</c:v>
                </c:pt>
                <c:pt idx="48">
                  <c:v>48.633699999999997</c:v>
                </c:pt>
                <c:pt idx="49">
                  <c:v>48.962499999999999</c:v>
                </c:pt>
                <c:pt idx="50">
                  <c:v>50.369799999999998</c:v>
                </c:pt>
                <c:pt idx="51">
                  <c:v>51.915700000000001</c:v>
                </c:pt>
                <c:pt idx="52">
                  <c:v>51.476199999999999</c:v>
                </c:pt>
                <c:pt idx="53">
                  <c:v>51.388399999999997</c:v>
                </c:pt>
                <c:pt idx="54">
                  <c:v>52.814399999999999</c:v>
                </c:pt>
                <c:pt idx="55">
                  <c:v>54.3523</c:v>
                </c:pt>
                <c:pt idx="56">
                  <c:v>55.613399999999999</c:v>
                </c:pt>
                <c:pt idx="57">
                  <c:v>56.988</c:v>
                </c:pt>
                <c:pt idx="58">
                  <c:v>58.867199999999997</c:v>
                </c:pt>
                <c:pt idx="59">
                  <c:v>60.867400000000004</c:v>
                </c:pt>
                <c:pt idx="60">
                  <c:v>63.2806</c:v>
                </c:pt>
                <c:pt idx="61">
                  <c:v>65.915700000000001</c:v>
                </c:pt>
                <c:pt idx="62">
                  <c:v>68.887100000000004</c:v>
                </c:pt>
                <c:pt idx="63">
                  <c:v>71.538499999999999</c:v>
                </c:pt>
                <c:pt idx="64">
                  <c:v>73.492400000000004</c:v>
                </c:pt>
                <c:pt idx="65">
                  <c:v>74.462599999999995</c:v>
                </c:pt>
                <c:pt idx="66">
                  <c:v>73.911900000000003</c:v>
                </c:pt>
                <c:pt idx="67">
                  <c:v>71.438000000000002</c:v>
                </c:pt>
                <c:pt idx="68">
                  <c:v>66.973600000000005</c:v>
                </c:pt>
                <c:pt idx="69">
                  <c:v>60.886800000000001</c:v>
                </c:pt>
                <c:pt idx="70">
                  <c:v>53.846200000000003</c:v>
                </c:pt>
                <c:pt idx="71">
                  <c:v>47.057899999999997</c:v>
                </c:pt>
                <c:pt idx="72">
                  <c:v>41.497300000000003</c:v>
                </c:pt>
                <c:pt idx="73">
                  <c:v>36.4512</c:v>
                </c:pt>
                <c:pt idx="74">
                  <c:v>32.205100000000002</c:v>
                </c:pt>
                <c:pt idx="75">
                  <c:v>28.582799999999999</c:v>
                </c:pt>
                <c:pt idx="76">
                  <c:v>26.146699999999999</c:v>
                </c:pt>
                <c:pt idx="77">
                  <c:v>24.5641</c:v>
                </c:pt>
                <c:pt idx="78">
                  <c:v>23.312899999999999</c:v>
                </c:pt>
                <c:pt idx="79">
                  <c:v>22.4908</c:v>
                </c:pt>
                <c:pt idx="80">
                  <c:v>21.540400000000002</c:v>
                </c:pt>
                <c:pt idx="81">
                  <c:v>19.7363</c:v>
                </c:pt>
                <c:pt idx="82">
                  <c:v>18.552499999999998</c:v>
                </c:pt>
                <c:pt idx="83">
                  <c:v>18.015699999999999</c:v>
                </c:pt>
                <c:pt idx="84">
                  <c:v>17.439800000000002</c:v>
                </c:pt>
                <c:pt idx="85">
                  <c:v>17.292999999999999</c:v>
                </c:pt>
                <c:pt idx="86">
                  <c:v>17.470500000000001</c:v>
                </c:pt>
                <c:pt idx="87">
                  <c:v>15.946199999999999</c:v>
                </c:pt>
                <c:pt idx="88">
                  <c:v>15.419499999999999</c:v>
                </c:pt>
                <c:pt idx="89">
                  <c:v>14.814399999999999</c:v>
                </c:pt>
                <c:pt idx="90">
                  <c:v>14.985300000000001</c:v>
                </c:pt>
                <c:pt idx="91">
                  <c:v>14.3332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2BC-424D-A9CC-105A1C7144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8785327"/>
        <c:axId val="1878776175"/>
      </c:scatterChart>
      <c:valAx>
        <c:axId val="187878532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878776175"/>
        <c:crosses val="autoZero"/>
        <c:crossBetween val="midCat"/>
        <c:majorUnit val="25"/>
      </c:valAx>
      <c:valAx>
        <c:axId val="1878776175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878785327"/>
        <c:crosses val="max"/>
        <c:crossBetween val="midCat"/>
        <c:majorUnit val="2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ru-RU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8889098487375348E-2"/>
          <c:y val="8.9590364788016089E-2"/>
          <c:w val="0.58495984140635249"/>
          <c:h val="0.76447474024424633"/>
        </c:manualLayout>
      </c:layout>
      <c:scatterChart>
        <c:scatterStyle val="smoothMarker"/>
        <c:varyColors val="0"/>
        <c:ser>
          <c:idx val="0"/>
          <c:order val="0"/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xVal>
            <c:numRef>
              <c:f>Лист1!$H$2:$H$118</c:f>
              <c:numCache>
                <c:formatCode>General</c:formatCode>
                <c:ptCount val="1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</c:numCache>
            </c:numRef>
          </c:xVal>
          <c:yVal>
            <c:numRef>
              <c:f>Лист1!$I$2:$I$118</c:f>
              <c:numCache>
                <c:formatCode>General</c:formatCode>
                <c:ptCount val="117"/>
                <c:pt idx="0">
                  <c:v>15</c:v>
                </c:pt>
                <c:pt idx="1">
                  <c:v>15.4368</c:v>
                </c:pt>
                <c:pt idx="2">
                  <c:v>15.3789</c:v>
                </c:pt>
                <c:pt idx="3">
                  <c:v>15.860300000000001</c:v>
                </c:pt>
                <c:pt idx="4">
                  <c:v>16.346399999999999</c:v>
                </c:pt>
                <c:pt idx="5">
                  <c:v>17.226600000000001</c:v>
                </c:pt>
                <c:pt idx="6">
                  <c:v>17.195399999999999</c:v>
                </c:pt>
                <c:pt idx="7">
                  <c:v>17.2926</c:v>
                </c:pt>
                <c:pt idx="8">
                  <c:v>18.4086</c:v>
                </c:pt>
                <c:pt idx="9">
                  <c:v>18.478200000000001</c:v>
                </c:pt>
                <c:pt idx="10">
                  <c:v>17.620699999999999</c:v>
                </c:pt>
                <c:pt idx="11">
                  <c:v>17.327100000000002</c:v>
                </c:pt>
                <c:pt idx="12">
                  <c:v>17.089200000000002</c:v>
                </c:pt>
                <c:pt idx="13">
                  <c:v>17.293099999999999</c:v>
                </c:pt>
                <c:pt idx="14">
                  <c:v>18.007899999999999</c:v>
                </c:pt>
                <c:pt idx="15">
                  <c:v>18.775200000000002</c:v>
                </c:pt>
                <c:pt idx="16">
                  <c:v>18.820799999999998</c:v>
                </c:pt>
                <c:pt idx="17">
                  <c:v>19.402200000000001</c:v>
                </c:pt>
                <c:pt idx="18">
                  <c:v>20.468900000000001</c:v>
                </c:pt>
                <c:pt idx="19">
                  <c:v>21.4757</c:v>
                </c:pt>
                <c:pt idx="20">
                  <c:v>22.269500000000001</c:v>
                </c:pt>
                <c:pt idx="21">
                  <c:v>23.168900000000001</c:v>
                </c:pt>
                <c:pt idx="22">
                  <c:v>23.911999999999999</c:v>
                </c:pt>
                <c:pt idx="23">
                  <c:v>25.471299999999999</c:v>
                </c:pt>
                <c:pt idx="24">
                  <c:v>26.781600000000001</c:v>
                </c:pt>
                <c:pt idx="25">
                  <c:v>28.6309</c:v>
                </c:pt>
                <c:pt idx="26">
                  <c:v>31.113</c:v>
                </c:pt>
                <c:pt idx="27">
                  <c:v>33.7973</c:v>
                </c:pt>
                <c:pt idx="28">
                  <c:v>36.672600000000003</c:v>
                </c:pt>
                <c:pt idx="29">
                  <c:v>40.75</c:v>
                </c:pt>
                <c:pt idx="30">
                  <c:v>45.868000000000002</c:v>
                </c:pt>
                <c:pt idx="31">
                  <c:v>52.819400000000002</c:v>
                </c:pt>
                <c:pt idx="32">
                  <c:v>60.722200000000001</c:v>
                </c:pt>
                <c:pt idx="33">
                  <c:v>68.277199999999993</c:v>
                </c:pt>
                <c:pt idx="34">
                  <c:v>75.046400000000006</c:v>
                </c:pt>
                <c:pt idx="35">
                  <c:v>80.447599999999994</c:v>
                </c:pt>
                <c:pt idx="36">
                  <c:v>84.352400000000003</c:v>
                </c:pt>
                <c:pt idx="37">
                  <c:v>87.101200000000006</c:v>
                </c:pt>
                <c:pt idx="38">
                  <c:v>89.879900000000006</c:v>
                </c:pt>
                <c:pt idx="39">
                  <c:v>90.968699999999998</c:v>
                </c:pt>
                <c:pt idx="40">
                  <c:v>90.740399999999994</c:v>
                </c:pt>
                <c:pt idx="41">
                  <c:v>90.178200000000004</c:v>
                </c:pt>
                <c:pt idx="42">
                  <c:v>89.956400000000002</c:v>
                </c:pt>
                <c:pt idx="43">
                  <c:v>89.689700000000002</c:v>
                </c:pt>
                <c:pt idx="44">
                  <c:v>88.667500000000004</c:v>
                </c:pt>
                <c:pt idx="45">
                  <c:v>88.189700000000002</c:v>
                </c:pt>
                <c:pt idx="46">
                  <c:v>88.141099999999994</c:v>
                </c:pt>
                <c:pt idx="47">
                  <c:v>87.504300000000001</c:v>
                </c:pt>
                <c:pt idx="48">
                  <c:v>86.773300000000006</c:v>
                </c:pt>
                <c:pt idx="49">
                  <c:v>85.811499999999995</c:v>
                </c:pt>
                <c:pt idx="50">
                  <c:v>85.311499999999995</c:v>
                </c:pt>
                <c:pt idx="51">
                  <c:v>85.348799999999997</c:v>
                </c:pt>
                <c:pt idx="52">
                  <c:v>85.088399999999993</c:v>
                </c:pt>
                <c:pt idx="53">
                  <c:v>84.238100000000003</c:v>
                </c:pt>
                <c:pt idx="54">
                  <c:v>83.622299999999996</c:v>
                </c:pt>
                <c:pt idx="55">
                  <c:v>83.556600000000003</c:v>
                </c:pt>
                <c:pt idx="56">
                  <c:v>83.332899999999995</c:v>
                </c:pt>
                <c:pt idx="57">
                  <c:v>82.195899999999995</c:v>
                </c:pt>
                <c:pt idx="58">
                  <c:v>82.333299999999994</c:v>
                </c:pt>
                <c:pt idx="59">
                  <c:v>83.206900000000005</c:v>
                </c:pt>
                <c:pt idx="60">
                  <c:v>84.299199999999999</c:v>
                </c:pt>
                <c:pt idx="61">
                  <c:v>84.435900000000004</c:v>
                </c:pt>
                <c:pt idx="62">
                  <c:v>83.640500000000003</c:v>
                </c:pt>
                <c:pt idx="63">
                  <c:v>82.828400000000002</c:v>
                </c:pt>
                <c:pt idx="64">
                  <c:v>83.275899999999993</c:v>
                </c:pt>
                <c:pt idx="65">
                  <c:v>84.219300000000004</c:v>
                </c:pt>
                <c:pt idx="66">
                  <c:v>84.977000000000004</c:v>
                </c:pt>
                <c:pt idx="67">
                  <c:v>85.677000000000007</c:v>
                </c:pt>
                <c:pt idx="68">
                  <c:v>86.029300000000006</c:v>
                </c:pt>
                <c:pt idx="69">
                  <c:v>86.712599999999995</c:v>
                </c:pt>
                <c:pt idx="70">
                  <c:v>87.413799999999995</c:v>
                </c:pt>
                <c:pt idx="71">
                  <c:v>87.080500000000001</c:v>
                </c:pt>
                <c:pt idx="72">
                  <c:v>87.0274</c:v>
                </c:pt>
                <c:pt idx="73">
                  <c:v>88.204800000000006</c:v>
                </c:pt>
                <c:pt idx="74">
                  <c:v>89.974599999999995</c:v>
                </c:pt>
                <c:pt idx="75">
                  <c:v>91.368200000000002</c:v>
                </c:pt>
                <c:pt idx="76">
                  <c:v>92.4392</c:v>
                </c:pt>
                <c:pt idx="77">
                  <c:v>93.992999999999995</c:v>
                </c:pt>
                <c:pt idx="78">
                  <c:v>95.574700000000007</c:v>
                </c:pt>
                <c:pt idx="79">
                  <c:v>97.202299999999994</c:v>
                </c:pt>
                <c:pt idx="80">
                  <c:v>99.0595</c:v>
                </c:pt>
                <c:pt idx="81">
                  <c:v>99.700500000000005</c:v>
                </c:pt>
                <c:pt idx="82">
                  <c:v>99.368200000000002</c:v>
                </c:pt>
                <c:pt idx="83">
                  <c:v>97.129000000000005</c:v>
                </c:pt>
                <c:pt idx="84">
                  <c:v>93.189800000000005</c:v>
                </c:pt>
                <c:pt idx="85">
                  <c:v>87.968000000000004</c:v>
                </c:pt>
                <c:pt idx="86">
                  <c:v>82.508499999999998</c:v>
                </c:pt>
                <c:pt idx="87">
                  <c:v>76.416700000000006</c:v>
                </c:pt>
                <c:pt idx="88">
                  <c:v>70.043199999999999</c:v>
                </c:pt>
                <c:pt idx="89">
                  <c:v>63.596899999999998</c:v>
                </c:pt>
                <c:pt idx="90">
                  <c:v>56.151400000000002</c:v>
                </c:pt>
                <c:pt idx="91">
                  <c:v>48.145600000000002</c:v>
                </c:pt>
                <c:pt idx="92">
                  <c:v>41.849800000000002</c:v>
                </c:pt>
                <c:pt idx="93">
                  <c:v>37.702500000000001</c:v>
                </c:pt>
                <c:pt idx="94">
                  <c:v>34.544199999999996</c:v>
                </c:pt>
                <c:pt idx="95">
                  <c:v>31.9194</c:v>
                </c:pt>
                <c:pt idx="96">
                  <c:v>30.206900000000001</c:v>
                </c:pt>
                <c:pt idx="97">
                  <c:v>28.797599999999999</c:v>
                </c:pt>
                <c:pt idx="98">
                  <c:v>26.9057</c:v>
                </c:pt>
                <c:pt idx="99">
                  <c:v>25.528500000000001</c:v>
                </c:pt>
                <c:pt idx="100">
                  <c:v>24.799800000000001</c:v>
                </c:pt>
                <c:pt idx="101">
                  <c:v>23.892199999999999</c:v>
                </c:pt>
                <c:pt idx="102">
                  <c:v>23.199000000000002</c:v>
                </c:pt>
                <c:pt idx="103">
                  <c:v>22.099699999999999</c:v>
                </c:pt>
                <c:pt idx="104">
                  <c:v>21.152200000000001</c:v>
                </c:pt>
                <c:pt idx="105">
                  <c:v>20.477499999999999</c:v>
                </c:pt>
                <c:pt idx="106">
                  <c:v>21.689299999999999</c:v>
                </c:pt>
                <c:pt idx="107">
                  <c:v>20.444800000000001</c:v>
                </c:pt>
                <c:pt idx="108">
                  <c:v>18.554099999999998</c:v>
                </c:pt>
                <c:pt idx="109">
                  <c:v>17.552600000000002</c:v>
                </c:pt>
                <c:pt idx="110">
                  <c:v>17.168099999999999</c:v>
                </c:pt>
                <c:pt idx="111">
                  <c:v>17.045999999999999</c:v>
                </c:pt>
                <c:pt idx="112">
                  <c:v>16.436800000000002</c:v>
                </c:pt>
                <c:pt idx="113">
                  <c:v>15.9138</c:v>
                </c:pt>
                <c:pt idx="114">
                  <c:v>15.666700000000001</c:v>
                </c:pt>
                <c:pt idx="115">
                  <c:v>15.6265</c:v>
                </c:pt>
                <c:pt idx="116">
                  <c:v>15.3332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9374-4314-B8FE-24290A2F6B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69587551"/>
        <c:axId val="1869596287"/>
      </c:scatterChart>
      <c:valAx>
        <c:axId val="1869587551"/>
        <c:scaling>
          <c:orientation val="minMax"/>
          <c:max val="115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869596287"/>
        <c:crosses val="autoZero"/>
        <c:crossBetween val="midCat"/>
        <c:majorUnit val="30"/>
      </c:valAx>
      <c:valAx>
        <c:axId val="1869596287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869587551"/>
        <c:crosses val="max"/>
        <c:crossBetween val="midCat"/>
        <c:majorUnit val="5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/>
      </a:pPr>
      <a:endParaRPr lang="ru-RU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2488834278106391E-2"/>
          <c:y val="5.9545038569643827E-2"/>
          <c:w val="0.61956567045975575"/>
          <c:h val="0.76151835623057573"/>
        </c:manualLayout>
      </c:layout>
      <c:scatterChart>
        <c:scatterStyle val="smoothMarker"/>
        <c:varyColors val="0"/>
        <c:ser>
          <c:idx val="0"/>
          <c:order val="0"/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xVal>
            <c:numRef>
              <c:f>Лист1!$K$2:$K$80</c:f>
              <c:numCache>
                <c:formatCode>General</c:formatCode>
                <c:ptCount val="7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</c:numCache>
            </c:numRef>
          </c:xVal>
          <c:yVal>
            <c:numRef>
              <c:f>Лист1!$L$2:$L$80</c:f>
              <c:numCache>
                <c:formatCode>General</c:formatCode>
                <c:ptCount val="79"/>
                <c:pt idx="0">
                  <c:v>18</c:v>
                </c:pt>
                <c:pt idx="1">
                  <c:v>17.700199999999999</c:v>
                </c:pt>
                <c:pt idx="2">
                  <c:v>17.474900000000002</c:v>
                </c:pt>
                <c:pt idx="3">
                  <c:v>17.6065</c:v>
                </c:pt>
                <c:pt idx="4">
                  <c:v>17.950900000000001</c:v>
                </c:pt>
                <c:pt idx="5">
                  <c:v>18.098500000000001</c:v>
                </c:pt>
                <c:pt idx="6">
                  <c:v>18.025600000000001</c:v>
                </c:pt>
                <c:pt idx="7">
                  <c:v>18.346900000000002</c:v>
                </c:pt>
                <c:pt idx="8">
                  <c:v>18.795100000000001</c:v>
                </c:pt>
                <c:pt idx="9">
                  <c:v>19.5</c:v>
                </c:pt>
                <c:pt idx="10">
                  <c:v>20.529900000000001</c:v>
                </c:pt>
                <c:pt idx="11">
                  <c:v>21.0321</c:v>
                </c:pt>
                <c:pt idx="12">
                  <c:v>20.974399999999999</c:v>
                </c:pt>
                <c:pt idx="13">
                  <c:v>21.796299999999999</c:v>
                </c:pt>
                <c:pt idx="14">
                  <c:v>23.1569</c:v>
                </c:pt>
                <c:pt idx="15">
                  <c:v>24.450700000000001</c:v>
                </c:pt>
                <c:pt idx="16">
                  <c:v>25.537600000000001</c:v>
                </c:pt>
                <c:pt idx="17">
                  <c:v>26.880299999999998</c:v>
                </c:pt>
                <c:pt idx="18">
                  <c:v>28.514800000000001</c:v>
                </c:pt>
                <c:pt idx="19">
                  <c:v>31.320499999999999</c:v>
                </c:pt>
                <c:pt idx="20">
                  <c:v>38.179499999999997</c:v>
                </c:pt>
                <c:pt idx="21">
                  <c:v>44.340200000000003</c:v>
                </c:pt>
                <c:pt idx="22">
                  <c:v>49.713799999999999</c:v>
                </c:pt>
                <c:pt idx="23">
                  <c:v>52.3718</c:v>
                </c:pt>
                <c:pt idx="24">
                  <c:v>53.489199999999997</c:v>
                </c:pt>
                <c:pt idx="25">
                  <c:v>53.659300000000002</c:v>
                </c:pt>
                <c:pt idx="26">
                  <c:v>52.703699999999998</c:v>
                </c:pt>
                <c:pt idx="27">
                  <c:v>51.6736</c:v>
                </c:pt>
                <c:pt idx="28">
                  <c:v>50.836500000000001</c:v>
                </c:pt>
                <c:pt idx="29">
                  <c:v>50.591500000000003</c:v>
                </c:pt>
                <c:pt idx="30">
                  <c:v>50.049300000000002</c:v>
                </c:pt>
                <c:pt idx="31">
                  <c:v>49.534199999999998</c:v>
                </c:pt>
                <c:pt idx="32">
                  <c:v>49.994999999999997</c:v>
                </c:pt>
                <c:pt idx="33">
                  <c:v>50.430999999999997</c:v>
                </c:pt>
                <c:pt idx="34">
                  <c:v>50.239100000000001</c:v>
                </c:pt>
                <c:pt idx="35">
                  <c:v>49.679400000000001</c:v>
                </c:pt>
                <c:pt idx="36">
                  <c:v>49.078899999999997</c:v>
                </c:pt>
                <c:pt idx="37">
                  <c:v>49.673099999999998</c:v>
                </c:pt>
                <c:pt idx="38">
                  <c:v>50.136099999999999</c:v>
                </c:pt>
                <c:pt idx="39">
                  <c:v>51.333300000000001</c:v>
                </c:pt>
                <c:pt idx="40">
                  <c:v>51.119700000000002</c:v>
                </c:pt>
                <c:pt idx="41">
                  <c:v>51.415100000000002</c:v>
                </c:pt>
                <c:pt idx="42">
                  <c:v>51.051299999999998</c:v>
                </c:pt>
                <c:pt idx="43">
                  <c:v>50.243499999999997</c:v>
                </c:pt>
                <c:pt idx="44">
                  <c:v>50.2224</c:v>
                </c:pt>
                <c:pt idx="45">
                  <c:v>50.591700000000003</c:v>
                </c:pt>
                <c:pt idx="46">
                  <c:v>50.555599999999998</c:v>
                </c:pt>
                <c:pt idx="47">
                  <c:v>50.739100000000001</c:v>
                </c:pt>
                <c:pt idx="48">
                  <c:v>51.459600000000002</c:v>
                </c:pt>
                <c:pt idx="49">
                  <c:v>51.692300000000003</c:v>
                </c:pt>
                <c:pt idx="50">
                  <c:v>52.086599999999997</c:v>
                </c:pt>
                <c:pt idx="51">
                  <c:v>52.621299999999998</c:v>
                </c:pt>
                <c:pt idx="52">
                  <c:v>53.1111</c:v>
                </c:pt>
                <c:pt idx="53">
                  <c:v>53.903599999999997</c:v>
                </c:pt>
                <c:pt idx="54">
                  <c:v>55.386600000000001</c:v>
                </c:pt>
                <c:pt idx="55">
                  <c:v>55.419699999999999</c:v>
                </c:pt>
                <c:pt idx="56">
                  <c:v>54.692300000000003</c:v>
                </c:pt>
                <c:pt idx="57">
                  <c:v>51.712000000000003</c:v>
                </c:pt>
                <c:pt idx="58">
                  <c:v>47.151899999999998</c:v>
                </c:pt>
                <c:pt idx="59">
                  <c:v>42.7502</c:v>
                </c:pt>
                <c:pt idx="60">
                  <c:v>38.2821</c:v>
                </c:pt>
                <c:pt idx="61">
                  <c:v>34.299300000000002</c:v>
                </c:pt>
                <c:pt idx="62">
                  <c:v>30.9649</c:v>
                </c:pt>
                <c:pt idx="63">
                  <c:v>28.168600000000001</c:v>
                </c:pt>
                <c:pt idx="64">
                  <c:v>26.011600000000001</c:v>
                </c:pt>
                <c:pt idx="65">
                  <c:v>24.722200000000001</c:v>
                </c:pt>
                <c:pt idx="66">
                  <c:v>23.493099999999998</c:v>
                </c:pt>
                <c:pt idx="67">
                  <c:v>22.633600000000001</c:v>
                </c:pt>
                <c:pt idx="68">
                  <c:v>22.3428</c:v>
                </c:pt>
                <c:pt idx="69">
                  <c:v>21.738700000000001</c:v>
                </c:pt>
                <c:pt idx="70">
                  <c:v>20.128</c:v>
                </c:pt>
                <c:pt idx="71">
                  <c:v>18.732299999999999</c:v>
                </c:pt>
                <c:pt idx="72">
                  <c:v>18.266300000000001</c:v>
                </c:pt>
                <c:pt idx="73">
                  <c:v>17.7179</c:v>
                </c:pt>
                <c:pt idx="74">
                  <c:v>16.9358</c:v>
                </c:pt>
                <c:pt idx="75">
                  <c:v>16.2179</c:v>
                </c:pt>
                <c:pt idx="76">
                  <c:v>15.5032</c:v>
                </c:pt>
                <c:pt idx="77">
                  <c:v>15.203900000000001</c:v>
                </c:pt>
                <c:pt idx="78">
                  <c:v>1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5C9B-44FE-8193-D0A3288ED6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8777423"/>
        <c:axId val="1878779919"/>
      </c:scatterChart>
      <c:valAx>
        <c:axId val="1878777423"/>
        <c:scaling>
          <c:orientation val="minMax"/>
          <c:max val="8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878779919"/>
        <c:crosses val="autoZero"/>
        <c:crossBetween val="midCat"/>
        <c:majorUnit val="20"/>
      </c:valAx>
      <c:valAx>
        <c:axId val="1878779919"/>
        <c:scaling>
          <c:orientation val="minMax"/>
          <c:max val="60"/>
          <c:min val="10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878777423"/>
        <c:crosses val="max"/>
        <c:crossBetween val="midCat"/>
        <c:majorUnit val="2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/>
      </a:pPr>
      <a:endParaRPr lang="ru-RU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1025371828521434E-2"/>
          <c:y val="0.13217095560810285"/>
          <c:w val="0.62892993417812593"/>
          <c:h val="0.59381737572500071"/>
        </c:manualLayout>
      </c:layout>
      <c:scatterChart>
        <c:scatterStyle val="smoothMarker"/>
        <c:varyColors val="0"/>
        <c:ser>
          <c:idx val="0"/>
          <c:order val="0"/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xVal>
            <c:strRef>
              <c:f>Лист1!$C$3:$C$89</c:f>
              <c:strCache>
                <c:ptCount val="8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</c:strCache>
            </c:strRef>
          </c:xVal>
          <c:yVal>
            <c:numRef>
              <c:f>Лист1!$D$3:$D$89</c:f>
              <c:numCache>
                <c:formatCode>@</c:formatCode>
                <c:ptCount val="87"/>
                <c:pt idx="0">
                  <c:v>0</c:v>
                </c:pt>
                <c:pt idx="1">
                  <c:v>0</c:v>
                </c:pt>
                <c:pt idx="2">
                  <c:v>0.18390000000000001</c:v>
                </c:pt>
                <c:pt idx="3">
                  <c:v>2.7966000000000002</c:v>
                </c:pt>
                <c:pt idx="4">
                  <c:v>2.5590000000000002</c:v>
                </c:pt>
                <c:pt idx="5">
                  <c:v>6.5194000000000001</c:v>
                </c:pt>
                <c:pt idx="6">
                  <c:v>10.5426</c:v>
                </c:pt>
                <c:pt idx="7">
                  <c:v>7.5774999999999997</c:v>
                </c:pt>
                <c:pt idx="8">
                  <c:v>6.5003000000000002</c:v>
                </c:pt>
                <c:pt idx="9">
                  <c:v>10.7395</c:v>
                </c:pt>
                <c:pt idx="10">
                  <c:v>11.333299999999999</c:v>
                </c:pt>
                <c:pt idx="11">
                  <c:v>11.333299999999999</c:v>
                </c:pt>
                <c:pt idx="12">
                  <c:v>13.674799999999999</c:v>
                </c:pt>
                <c:pt idx="13">
                  <c:v>17</c:v>
                </c:pt>
                <c:pt idx="14">
                  <c:v>18.630400000000002</c:v>
                </c:pt>
                <c:pt idx="15">
                  <c:v>18.913900000000002</c:v>
                </c:pt>
                <c:pt idx="16">
                  <c:v>21.177199999999999</c:v>
                </c:pt>
                <c:pt idx="17">
                  <c:v>22.666699999999999</c:v>
                </c:pt>
                <c:pt idx="18">
                  <c:v>28.587700000000002</c:v>
                </c:pt>
                <c:pt idx="19">
                  <c:v>30.0703</c:v>
                </c:pt>
                <c:pt idx="20">
                  <c:v>42.100099999999998</c:v>
                </c:pt>
                <c:pt idx="21">
                  <c:v>45.321800000000003</c:v>
                </c:pt>
                <c:pt idx="22">
                  <c:v>54.864600000000003</c:v>
                </c:pt>
                <c:pt idx="23">
                  <c:v>56.8643</c:v>
                </c:pt>
                <c:pt idx="24">
                  <c:v>60.761099999999999</c:v>
                </c:pt>
                <c:pt idx="25">
                  <c:v>63.944600000000001</c:v>
                </c:pt>
                <c:pt idx="26">
                  <c:v>67.604699999999994</c:v>
                </c:pt>
                <c:pt idx="27">
                  <c:v>62.735599999999998</c:v>
                </c:pt>
                <c:pt idx="28">
                  <c:v>60.816299999999998</c:v>
                </c:pt>
                <c:pt idx="29">
                  <c:v>58.841099999999997</c:v>
                </c:pt>
                <c:pt idx="30">
                  <c:v>56.666699999999999</c:v>
                </c:pt>
                <c:pt idx="31">
                  <c:v>56.666699999999999</c:v>
                </c:pt>
                <c:pt idx="32">
                  <c:v>55.980200000000004</c:v>
                </c:pt>
                <c:pt idx="33">
                  <c:v>52.515500000000003</c:v>
                </c:pt>
                <c:pt idx="34">
                  <c:v>55.480600000000003</c:v>
                </c:pt>
                <c:pt idx="35">
                  <c:v>56.666699999999999</c:v>
                </c:pt>
                <c:pt idx="36">
                  <c:v>56.151800000000001</c:v>
                </c:pt>
                <c:pt idx="37">
                  <c:v>55.191800000000001</c:v>
                </c:pt>
                <c:pt idx="38">
                  <c:v>56.007800000000003</c:v>
                </c:pt>
                <c:pt idx="39">
                  <c:v>54.250100000000003</c:v>
                </c:pt>
                <c:pt idx="40">
                  <c:v>56.044499999999999</c:v>
                </c:pt>
                <c:pt idx="41">
                  <c:v>54.604900000000001</c:v>
                </c:pt>
                <c:pt idx="42">
                  <c:v>51.131799999999998</c:v>
                </c:pt>
                <c:pt idx="43">
                  <c:v>55.25</c:v>
                </c:pt>
                <c:pt idx="44">
                  <c:v>56.666699999999999</c:v>
                </c:pt>
                <c:pt idx="45">
                  <c:v>56.666699999999999</c:v>
                </c:pt>
                <c:pt idx="46">
                  <c:v>57.307200000000002</c:v>
                </c:pt>
                <c:pt idx="47">
                  <c:v>62.091999999999999</c:v>
                </c:pt>
                <c:pt idx="48">
                  <c:v>62.333300000000001</c:v>
                </c:pt>
                <c:pt idx="49">
                  <c:v>62.333300000000001</c:v>
                </c:pt>
                <c:pt idx="50">
                  <c:v>62.333300000000001</c:v>
                </c:pt>
                <c:pt idx="51">
                  <c:v>62.333300000000001</c:v>
                </c:pt>
                <c:pt idx="52">
                  <c:v>63.519399999999997</c:v>
                </c:pt>
                <c:pt idx="53">
                  <c:v>66.484499999999997</c:v>
                </c:pt>
                <c:pt idx="54">
                  <c:v>66.7864</c:v>
                </c:pt>
                <c:pt idx="55">
                  <c:v>65.755099999999999</c:v>
                </c:pt>
                <c:pt idx="56">
                  <c:v>64.172200000000004</c:v>
                </c:pt>
                <c:pt idx="57">
                  <c:v>60.158900000000003</c:v>
                </c:pt>
                <c:pt idx="58">
                  <c:v>56.666699999999999</c:v>
                </c:pt>
                <c:pt idx="59">
                  <c:v>56.1464</c:v>
                </c:pt>
                <c:pt idx="60">
                  <c:v>51.238999999999997</c:v>
                </c:pt>
                <c:pt idx="61">
                  <c:v>46.225900000000003</c:v>
                </c:pt>
                <c:pt idx="62">
                  <c:v>39.789299999999997</c:v>
                </c:pt>
                <c:pt idx="63">
                  <c:v>34.254399999999997</c:v>
                </c:pt>
                <c:pt idx="64">
                  <c:v>30.1997</c:v>
                </c:pt>
                <c:pt idx="65">
                  <c:v>28.333300000000001</c:v>
                </c:pt>
                <c:pt idx="66">
                  <c:v>28.201599999999999</c:v>
                </c:pt>
                <c:pt idx="67">
                  <c:v>23.391500000000001</c:v>
                </c:pt>
                <c:pt idx="68">
                  <c:v>22.666699999999999</c:v>
                </c:pt>
                <c:pt idx="69">
                  <c:v>19.1828</c:v>
                </c:pt>
                <c:pt idx="70">
                  <c:v>16.1174</c:v>
                </c:pt>
                <c:pt idx="71">
                  <c:v>15.7136</c:v>
                </c:pt>
                <c:pt idx="72">
                  <c:v>14.710699999999999</c:v>
                </c:pt>
                <c:pt idx="73">
                  <c:v>11.491899999999999</c:v>
                </c:pt>
                <c:pt idx="74">
                  <c:v>6.7209000000000003</c:v>
                </c:pt>
                <c:pt idx="75">
                  <c:v>5.6666999999999996</c:v>
                </c:pt>
                <c:pt idx="76">
                  <c:v>3.4417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5B22-4649-9ECB-79C419B0E6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96179232"/>
        <c:axId val="1096175904"/>
      </c:scatterChart>
      <c:valAx>
        <c:axId val="109617923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096175904"/>
        <c:crosses val="autoZero"/>
        <c:crossBetween val="midCat"/>
        <c:majorUnit val="25"/>
      </c:valAx>
      <c:valAx>
        <c:axId val="1096175904"/>
        <c:scaling>
          <c:orientation val="minMax"/>
          <c:min val="0"/>
        </c:scaling>
        <c:delete val="0"/>
        <c:axPos val="l"/>
        <c:numFmt formatCode="@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096179232"/>
        <c:crosses val="autoZero"/>
        <c:crossBetween val="midCat"/>
        <c:majorUnit val="2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ru-RU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xVal>
            <c:strRef>
              <c:f>Лист1!$N$3:$N$87</c:f>
              <c:strCache>
                <c:ptCount val="8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</c:strCache>
            </c:strRef>
          </c:xVal>
          <c:yVal>
            <c:numRef>
              <c:f>Лист1!$O$3:$O$87</c:f>
              <c:numCache>
                <c:formatCode>@</c:formatCode>
                <c:ptCount val="85"/>
                <c:pt idx="0">
                  <c:v>13.842599999999999</c:v>
                </c:pt>
                <c:pt idx="1">
                  <c:v>14.7798</c:v>
                </c:pt>
                <c:pt idx="2">
                  <c:v>14.382300000000001</c:v>
                </c:pt>
                <c:pt idx="3">
                  <c:v>14.1502</c:v>
                </c:pt>
                <c:pt idx="4">
                  <c:v>15.0847</c:v>
                </c:pt>
                <c:pt idx="5">
                  <c:v>15.778</c:v>
                </c:pt>
                <c:pt idx="6">
                  <c:v>16.547599999999999</c:v>
                </c:pt>
                <c:pt idx="7">
                  <c:v>17.266999999999999</c:v>
                </c:pt>
                <c:pt idx="8">
                  <c:v>18.1845</c:v>
                </c:pt>
                <c:pt idx="9">
                  <c:v>19.464500000000001</c:v>
                </c:pt>
                <c:pt idx="10">
                  <c:v>20.410900000000002</c:v>
                </c:pt>
                <c:pt idx="11">
                  <c:v>20.814800000000002</c:v>
                </c:pt>
                <c:pt idx="12">
                  <c:v>20.5794</c:v>
                </c:pt>
                <c:pt idx="13">
                  <c:v>20.211600000000001</c:v>
                </c:pt>
                <c:pt idx="14">
                  <c:v>20.189299999999999</c:v>
                </c:pt>
                <c:pt idx="15">
                  <c:v>21.325399999999998</c:v>
                </c:pt>
                <c:pt idx="16">
                  <c:v>23.322700000000001</c:v>
                </c:pt>
                <c:pt idx="17">
                  <c:v>25.284500000000001</c:v>
                </c:pt>
                <c:pt idx="18">
                  <c:v>26.1754</c:v>
                </c:pt>
                <c:pt idx="19">
                  <c:v>26.9678</c:v>
                </c:pt>
                <c:pt idx="20">
                  <c:v>28.76</c:v>
                </c:pt>
                <c:pt idx="21">
                  <c:v>31.569400000000002</c:v>
                </c:pt>
                <c:pt idx="22">
                  <c:v>34.734999999999999</c:v>
                </c:pt>
                <c:pt idx="23">
                  <c:v>38.675699999999999</c:v>
                </c:pt>
                <c:pt idx="24">
                  <c:v>43.222799999999999</c:v>
                </c:pt>
                <c:pt idx="25">
                  <c:v>46.628700000000002</c:v>
                </c:pt>
                <c:pt idx="26">
                  <c:v>48.969499999999996</c:v>
                </c:pt>
                <c:pt idx="27">
                  <c:v>51.036799999999999</c:v>
                </c:pt>
                <c:pt idx="28">
                  <c:v>55.257199999999997</c:v>
                </c:pt>
                <c:pt idx="29">
                  <c:v>62.481400000000001</c:v>
                </c:pt>
                <c:pt idx="30">
                  <c:v>69.112200000000001</c:v>
                </c:pt>
                <c:pt idx="31">
                  <c:v>73.746799999999993</c:v>
                </c:pt>
                <c:pt idx="32">
                  <c:v>77.1083</c:v>
                </c:pt>
                <c:pt idx="33">
                  <c:v>79.614800000000002</c:v>
                </c:pt>
                <c:pt idx="34">
                  <c:v>80.977400000000003</c:v>
                </c:pt>
                <c:pt idx="35">
                  <c:v>80.460899999999995</c:v>
                </c:pt>
                <c:pt idx="36">
                  <c:v>78.765500000000003</c:v>
                </c:pt>
                <c:pt idx="37">
                  <c:v>77.174000000000007</c:v>
                </c:pt>
                <c:pt idx="38">
                  <c:v>74.434100000000001</c:v>
                </c:pt>
                <c:pt idx="39">
                  <c:v>73.194999999999993</c:v>
                </c:pt>
                <c:pt idx="40">
                  <c:v>72.453199999999995</c:v>
                </c:pt>
                <c:pt idx="41">
                  <c:v>71.8262</c:v>
                </c:pt>
                <c:pt idx="42">
                  <c:v>71.555499999999995</c:v>
                </c:pt>
                <c:pt idx="43">
                  <c:v>70.891800000000003</c:v>
                </c:pt>
                <c:pt idx="44">
                  <c:v>69.650800000000004</c:v>
                </c:pt>
                <c:pt idx="45">
                  <c:v>68.600099999999998</c:v>
                </c:pt>
                <c:pt idx="46">
                  <c:v>67.366900000000001</c:v>
                </c:pt>
                <c:pt idx="47">
                  <c:v>65.394800000000004</c:v>
                </c:pt>
                <c:pt idx="48">
                  <c:v>62.965400000000002</c:v>
                </c:pt>
                <c:pt idx="49">
                  <c:v>61.995899999999999</c:v>
                </c:pt>
                <c:pt idx="50">
                  <c:v>61.737099999999998</c:v>
                </c:pt>
                <c:pt idx="51">
                  <c:v>62.766199999999998</c:v>
                </c:pt>
                <c:pt idx="52">
                  <c:v>63.185499999999998</c:v>
                </c:pt>
                <c:pt idx="53">
                  <c:v>63.609900000000003</c:v>
                </c:pt>
                <c:pt idx="54">
                  <c:v>65.3035</c:v>
                </c:pt>
                <c:pt idx="55">
                  <c:v>66.012600000000006</c:v>
                </c:pt>
                <c:pt idx="56">
                  <c:v>66.188299999999998</c:v>
                </c:pt>
                <c:pt idx="57">
                  <c:v>67.010199999999998</c:v>
                </c:pt>
                <c:pt idx="58">
                  <c:v>68.830699999999993</c:v>
                </c:pt>
                <c:pt idx="59">
                  <c:v>70.933700000000002</c:v>
                </c:pt>
                <c:pt idx="60">
                  <c:v>72.738100000000003</c:v>
                </c:pt>
                <c:pt idx="61">
                  <c:v>72.526499999999999</c:v>
                </c:pt>
                <c:pt idx="62">
                  <c:v>71.138199999999998</c:v>
                </c:pt>
                <c:pt idx="63">
                  <c:v>70.416700000000006</c:v>
                </c:pt>
                <c:pt idx="64">
                  <c:v>69.397099999999995</c:v>
                </c:pt>
                <c:pt idx="65">
                  <c:v>66.542299999999997</c:v>
                </c:pt>
                <c:pt idx="66">
                  <c:v>63.341299999999997</c:v>
                </c:pt>
                <c:pt idx="67">
                  <c:v>57.401000000000003</c:v>
                </c:pt>
                <c:pt idx="68">
                  <c:v>48.781999999999996</c:v>
                </c:pt>
                <c:pt idx="69">
                  <c:v>41.488100000000003</c:v>
                </c:pt>
                <c:pt idx="70">
                  <c:v>35.362099999999998</c:v>
                </c:pt>
                <c:pt idx="71">
                  <c:v>30.391200000000001</c:v>
                </c:pt>
                <c:pt idx="72">
                  <c:v>26.958200000000001</c:v>
                </c:pt>
                <c:pt idx="73">
                  <c:v>24.388500000000001</c:v>
                </c:pt>
                <c:pt idx="74">
                  <c:v>22.788399999999999</c:v>
                </c:pt>
                <c:pt idx="75">
                  <c:v>21.764199999999999</c:v>
                </c:pt>
                <c:pt idx="76">
                  <c:v>20.844000000000001</c:v>
                </c:pt>
                <c:pt idx="77">
                  <c:v>20.7058</c:v>
                </c:pt>
                <c:pt idx="78">
                  <c:v>20.904800000000002</c:v>
                </c:pt>
                <c:pt idx="79">
                  <c:v>20.773800000000001</c:v>
                </c:pt>
                <c:pt idx="80">
                  <c:v>20.5243</c:v>
                </c:pt>
                <c:pt idx="81">
                  <c:v>20.333300000000001</c:v>
                </c:pt>
                <c:pt idx="82">
                  <c:v>20.498200000000001</c:v>
                </c:pt>
                <c:pt idx="83">
                  <c:v>20.717199999999998</c:v>
                </c:pt>
                <c:pt idx="84">
                  <c:v>20.8055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F774-4DB2-A789-03B549E107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09237984"/>
        <c:axId val="1109242560"/>
      </c:scatterChart>
      <c:valAx>
        <c:axId val="110923798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109242560"/>
        <c:crosses val="autoZero"/>
        <c:crossBetween val="midCat"/>
        <c:majorUnit val="25"/>
      </c:valAx>
      <c:valAx>
        <c:axId val="1109242560"/>
        <c:scaling>
          <c:orientation val="minMax"/>
          <c:min val="10"/>
        </c:scaling>
        <c:delete val="0"/>
        <c:axPos val="l"/>
        <c:numFmt formatCode="@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109237984"/>
        <c:crosses val="autoZero"/>
        <c:crossBetween val="midCat"/>
        <c:majorUnit val="2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ru-RU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527927672464079"/>
          <c:y val="0.15061117735463381"/>
          <c:w val="0.56776391375004531"/>
          <c:h val="0.52979556985361498"/>
        </c:manualLayout>
      </c:layout>
      <c:scatterChart>
        <c:scatterStyle val="smoothMarker"/>
        <c:varyColors val="0"/>
        <c:ser>
          <c:idx val="0"/>
          <c:order val="0"/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xVal>
            <c:strRef>
              <c:f>Лист1!$S$3:$S$76</c:f>
              <c:strCache>
                <c:ptCount val="7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</c:strCache>
            </c:strRef>
          </c:xVal>
          <c:yVal>
            <c:numRef>
              <c:f>Лист1!$T$3:$T$76</c:f>
              <c:numCache>
                <c:formatCode>@</c:formatCode>
                <c:ptCount val="74"/>
                <c:pt idx="0">
                  <c:v>17.333300000000001</c:v>
                </c:pt>
                <c:pt idx="1">
                  <c:v>17.442900000000002</c:v>
                </c:pt>
                <c:pt idx="2">
                  <c:v>17.352900000000002</c:v>
                </c:pt>
                <c:pt idx="3">
                  <c:v>17.251899999999999</c:v>
                </c:pt>
                <c:pt idx="4">
                  <c:v>17.5639</c:v>
                </c:pt>
                <c:pt idx="5">
                  <c:v>18.994700000000002</c:v>
                </c:pt>
                <c:pt idx="6">
                  <c:v>20.5381</c:v>
                </c:pt>
                <c:pt idx="7">
                  <c:v>22.299099999999999</c:v>
                </c:pt>
                <c:pt idx="8">
                  <c:v>23.8706</c:v>
                </c:pt>
                <c:pt idx="9">
                  <c:v>24.863800000000001</c:v>
                </c:pt>
                <c:pt idx="10">
                  <c:v>25.226900000000001</c:v>
                </c:pt>
                <c:pt idx="11">
                  <c:v>24.318200000000001</c:v>
                </c:pt>
                <c:pt idx="12">
                  <c:v>23.877600000000001</c:v>
                </c:pt>
                <c:pt idx="13">
                  <c:v>25.767099999999999</c:v>
                </c:pt>
                <c:pt idx="14">
                  <c:v>27.252099999999999</c:v>
                </c:pt>
                <c:pt idx="15">
                  <c:v>27.883600000000001</c:v>
                </c:pt>
                <c:pt idx="16">
                  <c:v>29.1355</c:v>
                </c:pt>
                <c:pt idx="17">
                  <c:v>31.533300000000001</c:v>
                </c:pt>
                <c:pt idx="18">
                  <c:v>35.203299999999999</c:v>
                </c:pt>
                <c:pt idx="19">
                  <c:v>39.869399999999999</c:v>
                </c:pt>
                <c:pt idx="20">
                  <c:v>44.8797</c:v>
                </c:pt>
                <c:pt idx="21">
                  <c:v>52.592500000000001</c:v>
                </c:pt>
                <c:pt idx="22">
                  <c:v>60.457500000000003</c:v>
                </c:pt>
                <c:pt idx="23">
                  <c:v>66.887900000000002</c:v>
                </c:pt>
                <c:pt idx="24">
                  <c:v>71.602699999999999</c:v>
                </c:pt>
                <c:pt idx="25">
                  <c:v>74.224400000000003</c:v>
                </c:pt>
                <c:pt idx="26">
                  <c:v>75.554000000000002</c:v>
                </c:pt>
                <c:pt idx="27">
                  <c:v>75.383200000000002</c:v>
                </c:pt>
                <c:pt idx="28">
                  <c:v>74.143199999999993</c:v>
                </c:pt>
                <c:pt idx="29">
                  <c:v>73.226200000000006</c:v>
                </c:pt>
                <c:pt idx="30">
                  <c:v>73.216899999999995</c:v>
                </c:pt>
                <c:pt idx="31">
                  <c:v>72.637500000000003</c:v>
                </c:pt>
                <c:pt idx="32">
                  <c:v>72.660499999999999</c:v>
                </c:pt>
                <c:pt idx="33">
                  <c:v>73.311400000000006</c:v>
                </c:pt>
                <c:pt idx="34">
                  <c:v>75.506200000000007</c:v>
                </c:pt>
                <c:pt idx="35">
                  <c:v>77.736900000000006</c:v>
                </c:pt>
                <c:pt idx="36">
                  <c:v>80.351600000000005</c:v>
                </c:pt>
                <c:pt idx="37">
                  <c:v>82.770499999999998</c:v>
                </c:pt>
                <c:pt idx="38">
                  <c:v>84.356899999999996</c:v>
                </c:pt>
                <c:pt idx="39">
                  <c:v>85.1815</c:v>
                </c:pt>
                <c:pt idx="40">
                  <c:v>84.706500000000005</c:v>
                </c:pt>
                <c:pt idx="41">
                  <c:v>82.85</c:v>
                </c:pt>
                <c:pt idx="42">
                  <c:v>81.301599999999993</c:v>
                </c:pt>
                <c:pt idx="43">
                  <c:v>79.406300000000002</c:v>
                </c:pt>
                <c:pt idx="44">
                  <c:v>76.048699999999997</c:v>
                </c:pt>
                <c:pt idx="45">
                  <c:v>71.541799999999995</c:v>
                </c:pt>
                <c:pt idx="46">
                  <c:v>66.200599999999994</c:v>
                </c:pt>
                <c:pt idx="47">
                  <c:v>60.154299999999999</c:v>
                </c:pt>
                <c:pt idx="48">
                  <c:v>53.187399999999997</c:v>
                </c:pt>
                <c:pt idx="49">
                  <c:v>47.4437</c:v>
                </c:pt>
                <c:pt idx="50">
                  <c:v>43.230400000000003</c:v>
                </c:pt>
                <c:pt idx="51">
                  <c:v>39.731999999999999</c:v>
                </c:pt>
                <c:pt idx="52">
                  <c:v>36.771000000000001</c:v>
                </c:pt>
                <c:pt idx="53">
                  <c:v>35.428800000000003</c:v>
                </c:pt>
                <c:pt idx="54">
                  <c:v>34.481299999999997</c:v>
                </c:pt>
                <c:pt idx="55">
                  <c:v>33.174900000000001</c:v>
                </c:pt>
                <c:pt idx="56">
                  <c:v>31.998799999999999</c:v>
                </c:pt>
                <c:pt idx="57">
                  <c:v>30.4239</c:v>
                </c:pt>
                <c:pt idx="58">
                  <c:v>28.1584</c:v>
                </c:pt>
                <c:pt idx="59">
                  <c:v>23.486899999999999</c:v>
                </c:pt>
                <c:pt idx="60">
                  <c:v>20.254100000000001</c:v>
                </c:pt>
                <c:pt idx="61">
                  <c:v>18.313500000000001</c:v>
                </c:pt>
                <c:pt idx="62">
                  <c:v>16.776399999999999</c:v>
                </c:pt>
                <c:pt idx="63">
                  <c:v>15.5639</c:v>
                </c:pt>
                <c:pt idx="64">
                  <c:v>14.9061</c:v>
                </c:pt>
                <c:pt idx="65">
                  <c:v>14.8551</c:v>
                </c:pt>
                <c:pt idx="66">
                  <c:v>14.041600000000001</c:v>
                </c:pt>
                <c:pt idx="67">
                  <c:v>13.763299999999999</c:v>
                </c:pt>
                <c:pt idx="68">
                  <c:v>13.2888</c:v>
                </c:pt>
                <c:pt idx="69">
                  <c:v>13.1412</c:v>
                </c:pt>
                <c:pt idx="70">
                  <c:v>13</c:v>
                </c:pt>
                <c:pt idx="71">
                  <c:v>13.0093</c:v>
                </c:pt>
                <c:pt idx="72">
                  <c:v>13.0017</c:v>
                </c:pt>
                <c:pt idx="73">
                  <c:v>12.212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A694-476A-ADA7-A0F4B04715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05477472"/>
        <c:axId val="1105472896"/>
      </c:scatterChart>
      <c:valAx>
        <c:axId val="110547747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105472896"/>
        <c:crosses val="autoZero"/>
        <c:crossBetween val="midCat"/>
        <c:majorUnit val="25"/>
      </c:valAx>
      <c:valAx>
        <c:axId val="1105472896"/>
        <c:scaling>
          <c:orientation val="minMax"/>
          <c:min val="10"/>
        </c:scaling>
        <c:delete val="0"/>
        <c:axPos val="l"/>
        <c:numFmt formatCode="@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105477472"/>
        <c:crosses val="autoZero"/>
        <c:crossBetween val="midCat"/>
        <c:majorUnit val="2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ru-RU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4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O$10:$P$10</c:f>
                <c:numCache>
                  <c:formatCode>General</c:formatCode>
                  <c:ptCount val="2"/>
                  <c:pt idx="0">
                    <c:v>2.293305102295836</c:v>
                  </c:pt>
                  <c:pt idx="1">
                    <c:v>0.4747557176239948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O$8:$P$8</c:f>
              <c:strCache>
                <c:ptCount val="2"/>
                <c:pt idx="0">
                  <c:v>control</c:v>
                </c:pt>
                <c:pt idx="1">
                  <c:v> + RNAse A</c:v>
                </c:pt>
              </c:strCache>
            </c:strRef>
          </c:cat>
          <c:val>
            <c:numRef>
              <c:f>Sheet1!$O$9:$P$9</c:f>
              <c:numCache>
                <c:formatCode>General</c:formatCode>
                <c:ptCount val="2"/>
                <c:pt idx="0">
                  <c:v>14.619924749343332</c:v>
                </c:pt>
                <c:pt idx="1">
                  <c:v>7.41825619136543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9CF-47DB-AEB0-E8EAA380D4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2136583343"/>
        <c:axId val="2136576687"/>
      </c:barChart>
      <c:catAx>
        <c:axId val="213658334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2136576687"/>
        <c:crosses val="autoZero"/>
        <c:auto val="1"/>
        <c:lblAlgn val="ctr"/>
        <c:lblOffset val="100"/>
        <c:noMultiLvlLbl val="0"/>
      </c:catAx>
      <c:valAx>
        <c:axId val="2136576687"/>
        <c:scaling>
          <c:orientation val="minMax"/>
          <c:max val="22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2136583343"/>
        <c:crosses val="autoZero"/>
        <c:crossBetween val="between"/>
        <c:majorUnit val="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ru-RU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54181"/>
            <a:ext cx="10363200" cy="5646232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18153"/>
            <a:ext cx="9144000" cy="3915571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ru-RU" smtClean="0"/>
              <a:t>Образец подзаголовка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2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676616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2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9706340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3453"/>
            <a:ext cx="2628900" cy="13743921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3453"/>
            <a:ext cx="7734300" cy="13743921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2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58283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2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267449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43217"/>
            <a:ext cx="10515600" cy="6746195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53234"/>
            <a:ext cx="10515600" cy="3547664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2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24736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17265"/>
            <a:ext cx="5181600" cy="10290109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17265"/>
            <a:ext cx="5181600" cy="10290109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2.11.2023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4122104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3457"/>
            <a:ext cx="10515600" cy="3134711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75639"/>
            <a:ext cx="5157787" cy="194839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24039"/>
            <a:ext cx="5157787" cy="871336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75639"/>
            <a:ext cx="5183188" cy="194839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24039"/>
            <a:ext cx="5183188" cy="871336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2.11.2023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38973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2.11.2023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55121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2.11.2023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3171507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1193"/>
            <a:ext cx="3932237" cy="378417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35081"/>
            <a:ext cx="6172200" cy="11525221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65370"/>
            <a:ext cx="3932237" cy="9013700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2.11.2023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340909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1193"/>
            <a:ext cx="3932237" cy="378417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35081"/>
            <a:ext cx="6172200" cy="11525221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ru-RU" smtClean="0"/>
              <a:t>Вставка рисунка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65370"/>
            <a:ext cx="3932237" cy="9013700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2.11.2023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8429276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3457"/>
            <a:ext cx="10515600" cy="313471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17265"/>
            <a:ext cx="10515600" cy="1029010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31594"/>
            <a:ext cx="2743200" cy="8634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D8C5BB-B180-47DC-8991-EB585F277454}" type="datetimeFigureOut">
              <a:rPr lang="ru-RU" smtClean="0"/>
              <a:t>12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31594"/>
            <a:ext cx="4114800" cy="8634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31594"/>
            <a:ext cx="2743200" cy="8634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5437370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6" Type="http://schemas.microsoft.com/office/2007/relationships/hdphoto" Target="../media/hdphoto11.wdp"/><Relationship Id="rId21" Type="http://schemas.openxmlformats.org/officeDocument/2006/relationships/image" Target="../media/image12.png"/><Relationship Id="rId42" Type="http://schemas.openxmlformats.org/officeDocument/2006/relationships/image" Target="../media/image23.png"/><Relationship Id="rId47" Type="http://schemas.microsoft.com/office/2007/relationships/hdphoto" Target="../media/hdphoto21.wdp"/><Relationship Id="rId63" Type="http://schemas.microsoft.com/office/2007/relationships/hdphoto" Target="../media/hdphoto25.wdp"/><Relationship Id="rId68" Type="http://schemas.openxmlformats.org/officeDocument/2006/relationships/image" Target="../media/image38.png"/><Relationship Id="rId84" Type="http://schemas.openxmlformats.org/officeDocument/2006/relationships/image" Target="../media/image43.png"/><Relationship Id="rId89" Type="http://schemas.microsoft.com/office/2007/relationships/hdphoto" Target="../media/hdphoto35.wdp"/><Relationship Id="rId16" Type="http://schemas.openxmlformats.org/officeDocument/2006/relationships/image" Target="../media/image9.png"/><Relationship Id="rId11" Type="http://schemas.microsoft.com/office/2007/relationships/hdphoto" Target="../media/hdphoto4.wdp"/><Relationship Id="rId32" Type="http://schemas.openxmlformats.org/officeDocument/2006/relationships/image" Target="../media/image18.png"/><Relationship Id="rId37" Type="http://schemas.microsoft.com/office/2007/relationships/hdphoto" Target="../media/hdphoto16.wdp"/><Relationship Id="rId53" Type="http://schemas.openxmlformats.org/officeDocument/2006/relationships/image" Target="../media/image31.png"/><Relationship Id="rId58" Type="http://schemas.openxmlformats.org/officeDocument/2006/relationships/chart" Target="../charts/chart1.xml"/><Relationship Id="rId74" Type="http://schemas.openxmlformats.org/officeDocument/2006/relationships/chart" Target="../charts/chart5.xml"/><Relationship Id="rId79" Type="http://schemas.microsoft.com/office/2007/relationships/hdphoto" Target="../media/hdphoto30.wdp"/><Relationship Id="rId102" Type="http://schemas.openxmlformats.org/officeDocument/2006/relationships/chart" Target="../charts/chart11.xml"/><Relationship Id="rId5" Type="http://schemas.openxmlformats.org/officeDocument/2006/relationships/image" Target="../media/image3.png"/><Relationship Id="rId90" Type="http://schemas.openxmlformats.org/officeDocument/2006/relationships/image" Target="../media/image46.png"/><Relationship Id="rId95" Type="http://schemas.microsoft.com/office/2007/relationships/hdphoto" Target="../media/hdphoto38.wdp"/><Relationship Id="rId22" Type="http://schemas.microsoft.com/office/2007/relationships/hdphoto" Target="../media/hdphoto9.wdp"/><Relationship Id="rId27" Type="http://schemas.openxmlformats.org/officeDocument/2006/relationships/image" Target="../media/image15.png"/><Relationship Id="rId43" Type="http://schemas.microsoft.com/office/2007/relationships/hdphoto" Target="../media/hdphoto19.wdp"/><Relationship Id="rId48" Type="http://schemas.openxmlformats.org/officeDocument/2006/relationships/image" Target="../media/image26.png"/><Relationship Id="rId64" Type="http://schemas.openxmlformats.org/officeDocument/2006/relationships/image" Target="../media/image36.png"/><Relationship Id="rId69" Type="http://schemas.microsoft.com/office/2007/relationships/hdphoto" Target="../media/hdphoto28.wdp"/><Relationship Id="rId80" Type="http://schemas.openxmlformats.org/officeDocument/2006/relationships/image" Target="../media/image41.png"/><Relationship Id="rId85" Type="http://schemas.microsoft.com/office/2007/relationships/hdphoto" Target="../media/hdphoto33.wdp"/><Relationship Id="rId12" Type="http://schemas.openxmlformats.org/officeDocument/2006/relationships/image" Target="../media/image7.png"/><Relationship Id="rId17" Type="http://schemas.microsoft.com/office/2007/relationships/hdphoto" Target="../media/hdphoto7.wdp"/><Relationship Id="rId25" Type="http://schemas.openxmlformats.org/officeDocument/2006/relationships/image" Target="../media/image14.png"/><Relationship Id="rId33" Type="http://schemas.microsoft.com/office/2007/relationships/hdphoto" Target="../media/hdphoto14.wdp"/><Relationship Id="rId38" Type="http://schemas.openxmlformats.org/officeDocument/2006/relationships/image" Target="../media/image21.png"/><Relationship Id="rId46" Type="http://schemas.openxmlformats.org/officeDocument/2006/relationships/image" Target="../media/image25.png"/><Relationship Id="rId59" Type="http://schemas.openxmlformats.org/officeDocument/2006/relationships/chart" Target="../charts/chart2.xml"/><Relationship Id="rId67" Type="http://schemas.microsoft.com/office/2007/relationships/hdphoto" Target="../media/hdphoto27.wdp"/><Relationship Id="rId103" Type="http://schemas.openxmlformats.org/officeDocument/2006/relationships/chart" Target="../charts/chart12.xml"/><Relationship Id="rId20" Type="http://schemas.microsoft.com/office/2007/relationships/hdphoto" Target="../media/hdphoto8.wdp"/><Relationship Id="rId41" Type="http://schemas.microsoft.com/office/2007/relationships/hdphoto" Target="../media/hdphoto18.wdp"/><Relationship Id="rId54" Type="http://schemas.microsoft.com/office/2007/relationships/hdphoto" Target="../media/hdphoto22.wdp"/><Relationship Id="rId62" Type="http://schemas.openxmlformats.org/officeDocument/2006/relationships/image" Target="../media/image35.png"/><Relationship Id="rId70" Type="http://schemas.openxmlformats.org/officeDocument/2006/relationships/image" Target="../media/image39.png"/><Relationship Id="rId75" Type="http://schemas.openxmlformats.org/officeDocument/2006/relationships/chart" Target="../charts/chart6.xml"/><Relationship Id="rId83" Type="http://schemas.microsoft.com/office/2007/relationships/hdphoto" Target="../media/hdphoto32.wdp"/><Relationship Id="rId88" Type="http://schemas.openxmlformats.org/officeDocument/2006/relationships/image" Target="../media/image45.png"/><Relationship Id="rId91" Type="http://schemas.microsoft.com/office/2007/relationships/hdphoto" Target="../media/hdphoto36.wdp"/><Relationship Id="rId96" Type="http://schemas.openxmlformats.org/officeDocument/2006/relationships/image" Target="../media/image49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5" Type="http://schemas.microsoft.com/office/2007/relationships/hdphoto" Target="../media/hdphoto6.wdp"/><Relationship Id="rId23" Type="http://schemas.openxmlformats.org/officeDocument/2006/relationships/image" Target="../media/image13.png"/><Relationship Id="rId28" Type="http://schemas.microsoft.com/office/2007/relationships/hdphoto" Target="../media/hdphoto12.wdp"/><Relationship Id="rId36" Type="http://schemas.openxmlformats.org/officeDocument/2006/relationships/image" Target="../media/image20.png"/><Relationship Id="rId49" Type="http://schemas.openxmlformats.org/officeDocument/2006/relationships/image" Target="../media/image27.png"/><Relationship Id="rId57" Type="http://schemas.openxmlformats.org/officeDocument/2006/relationships/image" Target="../media/image33.png"/><Relationship Id="rId10" Type="http://schemas.openxmlformats.org/officeDocument/2006/relationships/image" Target="../media/image6.png"/><Relationship Id="rId31" Type="http://schemas.microsoft.com/office/2007/relationships/hdphoto" Target="../media/hdphoto13.wdp"/><Relationship Id="rId44" Type="http://schemas.openxmlformats.org/officeDocument/2006/relationships/image" Target="../media/image24.png"/><Relationship Id="rId52" Type="http://schemas.openxmlformats.org/officeDocument/2006/relationships/image" Target="../media/image30.png"/><Relationship Id="rId60" Type="http://schemas.openxmlformats.org/officeDocument/2006/relationships/image" Target="../media/image34.png"/><Relationship Id="rId65" Type="http://schemas.microsoft.com/office/2007/relationships/hdphoto" Target="../media/hdphoto26.wdp"/><Relationship Id="rId73" Type="http://schemas.openxmlformats.org/officeDocument/2006/relationships/chart" Target="../charts/chart4.xml"/><Relationship Id="rId78" Type="http://schemas.openxmlformats.org/officeDocument/2006/relationships/image" Target="../media/image40.png"/><Relationship Id="rId81" Type="http://schemas.microsoft.com/office/2007/relationships/hdphoto" Target="../media/hdphoto31.wdp"/><Relationship Id="rId86" Type="http://schemas.openxmlformats.org/officeDocument/2006/relationships/image" Target="../media/image44.png"/><Relationship Id="rId94" Type="http://schemas.openxmlformats.org/officeDocument/2006/relationships/image" Target="../media/image48.png"/><Relationship Id="rId99" Type="http://schemas.microsoft.com/office/2007/relationships/hdphoto" Target="../media/hdphoto40.wdp"/><Relationship Id="rId101" Type="http://schemas.openxmlformats.org/officeDocument/2006/relationships/chart" Target="../charts/chart10.xml"/><Relationship Id="rId4" Type="http://schemas.microsoft.com/office/2007/relationships/hdphoto" Target="../media/hdphoto1.wdp"/><Relationship Id="rId9" Type="http://schemas.openxmlformats.org/officeDocument/2006/relationships/image" Target="../media/image5.png"/><Relationship Id="rId13" Type="http://schemas.microsoft.com/office/2007/relationships/hdphoto" Target="../media/hdphoto5.wdp"/><Relationship Id="rId18" Type="http://schemas.openxmlformats.org/officeDocument/2006/relationships/image" Target="../media/image10.png"/><Relationship Id="rId39" Type="http://schemas.microsoft.com/office/2007/relationships/hdphoto" Target="../media/hdphoto17.wdp"/><Relationship Id="rId34" Type="http://schemas.openxmlformats.org/officeDocument/2006/relationships/image" Target="../media/image19.png"/><Relationship Id="rId50" Type="http://schemas.openxmlformats.org/officeDocument/2006/relationships/image" Target="../media/image28.png"/><Relationship Id="rId55" Type="http://schemas.openxmlformats.org/officeDocument/2006/relationships/image" Target="../media/image32.png"/><Relationship Id="rId76" Type="http://schemas.openxmlformats.org/officeDocument/2006/relationships/chart" Target="../charts/chart7.xml"/><Relationship Id="rId97" Type="http://schemas.microsoft.com/office/2007/relationships/hdphoto" Target="../media/hdphoto39.wdp"/><Relationship Id="rId7" Type="http://schemas.openxmlformats.org/officeDocument/2006/relationships/image" Target="../media/image4.png"/><Relationship Id="rId71" Type="http://schemas.microsoft.com/office/2007/relationships/hdphoto" Target="../media/hdphoto29.wdp"/><Relationship Id="rId92" Type="http://schemas.openxmlformats.org/officeDocument/2006/relationships/image" Target="../media/image47.png"/><Relationship Id="rId2" Type="http://schemas.openxmlformats.org/officeDocument/2006/relationships/image" Target="../media/image1.png"/><Relationship Id="rId29" Type="http://schemas.openxmlformats.org/officeDocument/2006/relationships/image" Target="../media/image16.png"/><Relationship Id="rId24" Type="http://schemas.microsoft.com/office/2007/relationships/hdphoto" Target="../media/hdphoto10.wdp"/><Relationship Id="rId40" Type="http://schemas.openxmlformats.org/officeDocument/2006/relationships/image" Target="../media/image22.png"/><Relationship Id="rId45" Type="http://schemas.microsoft.com/office/2007/relationships/hdphoto" Target="../media/hdphoto20.wdp"/><Relationship Id="rId66" Type="http://schemas.openxmlformats.org/officeDocument/2006/relationships/image" Target="../media/image37.png"/><Relationship Id="rId87" Type="http://schemas.microsoft.com/office/2007/relationships/hdphoto" Target="../media/hdphoto34.wdp"/><Relationship Id="rId61" Type="http://schemas.microsoft.com/office/2007/relationships/hdphoto" Target="../media/hdphoto24.wdp"/><Relationship Id="rId82" Type="http://schemas.openxmlformats.org/officeDocument/2006/relationships/image" Target="../media/image42.png"/><Relationship Id="rId19" Type="http://schemas.openxmlformats.org/officeDocument/2006/relationships/image" Target="../media/image11.png"/><Relationship Id="rId14" Type="http://schemas.openxmlformats.org/officeDocument/2006/relationships/image" Target="../media/image8.png"/><Relationship Id="rId30" Type="http://schemas.openxmlformats.org/officeDocument/2006/relationships/image" Target="../media/image17.png"/><Relationship Id="rId35" Type="http://schemas.microsoft.com/office/2007/relationships/hdphoto" Target="../media/hdphoto15.wdp"/><Relationship Id="rId56" Type="http://schemas.microsoft.com/office/2007/relationships/hdphoto" Target="../media/hdphoto23.wdp"/><Relationship Id="rId77" Type="http://schemas.openxmlformats.org/officeDocument/2006/relationships/chart" Target="../charts/chart8.xml"/><Relationship Id="rId100" Type="http://schemas.openxmlformats.org/officeDocument/2006/relationships/chart" Target="../charts/chart9.xml"/><Relationship Id="rId8" Type="http://schemas.microsoft.com/office/2007/relationships/hdphoto" Target="../media/hdphoto3.wdp"/><Relationship Id="rId51" Type="http://schemas.openxmlformats.org/officeDocument/2006/relationships/image" Target="../media/image29.png"/><Relationship Id="rId72" Type="http://schemas.openxmlformats.org/officeDocument/2006/relationships/chart" Target="../charts/chart3.xml"/><Relationship Id="rId93" Type="http://schemas.microsoft.com/office/2007/relationships/hdphoto" Target="../media/hdphoto37.wdp"/><Relationship Id="rId98" Type="http://schemas.openxmlformats.org/officeDocument/2006/relationships/image" Target="../media/image50.png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3" name="Группа 542"/>
          <p:cNvGrpSpPr/>
          <p:nvPr/>
        </p:nvGrpSpPr>
        <p:grpSpPr>
          <a:xfrm>
            <a:off x="811819" y="2900138"/>
            <a:ext cx="3450029" cy="2252539"/>
            <a:chOff x="4048051" y="261866"/>
            <a:chExt cx="3450029" cy="2252539"/>
          </a:xfrm>
        </p:grpSpPr>
        <p:sp>
          <p:nvSpPr>
            <p:cNvPr id="534" name="TextBox 533"/>
            <p:cNvSpPr txBox="1"/>
            <p:nvPr/>
          </p:nvSpPr>
          <p:spPr>
            <a:xfrm>
              <a:off x="4062445" y="261866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B</a:t>
              </a:r>
              <a:endParaRPr lang="ru-RU" b="1" dirty="0"/>
            </a:p>
          </p:txBody>
        </p:sp>
        <p:grpSp>
          <p:nvGrpSpPr>
            <p:cNvPr id="14" name="Группа 13"/>
            <p:cNvGrpSpPr/>
            <p:nvPr/>
          </p:nvGrpSpPr>
          <p:grpSpPr>
            <a:xfrm>
              <a:off x="4048051" y="466344"/>
              <a:ext cx="3450029" cy="2048061"/>
              <a:chOff x="4048051" y="466344"/>
              <a:chExt cx="3450029" cy="2048061"/>
            </a:xfrm>
          </p:grpSpPr>
          <p:pic>
            <p:nvPicPr>
              <p:cNvPr id="15" name="Рисунок 14"/>
              <p:cNvPicPr>
                <a:picLocks noChangeAspect="1"/>
              </p:cNvPicPr>
              <p:nvPr/>
            </p:nvPicPr>
            <p:blipFill rotWithShape="1">
              <a:blip r:embed="rId2"/>
              <a:srcRect l="30672" t="12081" r="3280" b="45616"/>
              <a:stretch/>
            </p:blipFill>
            <p:spPr>
              <a:xfrm>
                <a:off x="4352544" y="466344"/>
                <a:ext cx="3145536" cy="1764792"/>
              </a:xfrm>
              <a:prstGeom prst="rect">
                <a:avLst/>
              </a:prstGeom>
            </p:spPr>
          </p:pic>
          <p:sp>
            <p:nvSpPr>
              <p:cNvPr id="16" name="TextBox 15"/>
              <p:cNvSpPr txBox="1"/>
              <p:nvPr/>
            </p:nvSpPr>
            <p:spPr>
              <a:xfrm rot="16200000">
                <a:off x="3645569" y="1118345"/>
                <a:ext cx="126662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 smtClean="0">
                    <a:cs typeface="Arial" panose="020B0604020202020204" pitchFamily="34" charset="0"/>
                  </a:rPr>
                  <a:t>Fold enrichment </a:t>
                </a:r>
              </a:p>
              <a:p>
                <a:pPr algn="ctr"/>
                <a:r>
                  <a:rPr lang="en-US" sz="1200" b="1" dirty="0" smtClean="0">
                    <a:cs typeface="Arial" panose="020B0604020202020204" pitchFamily="34" charset="0"/>
                  </a:rPr>
                  <a:t>in condensates</a:t>
                </a:r>
                <a:endParaRPr lang="ru-RU" sz="1200" b="1" dirty="0"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 rot="20040000">
                <a:off x="4451248" y="2252795"/>
                <a:ext cx="9829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 smtClean="0"/>
                  <a:t>Sup35PD-GFP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 rot="20040000">
                <a:off x="5447109" y="2197081"/>
                <a:ext cx="76014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 smtClean="0"/>
                  <a:t>GFP-Rnq1</a:t>
                </a: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 rot="20040000">
                <a:off x="6017751" y="2244362"/>
                <a:ext cx="94128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 smtClean="0"/>
                  <a:t>Mot3PD-GFP</a:t>
                </a:r>
              </a:p>
            </p:txBody>
          </p:sp>
          <p:sp>
            <p:nvSpPr>
              <p:cNvPr id="20" name="Левая круглая скобка 19"/>
              <p:cNvSpPr/>
              <p:nvPr/>
            </p:nvSpPr>
            <p:spPr>
              <a:xfrm rot="5400000">
                <a:off x="5645672" y="577554"/>
                <a:ext cx="36000" cy="756000"/>
              </a:xfrm>
              <a:prstGeom prst="leftBracket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21" name="Левая круглая скобка 20"/>
              <p:cNvSpPr/>
              <p:nvPr/>
            </p:nvSpPr>
            <p:spPr>
              <a:xfrm rot="5400000">
                <a:off x="6005672" y="83960"/>
                <a:ext cx="72000" cy="1512000"/>
              </a:xfrm>
              <a:prstGeom prst="leftBracket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5526455" y="761827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/>
                  <a:t>*</a:t>
                </a:r>
                <a:endParaRPr lang="ru-RU" sz="1400" dirty="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5904455" y="629777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/>
                  <a:t>*</a:t>
                </a:r>
                <a:endParaRPr lang="ru-RU" sz="1400" dirty="0"/>
              </a:p>
            </p:txBody>
          </p:sp>
        </p:grpSp>
      </p:grpSp>
      <p:grpSp>
        <p:nvGrpSpPr>
          <p:cNvPr id="551" name="Группа 550"/>
          <p:cNvGrpSpPr/>
          <p:nvPr/>
        </p:nvGrpSpPr>
        <p:grpSpPr>
          <a:xfrm>
            <a:off x="550998" y="5387150"/>
            <a:ext cx="8680057" cy="3234957"/>
            <a:chOff x="550998" y="5387150"/>
            <a:chExt cx="8680057" cy="3234957"/>
          </a:xfrm>
        </p:grpSpPr>
        <p:sp>
          <p:nvSpPr>
            <p:cNvPr id="535" name="TextBox 534"/>
            <p:cNvSpPr txBox="1"/>
            <p:nvPr/>
          </p:nvSpPr>
          <p:spPr>
            <a:xfrm>
              <a:off x="550998" y="5387150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C</a:t>
              </a:r>
              <a:endParaRPr lang="ru-RU" b="1" dirty="0"/>
            </a:p>
          </p:txBody>
        </p:sp>
        <p:grpSp>
          <p:nvGrpSpPr>
            <p:cNvPr id="25" name="Группа 24"/>
            <p:cNvGrpSpPr/>
            <p:nvPr/>
          </p:nvGrpSpPr>
          <p:grpSpPr>
            <a:xfrm>
              <a:off x="3817039" y="5691497"/>
              <a:ext cx="2524736" cy="1358879"/>
              <a:chOff x="4822127" y="218468"/>
              <a:chExt cx="2524736" cy="1358879"/>
            </a:xfrm>
          </p:grpSpPr>
          <p:pic>
            <p:nvPicPr>
              <p:cNvPr id="133" name="Рисунок 132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30000" contrast="10000"/>
                        </a14:imgEffect>
                      </a14:imgLayer>
                    </a14:imgProps>
                  </a:ext>
                </a:extLst>
              </a:blip>
              <a:srcRect l="17178" t="9949" r="10120"/>
              <a:stretch/>
            </p:blipFill>
            <p:spPr>
              <a:xfrm>
                <a:off x="4880114" y="472440"/>
                <a:ext cx="785190" cy="1059380"/>
              </a:xfrm>
              <a:prstGeom prst="rect">
                <a:avLst/>
              </a:prstGeom>
            </p:spPr>
          </p:pic>
          <p:pic>
            <p:nvPicPr>
              <p:cNvPr id="134" name="Рисунок 133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</a:extLst>
              </a:blip>
              <a:srcRect l="16762" t="10006" r="7774" b="1"/>
              <a:stretch/>
            </p:blipFill>
            <p:spPr>
              <a:xfrm>
                <a:off x="5675247" y="472440"/>
                <a:ext cx="815009" cy="1058706"/>
              </a:xfrm>
              <a:prstGeom prst="rect">
                <a:avLst/>
              </a:prstGeom>
            </p:spPr>
          </p:pic>
          <p:pic>
            <p:nvPicPr>
              <p:cNvPr id="135" name="Рисунок 134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</a:extLst>
              </a:blip>
              <a:srcRect l="19860" t="10007" r="10197"/>
              <a:stretch/>
            </p:blipFill>
            <p:spPr>
              <a:xfrm>
                <a:off x="6490257" y="472440"/>
                <a:ext cx="755375" cy="1058706"/>
              </a:xfrm>
              <a:prstGeom prst="rect">
                <a:avLst/>
              </a:prstGeom>
            </p:spPr>
          </p:pic>
          <p:sp>
            <p:nvSpPr>
              <p:cNvPr id="136" name="Овал 135"/>
              <p:cNvSpPr/>
              <p:nvPr/>
            </p:nvSpPr>
            <p:spPr>
              <a:xfrm rot="18145711">
                <a:off x="5820905" y="556565"/>
                <a:ext cx="411695" cy="531785"/>
              </a:xfrm>
              <a:prstGeom prst="ellipse">
                <a:avLst/>
              </a:prstGeom>
              <a:noFill/>
              <a:ln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137" name="Овал 136"/>
              <p:cNvSpPr/>
              <p:nvPr/>
            </p:nvSpPr>
            <p:spPr>
              <a:xfrm rot="18145711">
                <a:off x="5029084" y="559880"/>
                <a:ext cx="411695" cy="531785"/>
              </a:xfrm>
              <a:prstGeom prst="ellipse">
                <a:avLst/>
              </a:prstGeom>
              <a:noFill/>
              <a:ln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138" name="Овал 137"/>
              <p:cNvSpPr/>
              <p:nvPr/>
            </p:nvSpPr>
            <p:spPr>
              <a:xfrm rot="18145711">
                <a:off x="6619354" y="559879"/>
                <a:ext cx="411695" cy="531785"/>
              </a:xfrm>
              <a:prstGeom prst="ellipse">
                <a:avLst/>
              </a:prstGeom>
              <a:noFill/>
              <a:ln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139" name="Овал 138"/>
              <p:cNvSpPr/>
              <p:nvPr/>
            </p:nvSpPr>
            <p:spPr>
              <a:xfrm rot="16794768">
                <a:off x="6018685" y="970004"/>
                <a:ext cx="307908" cy="454272"/>
              </a:xfrm>
              <a:prstGeom prst="ellipse">
                <a:avLst/>
              </a:prstGeom>
              <a:noFill/>
              <a:ln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140" name="Овал 139"/>
              <p:cNvSpPr/>
              <p:nvPr/>
            </p:nvSpPr>
            <p:spPr>
              <a:xfrm rot="16794768">
                <a:off x="5226867" y="973319"/>
                <a:ext cx="307908" cy="454272"/>
              </a:xfrm>
              <a:prstGeom prst="ellipse">
                <a:avLst/>
              </a:prstGeom>
              <a:noFill/>
              <a:ln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141" name="Овал 140"/>
              <p:cNvSpPr/>
              <p:nvPr/>
            </p:nvSpPr>
            <p:spPr>
              <a:xfrm rot="16794768">
                <a:off x="6807193" y="983258"/>
                <a:ext cx="307908" cy="454272"/>
              </a:xfrm>
              <a:prstGeom prst="ellipse">
                <a:avLst/>
              </a:prstGeom>
              <a:noFill/>
              <a:ln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cxnSp>
            <p:nvCxnSpPr>
              <p:cNvPr id="142" name="Прямая соединительная линия 141"/>
              <p:cNvCxnSpPr/>
              <p:nvPr/>
            </p:nvCxnSpPr>
            <p:spPr>
              <a:xfrm>
                <a:off x="5670247" y="307177"/>
                <a:ext cx="0" cy="1255203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3" name="Прямая соединительная линия 142"/>
              <p:cNvCxnSpPr/>
              <p:nvPr/>
            </p:nvCxnSpPr>
            <p:spPr>
              <a:xfrm>
                <a:off x="6468691" y="280675"/>
                <a:ext cx="0" cy="1255203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4" name="TextBox 143"/>
              <p:cNvSpPr txBox="1"/>
              <p:nvPr/>
            </p:nvSpPr>
            <p:spPr>
              <a:xfrm>
                <a:off x="5698280" y="222607"/>
                <a:ext cx="7859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solidFill>
                      <a:srgbClr val="FF0000"/>
                    </a:solidFill>
                  </a:rPr>
                  <a:t>Pab1-RFP</a:t>
                </a:r>
                <a:endParaRPr lang="ru-RU" sz="120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145" name="TextBox 144"/>
              <p:cNvSpPr txBox="1"/>
              <p:nvPr/>
            </p:nvSpPr>
            <p:spPr>
              <a:xfrm flipH="1">
                <a:off x="6580115" y="218468"/>
                <a:ext cx="7667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rgbClr val="FFC000"/>
                    </a:solidFill>
                  </a:rPr>
                  <a:t>M</a:t>
                </a:r>
                <a:r>
                  <a:rPr lang="en-US" sz="1200" b="1" dirty="0" smtClean="0">
                    <a:solidFill>
                      <a:srgbClr val="FFC000"/>
                    </a:solidFill>
                  </a:rPr>
                  <a:t>erge</a:t>
                </a:r>
                <a:endParaRPr lang="ru-RU" sz="1200" b="1" dirty="0">
                  <a:solidFill>
                    <a:srgbClr val="FFC000"/>
                  </a:solidFill>
                </a:endParaRPr>
              </a:p>
            </p:txBody>
          </p:sp>
          <p:sp>
            <p:nvSpPr>
              <p:cNvPr id="146" name="TextBox 145"/>
              <p:cNvSpPr txBox="1"/>
              <p:nvPr/>
            </p:nvSpPr>
            <p:spPr>
              <a:xfrm flipH="1">
                <a:off x="4861601" y="221258"/>
                <a:ext cx="93767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solidFill>
                      <a:srgbClr val="00B050"/>
                    </a:solidFill>
                  </a:rPr>
                  <a:t>GFP-Rnq1</a:t>
                </a:r>
                <a:endParaRPr lang="ru-RU" sz="1200" b="1" dirty="0">
                  <a:solidFill>
                    <a:srgbClr val="00B050"/>
                  </a:solidFill>
                </a:endParaRPr>
              </a:p>
            </p:txBody>
          </p:sp>
          <p:cxnSp>
            <p:nvCxnSpPr>
              <p:cNvPr id="147" name="Прямая соединительная линия 146"/>
              <p:cNvCxnSpPr/>
              <p:nvPr/>
            </p:nvCxnSpPr>
            <p:spPr>
              <a:xfrm>
                <a:off x="4917556" y="1480842"/>
                <a:ext cx="108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8" name="Прямоугольник 147"/>
              <p:cNvSpPr/>
              <p:nvPr/>
            </p:nvSpPr>
            <p:spPr>
              <a:xfrm>
                <a:off x="4822127" y="221465"/>
                <a:ext cx="2479642" cy="135588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</p:grpSp>
        <p:grpSp>
          <p:nvGrpSpPr>
            <p:cNvPr id="26" name="Группа 25"/>
            <p:cNvGrpSpPr/>
            <p:nvPr/>
          </p:nvGrpSpPr>
          <p:grpSpPr>
            <a:xfrm>
              <a:off x="848363" y="7201705"/>
              <a:ext cx="2781495" cy="1265603"/>
              <a:chOff x="1915859" y="1621996"/>
              <a:chExt cx="2781495" cy="1265603"/>
            </a:xfrm>
          </p:grpSpPr>
          <p:pic>
            <p:nvPicPr>
              <p:cNvPr id="114" name="Рисунок 113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607755" y="1887723"/>
                <a:ext cx="895622" cy="946800"/>
              </a:xfrm>
              <a:prstGeom prst="rect">
                <a:avLst/>
              </a:prstGeom>
            </p:spPr>
          </p:pic>
          <p:grpSp>
            <p:nvGrpSpPr>
              <p:cNvPr id="115" name="Группа 114"/>
              <p:cNvGrpSpPr/>
              <p:nvPr/>
            </p:nvGrpSpPr>
            <p:grpSpPr>
              <a:xfrm>
                <a:off x="1915859" y="1621996"/>
                <a:ext cx="2781495" cy="1265603"/>
                <a:chOff x="206328" y="2039437"/>
                <a:chExt cx="2781495" cy="1265603"/>
              </a:xfrm>
            </p:grpSpPr>
            <p:grpSp>
              <p:nvGrpSpPr>
                <p:cNvPr id="116" name="Группа 115"/>
                <p:cNvGrpSpPr/>
                <p:nvPr/>
              </p:nvGrpSpPr>
              <p:grpSpPr>
                <a:xfrm>
                  <a:off x="206328" y="2039437"/>
                  <a:ext cx="2781495" cy="1256329"/>
                  <a:chOff x="1285611" y="3003590"/>
                  <a:chExt cx="2781495" cy="1256329"/>
                </a:xfrm>
              </p:grpSpPr>
              <p:grpSp>
                <p:nvGrpSpPr>
                  <p:cNvPr id="118" name="Группа 117"/>
                  <p:cNvGrpSpPr/>
                  <p:nvPr/>
                </p:nvGrpSpPr>
                <p:grpSpPr>
                  <a:xfrm>
                    <a:off x="1285611" y="3003590"/>
                    <a:ext cx="2781495" cy="1256329"/>
                    <a:chOff x="1273681" y="4416356"/>
                    <a:chExt cx="2781495" cy="1256329"/>
                  </a:xfrm>
                </p:grpSpPr>
                <p:grpSp>
                  <p:nvGrpSpPr>
                    <p:cNvPr id="120" name="Группа 119"/>
                    <p:cNvGrpSpPr/>
                    <p:nvPr/>
                  </p:nvGrpSpPr>
                  <p:grpSpPr>
                    <a:xfrm>
                      <a:off x="1417319" y="4678680"/>
                      <a:ext cx="2276888" cy="946616"/>
                      <a:chOff x="1417319" y="4678680"/>
                      <a:chExt cx="2276888" cy="946616"/>
                    </a:xfrm>
                  </p:grpSpPr>
                  <p:grpSp>
                    <p:nvGrpSpPr>
                      <p:cNvPr id="126" name="Группа 125"/>
                      <p:cNvGrpSpPr/>
                      <p:nvPr/>
                    </p:nvGrpSpPr>
                    <p:grpSpPr>
                      <a:xfrm>
                        <a:off x="1417319" y="4678680"/>
                        <a:ext cx="2276888" cy="946616"/>
                        <a:chOff x="1417319" y="4678680"/>
                        <a:chExt cx="2276888" cy="946616"/>
                      </a:xfrm>
                    </p:grpSpPr>
                    <p:pic>
                      <p:nvPicPr>
                        <p:cNvPr id="128" name="Рисунок 127"/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0">
                          <a:extLst>
                            <a:ext uri="{BEBA8EAE-BF5A-486C-A8C5-ECC9F3942E4B}">
                              <a14:imgProps xmlns:a14="http://schemas.microsoft.com/office/drawing/2010/main">
                                <a14:imgLayer r:embed="rId11">
                                  <a14:imgEffect>
                                    <a14:brightnessContrast contrast="10000"/>
                                  </a14:imgEffect>
                                </a14:imgLayer>
                              </a14:imgProps>
                            </a:ext>
                          </a:extLst>
                        </a:blip>
                        <a:srcRect l="9323" t="10467" r="10675" b="-1"/>
                        <a:stretch/>
                      </p:blipFill>
                      <p:spPr>
                        <a:xfrm>
                          <a:off x="1417319" y="4678680"/>
                          <a:ext cx="800101" cy="946616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129" name="Рисунок 128"/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2">
                          <a:extLst>
                            <a:ext uri="{BEBA8EAE-BF5A-486C-A8C5-ECC9F3942E4B}">
                              <a14:imgProps xmlns:a14="http://schemas.microsoft.com/office/drawing/2010/main">
                                <a14:imgLayer r:embed="rId13">
                                  <a14:imgEffect>
                                    <a14:brightnessContrast bright="40000" contrast="42000"/>
                                  </a14:imgEffect>
                                </a14:imgLayer>
                              </a14:imgProps>
                            </a:ext>
                          </a:extLst>
                        </a:blip>
                        <a:srcRect l="11625" t="10466" r="7613"/>
                        <a:stretch/>
                      </p:blipFill>
                      <p:spPr>
                        <a:xfrm>
                          <a:off x="2217420" y="4678680"/>
                          <a:ext cx="807720" cy="946615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130" name="Овал 129"/>
                        <p:cNvSpPr/>
                        <p:nvPr/>
                      </p:nvSpPr>
                      <p:spPr>
                        <a:xfrm rot="20076316">
                          <a:off x="3113829" y="4814209"/>
                          <a:ext cx="580378" cy="669617"/>
                        </a:xfrm>
                        <a:prstGeom prst="ellipse">
                          <a:avLst/>
                        </a:prstGeom>
                        <a:noFill/>
                        <a:ln>
                          <a:solidFill>
                            <a:schemeClr val="bg1"/>
                          </a:solidFill>
                          <a:prstDash val="sysDash"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ru-RU"/>
                        </a:p>
                      </p:txBody>
                    </p:sp>
                    <p:sp>
                      <p:nvSpPr>
                        <p:cNvPr id="131" name="Овал 130"/>
                        <p:cNvSpPr/>
                        <p:nvPr/>
                      </p:nvSpPr>
                      <p:spPr>
                        <a:xfrm rot="20076316">
                          <a:off x="2321349" y="4814209"/>
                          <a:ext cx="580378" cy="669617"/>
                        </a:xfrm>
                        <a:prstGeom prst="ellipse">
                          <a:avLst/>
                        </a:prstGeom>
                        <a:noFill/>
                        <a:ln>
                          <a:solidFill>
                            <a:schemeClr val="bg1"/>
                          </a:solidFill>
                          <a:prstDash val="sysDash"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ru-RU"/>
                        </a:p>
                      </p:txBody>
                    </p:sp>
                    <p:sp>
                      <p:nvSpPr>
                        <p:cNvPr id="132" name="Овал 131"/>
                        <p:cNvSpPr/>
                        <p:nvPr/>
                      </p:nvSpPr>
                      <p:spPr>
                        <a:xfrm rot="20076316">
                          <a:off x="1536489" y="4814209"/>
                          <a:ext cx="580378" cy="669617"/>
                        </a:xfrm>
                        <a:prstGeom prst="ellipse">
                          <a:avLst/>
                        </a:prstGeom>
                        <a:noFill/>
                        <a:ln>
                          <a:solidFill>
                            <a:schemeClr val="bg1"/>
                          </a:solidFill>
                          <a:prstDash val="sysDash"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ru-RU"/>
                        </a:p>
                      </p:txBody>
                    </p:sp>
                  </p:grpSp>
                  <p:cxnSp>
                    <p:nvCxnSpPr>
                      <p:cNvPr id="127" name="Прямая соединительная линия 126"/>
                      <p:cNvCxnSpPr/>
                      <p:nvPr/>
                    </p:nvCxnSpPr>
                    <p:spPr>
                      <a:xfrm>
                        <a:off x="1468165" y="5570685"/>
                        <a:ext cx="172800" cy="0"/>
                      </a:xfrm>
                      <a:prstGeom prst="line">
                        <a:avLst/>
                      </a:prstGeom>
                      <a:ln w="19050">
                        <a:solidFill>
                          <a:schemeClr val="bg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121" name="Прямая соединительная линия 120"/>
                    <p:cNvCxnSpPr/>
                    <p:nvPr/>
                  </p:nvCxnSpPr>
                  <p:spPr>
                    <a:xfrm>
                      <a:off x="2221319" y="4453890"/>
                      <a:ext cx="0" cy="1218795"/>
                    </a:xfrm>
                    <a:prstGeom prst="line">
                      <a:avLst/>
                    </a:prstGeom>
                    <a:ln w="12700">
                      <a:solidFill>
                        <a:schemeClr val="bg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2" name="Прямая соединительная линия 121"/>
                    <p:cNvCxnSpPr/>
                    <p:nvPr/>
                  </p:nvCxnSpPr>
                  <p:spPr>
                    <a:xfrm>
                      <a:off x="3029039" y="4431030"/>
                      <a:ext cx="0" cy="1218795"/>
                    </a:xfrm>
                    <a:prstGeom prst="line">
                      <a:avLst/>
                    </a:prstGeom>
                    <a:ln w="12700">
                      <a:solidFill>
                        <a:schemeClr val="bg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23" name="TextBox 122"/>
                    <p:cNvSpPr txBox="1"/>
                    <p:nvPr/>
                  </p:nvSpPr>
                  <p:spPr>
                    <a:xfrm flipH="1">
                      <a:off x="1273681" y="4416356"/>
                      <a:ext cx="111526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B050"/>
                          </a:solidFill>
                        </a:rPr>
                        <a:t>Mot3PD-GFP</a:t>
                      </a:r>
                      <a:endParaRPr lang="ru-RU" sz="1200" b="1" dirty="0">
                        <a:solidFill>
                          <a:srgbClr val="00B050"/>
                        </a:solidFill>
                      </a:endParaRPr>
                    </a:p>
                  </p:txBody>
                </p:sp>
                <p:sp>
                  <p:nvSpPr>
                    <p:cNvPr id="124" name="TextBox 123"/>
                    <p:cNvSpPr txBox="1"/>
                    <p:nvPr/>
                  </p:nvSpPr>
                  <p:spPr>
                    <a:xfrm>
                      <a:off x="2300832" y="4423396"/>
                      <a:ext cx="793807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 smtClean="0">
                          <a:solidFill>
                            <a:srgbClr val="FF0000"/>
                          </a:solidFill>
                        </a:rPr>
                        <a:t>Dcp2-RFP</a:t>
                      </a:r>
                      <a:endParaRPr lang="ru-RU" sz="1200" b="1" dirty="0">
                        <a:solidFill>
                          <a:srgbClr val="FF0000"/>
                        </a:solidFill>
                      </a:endParaRPr>
                    </a:p>
                  </p:txBody>
                </p:sp>
                <p:sp>
                  <p:nvSpPr>
                    <p:cNvPr id="125" name="TextBox 124"/>
                    <p:cNvSpPr txBox="1"/>
                    <p:nvPr/>
                  </p:nvSpPr>
                  <p:spPr>
                    <a:xfrm flipH="1">
                      <a:off x="3172163" y="4431030"/>
                      <a:ext cx="883013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/>
                        <a:t>M</a:t>
                      </a:r>
                      <a:r>
                        <a:rPr lang="en-US" sz="1200" b="1" dirty="0" smtClean="0"/>
                        <a:t>erge</a:t>
                      </a:r>
                      <a:endParaRPr lang="ru-RU" sz="1200" b="1" dirty="0"/>
                    </a:p>
                  </p:txBody>
                </p:sp>
              </p:grpSp>
              <p:cxnSp>
                <p:nvCxnSpPr>
                  <p:cNvPr id="119" name="Прямая со стрелкой 118"/>
                  <p:cNvCxnSpPr/>
                  <p:nvPr/>
                </p:nvCxnSpPr>
                <p:spPr>
                  <a:xfrm flipH="1" flipV="1">
                    <a:off x="3425291" y="3894714"/>
                    <a:ext cx="90899" cy="28150"/>
                  </a:xfrm>
                  <a:prstGeom prst="straightConnector1">
                    <a:avLst/>
                  </a:prstGeom>
                  <a:ln w="38100">
                    <a:solidFill>
                      <a:schemeClr val="accent1"/>
                    </a:solidFill>
                    <a:tailEnd type="stealt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17" name="Прямоугольник 116"/>
                <p:cNvSpPr/>
                <p:nvPr/>
              </p:nvSpPr>
              <p:spPr>
                <a:xfrm>
                  <a:off x="262943" y="2039437"/>
                  <a:ext cx="2595845" cy="1265603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</p:grpSp>
        </p:grpSp>
        <p:grpSp>
          <p:nvGrpSpPr>
            <p:cNvPr id="27" name="Группа 26"/>
            <p:cNvGrpSpPr/>
            <p:nvPr/>
          </p:nvGrpSpPr>
          <p:grpSpPr>
            <a:xfrm>
              <a:off x="3436472" y="7202046"/>
              <a:ext cx="3130611" cy="1420061"/>
              <a:chOff x="3109708" y="2039437"/>
              <a:chExt cx="3130611" cy="1420061"/>
            </a:xfrm>
          </p:grpSpPr>
          <p:grpSp>
            <p:nvGrpSpPr>
              <p:cNvPr id="94" name="Группа 93"/>
              <p:cNvGrpSpPr/>
              <p:nvPr/>
            </p:nvGrpSpPr>
            <p:grpSpPr>
              <a:xfrm>
                <a:off x="3109708" y="2054111"/>
                <a:ext cx="3130611" cy="1405387"/>
                <a:chOff x="5106609" y="3021304"/>
                <a:chExt cx="3130611" cy="1405387"/>
              </a:xfrm>
            </p:grpSpPr>
            <p:grpSp>
              <p:nvGrpSpPr>
                <p:cNvPr id="96" name="Группа 95"/>
                <p:cNvGrpSpPr/>
                <p:nvPr/>
              </p:nvGrpSpPr>
              <p:grpSpPr>
                <a:xfrm>
                  <a:off x="5106609" y="3021304"/>
                  <a:ext cx="3130611" cy="1405387"/>
                  <a:chOff x="5106609" y="2975584"/>
                  <a:chExt cx="3130611" cy="1405387"/>
                </a:xfrm>
              </p:grpSpPr>
              <p:grpSp>
                <p:nvGrpSpPr>
                  <p:cNvPr id="98" name="Группа 97"/>
                  <p:cNvGrpSpPr/>
                  <p:nvPr/>
                </p:nvGrpSpPr>
                <p:grpSpPr>
                  <a:xfrm>
                    <a:off x="5106609" y="2975584"/>
                    <a:ext cx="3065860" cy="1379613"/>
                    <a:chOff x="5502319" y="1112523"/>
                    <a:chExt cx="3065860" cy="1379613"/>
                  </a:xfrm>
                </p:grpSpPr>
                <p:grpSp>
                  <p:nvGrpSpPr>
                    <p:cNvPr id="100" name="Группа 99"/>
                    <p:cNvGrpSpPr/>
                    <p:nvPr/>
                  </p:nvGrpSpPr>
                  <p:grpSpPr>
                    <a:xfrm>
                      <a:off x="5681915" y="1221693"/>
                      <a:ext cx="2880000" cy="1270443"/>
                      <a:chOff x="8051735" y="520734"/>
                      <a:chExt cx="2880000" cy="1270443"/>
                    </a:xfrm>
                  </p:grpSpPr>
                  <p:grpSp>
                    <p:nvGrpSpPr>
                      <p:cNvPr id="104" name="Группа 103"/>
                      <p:cNvGrpSpPr>
                        <a:grpSpLocks noChangeAspect="1"/>
                      </p:cNvGrpSpPr>
                      <p:nvPr/>
                    </p:nvGrpSpPr>
                    <p:grpSpPr>
                      <a:xfrm>
                        <a:off x="8051735" y="673208"/>
                        <a:ext cx="2880000" cy="1079710"/>
                        <a:chOff x="8302125" y="458921"/>
                        <a:chExt cx="3360746" cy="1259942"/>
                      </a:xfrm>
                    </p:grpSpPr>
                    <p:grpSp>
                      <p:nvGrpSpPr>
                        <p:cNvPr id="107" name="Группа 106"/>
                        <p:cNvGrpSpPr/>
                        <p:nvPr/>
                      </p:nvGrpSpPr>
                      <p:grpSpPr>
                        <a:xfrm>
                          <a:off x="8302125" y="458921"/>
                          <a:ext cx="3360746" cy="1259942"/>
                          <a:chOff x="8302125" y="458921"/>
                          <a:chExt cx="3360746" cy="1259942"/>
                        </a:xfrm>
                      </p:grpSpPr>
                      <p:pic>
                        <p:nvPicPr>
                          <p:cNvPr id="111" name="Рисунок 110"/>
                          <p:cNvPicPr>
                            <a:picLocks noChangeAspect="1"/>
                          </p:cNvPicPr>
                          <p:nvPr/>
                        </p:nvPicPr>
                        <p:blipFill>
                          <a:blip r:embed="rId14">
                            <a:extLst>
                              <a:ext uri="{BEBA8EAE-BF5A-486C-A8C5-ECC9F3942E4B}">
                                <a14:imgProps xmlns:a14="http://schemas.microsoft.com/office/drawing/2010/main">
                                  <a14:imgLayer r:embed="rId15">
                                    <a14:imgEffect>
                                      <a14:brightnessContrast bright="20000" contrast="10000"/>
                                    </a14:imgEffect>
                                  </a14:imgLayer>
                                </a14:imgProps>
                              </a:ext>
                            </a:extLst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8302125" y="461563"/>
                            <a:ext cx="1123950" cy="1257300"/>
                          </a:xfrm>
                          <a:prstGeom prst="rect">
                            <a:avLst/>
                          </a:prstGeom>
                        </p:spPr>
                      </p:pic>
                      <p:pic>
                        <p:nvPicPr>
                          <p:cNvPr id="112" name="Рисунок 111"/>
                          <p:cNvPicPr>
                            <a:picLocks noChangeAspect="1"/>
                          </p:cNvPicPr>
                          <p:nvPr/>
                        </p:nvPicPr>
                        <p:blipFill>
                          <a:blip r:embed="rId16">
                            <a:extLst>
                              <a:ext uri="{BEBA8EAE-BF5A-486C-A8C5-ECC9F3942E4B}">
                                <a14:imgProps xmlns:a14="http://schemas.microsoft.com/office/drawing/2010/main">
                                  <a14:imgLayer r:embed="rId17">
                                    <a14:imgEffect>
                                      <a14:brightnessContrast bright="30000" contrast="30000"/>
                                    </a14:imgEffect>
                                  </a14:imgLayer>
                                </a14:imgProps>
                              </a:ext>
                            </a:extLst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9422583" y="458921"/>
                            <a:ext cx="1123950" cy="1257300"/>
                          </a:xfrm>
                          <a:prstGeom prst="rect">
                            <a:avLst/>
                          </a:prstGeom>
                        </p:spPr>
                      </p:pic>
                      <p:pic>
                        <p:nvPicPr>
                          <p:cNvPr id="113" name="Рисунок 112"/>
                          <p:cNvPicPr>
                            <a:picLocks noChangeAspect="1"/>
                          </p:cNvPicPr>
                          <p:nvPr/>
                        </p:nvPicPr>
                        <p:blipFill>
                          <a:blip r:embed="rId18"/>
                          <a:stretch>
                            <a:fillRect/>
                          </a:stretch>
                        </p:blipFill>
                        <p:spPr>
                          <a:xfrm>
                            <a:off x="10538921" y="458921"/>
                            <a:ext cx="1123950" cy="1257300"/>
                          </a:xfrm>
                          <a:prstGeom prst="rect">
                            <a:avLst/>
                          </a:prstGeom>
                        </p:spPr>
                      </p:pic>
                    </p:grpSp>
                    <p:sp>
                      <p:nvSpPr>
                        <p:cNvPr id="108" name="Овал 107"/>
                        <p:cNvSpPr/>
                        <p:nvPr/>
                      </p:nvSpPr>
                      <p:spPr>
                        <a:xfrm rot="2092937">
                          <a:off x="8633569" y="631658"/>
                          <a:ext cx="577962" cy="760501"/>
                        </a:xfrm>
                        <a:prstGeom prst="ellipse">
                          <a:avLst/>
                        </a:prstGeom>
                        <a:noFill/>
                        <a:ln>
                          <a:solidFill>
                            <a:schemeClr val="bg1"/>
                          </a:solidFill>
                          <a:prstDash val="sysDash"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ru-RU"/>
                        </a:p>
                      </p:txBody>
                    </p:sp>
                    <p:sp>
                      <p:nvSpPr>
                        <p:cNvPr id="109" name="Овал 108"/>
                        <p:cNvSpPr/>
                        <p:nvPr/>
                      </p:nvSpPr>
                      <p:spPr>
                        <a:xfrm rot="2092937">
                          <a:off x="9761329" y="624038"/>
                          <a:ext cx="577962" cy="760501"/>
                        </a:xfrm>
                        <a:prstGeom prst="ellipse">
                          <a:avLst/>
                        </a:prstGeom>
                        <a:noFill/>
                        <a:ln>
                          <a:solidFill>
                            <a:schemeClr val="bg1"/>
                          </a:solidFill>
                          <a:prstDash val="sysDash"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ru-RU"/>
                        </a:p>
                      </p:txBody>
                    </p:sp>
                    <p:sp>
                      <p:nvSpPr>
                        <p:cNvPr id="110" name="Овал 109"/>
                        <p:cNvSpPr/>
                        <p:nvPr/>
                      </p:nvSpPr>
                      <p:spPr>
                        <a:xfrm rot="2092937">
                          <a:off x="10866229" y="615146"/>
                          <a:ext cx="577962" cy="760501"/>
                        </a:xfrm>
                        <a:prstGeom prst="ellipse">
                          <a:avLst/>
                        </a:prstGeom>
                        <a:noFill/>
                        <a:ln>
                          <a:solidFill>
                            <a:schemeClr val="bg1"/>
                          </a:solidFill>
                          <a:prstDash val="sysDash"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ru-RU"/>
                        </a:p>
                      </p:txBody>
                    </p:sp>
                  </p:grpSp>
                  <p:cxnSp>
                    <p:nvCxnSpPr>
                      <p:cNvPr id="105" name="Прямая соединительная линия 104"/>
                      <p:cNvCxnSpPr/>
                      <p:nvPr/>
                    </p:nvCxnSpPr>
                    <p:spPr>
                      <a:xfrm>
                        <a:off x="9012054" y="535974"/>
                        <a:ext cx="0" cy="1255203"/>
                      </a:xfrm>
                      <a:prstGeom prst="line">
                        <a:avLst/>
                      </a:prstGeom>
                      <a:ln w="12700">
                        <a:solidFill>
                          <a:schemeClr val="bg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6" name="Прямая соединительная линия 105"/>
                      <p:cNvCxnSpPr/>
                      <p:nvPr/>
                    </p:nvCxnSpPr>
                    <p:spPr>
                      <a:xfrm>
                        <a:off x="9987414" y="520734"/>
                        <a:ext cx="0" cy="1255203"/>
                      </a:xfrm>
                      <a:prstGeom prst="line">
                        <a:avLst/>
                      </a:prstGeom>
                      <a:ln w="12700">
                        <a:solidFill>
                          <a:schemeClr val="bg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101" name="TextBox 100"/>
                    <p:cNvSpPr txBox="1"/>
                    <p:nvPr/>
                  </p:nvSpPr>
                  <p:spPr>
                    <a:xfrm flipH="1">
                      <a:off x="7801431" y="1112523"/>
                      <a:ext cx="76674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rgbClr val="FFC000"/>
                          </a:solidFill>
                        </a:rPr>
                        <a:t>M</a:t>
                      </a:r>
                      <a:r>
                        <a:rPr lang="en-US" sz="1200" b="1" dirty="0" smtClean="0">
                          <a:solidFill>
                            <a:srgbClr val="FFC000"/>
                          </a:solidFill>
                        </a:rPr>
                        <a:t>erge</a:t>
                      </a:r>
                      <a:endParaRPr lang="ru-RU" sz="1200" b="1" dirty="0">
                        <a:solidFill>
                          <a:srgbClr val="FFC000"/>
                        </a:solidFill>
                      </a:endParaRPr>
                    </a:p>
                  </p:txBody>
                </p:sp>
                <p:sp>
                  <p:nvSpPr>
                    <p:cNvPr id="102" name="TextBox 101"/>
                    <p:cNvSpPr txBox="1"/>
                    <p:nvPr/>
                  </p:nvSpPr>
                  <p:spPr>
                    <a:xfrm>
                      <a:off x="6776145" y="1114643"/>
                      <a:ext cx="78598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 smtClean="0">
                          <a:solidFill>
                            <a:srgbClr val="FF0000"/>
                          </a:solidFill>
                        </a:rPr>
                        <a:t>Pab1-RFP</a:t>
                      </a:r>
                      <a:endParaRPr lang="ru-RU" sz="1200" b="1" dirty="0">
                        <a:solidFill>
                          <a:srgbClr val="FF0000"/>
                        </a:solidFill>
                      </a:endParaRPr>
                    </a:p>
                  </p:txBody>
                </p:sp>
                <p:sp>
                  <p:nvSpPr>
                    <p:cNvPr id="103" name="TextBox 102"/>
                    <p:cNvSpPr txBox="1"/>
                    <p:nvPr/>
                  </p:nvSpPr>
                  <p:spPr>
                    <a:xfrm flipH="1">
                      <a:off x="5502319" y="1118291"/>
                      <a:ext cx="1322363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B050"/>
                          </a:solidFill>
                        </a:rPr>
                        <a:t>Mot3PD-GFP</a:t>
                      </a:r>
                      <a:endParaRPr lang="ru-RU" sz="1200" b="1" dirty="0">
                        <a:solidFill>
                          <a:srgbClr val="00B050"/>
                        </a:solidFill>
                      </a:endParaRPr>
                    </a:p>
                  </p:txBody>
                </p:sp>
              </p:grpSp>
              <p:sp>
                <p:nvSpPr>
                  <p:cNvPr id="99" name="Прямоугольник 98"/>
                  <p:cNvSpPr/>
                  <p:nvPr/>
                </p:nvSpPr>
                <p:spPr>
                  <a:xfrm>
                    <a:off x="5216348" y="4164697"/>
                    <a:ext cx="3020872" cy="21627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ru-RU"/>
                  </a:p>
                </p:txBody>
              </p:sp>
            </p:grpSp>
            <p:cxnSp>
              <p:nvCxnSpPr>
                <p:cNvPr id="97" name="Прямая соединительная линия 96"/>
                <p:cNvCxnSpPr/>
                <p:nvPr/>
              </p:nvCxnSpPr>
              <p:spPr>
                <a:xfrm flipV="1">
                  <a:off x="7999188" y="4151709"/>
                  <a:ext cx="1188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5" name="Прямоугольник 94"/>
              <p:cNvSpPr/>
              <p:nvPr/>
            </p:nvSpPr>
            <p:spPr>
              <a:xfrm>
                <a:off x="3224079" y="2039437"/>
                <a:ext cx="2989820" cy="126044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</p:grpSp>
        <p:sp>
          <p:nvSpPr>
            <p:cNvPr id="66" name="TextBox 65"/>
            <p:cNvSpPr txBox="1"/>
            <p:nvPr/>
          </p:nvSpPr>
          <p:spPr>
            <a:xfrm flipH="1">
              <a:off x="6413745" y="7239231"/>
              <a:ext cx="13249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rgbClr val="00B050"/>
                  </a:solidFill>
                </a:rPr>
                <a:t>Mot3PD-GFP</a:t>
              </a:r>
              <a:endParaRPr lang="ru-RU" sz="1200" b="1" dirty="0">
                <a:solidFill>
                  <a:srgbClr val="00B050"/>
                </a:solidFill>
              </a:endParaRPr>
            </a:p>
          </p:txBody>
        </p:sp>
        <p:grpSp>
          <p:nvGrpSpPr>
            <p:cNvPr id="3" name="Группа 2"/>
            <p:cNvGrpSpPr/>
            <p:nvPr/>
          </p:nvGrpSpPr>
          <p:grpSpPr>
            <a:xfrm>
              <a:off x="6597982" y="7203191"/>
              <a:ext cx="2633073" cy="1253825"/>
              <a:chOff x="7700094" y="4476993"/>
              <a:chExt cx="2633073" cy="1253825"/>
            </a:xfrm>
          </p:grpSpPr>
          <p:grpSp>
            <p:nvGrpSpPr>
              <p:cNvPr id="61" name="Группа 60"/>
              <p:cNvGrpSpPr/>
              <p:nvPr/>
            </p:nvGrpSpPr>
            <p:grpSpPr>
              <a:xfrm>
                <a:off x="7794691" y="4753311"/>
                <a:ext cx="869249" cy="936000"/>
                <a:chOff x="6579703" y="2315755"/>
                <a:chExt cx="869249" cy="936000"/>
              </a:xfrm>
            </p:grpSpPr>
            <p:pic>
              <p:nvPicPr>
                <p:cNvPr id="74" name="Рисунок 73"/>
                <p:cNvPicPr>
                  <a:picLocks noChangeAspect="1"/>
                </p:cNvPicPr>
                <p:nvPr/>
              </p:nvPicPr>
              <p:blipFill rotWithShape="1">
                <a:blip r:embed="rId19">
                  <a:extLst>
                    <a:ext uri="{BEBA8EAE-BF5A-486C-A8C5-ECC9F3942E4B}">
                      <a14:imgProps xmlns:a14="http://schemas.microsoft.com/office/drawing/2010/main">
                        <a14:imgLayer r:embed="rId20">
                          <a14:imgEffect>
                            <a14:brightnessContrast bright="30000" contrast="30000"/>
                          </a14:imgEffect>
                        </a14:imgLayer>
                      </a14:imgProps>
                    </a:ext>
                  </a:extLst>
                </a:blip>
                <a:srcRect l="9397"/>
                <a:stretch/>
              </p:blipFill>
              <p:spPr>
                <a:xfrm>
                  <a:off x="6579703" y="2315755"/>
                  <a:ext cx="869249" cy="936000"/>
                </a:xfrm>
                <a:prstGeom prst="rect">
                  <a:avLst/>
                </a:prstGeom>
              </p:spPr>
            </p:pic>
            <p:sp>
              <p:nvSpPr>
                <p:cNvPr id="75" name="Овал 74"/>
                <p:cNvSpPr/>
                <p:nvPr/>
              </p:nvSpPr>
              <p:spPr>
                <a:xfrm>
                  <a:off x="6636996" y="2445056"/>
                  <a:ext cx="630678" cy="654084"/>
                </a:xfrm>
                <a:prstGeom prst="ellipse">
                  <a:avLst/>
                </a:prstGeom>
                <a:noFill/>
                <a:ln>
                  <a:solidFill>
                    <a:schemeClr val="bg1"/>
                  </a:solidFill>
                  <a:prstDash val="sys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</p:grpSp>
          <p:grpSp>
            <p:nvGrpSpPr>
              <p:cNvPr id="62" name="Группа 61"/>
              <p:cNvGrpSpPr/>
              <p:nvPr/>
            </p:nvGrpSpPr>
            <p:grpSpPr>
              <a:xfrm>
                <a:off x="9369992" y="4752314"/>
                <a:ext cx="909485" cy="936000"/>
                <a:chOff x="8373662" y="2314758"/>
                <a:chExt cx="909485" cy="936000"/>
              </a:xfrm>
            </p:grpSpPr>
            <p:pic>
              <p:nvPicPr>
                <p:cNvPr id="72" name="Рисунок 71"/>
                <p:cNvPicPr>
                  <a:picLocks noChangeAspect="1"/>
                </p:cNvPicPr>
                <p:nvPr/>
              </p:nvPicPr>
              <p:blipFill rotWithShape="1">
                <a:blip r:embed="rId21">
                  <a:extLst>
                    <a:ext uri="{BEBA8EAE-BF5A-486C-A8C5-ECC9F3942E4B}">
                      <a14:imgProps xmlns:a14="http://schemas.microsoft.com/office/drawing/2010/main">
                        <a14:imgLayer r:embed="rId22">
                          <a14:imgEffect>
                            <a14:brightnessContrast bright="10000" contrast="20000"/>
                          </a14:imgEffect>
                        </a14:imgLayer>
                      </a14:imgProps>
                    </a:ext>
                  </a:extLst>
                </a:blip>
                <a:srcRect r="5202"/>
                <a:stretch/>
              </p:blipFill>
              <p:spPr>
                <a:xfrm>
                  <a:off x="8373662" y="2314758"/>
                  <a:ext cx="909485" cy="936000"/>
                </a:xfrm>
                <a:prstGeom prst="rect">
                  <a:avLst/>
                </a:prstGeom>
              </p:spPr>
            </p:pic>
            <p:sp>
              <p:nvSpPr>
                <p:cNvPr id="73" name="Овал 72"/>
                <p:cNvSpPr/>
                <p:nvPr/>
              </p:nvSpPr>
              <p:spPr>
                <a:xfrm>
                  <a:off x="8526134" y="2451751"/>
                  <a:ext cx="630678" cy="654084"/>
                </a:xfrm>
                <a:prstGeom prst="ellipse">
                  <a:avLst/>
                </a:prstGeom>
                <a:noFill/>
                <a:ln>
                  <a:solidFill>
                    <a:schemeClr val="bg1"/>
                  </a:solidFill>
                  <a:prstDash val="sys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</p:grpSp>
          <p:grpSp>
            <p:nvGrpSpPr>
              <p:cNvPr id="63" name="Группа 62"/>
              <p:cNvGrpSpPr/>
              <p:nvPr/>
            </p:nvGrpSpPr>
            <p:grpSpPr>
              <a:xfrm>
                <a:off x="8589825" y="4752664"/>
                <a:ext cx="867546" cy="936000"/>
                <a:chOff x="7533861" y="2315108"/>
                <a:chExt cx="867546" cy="936000"/>
              </a:xfrm>
            </p:grpSpPr>
            <p:pic>
              <p:nvPicPr>
                <p:cNvPr id="70" name="Рисунок 69"/>
                <p:cNvPicPr>
                  <a:picLocks noChangeAspect="1"/>
                </p:cNvPicPr>
                <p:nvPr/>
              </p:nvPicPr>
              <p:blipFill rotWithShape="1">
                <a:blip r:embed="rId23">
                  <a:extLst>
                    <a:ext uri="{BEBA8EAE-BF5A-486C-A8C5-ECC9F3942E4B}">
                      <a14:imgProps xmlns:a14="http://schemas.microsoft.com/office/drawing/2010/main">
                        <a14:imgLayer r:embed="rId24">
                          <a14:imgEffect>
                            <a14:brightnessContrast bright="20000" contrast="50000"/>
                          </a14:imgEffect>
                        </a14:imgLayer>
                      </a14:imgProps>
                    </a:ext>
                  </a:extLst>
                </a:blip>
                <a:srcRect l="9574"/>
                <a:stretch/>
              </p:blipFill>
              <p:spPr>
                <a:xfrm>
                  <a:off x="7533861" y="2315108"/>
                  <a:ext cx="867546" cy="936000"/>
                </a:xfrm>
                <a:prstGeom prst="rect">
                  <a:avLst/>
                </a:prstGeom>
              </p:spPr>
            </p:pic>
            <p:sp>
              <p:nvSpPr>
                <p:cNvPr id="71" name="Овал 70"/>
                <p:cNvSpPr/>
                <p:nvPr/>
              </p:nvSpPr>
              <p:spPr>
                <a:xfrm>
                  <a:off x="7612570" y="2452180"/>
                  <a:ext cx="630678" cy="654084"/>
                </a:xfrm>
                <a:prstGeom prst="ellipse">
                  <a:avLst/>
                </a:prstGeom>
                <a:noFill/>
                <a:ln>
                  <a:solidFill>
                    <a:schemeClr val="bg1"/>
                  </a:solidFill>
                  <a:prstDash val="sys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</p:grpSp>
          <p:cxnSp>
            <p:nvCxnSpPr>
              <p:cNvPr id="64" name="Прямая соединительная линия 63"/>
              <p:cNvCxnSpPr/>
              <p:nvPr/>
            </p:nvCxnSpPr>
            <p:spPr>
              <a:xfrm>
                <a:off x="8578335" y="4728749"/>
                <a:ext cx="0" cy="97200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Прямая соединительная линия 64"/>
              <p:cNvCxnSpPr/>
              <p:nvPr/>
            </p:nvCxnSpPr>
            <p:spPr>
              <a:xfrm>
                <a:off x="9416536" y="4732064"/>
                <a:ext cx="0" cy="97200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7" name="TextBox 66"/>
              <p:cNvSpPr txBox="1"/>
              <p:nvPr/>
            </p:nvSpPr>
            <p:spPr>
              <a:xfrm>
                <a:off x="8568727" y="4502821"/>
                <a:ext cx="86914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solidFill>
                      <a:srgbClr val="FF0000"/>
                    </a:solidFill>
                  </a:rPr>
                  <a:t>Hsp42-RFP</a:t>
                </a:r>
                <a:endParaRPr lang="ru-RU" sz="120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 flipH="1">
                <a:off x="9566419" y="4491667"/>
                <a:ext cx="7667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rgbClr val="FFC000"/>
                    </a:solidFill>
                  </a:rPr>
                  <a:t>M</a:t>
                </a:r>
                <a:r>
                  <a:rPr lang="en-US" sz="1200" b="1" dirty="0" smtClean="0">
                    <a:solidFill>
                      <a:srgbClr val="FFC000"/>
                    </a:solidFill>
                  </a:rPr>
                  <a:t>erge</a:t>
                </a:r>
                <a:endParaRPr lang="ru-RU" sz="1200" b="1" dirty="0">
                  <a:solidFill>
                    <a:srgbClr val="FFC000"/>
                  </a:solidFill>
                </a:endParaRPr>
              </a:p>
            </p:txBody>
          </p:sp>
          <p:sp>
            <p:nvSpPr>
              <p:cNvPr id="69" name="Прямоугольник 68"/>
              <p:cNvSpPr/>
              <p:nvPr/>
            </p:nvSpPr>
            <p:spPr>
              <a:xfrm>
                <a:off x="7700094" y="4476993"/>
                <a:ext cx="2633073" cy="125382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cxnSp>
            <p:nvCxnSpPr>
              <p:cNvPr id="60" name="Прямая соединительная линия 59"/>
              <p:cNvCxnSpPr/>
              <p:nvPr/>
            </p:nvCxnSpPr>
            <p:spPr>
              <a:xfrm>
                <a:off x="7834864" y="5634079"/>
                <a:ext cx="1548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" name="Группа 1"/>
            <p:cNvGrpSpPr/>
            <p:nvPr/>
          </p:nvGrpSpPr>
          <p:grpSpPr>
            <a:xfrm>
              <a:off x="6358787" y="5682739"/>
              <a:ext cx="2839032" cy="1380570"/>
              <a:chOff x="7460899" y="2987021"/>
              <a:chExt cx="2839032" cy="1380570"/>
            </a:xfrm>
          </p:grpSpPr>
          <p:grpSp>
            <p:nvGrpSpPr>
              <p:cNvPr id="28" name="Группа 27"/>
              <p:cNvGrpSpPr/>
              <p:nvPr/>
            </p:nvGrpSpPr>
            <p:grpSpPr>
              <a:xfrm>
                <a:off x="7460899" y="2987021"/>
                <a:ext cx="2839032" cy="1380570"/>
                <a:chOff x="8143707" y="148192"/>
                <a:chExt cx="2839032" cy="1380570"/>
              </a:xfrm>
            </p:grpSpPr>
            <p:grpSp>
              <p:nvGrpSpPr>
                <p:cNvPr id="76" name="Группа 75"/>
                <p:cNvGrpSpPr/>
                <p:nvPr/>
              </p:nvGrpSpPr>
              <p:grpSpPr>
                <a:xfrm>
                  <a:off x="8143707" y="148192"/>
                  <a:ext cx="2839032" cy="1380570"/>
                  <a:chOff x="6529989" y="148192"/>
                  <a:chExt cx="2839032" cy="1380570"/>
                </a:xfrm>
              </p:grpSpPr>
              <p:grpSp>
                <p:nvGrpSpPr>
                  <p:cNvPr id="78" name="Группа 77"/>
                  <p:cNvGrpSpPr/>
                  <p:nvPr/>
                </p:nvGrpSpPr>
                <p:grpSpPr>
                  <a:xfrm>
                    <a:off x="6599583" y="150028"/>
                    <a:ext cx="2721466" cy="1378734"/>
                    <a:chOff x="6887816" y="150028"/>
                    <a:chExt cx="2721466" cy="1378734"/>
                  </a:xfrm>
                </p:grpSpPr>
                <p:grpSp>
                  <p:nvGrpSpPr>
                    <p:cNvPr id="80" name="Группа 79"/>
                    <p:cNvGrpSpPr/>
                    <p:nvPr/>
                  </p:nvGrpSpPr>
                  <p:grpSpPr>
                    <a:xfrm>
                      <a:off x="8523432" y="413598"/>
                      <a:ext cx="1085850" cy="1066800"/>
                      <a:chOff x="8920994" y="413598"/>
                      <a:chExt cx="1085850" cy="1066800"/>
                    </a:xfrm>
                  </p:grpSpPr>
                  <p:pic>
                    <p:nvPicPr>
                      <p:cNvPr id="92" name="Рисунок 91"/>
                      <p:cNvPicPr>
                        <a:picLocks noChangeAspect="1"/>
                      </p:cNvPicPr>
                      <p:nvPr/>
                    </p:nvPicPr>
                    <p:blipFill>
                      <a:blip r:embed="rId25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26">
                                <a14:imgEffect>
                                  <a14:brightnessContrast bright="10000" contrast="10000"/>
                                </a14:imgEffect>
                              </a14:imgLayer>
                            </a14:imgProps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8920994" y="413598"/>
                        <a:ext cx="1085850" cy="1066800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93" name="Овал 92"/>
                      <p:cNvSpPr/>
                      <p:nvPr/>
                    </p:nvSpPr>
                    <p:spPr>
                      <a:xfrm rot="21122861">
                        <a:off x="9190597" y="547487"/>
                        <a:ext cx="695739" cy="817214"/>
                      </a:xfrm>
                      <a:prstGeom prst="ellipse">
                        <a:avLst/>
                      </a:prstGeom>
                      <a:noFill/>
                      <a:ln>
                        <a:solidFill>
                          <a:schemeClr val="bg1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ru-RU"/>
                      </a:p>
                    </p:txBody>
                  </p:sp>
                </p:grpSp>
                <p:grpSp>
                  <p:nvGrpSpPr>
                    <p:cNvPr id="81" name="Группа 80"/>
                    <p:cNvGrpSpPr/>
                    <p:nvPr/>
                  </p:nvGrpSpPr>
                  <p:grpSpPr>
                    <a:xfrm>
                      <a:off x="7586669" y="411902"/>
                      <a:ext cx="1085850" cy="1066800"/>
                      <a:chOff x="7835144" y="411902"/>
                      <a:chExt cx="1085850" cy="1066800"/>
                    </a:xfrm>
                  </p:grpSpPr>
                  <p:pic>
                    <p:nvPicPr>
                      <p:cNvPr id="90" name="Рисунок 89"/>
                      <p:cNvPicPr>
                        <a:picLocks noChangeAspect="1"/>
                      </p:cNvPicPr>
                      <p:nvPr/>
                    </p:nvPicPr>
                    <p:blipFill>
                      <a:blip r:embed="rId27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28">
                                <a14:imgEffect>
                                  <a14:brightnessContrast bright="20000" contrast="20000"/>
                                </a14:imgEffect>
                              </a14:imgLayer>
                            </a14:imgProps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7835144" y="411902"/>
                        <a:ext cx="1085850" cy="1066800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91" name="Овал 90"/>
                      <p:cNvSpPr/>
                      <p:nvPr/>
                    </p:nvSpPr>
                    <p:spPr>
                      <a:xfrm rot="21122861">
                        <a:off x="8140363" y="550800"/>
                        <a:ext cx="695739" cy="817214"/>
                      </a:xfrm>
                      <a:prstGeom prst="ellipse">
                        <a:avLst/>
                      </a:prstGeom>
                      <a:noFill/>
                      <a:ln>
                        <a:solidFill>
                          <a:schemeClr val="bg1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ru-RU"/>
                      </a:p>
                    </p:txBody>
                  </p:sp>
                </p:grpSp>
                <p:grpSp>
                  <p:nvGrpSpPr>
                    <p:cNvPr id="82" name="Группа 81"/>
                    <p:cNvGrpSpPr/>
                    <p:nvPr/>
                  </p:nvGrpSpPr>
                  <p:grpSpPr>
                    <a:xfrm>
                      <a:off x="6887816" y="411902"/>
                      <a:ext cx="947327" cy="1066800"/>
                      <a:chOff x="6887816" y="411902"/>
                      <a:chExt cx="947327" cy="1066800"/>
                    </a:xfrm>
                  </p:grpSpPr>
                  <p:pic>
                    <p:nvPicPr>
                      <p:cNvPr id="88" name="Рисунок 87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29"/>
                      <a:srcRect l="12757"/>
                      <a:stretch/>
                    </p:blipFill>
                    <p:spPr>
                      <a:xfrm>
                        <a:off x="6887816" y="411902"/>
                        <a:ext cx="947327" cy="1066800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89" name="Овал 88"/>
                      <p:cNvSpPr/>
                      <p:nvPr/>
                    </p:nvSpPr>
                    <p:spPr>
                      <a:xfrm rot="21122861">
                        <a:off x="7020557" y="544176"/>
                        <a:ext cx="695739" cy="817214"/>
                      </a:xfrm>
                      <a:prstGeom prst="ellipse">
                        <a:avLst/>
                      </a:prstGeom>
                      <a:noFill/>
                      <a:ln>
                        <a:solidFill>
                          <a:schemeClr val="bg1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ru-RU"/>
                      </a:p>
                    </p:txBody>
                  </p:sp>
                </p:grpSp>
                <p:cxnSp>
                  <p:nvCxnSpPr>
                    <p:cNvPr id="83" name="Прямая соединительная линия 82"/>
                    <p:cNvCxnSpPr/>
                    <p:nvPr/>
                  </p:nvCxnSpPr>
                  <p:spPr>
                    <a:xfrm>
                      <a:off x="7787411" y="270244"/>
                      <a:ext cx="0" cy="1255203"/>
                    </a:xfrm>
                    <a:prstGeom prst="line">
                      <a:avLst/>
                    </a:prstGeom>
                    <a:ln w="12700">
                      <a:solidFill>
                        <a:schemeClr val="bg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4" name="Прямая соединительная линия 83"/>
                    <p:cNvCxnSpPr/>
                    <p:nvPr/>
                  </p:nvCxnSpPr>
                  <p:spPr>
                    <a:xfrm>
                      <a:off x="8685246" y="273559"/>
                      <a:ext cx="0" cy="1255203"/>
                    </a:xfrm>
                    <a:prstGeom prst="line">
                      <a:avLst/>
                    </a:prstGeom>
                    <a:ln w="12700">
                      <a:solidFill>
                        <a:schemeClr val="bg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85" name="TextBox 84"/>
                    <p:cNvSpPr txBox="1"/>
                    <p:nvPr/>
                  </p:nvSpPr>
                  <p:spPr>
                    <a:xfrm flipH="1">
                      <a:off x="6928668" y="150028"/>
                      <a:ext cx="93767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 smtClean="0">
                          <a:solidFill>
                            <a:srgbClr val="00B050"/>
                          </a:solidFill>
                        </a:rPr>
                        <a:t>GFP-Rnq1</a:t>
                      </a:r>
                      <a:endParaRPr lang="ru-RU" sz="1200" b="1" dirty="0">
                        <a:solidFill>
                          <a:srgbClr val="00B050"/>
                        </a:solidFill>
                      </a:endParaRPr>
                    </a:p>
                  </p:txBody>
                </p:sp>
                <p:sp>
                  <p:nvSpPr>
                    <p:cNvPr id="86" name="TextBox 85"/>
                    <p:cNvSpPr txBox="1"/>
                    <p:nvPr/>
                  </p:nvSpPr>
                  <p:spPr>
                    <a:xfrm>
                      <a:off x="7824979" y="155189"/>
                      <a:ext cx="869149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 smtClean="0">
                          <a:solidFill>
                            <a:srgbClr val="FF0000"/>
                          </a:solidFill>
                        </a:rPr>
                        <a:t>Hsp42-RFP</a:t>
                      </a:r>
                      <a:endParaRPr lang="ru-RU" sz="1200" b="1" dirty="0">
                        <a:solidFill>
                          <a:srgbClr val="FF0000"/>
                        </a:solidFill>
                      </a:endParaRPr>
                    </a:p>
                  </p:txBody>
                </p:sp>
                <p:sp>
                  <p:nvSpPr>
                    <p:cNvPr id="87" name="TextBox 86"/>
                    <p:cNvSpPr txBox="1"/>
                    <p:nvPr/>
                  </p:nvSpPr>
                  <p:spPr>
                    <a:xfrm flipH="1">
                      <a:off x="8816143" y="157179"/>
                      <a:ext cx="76674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rgbClr val="FFC000"/>
                          </a:solidFill>
                        </a:rPr>
                        <a:t>M</a:t>
                      </a:r>
                      <a:r>
                        <a:rPr lang="en-US" sz="1200" b="1" dirty="0" smtClean="0">
                          <a:solidFill>
                            <a:srgbClr val="FFC000"/>
                          </a:solidFill>
                        </a:rPr>
                        <a:t>erge</a:t>
                      </a:r>
                      <a:endParaRPr lang="ru-RU" sz="1200" b="1" dirty="0">
                        <a:solidFill>
                          <a:srgbClr val="FFC000"/>
                        </a:solidFill>
                      </a:endParaRPr>
                    </a:p>
                  </p:txBody>
                </p:sp>
              </p:grpSp>
              <p:sp>
                <p:nvSpPr>
                  <p:cNvPr id="79" name="Прямоугольник 78"/>
                  <p:cNvSpPr/>
                  <p:nvPr/>
                </p:nvSpPr>
                <p:spPr>
                  <a:xfrm>
                    <a:off x="6529989" y="148192"/>
                    <a:ext cx="2839032" cy="1358774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ru-RU"/>
                  </a:p>
                </p:txBody>
              </p:sp>
            </p:grpSp>
            <p:cxnSp>
              <p:nvCxnSpPr>
                <p:cNvPr id="77" name="Прямая соединительная линия 76"/>
                <p:cNvCxnSpPr/>
                <p:nvPr/>
              </p:nvCxnSpPr>
              <p:spPr>
                <a:xfrm>
                  <a:off x="10717529" y="475587"/>
                  <a:ext cx="1728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0" name="Прямоугольник 29"/>
              <p:cNvSpPr/>
              <p:nvPr/>
            </p:nvSpPr>
            <p:spPr>
              <a:xfrm>
                <a:off x="7520554" y="4276388"/>
                <a:ext cx="2736000" cy="360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</p:grpSp>
        <p:grpSp>
          <p:nvGrpSpPr>
            <p:cNvPr id="31" name="Группа 30"/>
            <p:cNvGrpSpPr/>
            <p:nvPr/>
          </p:nvGrpSpPr>
          <p:grpSpPr>
            <a:xfrm>
              <a:off x="904022" y="5673795"/>
              <a:ext cx="2858534" cy="1420000"/>
              <a:chOff x="1852250" y="94086"/>
              <a:chExt cx="2858534" cy="1420000"/>
            </a:xfrm>
          </p:grpSpPr>
          <p:grpSp>
            <p:nvGrpSpPr>
              <p:cNvPr id="35" name="Группа 34"/>
              <p:cNvGrpSpPr/>
              <p:nvPr/>
            </p:nvGrpSpPr>
            <p:grpSpPr>
              <a:xfrm>
                <a:off x="1924292" y="101612"/>
                <a:ext cx="2701727" cy="1412474"/>
                <a:chOff x="1337006" y="1088437"/>
                <a:chExt cx="2701727" cy="1412474"/>
              </a:xfrm>
            </p:grpSpPr>
            <p:grpSp>
              <p:nvGrpSpPr>
                <p:cNvPr id="40" name="Группа 39"/>
                <p:cNvGrpSpPr/>
                <p:nvPr/>
              </p:nvGrpSpPr>
              <p:grpSpPr>
                <a:xfrm>
                  <a:off x="1337006" y="1088437"/>
                  <a:ext cx="2701727" cy="1412474"/>
                  <a:chOff x="1337006" y="1088437"/>
                  <a:chExt cx="2701727" cy="1412474"/>
                </a:xfrm>
              </p:grpSpPr>
              <p:grpSp>
                <p:nvGrpSpPr>
                  <p:cNvPr id="42" name="Группа 41"/>
                  <p:cNvGrpSpPr/>
                  <p:nvPr/>
                </p:nvGrpSpPr>
                <p:grpSpPr>
                  <a:xfrm>
                    <a:off x="1337006" y="1088437"/>
                    <a:ext cx="2701727" cy="1412474"/>
                    <a:chOff x="2955414" y="4697570"/>
                    <a:chExt cx="2701727" cy="1412474"/>
                  </a:xfrm>
                </p:grpSpPr>
                <p:grpSp>
                  <p:nvGrpSpPr>
                    <p:cNvPr id="44" name="Группа 43"/>
                    <p:cNvGrpSpPr/>
                    <p:nvPr/>
                  </p:nvGrpSpPr>
                  <p:grpSpPr>
                    <a:xfrm>
                      <a:off x="2955414" y="4838278"/>
                      <a:ext cx="2701727" cy="1271766"/>
                      <a:chOff x="2955414" y="4838278"/>
                      <a:chExt cx="2701727" cy="1271766"/>
                    </a:xfrm>
                  </p:grpSpPr>
                  <p:pic>
                    <p:nvPicPr>
                      <p:cNvPr id="47" name="Рисунок 46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30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31">
                                <a14:imgEffect>
                                  <a14:brightnessContrast bright="30000"/>
                                </a14:imgEffect>
                              </a14:imgLayer>
                            </a14:imgProps>
                          </a:ext>
                        </a:extLst>
                      </a:blip>
                      <a:srcRect b="7013"/>
                      <a:stretch/>
                    </p:blipFill>
                    <p:spPr>
                      <a:xfrm>
                        <a:off x="2955414" y="4939978"/>
                        <a:ext cx="900000" cy="106568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48" name="Рисунок 47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32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33">
                                <a14:imgEffect>
                                  <a14:brightnessContrast bright="30000" contrast="30000"/>
                                </a14:imgEffect>
                              </a14:imgLayer>
                            </a14:imgProps>
                          </a:ext>
                        </a:extLst>
                      </a:blip>
                      <a:srcRect t="1" b="7005"/>
                      <a:stretch/>
                    </p:blipFill>
                    <p:spPr>
                      <a:xfrm>
                        <a:off x="3857141" y="4938546"/>
                        <a:ext cx="900000" cy="1067112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49" name="Рисунок 48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34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35">
                                <a14:imgEffect>
                                  <a14:brightnessContrast bright="40000" contrast="40000"/>
                                </a14:imgEffect>
                              </a14:imgLayer>
                            </a14:imgProps>
                          </a:ext>
                        </a:extLst>
                      </a:blip>
                      <a:srcRect t="1" b="7005"/>
                      <a:stretch/>
                    </p:blipFill>
                    <p:spPr>
                      <a:xfrm>
                        <a:off x="4757141" y="4938546"/>
                        <a:ext cx="900000" cy="1067112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50" name="Овал 49"/>
                      <p:cNvSpPr/>
                      <p:nvPr/>
                    </p:nvSpPr>
                    <p:spPr>
                      <a:xfrm rot="17097825">
                        <a:off x="4113944" y="5452336"/>
                        <a:ext cx="406270" cy="532234"/>
                      </a:xfrm>
                      <a:prstGeom prst="ellipse">
                        <a:avLst/>
                      </a:prstGeom>
                      <a:noFill/>
                      <a:ln>
                        <a:solidFill>
                          <a:schemeClr val="bg1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ru-RU"/>
                      </a:p>
                    </p:txBody>
                  </p:sp>
                  <p:sp>
                    <p:nvSpPr>
                      <p:cNvPr id="51" name="Овал 50"/>
                      <p:cNvSpPr/>
                      <p:nvPr/>
                    </p:nvSpPr>
                    <p:spPr>
                      <a:xfrm rot="17097825">
                        <a:off x="3222734" y="5455650"/>
                        <a:ext cx="406270" cy="532234"/>
                      </a:xfrm>
                      <a:prstGeom prst="ellipse">
                        <a:avLst/>
                      </a:prstGeom>
                      <a:noFill/>
                      <a:ln>
                        <a:solidFill>
                          <a:schemeClr val="bg1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ru-RU"/>
                      </a:p>
                    </p:txBody>
                  </p:sp>
                  <p:sp>
                    <p:nvSpPr>
                      <p:cNvPr id="52" name="Овал 51"/>
                      <p:cNvSpPr/>
                      <p:nvPr/>
                    </p:nvSpPr>
                    <p:spPr>
                      <a:xfrm rot="17097825">
                        <a:off x="4107320" y="5445712"/>
                        <a:ext cx="406270" cy="532234"/>
                      </a:xfrm>
                      <a:prstGeom prst="ellipse">
                        <a:avLst/>
                      </a:prstGeom>
                      <a:noFill/>
                      <a:ln>
                        <a:solidFill>
                          <a:schemeClr val="bg1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ru-RU"/>
                      </a:p>
                    </p:txBody>
                  </p:sp>
                  <p:sp>
                    <p:nvSpPr>
                      <p:cNvPr id="53" name="Овал 52"/>
                      <p:cNvSpPr/>
                      <p:nvPr/>
                    </p:nvSpPr>
                    <p:spPr>
                      <a:xfrm rot="17097825">
                        <a:off x="5015095" y="5449027"/>
                        <a:ext cx="406270" cy="532234"/>
                      </a:xfrm>
                      <a:prstGeom prst="ellipse">
                        <a:avLst/>
                      </a:prstGeom>
                      <a:noFill/>
                      <a:ln>
                        <a:solidFill>
                          <a:schemeClr val="bg1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ru-RU"/>
                      </a:p>
                    </p:txBody>
                  </p:sp>
                  <p:sp>
                    <p:nvSpPr>
                      <p:cNvPr id="54" name="Овал 53"/>
                      <p:cNvSpPr/>
                      <p:nvPr/>
                    </p:nvSpPr>
                    <p:spPr>
                      <a:xfrm rot="18145711">
                        <a:off x="3199567" y="4981867"/>
                        <a:ext cx="411695" cy="531785"/>
                      </a:xfrm>
                      <a:prstGeom prst="ellipse">
                        <a:avLst/>
                      </a:prstGeom>
                      <a:noFill/>
                      <a:ln>
                        <a:solidFill>
                          <a:schemeClr val="bg1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ru-RU"/>
                      </a:p>
                    </p:txBody>
                  </p:sp>
                  <p:sp>
                    <p:nvSpPr>
                      <p:cNvPr id="55" name="Овал 54"/>
                      <p:cNvSpPr/>
                      <p:nvPr/>
                    </p:nvSpPr>
                    <p:spPr>
                      <a:xfrm rot="18145711">
                        <a:off x="4107343" y="4985180"/>
                        <a:ext cx="411695" cy="531785"/>
                      </a:xfrm>
                      <a:prstGeom prst="ellipse">
                        <a:avLst/>
                      </a:prstGeom>
                      <a:noFill/>
                      <a:ln>
                        <a:solidFill>
                          <a:schemeClr val="bg1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ru-RU"/>
                      </a:p>
                    </p:txBody>
                  </p:sp>
                  <p:sp>
                    <p:nvSpPr>
                      <p:cNvPr id="56" name="Овал 55"/>
                      <p:cNvSpPr/>
                      <p:nvPr/>
                    </p:nvSpPr>
                    <p:spPr>
                      <a:xfrm rot="18145711">
                        <a:off x="5005182" y="4988495"/>
                        <a:ext cx="411695" cy="531785"/>
                      </a:xfrm>
                      <a:prstGeom prst="ellipse">
                        <a:avLst/>
                      </a:prstGeom>
                      <a:noFill/>
                      <a:ln>
                        <a:solidFill>
                          <a:schemeClr val="bg1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ru-RU"/>
                      </a:p>
                    </p:txBody>
                  </p:sp>
                  <p:cxnSp>
                    <p:nvCxnSpPr>
                      <p:cNvPr id="57" name="Прямая соединительная линия 56"/>
                      <p:cNvCxnSpPr/>
                      <p:nvPr/>
                    </p:nvCxnSpPr>
                    <p:spPr>
                      <a:xfrm>
                        <a:off x="3847769" y="4854841"/>
                        <a:ext cx="0" cy="1255203"/>
                      </a:xfrm>
                      <a:prstGeom prst="line">
                        <a:avLst/>
                      </a:prstGeom>
                      <a:ln w="12700">
                        <a:solidFill>
                          <a:schemeClr val="bg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8" name="Прямая соединительная линия 57"/>
                      <p:cNvCxnSpPr/>
                      <p:nvPr/>
                    </p:nvCxnSpPr>
                    <p:spPr>
                      <a:xfrm>
                        <a:off x="4745604" y="4838278"/>
                        <a:ext cx="0" cy="1255203"/>
                      </a:xfrm>
                      <a:prstGeom prst="line">
                        <a:avLst/>
                      </a:prstGeom>
                      <a:ln w="12700">
                        <a:solidFill>
                          <a:schemeClr val="bg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45" name="TextBox 44"/>
                    <p:cNvSpPr txBox="1"/>
                    <p:nvPr/>
                  </p:nvSpPr>
                  <p:spPr>
                    <a:xfrm flipH="1">
                      <a:off x="3003597" y="4703703"/>
                      <a:ext cx="93767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 smtClean="0">
                          <a:solidFill>
                            <a:srgbClr val="00B050"/>
                          </a:solidFill>
                        </a:rPr>
                        <a:t>GFP-Rnq1</a:t>
                      </a:r>
                      <a:endParaRPr lang="ru-RU" sz="1200" b="1" dirty="0">
                        <a:solidFill>
                          <a:srgbClr val="00B050"/>
                        </a:solidFill>
                      </a:endParaRPr>
                    </a:p>
                  </p:txBody>
                </p:sp>
                <p:sp>
                  <p:nvSpPr>
                    <p:cNvPr id="46" name="TextBox 45"/>
                    <p:cNvSpPr txBox="1"/>
                    <p:nvPr/>
                  </p:nvSpPr>
                  <p:spPr>
                    <a:xfrm>
                      <a:off x="3921978" y="4697570"/>
                      <a:ext cx="793807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 smtClean="0">
                          <a:solidFill>
                            <a:srgbClr val="FF0000"/>
                          </a:solidFill>
                        </a:rPr>
                        <a:t>Dcp2-RFP</a:t>
                      </a:r>
                      <a:endParaRPr lang="ru-RU" sz="1200" b="1" dirty="0">
                        <a:solidFill>
                          <a:srgbClr val="FF0000"/>
                        </a:solidFill>
                      </a:endParaRPr>
                    </a:p>
                  </p:txBody>
                </p:sp>
              </p:grpSp>
              <p:cxnSp>
                <p:nvCxnSpPr>
                  <p:cNvPr id="43" name="Прямая соединительная линия 42"/>
                  <p:cNvCxnSpPr/>
                  <p:nvPr/>
                </p:nvCxnSpPr>
                <p:spPr>
                  <a:xfrm>
                    <a:off x="3884082" y="1408607"/>
                    <a:ext cx="108000" cy="0"/>
                  </a:xfrm>
                  <a:prstGeom prst="line">
                    <a:avLst/>
                  </a:prstGeom>
                  <a:ln w="1905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41" name="Прямая со стрелкой 40"/>
                <p:cNvCxnSpPr/>
                <p:nvPr/>
              </p:nvCxnSpPr>
              <p:spPr>
                <a:xfrm flipH="1" flipV="1">
                  <a:off x="3685032" y="1984992"/>
                  <a:ext cx="59203" cy="4320"/>
                </a:xfrm>
                <a:prstGeom prst="straightConnector1">
                  <a:avLst/>
                </a:prstGeom>
                <a:ln w="38100">
                  <a:solidFill>
                    <a:schemeClr val="accent1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6" name="Прямая со стрелкой 35"/>
              <p:cNvCxnSpPr/>
              <p:nvPr/>
            </p:nvCxnSpPr>
            <p:spPr>
              <a:xfrm flipH="1">
                <a:off x="4196836" y="501343"/>
                <a:ext cx="56796" cy="20165"/>
              </a:xfrm>
              <a:prstGeom prst="straightConnector1">
                <a:avLst/>
              </a:prstGeom>
              <a:ln w="38100">
                <a:solidFill>
                  <a:schemeClr val="accent1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Прямоугольник 36"/>
              <p:cNvSpPr/>
              <p:nvPr/>
            </p:nvSpPr>
            <p:spPr>
              <a:xfrm>
                <a:off x="1861132" y="314372"/>
                <a:ext cx="2849652" cy="4572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38" name="Прямоугольник 37"/>
              <p:cNvSpPr/>
              <p:nvPr/>
            </p:nvSpPr>
            <p:spPr>
              <a:xfrm>
                <a:off x="1852250" y="115433"/>
                <a:ext cx="2832403" cy="135244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 flipH="1">
                <a:off x="3885974" y="94086"/>
                <a:ext cx="7667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rgbClr val="FFC000"/>
                    </a:solidFill>
                  </a:rPr>
                  <a:t>M</a:t>
                </a:r>
                <a:r>
                  <a:rPr lang="en-US" sz="1200" b="1" dirty="0" smtClean="0">
                    <a:solidFill>
                      <a:srgbClr val="FFC000"/>
                    </a:solidFill>
                  </a:rPr>
                  <a:t>erge</a:t>
                </a:r>
                <a:endParaRPr lang="ru-RU" sz="1200" b="1" dirty="0">
                  <a:solidFill>
                    <a:srgbClr val="FFC000"/>
                  </a:solidFill>
                </a:endParaRPr>
              </a:p>
            </p:txBody>
          </p:sp>
        </p:grpSp>
        <p:cxnSp>
          <p:nvCxnSpPr>
            <p:cNvPr id="32" name="Прямая со стрелкой 31"/>
            <p:cNvCxnSpPr/>
            <p:nvPr/>
          </p:nvCxnSpPr>
          <p:spPr>
            <a:xfrm flipH="1" flipV="1">
              <a:off x="2981086" y="7783000"/>
              <a:ext cx="90896" cy="11430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Прямая со стрелкой 32"/>
            <p:cNvCxnSpPr/>
            <p:nvPr/>
          </p:nvCxnSpPr>
          <p:spPr>
            <a:xfrm flipH="1" flipV="1">
              <a:off x="3271241" y="6742673"/>
              <a:ext cx="90896" cy="11430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Прямая со стрелкой 33"/>
            <p:cNvCxnSpPr/>
            <p:nvPr/>
          </p:nvCxnSpPr>
          <p:spPr>
            <a:xfrm flipV="1">
              <a:off x="3230322" y="6299071"/>
              <a:ext cx="31717" cy="56122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Группа 4"/>
          <p:cNvGrpSpPr/>
          <p:nvPr/>
        </p:nvGrpSpPr>
        <p:grpSpPr>
          <a:xfrm>
            <a:off x="4724956" y="8713172"/>
            <a:ext cx="3145238" cy="2356720"/>
            <a:chOff x="3847099" y="8439377"/>
            <a:chExt cx="3145238" cy="2356720"/>
          </a:xfrm>
        </p:grpSpPr>
        <p:sp>
          <p:nvSpPr>
            <p:cNvPr id="592" name="TextBox 591"/>
            <p:cNvSpPr txBox="1"/>
            <p:nvPr/>
          </p:nvSpPr>
          <p:spPr>
            <a:xfrm>
              <a:off x="3847099" y="8439377"/>
              <a:ext cx="3321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G</a:t>
              </a:r>
              <a:endParaRPr lang="ru-RU" b="1" dirty="0"/>
            </a:p>
          </p:txBody>
        </p:sp>
        <p:grpSp>
          <p:nvGrpSpPr>
            <p:cNvPr id="237" name="Группа 236"/>
            <p:cNvGrpSpPr/>
            <p:nvPr/>
          </p:nvGrpSpPr>
          <p:grpSpPr>
            <a:xfrm>
              <a:off x="4278883" y="8595850"/>
              <a:ext cx="2713454" cy="2200247"/>
              <a:chOff x="4819078" y="1271873"/>
              <a:chExt cx="2713454" cy="2200247"/>
            </a:xfrm>
          </p:grpSpPr>
          <p:grpSp>
            <p:nvGrpSpPr>
              <p:cNvPr id="238" name="Группа 237"/>
              <p:cNvGrpSpPr/>
              <p:nvPr/>
            </p:nvGrpSpPr>
            <p:grpSpPr>
              <a:xfrm>
                <a:off x="4819078" y="2385717"/>
                <a:ext cx="2713454" cy="1086403"/>
                <a:chOff x="4819078" y="2445351"/>
                <a:chExt cx="2713454" cy="1086403"/>
              </a:xfrm>
            </p:grpSpPr>
            <p:grpSp>
              <p:nvGrpSpPr>
                <p:cNvPr id="257" name="Группа 256"/>
                <p:cNvGrpSpPr/>
                <p:nvPr/>
              </p:nvGrpSpPr>
              <p:grpSpPr>
                <a:xfrm>
                  <a:off x="4819078" y="2445351"/>
                  <a:ext cx="2628073" cy="1061853"/>
                  <a:chOff x="1307482" y="4411788"/>
                  <a:chExt cx="2990062" cy="1208110"/>
                </a:xfrm>
              </p:grpSpPr>
              <p:grpSp>
                <p:nvGrpSpPr>
                  <p:cNvPr id="259" name="Группа 258"/>
                  <p:cNvGrpSpPr>
                    <a:grpSpLocks noChangeAspect="1"/>
                  </p:cNvGrpSpPr>
                  <p:nvPr/>
                </p:nvGrpSpPr>
                <p:grpSpPr>
                  <a:xfrm>
                    <a:off x="1429193" y="4629396"/>
                    <a:ext cx="2868351" cy="990502"/>
                    <a:chOff x="1439227" y="2150851"/>
                    <a:chExt cx="3344850" cy="1155048"/>
                  </a:xfrm>
                </p:grpSpPr>
                <p:pic>
                  <p:nvPicPr>
                    <p:cNvPr id="264" name="Рисунок 263"/>
                    <p:cNvPicPr>
                      <a:picLocks noChangeAspect="1"/>
                    </p:cNvPicPr>
                    <p:nvPr/>
                  </p:nvPicPr>
                  <p:blipFill>
                    <a:blip r:embed="rId36">
                      <a:extLst>
                        <a:ext uri="{BEBA8EAE-BF5A-486C-A8C5-ECC9F3942E4B}">
                          <a14:imgProps xmlns:a14="http://schemas.microsoft.com/office/drawing/2010/main">
                            <a14:imgLayer r:embed="rId37">
                              <a14:imgEffect>
                                <a14:brightnessContrast bright="20000" contrast="30000"/>
                              </a14:imgEffect>
                            </a14:imgLayer>
                          </a14:imgProps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439227" y="2199823"/>
                      <a:ext cx="1116000" cy="10695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65" name="Рисунок 264"/>
                    <p:cNvPicPr>
                      <a:picLocks noChangeAspect="1"/>
                    </p:cNvPicPr>
                    <p:nvPr/>
                  </p:nvPicPr>
                  <p:blipFill>
                    <a:blip r:embed="rId38">
                      <a:extLst>
                        <a:ext uri="{BEBA8EAE-BF5A-486C-A8C5-ECC9F3942E4B}">
                          <a14:imgProps xmlns:a14="http://schemas.microsoft.com/office/drawing/2010/main">
                            <a14:imgLayer r:embed="rId39">
                              <a14:imgEffect>
                                <a14:brightnessContrast bright="20000" contrast="30000"/>
                              </a14:imgEffect>
                            </a14:imgLayer>
                          </a14:imgProps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2552864" y="2199823"/>
                      <a:ext cx="1116000" cy="10695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66" name="Рисунок 265"/>
                    <p:cNvPicPr>
                      <a:picLocks noChangeAspect="1"/>
                    </p:cNvPicPr>
                    <p:nvPr/>
                  </p:nvPicPr>
                  <p:blipFill>
                    <a:blip r:embed="rId40">
                      <a:extLst>
                        <a:ext uri="{BEBA8EAE-BF5A-486C-A8C5-ECC9F3942E4B}">
                          <a14:imgProps xmlns:a14="http://schemas.microsoft.com/office/drawing/2010/main">
                            <a14:imgLayer r:embed="rId41">
                              <a14:imgEffect>
                                <a14:brightnessContrast bright="20000" contrast="30000"/>
                              </a14:imgEffect>
                            </a14:imgLayer>
                          </a14:imgProps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3668077" y="2199823"/>
                      <a:ext cx="1116000" cy="1069500"/>
                    </a:xfrm>
                    <a:prstGeom prst="rect">
                      <a:avLst/>
                    </a:prstGeom>
                  </p:spPr>
                </p:pic>
                <p:cxnSp>
                  <p:nvCxnSpPr>
                    <p:cNvPr id="267" name="Прямая соединительная линия 266"/>
                    <p:cNvCxnSpPr/>
                    <p:nvPr/>
                  </p:nvCxnSpPr>
                  <p:spPr>
                    <a:xfrm>
                      <a:off x="2552864" y="2153899"/>
                      <a:ext cx="0" cy="1152000"/>
                    </a:xfrm>
                    <a:prstGeom prst="line">
                      <a:avLst/>
                    </a:prstGeom>
                    <a:ln w="12700">
                      <a:solidFill>
                        <a:schemeClr val="bg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8" name="Прямая соединительная линия 267"/>
                    <p:cNvCxnSpPr/>
                    <p:nvPr/>
                  </p:nvCxnSpPr>
                  <p:spPr>
                    <a:xfrm>
                      <a:off x="3656240" y="2150851"/>
                      <a:ext cx="0" cy="1152000"/>
                    </a:xfrm>
                    <a:prstGeom prst="line">
                      <a:avLst/>
                    </a:prstGeom>
                    <a:ln w="12700">
                      <a:solidFill>
                        <a:schemeClr val="bg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69" name="Овал 268"/>
                    <p:cNvSpPr/>
                    <p:nvPr/>
                  </p:nvSpPr>
                  <p:spPr>
                    <a:xfrm rot="1273501">
                      <a:off x="1717651" y="2351557"/>
                      <a:ext cx="726749" cy="813816"/>
                    </a:xfrm>
                    <a:prstGeom prst="ellipse">
                      <a:avLst/>
                    </a:prstGeom>
                    <a:noFill/>
                    <a:ln>
                      <a:solidFill>
                        <a:schemeClr val="bg1"/>
                      </a:solidFill>
                      <a:prstDash val="sysDash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ru-RU"/>
                    </a:p>
                  </p:txBody>
                </p:sp>
                <p:sp>
                  <p:nvSpPr>
                    <p:cNvPr id="270" name="Овал 269"/>
                    <p:cNvSpPr/>
                    <p:nvPr/>
                  </p:nvSpPr>
                  <p:spPr>
                    <a:xfrm rot="1273501">
                      <a:off x="2794797" y="2356999"/>
                      <a:ext cx="726749" cy="813816"/>
                    </a:xfrm>
                    <a:prstGeom prst="ellipse">
                      <a:avLst/>
                    </a:prstGeom>
                    <a:noFill/>
                    <a:ln>
                      <a:solidFill>
                        <a:schemeClr val="bg1"/>
                      </a:solidFill>
                      <a:prstDash val="sysDash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ru-RU"/>
                    </a:p>
                  </p:txBody>
                </p:sp>
                <p:sp>
                  <p:nvSpPr>
                    <p:cNvPr id="271" name="Овал 270"/>
                    <p:cNvSpPr/>
                    <p:nvPr/>
                  </p:nvSpPr>
                  <p:spPr>
                    <a:xfrm rot="1273501">
                      <a:off x="3921236" y="2360312"/>
                      <a:ext cx="726749" cy="813816"/>
                    </a:xfrm>
                    <a:prstGeom prst="ellipse">
                      <a:avLst/>
                    </a:prstGeom>
                    <a:noFill/>
                    <a:ln>
                      <a:solidFill>
                        <a:schemeClr val="bg1"/>
                      </a:solidFill>
                      <a:prstDash val="sysDash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ru-RU"/>
                    </a:p>
                  </p:txBody>
                </p:sp>
              </p:grpSp>
              <p:sp>
                <p:nvSpPr>
                  <p:cNvPr id="260" name="TextBox 259"/>
                  <p:cNvSpPr txBox="1"/>
                  <p:nvPr/>
                </p:nvSpPr>
                <p:spPr>
                  <a:xfrm flipH="1">
                    <a:off x="3495368" y="4411788"/>
                    <a:ext cx="741914" cy="31515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rgbClr val="FFC000"/>
                        </a:solidFill>
                      </a:rPr>
                      <a:t>M</a:t>
                    </a:r>
                    <a:r>
                      <a:rPr lang="en-US" sz="1200" b="1" dirty="0" smtClean="0">
                        <a:solidFill>
                          <a:srgbClr val="FFC000"/>
                        </a:solidFill>
                      </a:rPr>
                      <a:t>erge</a:t>
                    </a:r>
                    <a:endParaRPr lang="ru-RU" sz="1200" b="1" dirty="0">
                      <a:solidFill>
                        <a:srgbClr val="FFC000"/>
                      </a:solidFill>
                    </a:endParaRPr>
                  </a:p>
                </p:txBody>
              </p:sp>
              <p:sp>
                <p:nvSpPr>
                  <p:cNvPr id="261" name="TextBox 260"/>
                  <p:cNvSpPr txBox="1"/>
                  <p:nvPr/>
                </p:nvSpPr>
                <p:spPr>
                  <a:xfrm flipH="1">
                    <a:off x="1307482" y="4429293"/>
                    <a:ext cx="1240502" cy="31515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200" b="1" dirty="0" smtClean="0">
                        <a:solidFill>
                          <a:srgbClr val="00B050"/>
                        </a:solidFill>
                      </a:rPr>
                      <a:t>Mot3PD-GFP</a:t>
                    </a:r>
                    <a:endParaRPr lang="ru-RU" sz="1200" b="1" dirty="0">
                      <a:solidFill>
                        <a:srgbClr val="00B050"/>
                      </a:solidFill>
                    </a:endParaRPr>
                  </a:p>
                </p:txBody>
              </p:sp>
              <p:sp>
                <p:nvSpPr>
                  <p:cNvPr id="262" name="TextBox 261"/>
                  <p:cNvSpPr txBox="1"/>
                  <p:nvPr/>
                </p:nvSpPr>
                <p:spPr>
                  <a:xfrm>
                    <a:off x="2380403" y="4421003"/>
                    <a:ext cx="988865" cy="31515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solidFill>
                          <a:srgbClr val="FF0000"/>
                        </a:solidFill>
                      </a:rPr>
                      <a:t>Hsp42-RFP</a:t>
                    </a:r>
                    <a:endParaRPr lang="ru-RU" sz="1200" b="1" dirty="0">
                      <a:solidFill>
                        <a:srgbClr val="FF0000"/>
                      </a:solidFill>
                    </a:endParaRPr>
                  </a:p>
                </p:txBody>
              </p:sp>
              <p:cxnSp>
                <p:nvCxnSpPr>
                  <p:cNvPr id="263" name="Прямая соединительная линия 262"/>
                  <p:cNvCxnSpPr/>
                  <p:nvPr/>
                </p:nvCxnSpPr>
                <p:spPr>
                  <a:xfrm flipV="1">
                    <a:off x="1477120" y="4743506"/>
                    <a:ext cx="147600" cy="0"/>
                  </a:xfrm>
                  <a:prstGeom prst="line">
                    <a:avLst/>
                  </a:prstGeom>
                  <a:ln w="1905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58" name="Прямоугольник 257"/>
                <p:cNvSpPr/>
                <p:nvPr/>
              </p:nvSpPr>
              <p:spPr>
                <a:xfrm>
                  <a:off x="4835152" y="2482373"/>
                  <a:ext cx="2697380" cy="1049381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</p:grpSp>
          <p:grpSp>
            <p:nvGrpSpPr>
              <p:cNvPr id="239" name="Группа 238"/>
              <p:cNvGrpSpPr/>
              <p:nvPr/>
            </p:nvGrpSpPr>
            <p:grpSpPr>
              <a:xfrm>
                <a:off x="4835152" y="1271873"/>
                <a:ext cx="2697380" cy="1113799"/>
                <a:chOff x="4835152" y="1311629"/>
                <a:chExt cx="2697380" cy="1113799"/>
              </a:xfrm>
            </p:grpSpPr>
            <p:grpSp>
              <p:nvGrpSpPr>
                <p:cNvPr id="240" name="Группа 239"/>
                <p:cNvGrpSpPr/>
                <p:nvPr/>
              </p:nvGrpSpPr>
              <p:grpSpPr>
                <a:xfrm>
                  <a:off x="4835152" y="1314761"/>
                  <a:ext cx="2697380" cy="1110667"/>
                  <a:chOff x="1325770" y="1959945"/>
                  <a:chExt cx="3068915" cy="1263648"/>
                </a:xfrm>
              </p:grpSpPr>
              <p:grpSp>
                <p:nvGrpSpPr>
                  <p:cNvPr id="245" name="Группа 244"/>
                  <p:cNvGrpSpPr/>
                  <p:nvPr/>
                </p:nvGrpSpPr>
                <p:grpSpPr>
                  <a:xfrm>
                    <a:off x="1426584" y="2197659"/>
                    <a:ext cx="2861812" cy="991204"/>
                    <a:chOff x="1426584" y="2197659"/>
                    <a:chExt cx="2861812" cy="991204"/>
                  </a:xfrm>
                </p:grpSpPr>
                <p:pic>
                  <p:nvPicPr>
                    <p:cNvPr id="249" name="Рисунок 248"/>
                    <p:cNvPicPr>
                      <a:picLocks noChangeAspect="1"/>
                    </p:cNvPicPr>
                    <p:nvPr/>
                  </p:nvPicPr>
                  <p:blipFill>
                    <a:blip r:embed="rId42">
                      <a:extLst>
                        <a:ext uri="{BEBA8EAE-BF5A-486C-A8C5-ECC9F3942E4B}">
                          <a14:imgProps xmlns:a14="http://schemas.microsoft.com/office/drawing/2010/main">
                            <a14:imgLayer r:embed="rId43">
                              <a14:imgEffect>
                                <a14:brightnessContrast contrast="20000"/>
                              </a14:imgEffect>
                            </a14:imgLayer>
                          </a14:imgProps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426584" y="2213014"/>
                      <a:ext cx="957600" cy="975011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50" name="Рисунок 249"/>
                    <p:cNvPicPr>
                      <a:picLocks noChangeAspect="1"/>
                    </p:cNvPicPr>
                    <p:nvPr/>
                  </p:nvPicPr>
                  <p:blipFill>
                    <a:blip r:embed="rId44">
                      <a:extLst>
                        <a:ext uri="{BEBA8EAE-BF5A-486C-A8C5-ECC9F3942E4B}">
                          <a14:imgProps xmlns:a14="http://schemas.microsoft.com/office/drawing/2010/main">
                            <a14:imgLayer r:embed="rId45">
                              <a14:imgEffect>
                                <a14:brightnessContrast contrast="20000"/>
                              </a14:imgEffect>
                            </a14:imgLayer>
                          </a14:imgProps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2374535" y="2209569"/>
                      <a:ext cx="957600" cy="975011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51" name="Рисунок 250"/>
                    <p:cNvPicPr>
                      <a:picLocks noChangeAspect="1"/>
                    </p:cNvPicPr>
                    <p:nvPr/>
                  </p:nvPicPr>
                  <p:blipFill>
                    <a:blip r:embed="rId46">
                      <a:extLst>
                        <a:ext uri="{BEBA8EAE-BF5A-486C-A8C5-ECC9F3942E4B}">
                          <a14:imgProps xmlns:a14="http://schemas.microsoft.com/office/drawing/2010/main">
                            <a14:imgLayer r:embed="rId47">
                              <a14:imgEffect>
                                <a14:brightnessContrast contrast="20000"/>
                              </a14:imgEffect>
                            </a14:imgLayer>
                          </a14:imgProps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3330796" y="2209569"/>
                      <a:ext cx="957600" cy="975011"/>
                    </a:xfrm>
                    <a:prstGeom prst="rect">
                      <a:avLst/>
                    </a:prstGeom>
                  </p:spPr>
                </p:pic>
                <p:cxnSp>
                  <p:nvCxnSpPr>
                    <p:cNvPr id="252" name="Прямая соединительная линия 251"/>
                    <p:cNvCxnSpPr/>
                    <p:nvPr/>
                  </p:nvCxnSpPr>
                  <p:spPr>
                    <a:xfrm>
                      <a:off x="2388851" y="2197659"/>
                      <a:ext cx="0" cy="987889"/>
                    </a:xfrm>
                    <a:prstGeom prst="line">
                      <a:avLst/>
                    </a:prstGeom>
                    <a:ln w="12700">
                      <a:solidFill>
                        <a:schemeClr val="bg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3" name="Прямая соединительная линия 252"/>
                    <p:cNvCxnSpPr/>
                    <p:nvPr/>
                  </p:nvCxnSpPr>
                  <p:spPr>
                    <a:xfrm>
                      <a:off x="3326443" y="2200974"/>
                      <a:ext cx="0" cy="987889"/>
                    </a:xfrm>
                    <a:prstGeom prst="line">
                      <a:avLst/>
                    </a:prstGeom>
                    <a:ln w="12700">
                      <a:solidFill>
                        <a:schemeClr val="bg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54" name="Овал 253"/>
                    <p:cNvSpPr/>
                    <p:nvPr/>
                  </p:nvSpPr>
                  <p:spPr>
                    <a:xfrm rot="2306988">
                      <a:off x="3462199" y="2349152"/>
                      <a:ext cx="664664" cy="736731"/>
                    </a:xfrm>
                    <a:prstGeom prst="ellipse">
                      <a:avLst/>
                    </a:prstGeom>
                    <a:noFill/>
                    <a:ln>
                      <a:solidFill>
                        <a:schemeClr val="bg1"/>
                      </a:solidFill>
                      <a:prstDash val="sysDash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ru-RU"/>
                    </a:p>
                  </p:txBody>
                </p:sp>
                <p:sp>
                  <p:nvSpPr>
                    <p:cNvPr id="255" name="Овал 254"/>
                    <p:cNvSpPr/>
                    <p:nvPr/>
                  </p:nvSpPr>
                  <p:spPr>
                    <a:xfrm rot="2306988">
                      <a:off x="1567969" y="2360087"/>
                      <a:ext cx="664664" cy="736731"/>
                    </a:xfrm>
                    <a:prstGeom prst="ellipse">
                      <a:avLst/>
                    </a:prstGeom>
                    <a:noFill/>
                    <a:ln>
                      <a:solidFill>
                        <a:schemeClr val="bg1"/>
                      </a:solidFill>
                      <a:prstDash val="sysDash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ru-RU"/>
                    </a:p>
                  </p:txBody>
                </p:sp>
                <p:sp>
                  <p:nvSpPr>
                    <p:cNvPr id="256" name="Овал 255"/>
                    <p:cNvSpPr/>
                    <p:nvPr/>
                  </p:nvSpPr>
                  <p:spPr>
                    <a:xfrm rot="2306988">
                      <a:off x="2472433" y="2360087"/>
                      <a:ext cx="664664" cy="736731"/>
                    </a:xfrm>
                    <a:prstGeom prst="ellipse">
                      <a:avLst/>
                    </a:prstGeom>
                    <a:noFill/>
                    <a:ln>
                      <a:solidFill>
                        <a:schemeClr val="bg1"/>
                      </a:solidFill>
                      <a:prstDash val="sysDash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ru-RU"/>
                    </a:p>
                  </p:txBody>
                </p:sp>
              </p:grpSp>
              <p:sp>
                <p:nvSpPr>
                  <p:cNvPr id="246" name="TextBox 245"/>
                  <p:cNvSpPr txBox="1"/>
                  <p:nvPr/>
                </p:nvSpPr>
                <p:spPr>
                  <a:xfrm>
                    <a:off x="2357210" y="1959945"/>
                    <a:ext cx="988865" cy="31515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solidFill>
                          <a:srgbClr val="FF0000"/>
                        </a:solidFill>
                      </a:rPr>
                      <a:t>Hsp42-RFP</a:t>
                    </a:r>
                    <a:endParaRPr lang="ru-RU" sz="1200" b="1" dirty="0">
                      <a:solidFill>
                        <a:srgbClr val="FF0000"/>
                      </a:solidFill>
                    </a:endParaRPr>
                  </a:p>
                </p:txBody>
              </p:sp>
              <p:cxnSp>
                <p:nvCxnSpPr>
                  <p:cNvPr id="247" name="Прямая соединительная линия 246"/>
                  <p:cNvCxnSpPr/>
                  <p:nvPr/>
                </p:nvCxnSpPr>
                <p:spPr>
                  <a:xfrm>
                    <a:off x="1479995" y="2296710"/>
                    <a:ext cx="158399" cy="0"/>
                  </a:xfrm>
                  <a:prstGeom prst="line">
                    <a:avLst/>
                  </a:prstGeom>
                  <a:ln w="1905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48" name="Прямоугольник 247"/>
                  <p:cNvSpPr/>
                  <p:nvPr/>
                </p:nvSpPr>
                <p:spPr>
                  <a:xfrm>
                    <a:off x="1325770" y="2000721"/>
                    <a:ext cx="3068915" cy="1222872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ru-RU"/>
                  </a:p>
                </p:txBody>
              </p:sp>
            </p:grpSp>
            <p:sp>
              <p:nvSpPr>
                <p:cNvPr id="241" name="Прямоугольник 240"/>
                <p:cNvSpPr/>
                <p:nvPr/>
              </p:nvSpPr>
              <p:spPr>
                <a:xfrm>
                  <a:off x="4923761" y="1515586"/>
                  <a:ext cx="2531336" cy="31642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242" name="Прямоугольник 241"/>
                <p:cNvSpPr/>
                <p:nvPr/>
              </p:nvSpPr>
              <p:spPr>
                <a:xfrm>
                  <a:off x="4917064" y="2372866"/>
                  <a:ext cx="2531336" cy="31642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243" name="TextBox 242"/>
                <p:cNvSpPr txBox="1"/>
                <p:nvPr/>
              </p:nvSpPr>
              <p:spPr>
                <a:xfrm flipH="1">
                  <a:off x="6730861" y="1311629"/>
                  <a:ext cx="65209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srgbClr val="FFC000"/>
                      </a:solidFill>
                    </a:rPr>
                    <a:t>M</a:t>
                  </a:r>
                  <a:r>
                    <a:rPr lang="en-US" sz="1200" b="1" dirty="0" smtClean="0">
                      <a:solidFill>
                        <a:srgbClr val="FFC000"/>
                      </a:solidFill>
                    </a:rPr>
                    <a:t>erge</a:t>
                  </a:r>
                  <a:endParaRPr lang="ru-RU" sz="1200" b="1" dirty="0">
                    <a:solidFill>
                      <a:srgbClr val="FFC000"/>
                    </a:solidFill>
                  </a:endParaRPr>
                </a:p>
              </p:txBody>
            </p:sp>
            <p:sp>
              <p:nvSpPr>
                <p:cNvPr id="244" name="TextBox 243"/>
                <p:cNvSpPr txBox="1"/>
                <p:nvPr/>
              </p:nvSpPr>
              <p:spPr>
                <a:xfrm flipH="1">
                  <a:off x="4995512" y="1312320"/>
                  <a:ext cx="82415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 smtClean="0">
                      <a:solidFill>
                        <a:srgbClr val="00B050"/>
                      </a:solidFill>
                    </a:rPr>
                    <a:t>GFP-Rnq1</a:t>
                  </a:r>
                  <a:endParaRPr lang="ru-RU" sz="1200" b="1" dirty="0">
                    <a:solidFill>
                      <a:srgbClr val="00B050"/>
                    </a:solidFill>
                  </a:endParaRPr>
                </a:p>
              </p:txBody>
            </p:sp>
          </p:grpSp>
        </p:grpSp>
      </p:grpSp>
      <p:grpSp>
        <p:nvGrpSpPr>
          <p:cNvPr id="7" name="Группа 6"/>
          <p:cNvGrpSpPr/>
          <p:nvPr/>
        </p:nvGrpSpPr>
        <p:grpSpPr>
          <a:xfrm>
            <a:off x="5377979" y="11463429"/>
            <a:ext cx="2382393" cy="2164556"/>
            <a:chOff x="7371023" y="6036944"/>
            <a:chExt cx="2382393" cy="2164556"/>
          </a:xfrm>
        </p:grpSpPr>
        <p:grpSp>
          <p:nvGrpSpPr>
            <p:cNvPr id="216" name="Группа 215"/>
            <p:cNvGrpSpPr/>
            <p:nvPr/>
          </p:nvGrpSpPr>
          <p:grpSpPr>
            <a:xfrm>
              <a:off x="7611891" y="6133433"/>
              <a:ext cx="2141525" cy="2068067"/>
              <a:chOff x="3992955" y="1015195"/>
              <a:chExt cx="2141525" cy="2068067"/>
            </a:xfrm>
          </p:grpSpPr>
          <p:grpSp>
            <p:nvGrpSpPr>
              <p:cNvPr id="217" name="Группа 216"/>
              <p:cNvGrpSpPr/>
              <p:nvPr/>
            </p:nvGrpSpPr>
            <p:grpSpPr>
              <a:xfrm>
                <a:off x="3992955" y="1015195"/>
                <a:ext cx="2141525" cy="2068067"/>
                <a:chOff x="3992955" y="1015195"/>
                <a:chExt cx="2141525" cy="2068067"/>
              </a:xfrm>
            </p:grpSpPr>
            <p:grpSp>
              <p:nvGrpSpPr>
                <p:cNvPr id="221" name="Группа 220"/>
                <p:cNvGrpSpPr/>
                <p:nvPr/>
              </p:nvGrpSpPr>
              <p:grpSpPr>
                <a:xfrm>
                  <a:off x="4284746" y="1227308"/>
                  <a:ext cx="1823321" cy="1855954"/>
                  <a:chOff x="1283128" y="531569"/>
                  <a:chExt cx="1823321" cy="1855954"/>
                </a:xfrm>
              </p:grpSpPr>
              <p:pic>
                <p:nvPicPr>
                  <p:cNvPr id="230" name="Рисунок 229"/>
                  <p:cNvPicPr>
                    <a:picLocks noChangeAspect="1"/>
                  </p:cNvPicPr>
                  <p:nvPr/>
                </p:nvPicPr>
                <p:blipFill>
                  <a:blip r:embed="rId48"/>
                  <a:stretch>
                    <a:fillRect/>
                  </a:stretch>
                </p:blipFill>
                <p:spPr>
                  <a:xfrm>
                    <a:off x="1306449" y="549021"/>
                    <a:ext cx="900000" cy="919252"/>
                  </a:xfrm>
                  <a:prstGeom prst="rect">
                    <a:avLst/>
                  </a:prstGeom>
                </p:spPr>
              </p:pic>
              <p:pic>
                <p:nvPicPr>
                  <p:cNvPr id="231" name="Рисунок 230"/>
                  <p:cNvPicPr>
                    <a:picLocks noChangeAspect="1"/>
                  </p:cNvPicPr>
                  <p:nvPr/>
                </p:nvPicPr>
                <p:blipFill>
                  <a:blip r:embed="rId49"/>
                  <a:stretch>
                    <a:fillRect/>
                  </a:stretch>
                </p:blipFill>
                <p:spPr>
                  <a:xfrm>
                    <a:off x="2206449" y="549021"/>
                    <a:ext cx="900000" cy="919251"/>
                  </a:xfrm>
                  <a:prstGeom prst="rect">
                    <a:avLst/>
                  </a:prstGeom>
                </p:spPr>
              </p:pic>
              <p:pic>
                <p:nvPicPr>
                  <p:cNvPr id="233" name="Рисунок 232"/>
                  <p:cNvPicPr>
                    <a:picLocks noChangeAspect="1"/>
                  </p:cNvPicPr>
                  <p:nvPr/>
                </p:nvPicPr>
                <p:blipFill>
                  <a:blip r:embed="rId50"/>
                  <a:stretch>
                    <a:fillRect/>
                  </a:stretch>
                </p:blipFill>
                <p:spPr>
                  <a:xfrm>
                    <a:off x="1306449" y="1468272"/>
                    <a:ext cx="900000" cy="919251"/>
                  </a:xfrm>
                  <a:prstGeom prst="rect">
                    <a:avLst/>
                  </a:prstGeom>
                </p:spPr>
              </p:pic>
              <p:cxnSp>
                <p:nvCxnSpPr>
                  <p:cNvPr id="234" name="Прямая соединительная линия 233"/>
                  <p:cNvCxnSpPr/>
                  <p:nvPr/>
                </p:nvCxnSpPr>
                <p:spPr>
                  <a:xfrm>
                    <a:off x="3106449" y="531569"/>
                    <a:ext cx="0" cy="946642"/>
                  </a:xfrm>
                  <a:prstGeom prst="line">
                    <a:avLst/>
                  </a:prstGeom>
                  <a:ln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5" name="Прямая соединительная линия 234"/>
                  <p:cNvCxnSpPr/>
                  <p:nvPr/>
                </p:nvCxnSpPr>
                <p:spPr>
                  <a:xfrm>
                    <a:off x="2205302" y="534884"/>
                    <a:ext cx="0" cy="946642"/>
                  </a:xfrm>
                  <a:prstGeom prst="line">
                    <a:avLst/>
                  </a:prstGeom>
                  <a:ln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6" name="Прямая соединительная линия 235"/>
                  <p:cNvCxnSpPr/>
                  <p:nvPr/>
                </p:nvCxnSpPr>
                <p:spPr>
                  <a:xfrm rot="5400000">
                    <a:off x="1756449" y="994951"/>
                    <a:ext cx="0" cy="946642"/>
                  </a:xfrm>
                  <a:prstGeom prst="line">
                    <a:avLst/>
                  </a:prstGeom>
                  <a:ln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22" name="Овал 221"/>
                <p:cNvSpPr/>
                <p:nvPr/>
              </p:nvSpPr>
              <p:spPr>
                <a:xfrm rot="17097825">
                  <a:off x="4565446" y="1434512"/>
                  <a:ext cx="406270" cy="532234"/>
                </a:xfrm>
                <a:prstGeom prst="ellipse">
                  <a:avLst/>
                </a:prstGeom>
                <a:noFill/>
                <a:ln>
                  <a:solidFill>
                    <a:schemeClr val="bg1"/>
                  </a:solidFill>
                  <a:prstDash val="sys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223" name="Овал 222"/>
                <p:cNvSpPr/>
                <p:nvPr/>
              </p:nvSpPr>
              <p:spPr>
                <a:xfrm rot="17097825">
                  <a:off x="5483162" y="1437827"/>
                  <a:ext cx="406270" cy="532234"/>
                </a:xfrm>
                <a:prstGeom prst="ellipse">
                  <a:avLst/>
                </a:prstGeom>
                <a:noFill/>
                <a:ln>
                  <a:solidFill>
                    <a:schemeClr val="bg1"/>
                  </a:solidFill>
                  <a:prstDash val="sys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225" name="Овал 224"/>
                <p:cNvSpPr/>
                <p:nvPr/>
              </p:nvSpPr>
              <p:spPr>
                <a:xfrm rot="17097825">
                  <a:off x="4558822" y="2372107"/>
                  <a:ext cx="406270" cy="532234"/>
                </a:xfrm>
                <a:prstGeom prst="ellipse">
                  <a:avLst/>
                </a:prstGeom>
                <a:noFill/>
                <a:ln>
                  <a:solidFill>
                    <a:schemeClr val="bg1"/>
                  </a:solidFill>
                  <a:prstDash val="sys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cxnSp>
              <p:nvCxnSpPr>
                <p:cNvPr id="226" name="Прямая соединительная линия 225"/>
                <p:cNvCxnSpPr/>
                <p:nvPr/>
              </p:nvCxnSpPr>
              <p:spPr>
                <a:xfrm>
                  <a:off x="5051246" y="3028418"/>
                  <a:ext cx="936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7" name="TextBox 226"/>
                <p:cNvSpPr txBox="1"/>
                <p:nvPr/>
              </p:nvSpPr>
              <p:spPr>
                <a:xfrm>
                  <a:off x="4321163" y="1015195"/>
                  <a:ext cx="181331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 smtClean="0">
                      <a:solidFill>
                        <a:srgbClr val="00B050"/>
                      </a:solidFill>
                    </a:rPr>
                    <a:t>Ure2PD-GFP </a:t>
                  </a:r>
                  <a:r>
                    <a:rPr lang="en-US" sz="1100" b="1" dirty="0" smtClean="0"/>
                    <a:t>      </a:t>
                  </a:r>
                  <a:r>
                    <a:rPr lang="en-US" sz="1100" b="1" dirty="0" err="1" smtClean="0">
                      <a:solidFill>
                        <a:srgbClr val="FF0000"/>
                      </a:solidFill>
                    </a:rPr>
                    <a:t>Proteostat</a:t>
                  </a:r>
                  <a:endParaRPr lang="ru-RU" sz="1100" b="1" dirty="0">
                    <a:solidFill>
                      <a:srgbClr val="FF0000"/>
                    </a:solidFill>
                  </a:endParaRPr>
                </a:p>
              </p:txBody>
            </p:sp>
            <p:cxnSp>
              <p:nvCxnSpPr>
                <p:cNvPr id="228" name="Прямая со стрелкой 227"/>
                <p:cNvCxnSpPr/>
                <p:nvPr/>
              </p:nvCxnSpPr>
              <p:spPr>
                <a:xfrm>
                  <a:off x="4234069" y="1304869"/>
                  <a:ext cx="0" cy="172800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9" name="TextBox 228"/>
                <p:cNvSpPr txBox="1"/>
                <p:nvPr/>
              </p:nvSpPr>
              <p:spPr>
                <a:xfrm rot="16200000">
                  <a:off x="3587171" y="2025511"/>
                  <a:ext cx="108856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/>
                    <a:t>+ HXD, 30 min</a:t>
                  </a:r>
                  <a:endParaRPr lang="ru-RU" sz="1200" b="1" dirty="0"/>
                </a:p>
              </p:txBody>
            </p:sp>
          </p:grpSp>
          <p:cxnSp>
            <p:nvCxnSpPr>
              <p:cNvPr id="218" name="Прямая соединительная линия 217"/>
              <p:cNvCxnSpPr/>
              <p:nvPr/>
            </p:nvCxnSpPr>
            <p:spPr>
              <a:xfrm>
                <a:off x="6117211" y="1227308"/>
                <a:ext cx="0" cy="1027950"/>
              </a:xfrm>
              <a:prstGeom prst="line">
                <a:avLst/>
              </a:prstGeom>
              <a:ln w="254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9" name="Прямая соединительная линия 218"/>
              <p:cNvCxnSpPr/>
              <p:nvPr/>
            </p:nvCxnSpPr>
            <p:spPr>
              <a:xfrm>
                <a:off x="5216859" y="1186654"/>
                <a:ext cx="0" cy="1027950"/>
              </a:xfrm>
              <a:prstGeom prst="line">
                <a:avLst/>
              </a:prstGeom>
              <a:ln w="254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0" name="Прямая соединительная линия 219"/>
              <p:cNvCxnSpPr/>
              <p:nvPr/>
            </p:nvCxnSpPr>
            <p:spPr>
              <a:xfrm rot="5400000">
                <a:off x="4712859" y="1669950"/>
                <a:ext cx="0" cy="1008000"/>
              </a:xfrm>
              <a:prstGeom prst="line">
                <a:avLst/>
              </a:prstGeom>
              <a:ln w="254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72" name="TextBox 271"/>
            <p:cNvSpPr txBox="1"/>
            <p:nvPr/>
          </p:nvSpPr>
          <p:spPr>
            <a:xfrm>
              <a:off x="7371023" y="6036944"/>
              <a:ext cx="3321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H</a:t>
              </a:r>
              <a:endParaRPr lang="ru-RU" b="1" dirty="0"/>
            </a:p>
          </p:txBody>
        </p:sp>
      </p:grpSp>
      <p:grpSp>
        <p:nvGrpSpPr>
          <p:cNvPr id="4" name="Группа 3"/>
          <p:cNvGrpSpPr/>
          <p:nvPr/>
        </p:nvGrpSpPr>
        <p:grpSpPr>
          <a:xfrm>
            <a:off x="8219660" y="11463332"/>
            <a:ext cx="1831037" cy="3233090"/>
            <a:chOff x="9076177" y="10343201"/>
            <a:chExt cx="1831037" cy="3233090"/>
          </a:xfrm>
        </p:grpSpPr>
        <p:sp>
          <p:nvSpPr>
            <p:cNvPr id="594" name="TextBox 593"/>
            <p:cNvSpPr txBox="1"/>
            <p:nvPr/>
          </p:nvSpPr>
          <p:spPr>
            <a:xfrm>
              <a:off x="9076177" y="10343201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J</a:t>
              </a:r>
              <a:endParaRPr lang="ru-RU" b="1" dirty="0"/>
            </a:p>
          </p:txBody>
        </p:sp>
        <p:grpSp>
          <p:nvGrpSpPr>
            <p:cNvPr id="273" name="Группа 272"/>
            <p:cNvGrpSpPr/>
            <p:nvPr/>
          </p:nvGrpSpPr>
          <p:grpSpPr>
            <a:xfrm>
              <a:off x="9299212" y="10429785"/>
              <a:ext cx="1608002" cy="3146506"/>
              <a:chOff x="4584633" y="570798"/>
              <a:chExt cx="1608002" cy="3146506"/>
            </a:xfrm>
          </p:grpSpPr>
          <p:sp>
            <p:nvSpPr>
              <p:cNvPr id="274" name="TextBox 273"/>
              <p:cNvSpPr txBox="1"/>
              <p:nvPr/>
            </p:nvSpPr>
            <p:spPr>
              <a:xfrm rot="16200000">
                <a:off x="4230380" y="1470289"/>
                <a:ext cx="979135" cy="27063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vert="horz" wrap="none" lIns="97959" tIns="48980" rIns="97959" bIns="48980" anchorCtr="0" compatLnSpc="1">
                <a:spAutoFit/>
              </a:bodyPr>
              <a:lstStyle/>
              <a:p>
                <a:pPr hangingPunct="0">
                  <a:lnSpc>
                    <a:spcPct val="93000"/>
                  </a:lnSpc>
                  <a:tabLst>
                    <a:tab pos="0" algn="l"/>
                    <a:tab pos="488603" algn="l"/>
                    <a:tab pos="977600" algn="l"/>
                    <a:tab pos="1466597" algn="l"/>
                    <a:tab pos="1955594" algn="l"/>
                    <a:tab pos="2444590" algn="l"/>
                    <a:tab pos="2933586" algn="l"/>
                    <a:tab pos="3422583" algn="l"/>
                    <a:tab pos="3911579" algn="l"/>
                    <a:tab pos="4400574" algn="l"/>
                    <a:tab pos="4889572" algn="l"/>
                    <a:tab pos="5378567" algn="l"/>
                    <a:tab pos="5867564" algn="l"/>
                    <a:tab pos="6356561" algn="l"/>
                    <a:tab pos="6845557" algn="l"/>
                    <a:tab pos="7334553" algn="l"/>
                    <a:tab pos="7823550" algn="l"/>
                    <a:tab pos="8312546" algn="l"/>
                    <a:tab pos="8801541" algn="l"/>
                    <a:tab pos="9290539" algn="l"/>
                    <a:tab pos="9779535" algn="l"/>
                  </a:tabLst>
                </a:pPr>
                <a:r>
                  <a:rPr lang="ru-RU" sz="1200" b="1" dirty="0" err="1">
                    <a:solidFill>
                      <a:srgbClr val="000000"/>
                    </a:solidFill>
                    <a:ea typeface="Microsoft YaHei" pitchFamily="2"/>
                    <a:cs typeface="Microsoft YaHei" pitchFamily="2"/>
                  </a:rPr>
                  <a:t>unsonicated</a:t>
                </a:r>
                <a:endParaRPr lang="ru-RU" sz="1200" b="1" dirty="0">
                  <a:solidFill>
                    <a:srgbClr val="000000"/>
                  </a:solidFill>
                  <a:ea typeface="Microsoft YaHei" pitchFamily="2"/>
                  <a:cs typeface="Microsoft YaHei" pitchFamily="2"/>
                </a:endParaRPr>
              </a:p>
            </p:txBody>
          </p:sp>
          <p:sp>
            <p:nvSpPr>
              <p:cNvPr id="275" name="TextBox 274"/>
              <p:cNvSpPr txBox="1"/>
              <p:nvPr/>
            </p:nvSpPr>
            <p:spPr>
              <a:xfrm rot="16200000">
                <a:off x="4313736" y="2686901"/>
                <a:ext cx="812423" cy="27063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vert="horz" wrap="none" lIns="97959" tIns="48980" rIns="97959" bIns="48980" anchorCtr="0" compatLnSpc="1">
                <a:spAutoFit/>
              </a:bodyPr>
              <a:lstStyle/>
              <a:p>
                <a:pPr hangingPunct="0">
                  <a:lnSpc>
                    <a:spcPct val="93000"/>
                  </a:lnSpc>
                  <a:tabLst>
                    <a:tab pos="0" algn="l"/>
                    <a:tab pos="488603" algn="l"/>
                    <a:tab pos="977600" algn="l"/>
                    <a:tab pos="1466597" algn="l"/>
                    <a:tab pos="1955594" algn="l"/>
                    <a:tab pos="2444590" algn="l"/>
                    <a:tab pos="2933586" algn="l"/>
                    <a:tab pos="3422583" algn="l"/>
                    <a:tab pos="3911579" algn="l"/>
                    <a:tab pos="4400574" algn="l"/>
                    <a:tab pos="4889572" algn="l"/>
                    <a:tab pos="5378567" algn="l"/>
                    <a:tab pos="5867564" algn="l"/>
                    <a:tab pos="6356561" algn="l"/>
                    <a:tab pos="6845557" algn="l"/>
                    <a:tab pos="7334553" algn="l"/>
                    <a:tab pos="7823550" algn="l"/>
                    <a:tab pos="8312546" algn="l"/>
                    <a:tab pos="8801541" algn="l"/>
                    <a:tab pos="9290539" algn="l"/>
                    <a:tab pos="9779535" algn="l"/>
                  </a:tabLst>
                </a:pPr>
                <a:r>
                  <a:rPr lang="ru-RU" sz="1200" b="1" dirty="0" err="1">
                    <a:solidFill>
                      <a:srgbClr val="000000"/>
                    </a:solidFill>
                    <a:ea typeface="Microsoft YaHei" pitchFamily="2"/>
                    <a:cs typeface="Microsoft YaHei" pitchFamily="2"/>
                  </a:rPr>
                  <a:t>sonicated</a:t>
                </a:r>
                <a:endParaRPr lang="ru-RU" sz="1200" b="1" dirty="0">
                  <a:solidFill>
                    <a:srgbClr val="000000"/>
                  </a:solidFill>
                  <a:ea typeface="Microsoft YaHei" pitchFamily="2"/>
                  <a:cs typeface="Microsoft YaHei" pitchFamily="2"/>
                </a:endParaRPr>
              </a:p>
            </p:txBody>
          </p:sp>
          <p:sp>
            <p:nvSpPr>
              <p:cNvPr id="276" name="TextBox 275"/>
              <p:cNvSpPr txBox="1"/>
              <p:nvPr/>
            </p:nvSpPr>
            <p:spPr>
              <a:xfrm>
                <a:off x="5218950" y="3475271"/>
                <a:ext cx="973685" cy="24203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vert="horz" wrap="none" lIns="97959" tIns="48980" rIns="97959" bIns="48980" anchorCtr="0" compatLnSpc="1">
                <a:spAutoFit/>
              </a:bodyPr>
              <a:lstStyle/>
              <a:p>
                <a:pPr hangingPunct="0">
                  <a:lnSpc>
                    <a:spcPct val="93000"/>
                  </a:lnSpc>
                  <a:tabLst>
                    <a:tab pos="0" algn="l"/>
                    <a:tab pos="488603" algn="l"/>
                    <a:tab pos="977600" algn="l"/>
                    <a:tab pos="1466597" algn="l"/>
                    <a:tab pos="1955594" algn="l"/>
                    <a:tab pos="2444590" algn="l"/>
                    <a:tab pos="2933586" algn="l"/>
                    <a:tab pos="3422583" algn="l"/>
                    <a:tab pos="3911579" algn="l"/>
                    <a:tab pos="4400574" algn="l"/>
                    <a:tab pos="4889572" algn="l"/>
                    <a:tab pos="5378567" algn="l"/>
                    <a:tab pos="5867564" algn="l"/>
                    <a:tab pos="6356561" algn="l"/>
                    <a:tab pos="6845557" algn="l"/>
                    <a:tab pos="7334553" algn="l"/>
                    <a:tab pos="7823550" algn="l"/>
                    <a:tab pos="8312546" algn="l"/>
                    <a:tab pos="8801541" algn="l"/>
                    <a:tab pos="9290539" algn="l"/>
                    <a:tab pos="9779535" algn="l"/>
                  </a:tabLst>
                </a:pPr>
                <a:r>
                  <a:rPr lang="ru-RU" sz="1000" b="1" dirty="0">
                    <a:solidFill>
                      <a:srgbClr val="000000"/>
                    </a:solidFill>
                    <a:ea typeface="Microsoft YaHei" pitchFamily="2"/>
                    <a:cs typeface="Microsoft YaHei" pitchFamily="2"/>
                  </a:rPr>
                  <a:t>WB: anti-Rnq1</a:t>
                </a:r>
              </a:p>
            </p:txBody>
          </p:sp>
          <p:sp>
            <p:nvSpPr>
              <p:cNvPr id="277" name="TextBox 276"/>
              <p:cNvSpPr txBox="1"/>
              <p:nvPr/>
            </p:nvSpPr>
            <p:spPr>
              <a:xfrm>
                <a:off x="5183845" y="570798"/>
                <a:ext cx="615978" cy="30082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vert="horz" wrap="none" lIns="97959" tIns="48980" rIns="97959" bIns="48980" anchorCtr="0" compatLnSpc="1">
                <a:spAutoFit/>
              </a:bodyPr>
              <a:lstStyle/>
              <a:p>
                <a:pPr hangingPunct="0">
                  <a:lnSpc>
                    <a:spcPct val="93000"/>
                  </a:lnSpc>
                  <a:tabLst>
                    <a:tab pos="0" algn="l"/>
                    <a:tab pos="488603" algn="l"/>
                    <a:tab pos="977600" algn="l"/>
                    <a:tab pos="1466597" algn="l"/>
                    <a:tab pos="1955594" algn="l"/>
                    <a:tab pos="2444590" algn="l"/>
                    <a:tab pos="2933586" algn="l"/>
                    <a:tab pos="3422583" algn="l"/>
                    <a:tab pos="3911579" algn="l"/>
                    <a:tab pos="4400574" algn="l"/>
                    <a:tab pos="4889572" algn="l"/>
                    <a:tab pos="5378567" algn="l"/>
                    <a:tab pos="5867564" algn="l"/>
                    <a:tab pos="6356561" algn="l"/>
                    <a:tab pos="6845557" algn="l"/>
                    <a:tab pos="7334553" algn="l"/>
                    <a:tab pos="7823550" algn="l"/>
                    <a:tab pos="8312546" algn="l"/>
                    <a:tab pos="8801541" algn="l"/>
                    <a:tab pos="9290539" algn="l"/>
                    <a:tab pos="9779535" algn="l"/>
                  </a:tabLst>
                </a:pPr>
                <a:r>
                  <a:rPr lang="ru-RU" sz="1200" b="1" dirty="0" err="1">
                    <a:solidFill>
                      <a:srgbClr val="000000"/>
                    </a:solidFill>
                    <a:latin typeface="Arial" pitchFamily="18"/>
                    <a:ea typeface="Microsoft YaHei" pitchFamily="2"/>
                    <a:cs typeface="Microsoft YaHei" pitchFamily="2"/>
                  </a:rPr>
                  <a:t>Time</a:t>
                </a:r>
                <a:endParaRPr lang="ru-RU" sz="1200" b="1" dirty="0">
                  <a:solidFill>
                    <a:srgbClr val="000000"/>
                  </a:solidFill>
                  <a:latin typeface="Arial" pitchFamily="18"/>
                  <a:ea typeface="Microsoft YaHei" pitchFamily="2"/>
                  <a:cs typeface="Microsoft YaHei" pitchFamily="2"/>
                </a:endParaRPr>
              </a:p>
            </p:txBody>
          </p:sp>
          <p:pic>
            <p:nvPicPr>
              <p:cNvPr id="278" name="Рисунок 277">
                <a:extLst>
                  <a:ext uri="{FF2B5EF4-FFF2-40B4-BE49-F238E27FC236}">
                    <a16:creationId xmlns:a16="http://schemas.microsoft.com/office/drawing/2014/main" id="{00000000-0000-0000-0000-00000000000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1">
                <a:lum/>
                <a:alphaModFix/>
              </a:blip>
              <a:srcRect/>
              <a:stretch>
                <a:fillRect/>
              </a:stretch>
            </p:blipFill>
            <p:spPr>
              <a:xfrm>
                <a:off x="4869595" y="1007788"/>
                <a:ext cx="1261891" cy="1191997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79" name="Рисунок 278">
                <a:extLst>
                  <a:ext uri="{FF2B5EF4-FFF2-40B4-BE49-F238E27FC236}">
                    <a16:creationId xmlns:a16="http://schemas.microsoft.com/office/drawing/2014/main" id="{00000000-0000-0000-0000-00000000000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2">
                <a:lum contrast="7000"/>
                <a:alphaModFix/>
              </a:blip>
              <a:srcRect/>
              <a:stretch>
                <a:fillRect/>
              </a:stretch>
            </p:blipFill>
            <p:spPr>
              <a:xfrm>
                <a:off x="4860076" y="2229429"/>
                <a:ext cx="1271410" cy="1221369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280" name="Полилиния 279"/>
              <p:cNvSpPr/>
              <p:nvPr/>
            </p:nvSpPr>
            <p:spPr>
              <a:xfrm>
                <a:off x="4852732" y="792807"/>
                <a:ext cx="1278208" cy="207367"/>
              </a:xfrm>
              <a:custGeom>
                <a:avLst>
                  <a:gd name="f0" fmla="val 108"/>
                </a:avLst>
                <a:gdLst>
                  <a:gd name="f1" fmla="val 10800000"/>
                  <a:gd name="f2" fmla="val 5400000"/>
                  <a:gd name="f3" fmla="val 16200000"/>
                  <a:gd name="f4" fmla="val w"/>
                  <a:gd name="f5" fmla="val h"/>
                  <a:gd name="f6" fmla="val ss"/>
                  <a:gd name="f7" fmla="val 0"/>
                  <a:gd name="f8" fmla="*/ 5419351 1 1725033"/>
                  <a:gd name="f9" fmla="val 45"/>
                  <a:gd name="f10" fmla="val 10800"/>
                  <a:gd name="f11" fmla="val -2147483647"/>
                  <a:gd name="f12" fmla="val 2147483647"/>
                  <a:gd name="f13" fmla="abs f4"/>
                  <a:gd name="f14" fmla="abs f5"/>
                  <a:gd name="f15" fmla="abs f6"/>
                  <a:gd name="f16" fmla="*/ f8 1 180"/>
                  <a:gd name="f17" fmla="pin 0 f0 10800"/>
                  <a:gd name="f18" fmla="+- 0 0 f2"/>
                  <a:gd name="f19" fmla="?: f13 f4 1"/>
                  <a:gd name="f20" fmla="?: f14 f5 1"/>
                  <a:gd name="f21" fmla="?: f15 f6 1"/>
                  <a:gd name="f22" fmla="*/ f9 f16 1"/>
                  <a:gd name="f23" fmla="+- f7 f17 0"/>
                  <a:gd name="f24" fmla="*/ f19 1 21600"/>
                  <a:gd name="f25" fmla="*/ f20 1 21600"/>
                  <a:gd name="f26" fmla="*/ 21600 f19 1"/>
                  <a:gd name="f27" fmla="*/ 21600 f20 1"/>
                  <a:gd name="f28" fmla="+- 0 0 f22"/>
                  <a:gd name="f29" fmla="min f25 f24"/>
                  <a:gd name="f30" fmla="*/ f26 1 f21"/>
                  <a:gd name="f31" fmla="*/ f27 1 f21"/>
                  <a:gd name="f32" fmla="*/ f28 f1 1"/>
                  <a:gd name="f33" fmla="*/ f32 1 f8"/>
                  <a:gd name="f34" fmla="+- f31 0 f17"/>
                  <a:gd name="f35" fmla="+- f30 0 f17"/>
                  <a:gd name="f36" fmla="*/ f17 f29 1"/>
                  <a:gd name="f37" fmla="*/ f7 f29 1"/>
                  <a:gd name="f38" fmla="*/ f23 f29 1"/>
                  <a:gd name="f39" fmla="*/ f31 f29 1"/>
                  <a:gd name="f40" fmla="*/ f30 f29 1"/>
                  <a:gd name="f41" fmla="+- f33 0 f2"/>
                  <a:gd name="f42" fmla="+- f37 0 f38"/>
                  <a:gd name="f43" fmla="+- f38 0 f37"/>
                  <a:gd name="f44" fmla="*/ f34 f29 1"/>
                  <a:gd name="f45" fmla="*/ f35 f29 1"/>
                  <a:gd name="f46" fmla="cos 1 f41"/>
                  <a:gd name="f47" fmla="abs f42"/>
                  <a:gd name="f48" fmla="abs f43"/>
                  <a:gd name="f49" fmla="?: f42 f18 f2"/>
                  <a:gd name="f50" fmla="?: f42 f2 f18"/>
                  <a:gd name="f51" fmla="?: f42 f3 f2"/>
                  <a:gd name="f52" fmla="?: f42 f2 f3"/>
                  <a:gd name="f53" fmla="+- f39 0 f44"/>
                  <a:gd name="f54" fmla="?: f43 f18 f2"/>
                  <a:gd name="f55" fmla="?: f43 f2 f18"/>
                  <a:gd name="f56" fmla="+- f40 0 f45"/>
                  <a:gd name="f57" fmla="+- f44 0 f39"/>
                  <a:gd name="f58" fmla="+- f45 0 f40"/>
                  <a:gd name="f59" fmla="?: f42 0 f1"/>
                  <a:gd name="f60" fmla="?: f42 f1 0"/>
                  <a:gd name="f61" fmla="+- 0 0 f46"/>
                  <a:gd name="f62" fmla="?: f42 f52 f51"/>
                  <a:gd name="f63" fmla="?: f42 f51 f52"/>
                  <a:gd name="f64" fmla="?: f43 f50 f49"/>
                  <a:gd name="f65" fmla="abs f53"/>
                  <a:gd name="f66" fmla="?: f53 0 f1"/>
                  <a:gd name="f67" fmla="?: f53 f1 0"/>
                  <a:gd name="f68" fmla="?: f53 f54 f55"/>
                  <a:gd name="f69" fmla="abs f56"/>
                  <a:gd name="f70" fmla="abs f57"/>
                  <a:gd name="f71" fmla="?: f56 f18 f2"/>
                  <a:gd name="f72" fmla="?: f56 f2 f18"/>
                  <a:gd name="f73" fmla="?: f56 f3 f2"/>
                  <a:gd name="f74" fmla="?: f56 f2 f3"/>
                  <a:gd name="f75" fmla="abs f58"/>
                  <a:gd name="f76" fmla="?: f58 f18 f2"/>
                  <a:gd name="f77" fmla="?: f58 f2 f18"/>
                  <a:gd name="f78" fmla="?: f58 f60 f59"/>
                  <a:gd name="f79" fmla="?: f58 f59 f60"/>
                  <a:gd name="f80" fmla="*/ f17 f61 1"/>
                  <a:gd name="f81" fmla="?: f43 f63 f62"/>
                  <a:gd name="f82" fmla="?: f43 f67 f66"/>
                  <a:gd name="f83" fmla="?: f43 f66 f67"/>
                  <a:gd name="f84" fmla="?: f56 f74 f73"/>
                  <a:gd name="f85" fmla="?: f56 f73 f74"/>
                  <a:gd name="f86" fmla="?: f57 f72 f71"/>
                  <a:gd name="f87" fmla="?: f42 f78 f79"/>
                  <a:gd name="f88" fmla="?: f42 f76 f77"/>
                  <a:gd name="f89" fmla="*/ f80 3163 1"/>
                  <a:gd name="f90" fmla="?: f53 f82 f83"/>
                  <a:gd name="f91" fmla="?: f57 f85 f84"/>
                  <a:gd name="f92" fmla="*/ f89 1 7636"/>
                  <a:gd name="f93" fmla="+- f7 f92 0"/>
                  <a:gd name="f94" fmla="+- f30 0 f92"/>
                  <a:gd name="f95" fmla="+- f31 0 f92"/>
                  <a:gd name="f96" fmla="*/ f93 f29 1"/>
                  <a:gd name="f97" fmla="*/ f94 f29 1"/>
                  <a:gd name="f98" fmla="*/ f95 f29 1"/>
                </a:gdLst>
                <a:ahLst>
                  <a:ahXY gdRefX="f0" minX="f7" maxX="f10">
                    <a:pos x="f36" y="f37"/>
                  </a:ahXY>
                </a:ahLst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</a:cxnLst>
                <a:rect l="f96" t="f96" r="f97" b="f98"/>
                <a:pathLst>
                  <a:path>
                    <a:moveTo>
                      <a:pt x="f38" y="f37"/>
                    </a:moveTo>
                    <a:arcTo wR="f47" hR="f48" stAng="f81" swAng="f64"/>
                    <a:lnTo>
                      <a:pt x="f37" y="f44"/>
                    </a:lnTo>
                    <a:arcTo wR="f48" hR="f65" stAng="f90" swAng="f68"/>
                    <a:lnTo>
                      <a:pt x="f45" y="f39"/>
                    </a:lnTo>
                    <a:arcTo wR="f69" hR="f70" stAng="f91" swAng="f86"/>
                    <a:lnTo>
                      <a:pt x="f40" y="f38"/>
                    </a:lnTo>
                    <a:arcTo wR="f75" hR="f47" stAng="f87" swAng="f88"/>
                    <a:close/>
                  </a:path>
                </a:pathLst>
              </a:custGeom>
              <a:solidFill>
                <a:srgbClr val="CFE7F5">
                  <a:alpha val="0"/>
                </a:srgbClr>
              </a:solidFill>
              <a:ln w="9360">
                <a:solidFill>
                  <a:srgbClr val="808080"/>
                </a:solidFill>
                <a:prstDash val="solid"/>
                <a:round/>
              </a:ln>
            </p:spPr>
            <p:txBody>
              <a:bodyPr vert="horz" wrap="none" lIns="97959" tIns="50939" rIns="97959" bIns="50939" anchor="ctr" anchorCtr="0" compatLnSpc="1">
                <a:noAutofit/>
              </a:bodyPr>
              <a:lstStyle/>
              <a:p>
                <a:pPr hangingPunct="0">
                  <a:lnSpc>
                    <a:spcPct val="93000"/>
                  </a:lnSpc>
                  <a:tabLst>
                    <a:tab pos="0" algn="l"/>
                    <a:tab pos="488603" algn="l"/>
                    <a:tab pos="977600" algn="l"/>
                    <a:tab pos="1466597" algn="l"/>
                    <a:tab pos="1955594" algn="l"/>
                    <a:tab pos="2444590" algn="l"/>
                    <a:tab pos="2933586" algn="l"/>
                    <a:tab pos="3422583" algn="l"/>
                    <a:tab pos="3911579" algn="l"/>
                    <a:tab pos="4400574" algn="l"/>
                    <a:tab pos="4889572" algn="l"/>
                    <a:tab pos="5378567" algn="l"/>
                    <a:tab pos="5867564" algn="l"/>
                    <a:tab pos="6356561" algn="l"/>
                    <a:tab pos="6845557" algn="l"/>
                    <a:tab pos="7334553" algn="l"/>
                    <a:tab pos="7823550" algn="l"/>
                    <a:tab pos="8312546" algn="l"/>
                    <a:tab pos="8801541" algn="l"/>
                    <a:tab pos="9290539" algn="l"/>
                    <a:tab pos="9779535" algn="l"/>
                  </a:tabLst>
                </a:pPr>
                <a:endParaRPr lang="ru-RU" sz="1959">
                  <a:solidFill>
                    <a:srgbClr val="000000"/>
                  </a:solidFill>
                  <a:latin typeface="Arial" pitchFamily="18"/>
                  <a:ea typeface="Microsoft YaHei" pitchFamily="2"/>
                  <a:cs typeface="Microsoft YaHei" pitchFamily="2"/>
                </a:endParaRPr>
              </a:p>
            </p:txBody>
          </p:sp>
          <p:sp>
            <p:nvSpPr>
              <p:cNvPr id="281" name="Полилиния 280"/>
              <p:cNvSpPr/>
              <p:nvPr/>
            </p:nvSpPr>
            <p:spPr>
              <a:xfrm>
                <a:off x="4853008" y="1003165"/>
                <a:ext cx="1277937" cy="1201789"/>
              </a:xfrm>
              <a:custGeom>
                <a:avLst>
                  <a:gd name="f0" fmla="val 108"/>
                </a:avLst>
                <a:gdLst>
                  <a:gd name="f1" fmla="val 10800000"/>
                  <a:gd name="f2" fmla="val 5400000"/>
                  <a:gd name="f3" fmla="val 16200000"/>
                  <a:gd name="f4" fmla="val w"/>
                  <a:gd name="f5" fmla="val h"/>
                  <a:gd name="f6" fmla="val ss"/>
                  <a:gd name="f7" fmla="val 0"/>
                  <a:gd name="f8" fmla="*/ 5419351 1 1725033"/>
                  <a:gd name="f9" fmla="val 45"/>
                  <a:gd name="f10" fmla="val 10800"/>
                  <a:gd name="f11" fmla="val -2147483647"/>
                  <a:gd name="f12" fmla="val 2147483647"/>
                  <a:gd name="f13" fmla="abs f4"/>
                  <a:gd name="f14" fmla="abs f5"/>
                  <a:gd name="f15" fmla="abs f6"/>
                  <a:gd name="f16" fmla="*/ f8 1 180"/>
                  <a:gd name="f17" fmla="pin 0 f0 10800"/>
                  <a:gd name="f18" fmla="+- 0 0 f2"/>
                  <a:gd name="f19" fmla="?: f13 f4 1"/>
                  <a:gd name="f20" fmla="?: f14 f5 1"/>
                  <a:gd name="f21" fmla="?: f15 f6 1"/>
                  <a:gd name="f22" fmla="*/ f9 f16 1"/>
                  <a:gd name="f23" fmla="+- f7 f17 0"/>
                  <a:gd name="f24" fmla="*/ f19 1 21600"/>
                  <a:gd name="f25" fmla="*/ f20 1 21600"/>
                  <a:gd name="f26" fmla="*/ 21600 f19 1"/>
                  <a:gd name="f27" fmla="*/ 21600 f20 1"/>
                  <a:gd name="f28" fmla="+- 0 0 f22"/>
                  <a:gd name="f29" fmla="min f25 f24"/>
                  <a:gd name="f30" fmla="*/ f26 1 f21"/>
                  <a:gd name="f31" fmla="*/ f27 1 f21"/>
                  <a:gd name="f32" fmla="*/ f28 f1 1"/>
                  <a:gd name="f33" fmla="*/ f32 1 f8"/>
                  <a:gd name="f34" fmla="+- f31 0 f17"/>
                  <a:gd name="f35" fmla="+- f30 0 f17"/>
                  <a:gd name="f36" fmla="*/ f17 f29 1"/>
                  <a:gd name="f37" fmla="*/ f7 f29 1"/>
                  <a:gd name="f38" fmla="*/ f23 f29 1"/>
                  <a:gd name="f39" fmla="*/ f31 f29 1"/>
                  <a:gd name="f40" fmla="*/ f30 f29 1"/>
                  <a:gd name="f41" fmla="+- f33 0 f2"/>
                  <a:gd name="f42" fmla="+- f37 0 f38"/>
                  <a:gd name="f43" fmla="+- f38 0 f37"/>
                  <a:gd name="f44" fmla="*/ f34 f29 1"/>
                  <a:gd name="f45" fmla="*/ f35 f29 1"/>
                  <a:gd name="f46" fmla="cos 1 f41"/>
                  <a:gd name="f47" fmla="abs f42"/>
                  <a:gd name="f48" fmla="abs f43"/>
                  <a:gd name="f49" fmla="?: f42 f18 f2"/>
                  <a:gd name="f50" fmla="?: f42 f2 f18"/>
                  <a:gd name="f51" fmla="?: f42 f3 f2"/>
                  <a:gd name="f52" fmla="?: f42 f2 f3"/>
                  <a:gd name="f53" fmla="+- f39 0 f44"/>
                  <a:gd name="f54" fmla="?: f43 f18 f2"/>
                  <a:gd name="f55" fmla="?: f43 f2 f18"/>
                  <a:gd name="f56" fmla="+- f40 0 f45"/>
                  <a:gd name="f57" fmla="+- f44 0 f39"/>
                  <a:gd name="f58" fmla="+- f45 0 f40"/>
                  <a:gd name="f59" fmla="?: f42 0 f1"/>
                  <a:gd name="f60" fmla="?: f42 f1 0"/>
                  <a:gd name="f61" fmla="+- 0 0 f46"/>
                  <a:gd name="f62" fmla="?: f42 f52 f51"/>
                  <a:gd name="f63" fmla="?: f42 f51 f52"/>
                  <a:gd name="f64" fmla="?: f43 f50 f49"/>
                  <a:gd name="f65" fmla="abs f53"/>
                  <a:gd name="f66" fmla="?: f53 0 f1"/>
                  <a:gd name="f67" fmla="?: f53 f1 0"/>
                  <a:gd name="f68" fmla="?: f53 f54 f55"/>
                  <a:gd name="f69" fmla="abs f56"/>
                  <a:gd name="f70" fmla="abs f57"/>
                  <a:gd name="f71" fmla="?: f56 f18 f2"/>
                  <a:gd name="f72" fmla="?: f56 f2 f18"/>
                  <a:gd name="f73" fmla="?: f56 f3 f2"/>
                  <a:gd name="f74" fmla="?: f56 f2 f3"/>
                  <a:gd name="f75" fmla="abs f58"/>
                  <a:gd name="f76" fmla="?: f58 f18 f2"/>
                  <a:gd name="f77" fmla="?: f58 f2 f18"/>
                  <a:gd name="f78" fmla="?: f58 f60 f59"/>
                  <a:gd name="f79" fmla="?: f58 f59 f60"/>
                  <a:gd name="f80" fmla="*/ f17 f61 1"/>
                  <a:gd name="f81" fmla="?: f43 f63 f62"/>
                  <a:gd name="f82" fmla="?: f43 f67 f66"/>
                  <a:gd name="f83" fmla="?: f43 f66 f67"/>
                  <a:gd name="f84" fmla="?: f56 f74 f73"/>
                  <a:gd name="f85" fmla="?: f56 f73 f74"/>
                  <a:gd name="f86" fmla="?: f57 f72 f71"/>
                  <a:gd name="f87" fmla="?: f42 f78 f79"/>
                  <a:gd name="f88" fmla="?: f42 f76 f77"/>
                  <a:gd name="f89" fmla="*/ f80 3163 1"/>
                  <a:gd name="f90" fmla="?: f53 f82 f83"/>
                  <a:gd name="f91" fmla="?: f57 f85 f84"/>
                  <a:gd name="f92" fmla="*/ f89 1 7636"/>
                  <a:gd name="f93" fmla="+- f7 f92 0"/>
                  <a:gd name="f94" fmla="+- f30 0 f92"/>
                  <a:gd name="f95" fmla="+- f31 0 f92"/>
                  <a:gd name="f96" fmla="*/ f93 f29 1"/>
                  <a:gd name="f97" fmla="*/ f94 f29 1"/>
                  <a:gd name="f98" fmla="*/ f95 f29 1"/>
                </a:gdLst>
                <a:ahLst>
                  <a:ahXY gdRefX="f0" minX="f7" maxX="f10">
                    <a:pos x="f36" y="f37"/>
                  </a:ahXY>
                </a:ahLst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</a:cxnLst>
                <a:rect l="f96" t="f96" r="f97" b="f98"/>
                <a:pathLst>
                  <a:path>
                    <a:moveTo>
                      <a:pt x="f38" y="f37"/>
                    </a:moveTo>
                    <a:arcTo wR="f47" hR="f48" stAng="f81" swAng="f64"/>
                    <a:lnTo>
                      <a:pt x="f37" y="f44"/>
                    </a:lnTo>
                    <a:arcTo wR="f48" hR="f65" stAng="f90" swAng="f68"/>
                    <a:lnTo>
                      <a:pt x="f45" y="f39"/>
                    </a:lnTo>
                    <a:arcTo wR="f69" hR="f70" stAng="f91" swAng="f86"/>
                    <a:lnTo>
                      <a:pt x="f40" y="f38"/>
                    </a:lnTo>
                    <a:arcTo wR="f75" hR="f47" stAng="f87" swAng="f88"/>
                    <a:close/>
                  </a:path>
                </a:pathLst>
              </a:custGeom>
              <a:solidFill>
                <a:srgbClr val="CFE7F5">
                  <a:alpha val="0"/>
                </a:srgbClr>
              </a:solidFill>
              <a:ln w="9360">
                <a:solidFill>
                  <a:srgbClr val="808080"/>
                </a:solidFill>
                <a:prstDash val="solid"/>
                <a:round/>
              </a:ln>
            </p:spPr>
            <p:txBody>
              <a:bodyPr vert="horz" wrap="none" lIns="97959" tIns="50939" rIns="97959" bIns="50939" anchor="ctr" anchorCtr="0" compatLnSpc="1">
                <a:noAutofit/>
              </a:bodyPr>
              <a:lstStyle/>
              <a:p>
                <a:pPr hangingPunct="0">
                  <a:lnSpc>
                    <a:spcPct val="93000"/>
                  </a:lnSpc>
                  <a:tabLst>
                    <a:tab pos="0" algn="l"/>
                    <a:tab pos="488603" algn="l"/>
                    <a:tab pos="977600" algn="l"/>
                    <a:tab pos="1466597" algn="l"/>
                    <a:tab pos="1955594" algn="l"/>
                    <a:tab pos="2444590" algn="l"/>
                    <a:tab pos="2933586" algn="l"/>
                    <a:tab pos="3422583" algn="l"/>
                    <a:tab pos="3911579" algn="l"/>
                    <a:tab pos="4400574" algn="l"/>
                    <a:tab pos="4889572" algn="l"/>
                    <a:tab pos="5378567" algn="l"/>
                    <a:tab pos="5867564" algn="l"/>
                    <a:tab pos="6356561" algn="l"/>
                    <a:tab pos="6845557" algn="l"/>
                    <a:tab pos="7334553" algn="l"/>
                    <a:tab pos="7823550" algn="l"/>
                    <a:tab pos="8312546" algn="l"/>
                    <a:tab pos="8801541" algn="l"/>
                    <a:tab pos="9290539" algn="l"/>
                    <a:tab pos="9779535" algn="l"/>
                  </a:tabLst>
                </a:pPr>
                <a:endParaRPr lang="ru-RU" sz="1959">
                  <a:solidFill>
                    <a:srgbClr val="000000"/>
                  </a:solidFill>
                  <a:latin typeface="Arial" pitchFamily="18"/>
                  <a:ea typeface="Microsoft YaHei" pitchFamily="2"/>
                  <a:cs typeface="Microsoft YaHei" pitchFamily="2"/>
                </a:endParaRPr>
              </a:p>
            </p:txBody>
          </p:sp>
          <p:sp>
            <p:nvSpPr>
              <p:cNvPr id="282" name="Полилиния 281"/>
              <p:cNvSpPr/>
              <p:nvPr/>
            </p:nvSpPr>
            <p:spPr>
              <a:xfrm>
                <a:off x="4853278" y="2199785"/>
                <a:ext cx="1277664" cy="1251011"/>
              </a:xfrm>
              <a:custGeom>
                <a:avLst>
                  <a:gd name="f0" fmla="val 108"/>
                </a:avLst>
                <a:gdLst>
                  <a:gd name="f1" fmla="val 10800000"/>
                  <a:gd name="f2" fmla="val 5400000"/>
                  <a:gd name="f3" fmla="val 16200000"/>
                  <a:gd name="f4" fmla="val w"/>
                  <a:gd name="f5" fmla="val h"/>
                  <a:gd name="f6" fmla="val ss"/>
                  <a:gd name="f7" fmla="val 0"/>
                  <a:gd name="f8" fmla="*/ 5419351 1 1725033"/>
                  <a:gd name="f9" fmla="val 45"/>
                  <a:gd name="f10" fmla="val 10800"/>
                  <a:gd name="f11" fmla="val -2147483647"/>
                  <a:gd name="f12" fmla="val 2147483647"/>
                  <a:gd name="f13" fmla="abs f4"/>
                  <a:gd name="f14" fmla="abs f5"/>
                  <a:gd name="f15" fmla="abs f6"/>
                  <a:gd name="f16" fmla="*/ f8 1 180"/>
                  <a:gd name="f17" fmla="pin 0 f0 10800"/>
                  <a:gd name="f18" fmla="+- 0 0 f2"/>
                  <a:gd name="f19" fmla="?: f13 f4 1"/>
                  <a:gd name="f20" fmla="?: f14 f5 1"/>
                  <a:gd name="f21" fmla="?: f15 f6 1"/>
                  <a:gd name="f22" fmla="*/ f9 f16 1"/>
                  <a:gd name="f23" fmla="+- f7 f17 0"/>
                  <a:gd name="f24" fmla="*/ f19 1 21600"/>
                  <a:gd name="f25" fmla="*/ f20 1 21600"/>
                  <a:gd name="f26" fmla="*/ 21600 f19 1"/>
                  <a:gd name="f27" fmla="*/ 21600 f20 1"/>
                  <a:gd name="f28" fmla="+- 0 0 f22"/>
                  <a:gd name="f29" fmla="min f25 f24"/>
                  <a:gd name="f30" fmla="*/ f26 1 f21"/>
                  <a:gd name="f31" fmla="*/ f27 1 f21"/>
                  <a:gd name="f32" fmla="*/ f28 f1 1"/>
                  <a:gd name="f33" fmla="*/ f32 1 f8"/>
                  <a:gd name="f34" fmla="+- f31 0 f17"/>
                  <a:gd name="f35" fmla="+- f30 0 f17"/>
                  <a:gd name="f36" fmla="*/ f17 f29 1"/>
                  <a:gd name="f37" fmla="*/ f7 f29 1"/>
                  <a:gd name="f38" fmla="*/ f23 f29 1"/>
                  <a:gd name="f39" fmla="*/ f31 f29 1"/>
                  <a:gd name="f40" fmla="*/ f30 f29 1"/>
                  <a:gd name="f41" fmla="+- f33 0 f2"/>
                  <a:gd name="f42" fmla="+- f37 0 f38"/>
                  <a:gd name="f43" fmla="+- f38 0 f37"/>
                  <a:gd name="f44" fmla="*/ f34 f29 1"/>
                  <a:gd name="f45" fmla="*/ f35 f29 1"/>
                  <a:gd name="f46" fmla="cos 1 f41"/>
                  <a:gd name="f47" fmla="abs f42"/>
                  <a:gd name="f48" fmla="abs f43"/>
                  <a:gd name="f49" fmla="?: f42 f18 f2"/>
                  <a:gd name="f50" fmla="?: f42 f2 f18"/>
                  <a:gd name="f51" fmla="?: f42 f3 f2"/>
                  <a:gd name="f52" fmla="?: f42 f2 f3"/>
                  <a:gd name="f53" fmla="+- f39 0 f44"/>
                  <a:gd name="f54" fmla="?: f43 f18 f2"/>
                  <a:gd name="f55" fmla="?: f43 f2 f18"/>
                  <a:gd name="f56" fmla="+- f40 0 f45"/>
                  <a:gd name="f57" fmla="+- f44 0 f39"/>
                  <a:gd name="f58" fmla="+- f45 0 f40"/>
                  <a:gd name="f59" fmla="?: f42 0 f1"/>
                  <a:gd name="f60" fmla="?: f42 f1 0"/>
                  <a:gd name="f61" fmla="+- 0 0 f46"/>
                  <a:gd name="f62" fmla="?: f42 f52 f51"/>
                  <a:gd name="f63" fmla="?: f42 f51 f52"/>
                  <a:gd name="f64" fmla="?: f43 f50 f49"/>
                  <a:gd name="f65" fmla="abs f53"/>
                  <a:gd name="f66" fmla="?: f53 0 f1"/>
                  <a:gd name="f67" fmla="?: f53 f1 0"/>
                  <a:gd name="f68" fmla="?: f53 f54 f55"/>
                  <a:gd name="f69" fmla="abs f56"/>
                  <a:gd name="f70" fmla="abs f57"/>
                  <a:gd name="f71" fmla="?: f56 f18 f2"/>
                  <a:gd name="f72" fmla="?: f56 f2 f18"/>
                  <a:gd name="f73" fmla="?: f56 f3 f2"/>
                  <a:gd name="f74" fmla="?: f56 f2 f3"/>
                  <a:gd name="f75" fmla="abs f58"/>
                  <a:gd name="f76" fmla="?: f58 f18 f2"/>
                  <a:gd name="f77" fmla="?: f58 f2 f18"/>
                  <a:gd name="f78" fmla="?: f58 f60 f59"/>
                  <a:gd name="f79" fmla="?: f58 f59 f60"/>
                  <a:gd name="f80" fmla="*/ f17 f61 1"/>
                  <a:gd name="f81" fmla="?: f43 f63 f62"/>
                  <a:gd name="f82" fmla="?: f43 f67 f66"/>
                  <a:gd name="f83" fmla="?: f43 f66 f67"/>
                  <a:gd name="f84" fmla="?: f56 f74 f73"/>
                  <a:gd name="f85" fmla="?: f56 f73 f74"/>
                  <a:gd name="f86" fmla="?: f57 f72 f71"/>
                  <a:gd name="f87" fmla="?: f42 f78 f79"/>
                  <a:gd name="f88" fmla="?: f42 f76 f77"/>
                  <a:gd name="f89" fmla="*/ f80 3163 1"/>
                  <a:gd name="f90" fmla="?: f53 f82 f83"/>
                  <a:gd name="f91" fmla="?: f57 f85 f84"/>
                  <a:gd name="f92" fmla="*/ f89 1 7636"/>
                  <a:gd name="f93" fmla="+- f7 f92 0"/>
                  <a:gd name="f94" fmla="+- f30 0 f92"/>
                  <a:gd name="f95" fmla="+- f31 0 f92"/>
                  <a:gd name="f96" fmla="*/ f93 f29 1"/>
                  <a:gd name="f97" fmla="*/ f94 f29 1"/>
                  <a:gd name="f98" fmla="*/ f95 f29 1"/>
                </a:gdLst>
                <a:ahLst>
                  <a:ahXY gdRefX="f0" minX="f7" maxX="f10">
                    <a:pos x="f36" y="f37"/>
                  </a:ahXY>
                </a:ahLst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</a:cxnLst>
                <a:rect l="f96" t="f96" r="f97" b="f98"/>
                <a:pathLst>
                  <a:path>
                    <a:moveTo>
                      <a:pt x="f38" y="f37"/>
                    </a:moveTo>
                    <a:arcTo wR="f47" hR="f48" stAng="f81" swAng="f64"/>
                    <a:lnTo>
                      <a:pt x="f37" y="f44"/>
                    </a:lnTo>
                    <a:arcTo wR="f48" hR="f65" stAng="f90" swAng="f68"/>
                    <a:lnTo>
                      <a:pt x="f45" y="f39"/>
                    </a:lnTo>
                    <a:arcTo wR="f69" hR="f70" stAng="f91" swAng="f86"/>
                    <a:lnTo>
                      <a:pt x="f40" y="f38"/>
                    </a:lnTo>
                    <a:arcTo wR="f75" hR="f47" stAng="f87" swAng="f88"/>
                    <a:close/>
                  </a:path>
                </a:pathLst>
              </a:custGeom>
              <a:solidFill>
                <a:srgbClr val="CFE7F5">
                  <a:alpha val="0"/>
                </a:srgbClr>
              </a:solidFill>
              <a:ln w="9360">
                <a:solidFill>
                  <a:srgbClr val="808080"/>
                </a:solidFill>
                <a:prstDash val="solid"/>
                <a:round/>
              </a:ln>
            </p:spPr>
            <p:txBody>
              <a:bodyPr vert="horz" wrap="none" lIns="97959" tIns="50939" rIns="97959" bIns="50939" anchor="ctr" anchorCtr="0" compatLnSpc="1">
                <a:noAutofit/>
              </a:bodyPr>
              <a:lstStyle/>
              <a:p>
                <a:pPr hangingPunct="0">
                  <a:lnSpc>
                    <a:spcPct val="93000"/>
                  </a:lnSpc>
                  <a:tabLst>
                    <a:tab pos="0" algn="l"/>
                    <a:tab pos="488603" algn="l"/>
                    <a:tab pos="977600" algn="l"/>
                    <a:tab pos="1466597" algn="l"/>
                    <a:tab pos="1955594" algn="l"/>
                    <a:tab pos="2444590" algn="l"/>
                    <a:tab pos="2933586" algn="l"/>
                    <a:tab pos="3422583" algn="l"/>
                    <a:tab pos="3911579" algn="l"/>
                    <a:tab pos="4400574" algn="l"/>
                    <a:tab pos="4889572" algn="l"/>
                    <a:tab pos="5378567" algn="l"/>
                    <a:tab pos="5867564" algn="l"/>
                    <a:tab pos="6356561" algn="l"/>
                    <a:tab pos="6845557" algn="l"/>
                    <a:tab pos="7334553" algn="l"/>
                    <a:tab pos="7823550" algn="l"/>
                    <a:tab pos="8312546" algn="l"/>
                    <a:tab pos="8801541" algn="l"/>
                    <a:tab pos="9290539" algn="l"/>
                    <a:tab pos="9779535" algn="l"/>
                  </a:tabLst>
                </a:pPr>
                <a:endParaRPr lang="ru-RU" sz="1959">
                  <a:solidFill>
                    <a:srgbClr val="000000"/>
                  </a:solidFill>
                  <a:latin typeface="Arial" pitchFamily="18"/>
                  <a:ea typeface="Microsoft YaHei" pitchFamily="2"/>
                  <a:cs typeface="Microsoft YaHei" pitchFamily="2"/>
                </a:endParaRPr>
              </a:p>
            </p:txBody>
          </p:sp>
          <p:sp>
            <p:nvSpPr>
              <p:cNvPr id="283" name="Полилиния 282"/>
              <p:cNvSpPr/>
              <p:nvPr/>
            </p:nvSpPr>
            <p:spPr>
              <a:xfrm>
                <a:off x="4853005" y="605426"/>
                <a:ext cx="1278208" cy="187380"/>
              </a:xfrm>
              <a:custGeom>
                <a:avLst>
                  <a:gd name="f0" fmla="val 108"/>
                </a:avLst>
                <a:gdLst>
                  <a:gd name="f1" fmla="val 10800000"/>
                  <a:gd name="f2" fmla="val 5400000"/>
                  <a:gd name="f3" fmla="val 16200000"/>
                  <a:gd name="f4" fmla="val w"/>
                  <a:gd name="f5" fmla="val h"/>
                  <a:gd name="f6" fmla="val ss"/>
                  <a:gd name="f7" fmla="val 0"/>
                  <a:gd name="f8" fmla="*/ 5419351 1 1725033"/>
                  <a:gd name="f9" fmla="val 45"/>
                  <a:gd name="f10" fmla="val 10800"/>
                  <a:gd name="f11" fmla="val -2147483647"/>
                  <a:gd name="f12" fmla="val 2147483647"/>
                  <a:gd name="f13" fmla="abs f4"/>
                  <a:gd name="f14" fmla="abs f5"/>
                  <a:gd name="f15" fmla="abs f6"/>
                  <a:gd name="f16" fmla="*/ f8 1 180"/>
                  <a:gd name="f17" fmla="pin 0 f0 10800"/>
                  <a:gd name="f18" fmla="+- 0 0 f2"/>
                  <a:gd name="f19" fmla="?: f13 f4 1"/>
                  <a:gd name="f20" fmla="?: f14 f5 1"/>
                  <a:gd name="f21" fmla="?: f15 f6 1"/>
                  <a:gd name="f22" fmla="*/ f9 f16 1"/>
                  <a:gd name="f23" fmla="+- f7 f17 0"/>
                  <a:gd name="f24" fmla="*/ f19 1 21600"/>
                  <a:gd name="f25" fmla="*/ f20 1 21600"/>
                  <a:gd name="f26" fmla="*/ 21600 f19 1"/>
                  <a:gd name="f27" fmla="*/ 21600 f20 1"/>
                  <a:gd name="f28" fmla="+- 0 0 f22"/>
                  <a:gd name="f29" fmla="min f25 f24"/>
                  <a:gd name="f30" fmla="*/ f26 1 f21"/>
                  <a:gd name="f31" fmla="*/ f27 1 f21"/>
                  <a:gd name="f32" fmla="*/ f28 f1 1"/>
                  <a:gd name="f33" fmla="*/ f32 1 f8"/>
                  <a:gd name="f34" fmla="+- f31 0 f17"/>
                  <a:gd name="f35" fmla="+- f30 0 f17"/>
                  <a:gd name="f36" fmla="*/ f17 f29 1"/>
                  <a:gd name="f37" fmla="*/ f7 f29 1"/>
                  <a:gd name="f38" fmla="*/ f23 f29 1"/>
                  <a:gd name="f39" fmla="*/ f31 f29 1"/>
                  <a:gd name="f40" fmla="*/ f30 f29 1"/>
                  <a:gd name="f41" fmla="+- f33 0 f2"/>
                  <a:gd name="f42" fmla="+- f37 0 f38"/>
                  <a:gd name="f43" fmla="+- f38 0 f37"/>
                  <a:gd name="f44" fmla="*/ f34 f29 1"/>
                  <a:gd name="f45" fmla="*/ f35 f29 1"/>
                  <a:gd name="f46" fmla="cos 1 f41"/>
                  <a:gd name="f47" fmla="abs f42"/>
                  <a:gd name="f48" fmla="abs f43"/>
                  <a:gd name="f49" fmla="?: f42 f18 f2"/>
                  <a:gd name="f50" fmla="?: f42 f2 f18"/>
                  <a:gd name="f51" fmla="?: f42 f3 f2"/>
                  <a:gd name="f52" fmla="?: f42 f2 f3"/>
                  <a:gd name="f53" fmla="+- f39 0 f44"/>
                  <a:gd name="f54" fmla="?: f43 f18 f2"/>
                  <a:gd name="f55" fmla="?: f43 f2 f18"/>
                  <a:gd name="f56" fmla="+- f40 0 f45"/>
                  <a:gd name="f57" fmla="+- f44 0 f39"/>
                  <a:gd name="f58" fmla="+- f45 0 f40"/>
                  <a:gd name="f59" fmla="?: f42 0 f1"/>
                  <a:gd name="f60" fmla="?: f42 f1 0"/>
                  <a:gd name="f61" fmla="+- 0 0 f46"/>
                  <a:gd name="f62" fmla="?: f42 f52 f51"/>
                  <a:gd name="f63" fmla="?: f42 f51 f52"/>
                  <a:gd name="f64" fmla="?: f43 f50 f49"/>
                  <a:gd name="f65" fmla="abs f53"/>
                  <a:gd name="f66" fmla="?: f53 0 f1"/>
                  <a:gd name="f67" fmla="?: f53 f1 0"/>
                  <a:gd name="f68" fmla="?: f53 f54 f55"/>
                  <a:gd name="f69" fmla="abs f56"/>
                  <a:gd name="f70" fmla="abs f57"/>
                  <a:gd name="f71" fmla="?: f56 f18 f2"/>
                  <a:gd name="f72" fmla="?: f56 f2 f18"/>
                  <a:gd name="f73" fmla="?: f56 f3 f2"/>
                  <a:gd name="f74" fmla="?: f56 f2 f3"/>
                  <a:gd name="f75" fmla="abs f58"/>
                  <a:gd name="f76" fmla="?: f58 f18 f2"/>
                  <a:gd name="f77" fmla="?: f58 f2 f18"/>
                  <a:gd name="f78" fmla="?: f58 f60 f59"/>
                  <a:gd name="f79" fmla="?: f58 f59 f60"/>
                  <a:gd name="f80" fmla="*/ f17 f61 1"/>
                  <a:gd name="f81" fmla="?: f43 f63 f62"/>
                  <a:gd name="f82" fmla="?: f43 f67 f66"/>
                  <a:gd name="f83" fmla="?: f43 f66 f67"/>
                  <a:gd name="f84" fmla="?: f56 f74 f73"/>
                  <a:gd name="f85" fmla="?: f56 f73 f74"/>
                  <a:gd name="f86" fmla="?: f57 f72 f71"/>
                  <a:gd name="f87" fmla="?: f42 f78 f79"/>
                  <a:gd name="f88" fmla="?: f42 f76 f77"/>
                  <a:gd name="f89" fmla="*/ f80 3163 1"/>
                  <a:gd name="f90" fmla="?: f53 f82 f83"/>
                  <a:gd name="f91" fmla="?: f57 f85 f84"/>
                  <a:gd name="f92" fmla="*/ f89 1 7636"/>
                  <a:gd name="f93" fmla="+- f7 f92 0"/>
                  <a:gd name="f94" fmla="+- f30 0 f92"/>
                  <a:gd name="f95" fmla="+- f31 0 f92"/>
                  <a:gd name="f96" fmla="*/ f93 f29 1"/>
                  <a:gd name="f97" fmla="*/ f94 f29 1"/>
                  <a:gd name="f98" fmla="*/ f95 f29 1"/>
                </a:gdLst>
                <a:ahLst>
                  <a:ahXY gdRefX="f0" minX="f7" maxX="f10">
                    <a:pos x="f36" y="f37"/>
                  </a:ahXY>
                </a:ahLst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</a:cxnLst>
                <a:rect l="f96" t="f96" r="f97" b="f98"/>
                <a:pathLst>
                  <a:path>
                    <a:moveTo>
                      <a:pt x="f38" y="f37"/>
                    </a:moveTo>
                    <a:arcTo wR="f47" hR="f48" stAng="f81" swAng="f64"/>
                    <a:lnTo>
                      <a:pt x="f37" y="f44"/>
                    </a:lnTo>
                    <a:arcTo wR="f48" hR="f65" stAng="f90" swAng="f68"/>
                    <a:lnTo>
                      <a:pt x="f45" y="f39"/>
                    </a:lnTo>
                    <a:arcTo wR="f69" hR="f70" stAng="f91" swAng="f86"/>
                    <a:lnTo>
                      <a:pt x="f40" y="f38"/>
                    </a:lnTo>
                    <a:arcTo wR="f75" hR="f47" stAng="f87" swAng="f88"/>
                    <a:close/>
                  </a:path>
                </a:pathLst>
              </a:custGeom>
              <a:solidFill>
                <a:srgbClr val="CFE7F5">
                  <a:alpha val="0"/>
                </a:srgbClr>
              </a:solidFill>
              <a:ln w="9360">
                <a:solidFill>
                  <a:srgbClr val="808080"/>
                </a:solidFill>
                <a:prstDash val="solid"/>
                <a:round/>
              </a:ln>
            </p:spPr>
            <p:txBody>
              <a:bodyPr vert="horz" wrap="none" lIns="97959" tIns="50939" rIns="97959" bIns="50939" anchor="ctr" anchorCtr="0" compatLnSpc="1">
                <a:noAutofit/>
              </a:bodyPr>
              <a:lstStyle/>
              <a:p>
                <a:pPr hangingPunct="0">
                  <a:lnSpc>
                    <a:spcPct val="93000"/>
                  </a:lnSpc>
                  <a:tabLst>
                    <a:tab pos="0" algn="l"/>
                    <a:tab pos="488603" algn="l"/>
                    <a:tab pos="977600" algn="l"/>
                    <a:tab pos="1466597" algn="l"/>
                    <a:tab pos="1955594" algn="l"/>
                    <a:tab pos="2444590" algn="l"/>
                    <a:tab pos="2933586" algn="l"/>
                    <a:tab pos="3422583" algn="l"/>
                    <a:tab pos="3911579" algn="l"/>
                    <a:tab pos="4400574" algn="l"/>
                    <a:tab pos="4889572" algn="l"/>
                    <a:tab pos="5378567" algn="l"/>
                    <a:tab pos="5867564" algn="l"/>
                    <a:tab pos="6356561" algn="l"/>
                    <a:tab pos="6845557" algn="l"/>
                    <a:tab pos="7334553" algn="l"/>
                    <a:tab pos="7823550" algn="l"/>
                    <a:tab pos="8312546" algn="l"/>
                    <a:tab pos="8801541" algn="l"/>
                    <a:tab pos="9290539" algn="l"/>
                    <a:tab pos="9779535" algn="l"/>
                  </a:tabLst>
                </a:pPr>
                <a:endParaRPr lang="ru-RU" sz="1959">
                  <a:solidFill>
                    <a:srgbClr val="000000"/>
                  </a:solidFill>
                  <a:latin typeface="Arial" pitchFamily="18"/>
                  <a:ea typeface="Microsoft YaHei" pitchFamily="2"/>
                  <a:cs typeface="Microsoft YaHei" pitchFamily="2"/>
                </a:endParaRPr>
              </a:p>
            </p:txBody>
          </p:sp>
          <p:sp>
            <p:nvSpPr>
              <p:cNvPr id="284" name="Полилиния 283"/>
              <p:cNvSpPr/>
              <p:nvPr/>
            </p:nvSpPr>
            <p:spPr>
              <a:xfrm>
                <a:off x="4607970" y="1003165"/>
                <a:ext cx="245308" cy="1201789"/>
              </a:xfrm>
              <a:custGeom>
                <a:avLst>
                  <a:gd name="f0" fmla="val 108"/>
                </a:avLst>
                <a:gdLst>
                  <a:gd name="f1" fmla="val 10800000"/>
                  <a:gd name="f2" fmla="val 5400000"/>
                  <a:gd name="f3" fmla="val 16200000"/>
                  <a:gd name="f4" fmla="val w"/>
                  <a:gd name="f5" fmla="val h"/>
                  <a:gd name="f6" fmla="val ss"/>
                  <a:gd name="f7" fmla="val 0"/>
                  <a:gd name="f8" fmla="*/ 5419351 1 1725033"/>
                  <a:gd name="f9" fmla="val 45"/>
                  <a:gd name="f10" fmla="val 10800"/>
                  <a:gd name="f11" fmla="val -2147483647"/>
                  <a:gd name="f12" fmla="val 2147483647"/>
                  <a:gd name="f13" fmla="abs f4"/>
                  <a:gd name="f14" fmla="abs f5"/>
                  <a:gd name="f15" fmla="abs f6"/>
                  <a:gd name="f16" fmla="*/ f8 1 180"/>
                  <a:gd name="f17" fmla="pin 0 f0 10800"/>
                  <a:gd name="f18" fmla="+- 0 0 f2"/>
                  <a:gd name="f19" fmla="?: f13 f4 1"/>
                  <a:gd name="f20" fmla="?: f14 f5 1"/>
                  <a:gd name="f21" fmla="?: f15 f6 1"/>
                  <a:gd name="f22" fmla="*/ f9 f16 1"/>
                  <a:gd name="f23" fmla="+- f7 f17 0"/>
                  <a:gd name="f24" fmla="*/ f19 1 21600"/>
                  <a:gd name="f25" fmla="*/ f20 1 21600"/>
                  <a:gd name="f26" fmla="*/ 21600 f19 1"/>
                  <a:gd name="f27" fmla="*/ 21600 f20 1"/>
                  <a:gd name="f28" fmla="+- 0 0 f22"/>
                  <a:gd name="f29" fmla="min f25 f24"/>
                  <a:gd name="f30" fmla="*/ f26 1 f21"/>
                  <a:gd name="f31" fmla="*/ f27 1 f21"/>
                  <a:gd name="f32" fmla="*/ f28 f1 1"/>
                  <a:gd name="f33" fmla="*/ f32 1 f8"/>
                  <a:gd name="f34" fmla="+- f31 0 f17"/>
                  <a:gd name="f35" fmla="+- f30 0 f17"/>
                  <a:gd name="f36" fmla="*/ f17 f29 1"/>
                  <a:gd name="f37" fmla="*/ f7 f29 1"/>
                  <a:gd name="f38" fmla="*/ f23 f29 1"/>
                  <a:gd name="f39" fmla="*/ f31 f29 1"/>
                  <a:gd name="f40" fmla="*/ f30 f29 1"/>
                  <a:gd name="f41" fmla="+- f33 0 f2"/>
                  <a:gd name="f42" fmla="+- f37 0 f38"/>
                  <a:gd name="f43" fmla="+- f38 0 f37"/>
                  <a:gd name="f44" fmla="*/ f34 f29 1"/>
                  <a:gd name="f45" fmla="*/ f35 f29 1"/>
                  <a:gd name="f46" fmla="cos 1 f41"/>
                  <a:gd name="f47" fmla="abs f42"/>
                  <a:gd name="f48" fmla="abs f43"/>
                  <a:gd name="f49" fmla="?: f42 f18 f2"/>
                  <a:gd name="f50" fmla="?: f42 f2 f18"/>
                  <a:gd name="f51" fmla="?: f42 f3 f2"/>
                  <a:gd name="f52" fmla="?: f42 f2 f3"/>
                  <a:gd name="f53" fmla="+- f39 0 f44"/>
                  <a:gd name="f54" fmla="?: f43 f18 f2"/>
                  <a:gd name="f55" fmla="?: f43 f2 f18"/>
                  <a:gd name="f56" fmla="+- f40 0 f45"/>
                  <a:gd name="f57" fmla="+- f44 0 f39"/>
                  <a:gd name="f58" fmla="+- f45 0 f40"/>
                  <a:gd name="f59" fmla="?: f42 0 f1"/>
                  <a:gd name="f60" fmla="?: f42 f1 0"/>
                  <a:gd name="f61" fmla="+- 0 0 f46"/>
                  <a:gd name="f62" fmla="?: f42 f52 f51"/>
                  <a:gd name="f63" fmla="?: f42 f51 f52"/>
                  <a:gd name="f64" fmla="?: f43 f50 f49"/>
                  <a:gd name="f65" fmla="abs f53"/>
                  <a:gd name="f66" fmla="?: f53 0 f1"/>
                  <a:gd name="f67" fmla="?: f53 f1 0"/>
                  <a:gd name="f68" fmla="?: f53 f54 f55"/>
                  <a:gd name="f69" fmla="abs f56"/>
                  <a:gd name="f70" fmla="abs f57"/>
                  <a:gd name="f71" fmla="?: f56 f18 f2"/>
                  <a:gd name="f72" fmla="?: f56 f2 f18"/>
                  <a:gd name="f73" fmla="?: f56 f3 f2"/>
                  <a:gd name="f74" fmla="?: f56 f2 f3"/>
                  <a:gd name="f75" fmla="abs f58"/>
                  <a:gd name="f76" fmla="?: f58 f18 f2"/>
                  <a:gd name="f77" fmla="?: f58 f2 f18"/>
                  <a:gd name="f78" fmla="?: f58 f60 f59"/>
                  <a:gd name="f79" fmla="?: f58 f59 f60"/>
                  <a:gd name="f80" fmla="*/ f17 f61 1"/>
                  <a:gd name="f81" fmla="?: f43 f63 f62"/>
                  <a:gd name="f82" fmla="?: f43 f67 f66"/>
                  <a:gd name="f83" fmla="?: f43 f66 f67"/>
                  <a:gd name="f84" fmla="?: f56 f74 f73"/>
                  <a:gd name="f85" fmla="?: f56 f73 f74"/>
                  <a:gd name="f86" fmla="?: f57 f72 f71"/>
                  <a:gd name="f87" fmla="?: f42 f78 f79"/>
                  <a:gd name="f88" fmla="?: f42 f76 f77"/>
                  <a:gd name="f89" fmla="*/ f80 3163 1"/>
                  <a:gd name="f90" fmla="?: f53 f82 f83"/>
                  <a:gd name="f91" fmla="?: f57 f85 f84"/>
                  <a:gd name="f92" fmla="*/ f89 1 7636"/>
                  <a:gd name="f93" fmla="+- f7 f92 0"/>
                  <a:gd name="f94" fmla="+- f30 0 f92"/>
                  <a:gd name="f95" fmla="+- f31 0 f92"/>
                  <a:gd name="f96" fmla="*/ f93 f29 1"/>
                  <a:gd name="f97" fmla="*/ f94 f29 1"/>
                  <a:gd name="f98" fmla="*/ f95 f29 1"/>
                </a:gdLst>
                <a:ahLst>
                  <a:ahXY gdRefX="f0" minX="f7" maxX="f10">
                    <a:pos x="f36" y="f37"/>
                  </a:ahXY>
                </a:ahLst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</a:cxnLst>
                <a:rect l="f96" t="f96" r="f97" b="f98"/>
                <a:pathLst>
                  <a:path>
                    <a:moveTo>
                      <a:pt x="f38" y="f37"/>
                    </a:moveTo>
                    <a:arcTo wR="f47" hR="f48" stAng="f81" swAng="f64"/>
                    <a:lnTo>
                      <a:pt x="f37" y="f44"/>
                    </a:lnTo>
                    <a:arcTo wR="f48" hR="f65" stAng="f90" swAng="f68"/>
                    <a:lnTo>
                      <a:pt x="f45" y="f39"/>
                    </a:lnTo>
                    <a:arcTo wR="f69" hR="f70" stAng="f91" swAng="f86"/>
                    <a:lnTo>
                      <a:pt x="f40" y="f38"/>
                    </a:lnTo>
                    <a:arcTo wR="f75" hR="f47" stAng="f87" swAng="f88"/>
                    <a:close/>
                  </a:path>
                </a:pathLst>
              </a:custGeom>
              <a:solidFill>
                <a:srgbClr val="CFE7F5">
                  <a:alpha val="0"/>
                </a:srgbClr>
              </a:solidFill>
              <a:ln w="9360">
                <a:solidFill>
                  <a:srgbClr val="808080"/>
                </a:solidFill>
                <a:prstDash val="solid"/>
                <a:round/>
              </a:ln>
            </p:spPr>
            <p:txBody>
              <a:bodyPr vert="horz" wrap="none" lIns="97959" tIns="50939" rIns="97959" bIns="50939" anchor="ctr" anchorCtr="0" compatLnSpc="1">
                <a:noAutofit/>
              </a:bodyPr>
              <a:lstStyle/>
              <a:p>
                <a:pPr hangingPunct="0">
                  <a:lnSpc>
                    <a:spcPct val="93000"/>
                  </a:lnSpc>
                  <a:tabLst>
                    <a:tab pos="0" algn="l"/>
                    <a:tab pos="488603" algn="l"/>
                    <a:tab pos="977600" algn="l"/>
                    <a:tab pos="1466597" algn="l"/>
                    <a:tab pos="1955594" algn="l"/>
                    <a:tab pos="2444590" algn="l"/>
                    <a:tab pos="2933586" algn="l"/>
                    <a:tab pos="3422583" algn="l"/>
                    <a:tab pos="3911579" algn="l"/>
                    <a:tab pos="4400574" algn="l"/>
                    <a:tab pos="4889572" algn="l"/>
                    <a:tab pos="5378567" algn="l"/>
                    <a:tab pos="5867564" algn="l"/>
                    <a:tab pos="6356561" algn="l"/>
                    <a:tab pos="6845557" algn="l"/>
                    <a:tab pos="7334553" algn="l"/>
                    <a:tab pos="7823550" algn="l"/>
                    <a:tab pos="8312546" algn="l"/>
                    <a:tab pos="8801541" algn="l"/>
                    <a:tab pos="9290539" algn="l"/>
                    <a:tab pos="9779535" algn="l"/>
                  </a:tabLst>
                </a:pPr>
                <a:endParaRPr lang="ru-RU" sz="1200" b="1" dirty="0">
                  <a:solidFill>
                    <a:srgbClr val="000000"/>
                  </a:solidFill>
                  <a:ea typeface="Microsoft YaHei" pitchFamily="2"/>
                  <a:cs typeface="Microsoft YaHei" pitchFamily="2"/>
                </a:endParaRPr>
              </a:p>
            </p:txBody>
          </p:sp>
          <p:sp>
            <p:nvSpPr>
              <p:cNvPr id="285" name="Полилиния 284"/>
              <p:cNvSpPr/>
              <p:nvPr/>
            </p:nvSpPr>
            <p:spPr>
              <a:xfrm>
                <a:off x="4607970" y="2199785"/>
                <a:ext cx="245308" cy="1251011"/>
              </a:xfrm>
              <a:custGeom>
                <a:avLst>
                  <a:gd name="f0" fmla="val 108"/>
                </a:avLst>
                <a:gdLst>
                  <a:gd name="f1" fmla="val 10800000"/>
                  <a:gd name="f2" fmla="val 5400000"/>
                  <a:gd name="f3" fmla="val 16200000"/>
                  <a:gd name="f4" fmla="val w"/>
                  <a:gd name="f5" fmla="val h"/>
                  <a:gd name="f6" fmla="val ss"/>
                  <a:gd name="f7" fmla="val 0"/>
                  <a:gd name="f8" fmla="*/ 5419351 1 1725033"/>
                  <a:gd name="f9" fmla="val 45"/>
                  <a:gd name="f10" fmla="val 10800"/>
                  <a:gd name="f11" fmla="val -2147483647"/>
                  <a:gd name="f12" fmla="val 2147483647"/>
                  <a:gd name="f13" fmla="abs f4"/>
                  <a:gd name="f14" fmla="abs f5"/>
                  <a:gd name="f15" fmla="abs f6"/>
                  <a:gd name="f16" fmla="*/ f8 1 180"/>
                  <a:gd name="f17" fmla="pin 0 f0 10800"/>
                  <a:gd name="f18" fmla="+- 0 0 f2"/>
                  <a:gd name="f19" fmla="?: f13 f4 1"/>
                  <a:gd name="f20" fmla="?: f14 f5 1"/>
                  <a:gd name="f21" fmla="?: f15 f6 1"/>
                  <a:gd name="f22" fmla="*/ f9 f16 1"/>
                  <a:gd name="f23" fmla="+- f7 f17 0"/>
                  <a:gd name="f24" fmla="*/ f19 1 21600"/>
                  <a:gd name="f25" fmla="*/ f20 1 21600"/>
                  <a:gd name="f26" fmla="*/ 21600 f19 1"/>
                  <a:gd name="f27" fmla="*/ 21600 f20 1"/>
                  <a:gd name="f28" fmla="+- 0 0 f22"/>
                  <a:gd name="f29" fmla="min f25 f24"/>
                  <a:gd name="f30" fmla="*/ f26 1 f21"/>
                  <a:gd name="f31" fmla="*/ f27 1 f21"/>
                  <a:gd name="f32" fmla="*/ f28 f1 1"/>
                  <a:gd name="f33" fmla="*/ f32 1 f8"/>
                  <a:gd name="f34" fmla="+- f31 0 f17"/>
                  <a:gd name="f35" fmla="+- f30 0 f17"/>
                  <a:gd name="f36" fmla="*/ f17 f29 1"/>
                  <a:gd name="f37" fmla="*/ f7 f29 1"/>
                  <a:gd name="f38" fmla="*/ f23 f29 1"/>
                  <a:gd name="f39" fmla="*/ f31 f29 1"/>
                  <a:gd name="f40" fmla="*/ f30 f29 1"/>
                  <a:gd name="f41" fmla="+- f33 0 f2"/>
                  <a:gd name="f42" fmla="+- f37 0 f38"/>
                  <a:gd name="f43" fmla="+- f38 0 f37"/>
                  <a:gd name="f44" fmla="*/ f34 f29 1"/>
                  <a:gd name="f45" fmla="*/ f35 f29 1"/>
                  <a:gd name="f46" fmla="cos 1 f41"/>
                  <a:gd name="f47" fmla="abs f42"/>
                  <a:gd name="f48" fmla="abs f43"/>
                  <a:gd name="f49" fmla="?: f42 f18 f2"/>
                  <a:gd name="f50" fmla="?: f42 f2 f18"/>
                  <a:gd name="f51" fmla="?: f42 f3 f2"/>
                  <a:gd name="f52" fmla="?: f42 f2 f3"/>
                  <a:gd name="f53" fmla="+- f39 0 f44"/>
                  <a:gd name="f54" fmla="?: f43 f18 f2"/>
                  <a:gd name="f55" fmla="?: f43 f2 f18"/>
                  <a:gd name="f56" fmla="+- f40 0 f45"/>
                  <a:gd name="f57" fmla="+- f44 0 f39"/>
                  <a:gd name="f58" fmla="+- f45 0 f40"/>
                  <a:gd name="f59" fmla="?: f42 0 f1"/>
                  <a:gd name="f60" fmla="?: f42 f1 0"/>
                  <a:gd name="f61" fmla="+- 0 0 f46"/>
                  <a:gd name="f62" fmla="?: f42 f52 f51"/>
                  <a:gd name="f63" fmla="?: f42 f51 f52"/>
                  <a:gd name="f64" fmla="?: f43 f50 f49"/>
                  <a:gd name="f65" fmla="abs f53"/>
                  <a:gd name="f66" fmla="?: f53 0 f1"/>
                  <a:gd name="f67" fmla="?: f53 f1 0"/>
                  <a:gd name="f68" fmla="?: f53 f54 f55"/>
                  <a:gd name="f69" fmla="abs f56"/>
                  <a:gd name="f70" fmla="abs f57"/>
                  <a:gd name="f71" fmla="?: f56 f18 f2"/>
                  <a:gd name="f72" fmla="?: f56 f2 f18"/>
                  <a:gd name="f73" fmla="?: f56 f3 f2"/>
                  <a:gd name="f74" fmla="?: f56 f2 f3"/>
                  <a:gd name="f75" fmla="abs f58"/>
                  <a:gd name="f76" fmla="?: f58 f18 f2"/>
                  <a:gd name="f77" fmla="?: f58 f2 f18"/>
                  <a:gd name="f78" fmla="?: f58 f60 f59"/>
                  <a:gd name="f79" fmla="?: f58 f59 f60"/>
                  <a:gd name="f80" fmla="*/ f17 f61 1"/>
                  <a:gd name="f81" fmla="?: f43 f63 f62"/>
                  <a:gd name="f82" fmla="?: f43 f67 f66"/>
                  <a:gd name="f83" fmla="?: f43 f66 f67"/>
                  <a:gd name="f84" fmla="?: f56 f74 f73"/>
                  <a:gd name="f85" fmla="?: f56 f73 f74"/>
                  <a:gd name="f86" fmla="?: f57 f72 f71"/>
                  <a:gd name="f87" fmla="?: f42 f78 f79"/>
                  <a:gd name="f88" fmla="?: f42 f76 f77"/>
                  <a:gd name="f89" fmla="*/ f80 3163 1"/>
                  <a:gd name="f90" fmla="?: f53 f82 f83"/>
                  <a:gd name="f91" fmla="?: f57 f85 f84"/>
                  <a:gd name="f92" fmla="*/ f89 1 7636"/>
                  <a:gd name="f93" fmla="+- f7 f92 0"/>
                  <a:gd name="f94" fmla="+- f30 0 f92"/>
                  <a:gd name="f95" fmla="+- f31 0 f92"/>
                  <a:gd name="f96" fmla="*/ f93 f29 1"/>
                  <a:gd name="f97" fmla="*/ f94 f29 1"/>
                  <a:gd name="f98" fmla="*/ f95 f29 1"/>
                </a:gdLst>
                <a:ahLst>
                  <a:ahXY gdRefX="f0" minX="f7" maxX="f10">
                    <a:pos x="f36" y="f37"/>
                  </a:ahXY>
                </a:ahLst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</a:cxnLst>
                <a:rect l="f96" t="f96" r="f97" b="f98"/>
                <a:pathLst>
                  <a:path>
                    <a:moveTo>
                      <a:pt x="f38" y="f37"/>
                    </a:moveTo>
                    <a:arcTo wR="f47" hR="f48" stAng="f81" swAng="f64"/>
                    <a:lnTo>
                      <a:pt x="f37" y="f44"/>
                    </a:lnTo>
                    <a:arcTo wR="f48" hR="f65" stAng="f90" swAng="f68"/>
                    <a:lnTo>
                      <a:pt x="f45" y="f39"/>
                    </a:lnTo>
                    <a:arcTo wR="f69" hR="f70" stAng="f91" swAng="f86"/>
                    <a:lnTo>
                      <a:pt x="f40" y="f38"/>
                    </a:lnTo>
                    <a:arcTo wR="f75" hR="f47" stAng="f87" swAng="f88"/>
                    <a:close/>
                  </a:path>
                </a:pathLst>
              </a:custGeom>
              <a:solidFill>
                <a:srgbClr val="CFE7F5">
                  <a:alpha val="0"/>
                </a:srgbClr>
              </a:solidFill>
              <a:ln w="9360">
                <a:solidFill>
                  <a:srgbClr val="808080"/>
                </a:solidFill>
                <a:prstDash val="solid"/>
                <a:round/>
              </a:ln>
            </p:spPr>
            <p:txBody>
              <a:bodyPr vert="horz" wrap="none" lIns="97959" tIns="50939" rIns="97959" bIns="50939" anchor="ctr" anchorCtr="0" compatLnSpc="1">
                <a:noAutofit/>
              </a:bodyPr>
              <a:lstStyle/>
              <a:p>
                <a:pPr hangingPunct="0">
                  <a:lnSpc>
                    <a:spcPct val="93000"/>
                  </a:lnSpc>
                  <a:tabLst>
                    <a:tab pos="0" algn="l"/>
                    <a:tab pos="488603" algn="l"/>
                    <a:tab pos="977600" algn="l"/>
                    <a:tab pos="1466597" algn="l"/>
                    <a:tab pos="1955594" algn="l"/>
                    <a:tab pos="2444590" algn="l"/>
                    <a:tab pos="2933586" algn="l"/>
                    <a:tab pos="3422583" algn="l"/>
                    <a:tab pos="3911579" algn="l"/>
                    <a:tab pos="4400574" algn="l"/>
                    <a:tab pos="4889572" algn="l"/>
                    <a:tab pos="5378567" algn="l"/>
                    <a:tab pos="5867564" algn="l"/>
                    <a:tab pos="6356561" algn="l"/>
                    <a:tab pos="6845557" algn="l"/>
                    <a:tab pos="7334553" algn="l"/>
                    <a:tab pos="7823550" algn="l"/>
                    <a:tab pos="8312546" algn="l"/>
                    <a:tab pos="8801541" algn="l"/>
                    <a:tab pos="9290539" algn="l"/>
                    <a:tab pos="9779535" algn="l"/>
                  </a:tabLst>
                </a:pPr>
                <a:endParaRPr lang="ru-RU" sz="1959">
                  <a:solidFill>
                    <a:srgbClr val="000000"/>
                  </a:solidFill>
                  <a:latin typeface="Arial" pitchFamily="18"/>
                  <a:ea typeface="Microsoft YaHei" pitchFamily="2"/>
                  <a:cs typeface="Microsoft YaHei" pitchFamily="2"/>
                </a:endParaRPr>
              </a:p>
            </p:txBody>
          </p:sp>
          <p:sp>
            <p:nvSpPr>
              <p:cNvPr id="286" name="Полилиния 285"/>
              <p:cNvSpPr/>
              <p:nvPr/>
            </p:nvSpPr>
            <p:spPr>
              <a:xfrm>
                <a:off x="4810092" y="798021"/>
                <a:ext cx="1366987" cy="285478"/>
              </a:xfrm>
              <a:custGeom>
                <a:avLst/>
                <a:gdLst>
                  <a:gd name="f0" fmla="val 0"/>
                  <a:gd name="f1" fmla="val 21600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</a:cxnLst>
                <a:rect l="l" t="t" r="r" b="b"/>
                <a:pathLst>
                  <a:path w="21600" h="21600">
                    <a:moveTo>
                      <a:pt x="f0" y="f0"/>
                    </a:moveTo>
                    <a:lnTo>
                      <a:pt x="f1" y="f0"/>
                    </a:lnTo>
                    <a:lnTo>
                      <a:pt x="f1" y="f1"/>
                    </a:lnTo>
                    <a:lnTo>
                      <a:pt x="f0" y="f1"/>
                    </a:lnTo>
                    <a:lnTo>
                      <a:pt x="f0" y="f0"/>
                    </a:lnTo>
                    <a:close/>
                  </a:path>
                </a:pathLst>
              </a:custGeom>
              <a:noFill/>
              <a:ln>
                <a:noFill/>
                <a:prstDash val="solid"/>
              </a:ln>
            </p:spPr>
            <p:txBody>
              <a:bodyPr vert="horz" wrap="square" lIns="97959" tIns="48980" rIns="97959" bIns="48980" anchor="t" anchorCtr="0" compatLnSpc="1">
                <a:noAutofit/>
              </a:bodyPr>
              <a:lstStyle/>
              <a:p>
                <a:pPr hangingPunct="0">
                  <a:lnSpc>
                    <a:spcPct val="93000"/>
                  </a:lnSpc>
                  <a:tabLst>
                    <a:tab pos="0" algn="l"/>
                    <a:tab pos="488603" algn="l"/>
                    <a:tab pos="977600" algn="l"/>
                    <a:tab pos="1466597" algn="l"/>
                    <a:tab pos="1955594" algn="l"/>
                    <a:tab pos="2444590" algn="l"/>
                    <a:tab pos="2933586" algn="l"/>
                    <a:tab pos="3422583" algn="l"/>
                    <a:tab pos="3911579" algn="l"/>
                    <a:tab pos="4400574" algn="l"/>
                    <a:tab pos="4889572" algn="l"/>
                    <a:tab pos="5378567" algn="l"/>
                    <a:tab pos="5867564" algn="l"/>
                    <a:tab pos="6356561" algn="l"/>
                    <a:tab pos="6845557" algn="l"/>
                    <a:tab pos="7334553" algn="l"/>
                    <a:tab pos="7823550" algn="l"/>
                    <a:tab pos="8312546" algn="l"/>
                    <a:tab pos="8801541" algn="l"/>
                    <a:tab pos="9290539" algn="l"/>
                    <a:tab pos="9779535" algn="l"/>
                  </a:tabLst>
                  <a:defRPr sz="1100"/>
                </a:pPr>
                <a:r>
                  <a:rPr lang="ru-RU" sz="1000" b="1" dirty="0" smtClean="0">
                    <a:solidFill>
                      <a:srgbClr val="000000"/>
                    </a:solidFill>
                    <a:latin typeface="Arial" pitchFamily="18"/>
                    <a:ea typeface="Microsoft YaHei" pitchFamily="2"/>
                    <a:cs typeface="Microsoft YaHei" pitchFamily="2"/>
                  </a:rPr>
                  <a:t>0h</a:t>
                </a:r>
                <a:r>
                  <a:rPr lang="en-US" sz="800" b="1" dirty="0" smtClean="0">
                    <a:solidFill>
                      <a:srgbClr val="000000"/>
                    </a:solidFill>
                    <a:latin typeface="Arial" pitchFamily="18"/>
                    <a:ea typeface="Microsoft YaHei" pitchFamily="2"/>
                    <a:cs typeface="Microsoft YaHei" pitchFamily="2"/>
                  </a:rPr>
                  <a:t> </a:t>
                </a:r>
                <a:r>
                  <a:rPr lang="ru-RU" sz="1000" b="1" dirty="0" smtClean="0">
                    <a:solidFill>
                      <a:srgbClr val="000000"/>
                    </a:solidFill>
                    <a:latin typeface="Arial" pitchFamily="18"/>
                    <a:ea typeface="Microsoft YaHei" pitchFamily="2"/>
                    <a:cs typeface="Microsoft YaHei" pitchFamily="2"/>
                  </a:rPr>
                  <a:t>4h 8h 24h</a:t>
                </a:r>
                <a:r>
                  <a:rPr lang="en-US" sz="1000" b="1" dirty="0" smtClean="0">
                    <a:solidFill>
                      <a:srgbClr val="000000"/>
                    </a:solidFill>
                    <a:latin typeface="Arial" pitchFamily="18"/>
                    <a:ea typeface="Microsoft YaHei" pitchFamily="2"/>
                    <a:cs typeface="Microsoft YaHei" pitchFamily="2"/>
                  </a:rPr>
                  <a:t> </a:t>
                </a:r>
                <a:r>
                  <a:rPr lang="ru-RU" sz="1000" b="1" dirty="0" smtClean="0">
                    <a:solidFill>
                      <a:srgbClr val="000000"/>
                    </a:solidFill>
                    <a:latin typeface="Arial" pitchFamily="18"/>
                    <a:ea typeface="Microsoft YaHei" pitchFamily="2"/>
                    <a:cs typeface="Microsoft YaHei" pitchFamily="2"/>
                  </a:rPr>
                  <a:t>3d 7d</a:t>
                </a:r>
                <a:endParaRPr lang="ru-RU" sz="1000" b="1" dirty="0">
                  <a:solidFill>
                    <a:srgbClr val="000000"/>
                  </a:solidFill>
                  <a:latin typeface="Arial" pitchFamily="18"/>
                  <a:ea typeface="Microsoft YaHei" pitchFamily="2"/>
                  <a:cs typeface="Microsoft YaHei" pitchFamily="2"/>
                </a:endParaRPr>
              </a:p>
            </p:txBody>
          </p:sp>
        </p:grpSp>
      </p:grpSp>
      <p:grpSp>
        <p:nvGrpSpPr>
          <p:cNvPr id="10" name="Группа 9"/>
          <p:cNvGrpSpPr/>
          <p:nvPr/>
        </p:nvGrpSpPr>
        <p:grpSpPr>
          <a:xfrm>
            <a:off x="560397" y="8715143"/>
            <a:ext cx="4281164" cy="2334789"/>
            <a:chOff x="579187" y="6031444"/>
            <a:chExt cx="4281164" cy="2334789"/>
          </a:xfrm>
        </p:grpSpPr>
        <p:sp>
          <p:nvSpPr>
            <p:cNvPr id="593" name="TextBox 592"/>
            <p:cNvSpPr txBox="1"/>
            <p:nvPr/>
          </p:nvSpPr>
          <p:spPr>
            <a:xfrm>
              <a:off x="579187" y="6031444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E</a:t>
              </a:r>
              <a:endParaRPr lang="ru-RU" b="1" dirty="0"/>
            </a:p>
          </p:txBody>
        </p:sp>
        <p:grpSp>
          <p:nvGrpSpPr>
            <p:cNvPr id="292" name="Группа 291"/>
            <p:cNvGrpSpPr/>
            <p:nvPr/>
          </p:nvGrpSpPr>
          <p:grpSpPr>
            <a:xfrm>
              <a:off x="847452" y="6199396"/>
              <a:ext cx="4012899" cy="2166837"/>
              <a:chOff x="4329925" y="272498"/>
              <a:chExt cx="4012899" cy="2166837"/>
            </a:xfrm>
          </p:grpSpPr>
          <p:sp>
            <p:nvSpPr>
              <p:cNvPr id="293" name="Прямоугольник 292"/>
              <p:cNvSpPr/>
              <p:nvPr/>
            </p:nvSpPr>
            <p:spPr>
              <a:xfrm>
                <a:off x="4456835" y="404357"/>
                <a:ext cx="1921436" cy="10668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pic>
            <p:nvPicPr>
              <p:cNvPr id="294" name="Рисунок 293"/>
              <p:cNvPicPr>
                <a:picLocks noChangeAspect="1"/>
              </p:cNvPicPr>
              <p:nvPr/>
            </p:nvPicPr>
            <p:blipFill>
              <a:blip r:embed="rId53">
                <a:extLst>
                  <a:ext uri="{BEBA8EAE-BF5A-486C-A8C5-ECC9F3942E4B}">
                    <a14:imgProps xmlns:a14="http://schemas.microsoft.com/office/drawing/2010/main">
                      <a14:imgLayer r:embed="rId54">
                        <a14:imgEffect>
                          <a14:brightnessContrast bright="-5000" contrast="15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440979" y="1242716"/>
                <a:ext cx="627751" cy="756000"/>
              </a:xfrm>
              <a:prstGeom prst="rect">
                <a:avLst/>
              </a:prstGeom>
            </p:spPr>
          </p:pic>
          <p:pic>
            <p:nvPicPr>
              <p:cNvPr id="295" name="Рисунок 294"/>
              <p:cNvPicPr>
                <a:picLocks noChangeAspect="1"/>
              </p:cNvPicPr>
              <p:nvPr/>
            </p:nvPicPr>
            <p:blipFill>
              <a:blip r:embed="rId55">
                <a:extLst>
                  <a:ext uri="{BEBA8EAE-BF5A-486C-A8C5-ECC9F3942E4B}">
                    <a14:imgProps xmlns:a14="http://schemas.microsoft.com/office/drawing/2010/main">
                      <a14:imgLayer r:embed="rId56">
                        <a14:imgEffect>
                          <a14:brightnessContrast bright="4000" contrast="34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5076350" y="1242716"/>
                <a:ext cx="627751" cy="756000"/>
              </a:xfrm>
              <a:prstGeom prst="rect">
                <a:avLst/>
              </a:prstGeom>
            </p:spPr>
          </p:pic>
          <p:pic>
            <p:nvPicPr>
              <p:cNvPr id="296" name="Рисунок 295"/>
              <p:cNvPicPr>
                <a:picLocks noChangeAspect="1"/>
              </p:cNvPicPr>
              <p:nvPr/>
            </p:nvPicPr>
            <p:blipFill>
              <a:blip r:embed="rId57"/>
              <a:stretch>
                <a:fillRect/>
              </a:stretch>
            </p:blipFill>
            <p:spPr>
              <a:xfrm>
                <a:off x="5711721" y="1242716"/>
                <a:ext cx="627751" cy="756000"/>
              </a:xfrm>
              <a:prstGeom prst="rect">
                <a:avLst/>
              </a:prstGeom>
            </p:spPr>
          </p:pic>
          <p:sp>
            <p:nvSpPr>
              <p:cNvPr id="297" name="Овал 296"/>
              <p:cNvSpPr/>
              <p:nvPr/>
            </p:nvSpPr>
            <p:spPr>
              <a:xfrm rot="172955">
                <a:off x="5136152" y="1346821"/>
                <a:ext cx="552551" cy="579439"/>
              </a:xfrm>
              <a:prstGeom prst="ellipse">
                <a:avLst/>
              </a:prstGeom>
              <a:noFill/>
              <a:ln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298" name="Овал 297"/>
              <p:cNvSpPr/>
              <p:nvPr/>
            </p:nvSpPr>
            <p:spPr>
              <a:xfrm rot="172955">
                <a:off x="5768612" y="1350631"/>
                <a:ext cx="552551" cy="579439"/>
              </a:xfrm>
              <a:prstGeom prst="ellipse">
                <a:avLst/>
              </a:prstGeom>
              <a:noFill/>
              <a:ln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299" name="Овал 298"/>
              <p:cNvSpPr/>
              <p:nvPr/>
            </p:nvSpPr>
            <p:spPr>
              <a:xfrm rot="172955">
                <a:off x="4496072" y="1346821"/>
                <a:ext cx="552551" cy="579439"/>
              </a:xfrm>
              <a:prstGeom prst="ellipse">
                <a:avLst/>
              </a:prstGeom>
              <a:noFill/>
              <a:ln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cxnSp>
            <p:nvCxnSpPr>
              <p:cNvPr id="300" name="Прямая соединительная линия 299"/>
              <p:cNvCxnSpPr/>
              <p:nvPr/>
            </p:nvCxnSpPr>
            <p:spPr>
              <a:xfrm>
                <a:off x="5780100" y="1644160"/>
                <a:ext cx="540000" cy="2257"/>
              </a:xfrm>
              <a:prstGeom prst="line">
                <a:avLst/>
              </a:prstGeom>
              <a:ln w="12700">
                <a:solidFill>
                  <a:srgbClr val="00B0F0"/>
                </a:solidFill>
                <a:prstDash val="sysDash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1" name="Прямая соединительная линия 300"/>
              <p:cNvCxnSpPr/>
              <p:nvPr/>
            </p:nvCxnSpPr>
            <p:spPr>
              <a:xfrm>
                <a:off x="6196827" y="1282210"/>
                <a:ext cx="108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aphicFrame>
            <p:nvGraphicFramePr>
              <p:cNvPr id="302" name="Диаграмма 30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616623347"/>
                  </p:ext>
                </p:extLst>
              </p:nvPr>
            </p:nvGraphicFramePr>
            <p:xfrm>
              <a:off x="6592712" y="1224980"/>
              <a:ext cx="1620521" cy="83835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8"/>
              </a:graphicData>
            </a:graphic>
          </p:graphicFrame>
          <p:graphicFrame>
            <p:nvGraphicFramePr>
              <p:cNvPr id="303" name="Диаграмма 30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208269736"/>
                  </p:ext>
                </p:extLst>
              </p:nvPr>
            </p:nvGraphicFramePr>
            <p:xfrm>
              <a:off x="6581661" y="272498"/>
              <a:ext cx="1620521" cy="111467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9"/>
              </a:graphicData>
            </a:graphic>
          </p:graphicFrame>
          <p:sp>
            <p:nvSpPr>
              <p:cNvPr id="304" name="TextBox 303"/>
              <p:cNvSpPr txBox="1"/>
              <p:nvPr/>
            </p:nvSpPr>
            <p:spPr>
              <a:xfrm>
                <a:off x="6518913" y="2008448"/>
                <a:ext cx="1823911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/>
                  <a:t>Distance </a:t>
                </a:r>
                <a:r>
                  <a:rPr lang="en-US" sz="1100" b="1" dirty="0" smtClean="0"/>
                  <a:t>along dotted </a:t>
                </a:r>
              </a:p>
              <a:p>
                <a:pPr algn="ctr"/>
                <a:r>
                  <a:rPr lang="en-US" sz="1100" b="1" dirty="0" smtClean="0"/>
                  <a:t>line </a:t>
                </a:r>
                <a:r>
                  <a:rPr lang="en-US" sz="1100" b="1" dirty="0"/>
                  <a:t>(pixels)</a:t>
                </a:r>
                <a:endParaRPr lang="ru-RU" sz="1100" b="1" dirty="0"/>
              </a:p>
            </p:txBody>
          </p:sp>
          <p:sp>
            <p:nvSpPr>
              <p:cNvPr id="305" name="TextBox 304"/>
              <p:cNvSpPr txBox="1"/>
              <p:nvPr/>
            </p:nvSpPr>
            <p:spPr>
              <a:xfrm rot="16200000">
                <a:off x="5969211" y="967845"/>
                <a:ext cx="11175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Intensity (</a:t>
                </a:r>
                <a:r>
                  <a:rPr lang="en-US" sz="1200" b="1" dirty="0" err="1" smtClean="0"/>
                  <a:t>a.u</a:t>
                </a:r>
                <a:r>
                  <a:rPr lang="en-US" sz="1200" b="1" dirty="0" smtClean="0"/>
                  <a:t>.)</a:t>
                </a:r>
                <a:endParaRPr lang="ru-RU" sz="1200" b="1" dirty="0"/>
              </a:p>
            </p:txBody>
          </p:sp>
          <p:sp>
            <p:nvSpPr>
              <p:cNvPr id="306" name="TextBox 305"/>
              <p:cNvSpPr txBox="1"/>
              <p:nvPr/>
            </p:nvSpPr>
            <p:spPr>
              <a:xfrm>
                <a:off x="4329925" y="280088"/>
                <a:ext cx="85926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solidFill>
                      <a:srgbClr val="00B050"/>
                    </a:solidFill>
                  </a:rPr>
                  <a:t>GFP-Rnq1</a:t>
                </a:r>
                <a:endParaRPr lang="ru-RU" sz="1200" b="1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307" name="TextBox 306"/>
              <p:cNvSpPr txBox="1"/>
              <p:nvPr/>
            </p:nvSpPr>
            <p:spPr>
              <a:xfrm>
                <a:off x="5741488" y="289232"/>
                <a:ext cx="5979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solidFill>
                      <a:srgbClr val="FFC000"/>
                    </a:solidFill>
                  </a:rPr>
                  <a:t>Merge</a:t>
                </a:r>
                <a:endParaRPr lang="ru-RU" sz="1200" b="1" dirty="0">
                  <a:solidFill>
                    <a:srgbClr val="FFC000"/>
                  </a:solidFill>
                </a:endParaRPr>
              </a:p>
            </p:txBody>
          </p:sp>
          <p:sp>
            <p:nvSpPr>
              <p:cNvPr id="308" name="TextBox 307"/>
              <p:cNvSpPr txBox="1"/>
              <p:nvPr/>
            </p:nvSpPr>
            <p:spPr>
              <a:xfrm>
                <a:off x="4997563" y="280308"/>
                <a:ext cx="85119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 smtClean="0">
                    <a:solidFill>
                      <a:srgbClr val="FF0000"/>
                    </a:solidFill>
                  </a:rPr>
                  <a:t>Proteostat</a:t>
                </a:r>
                <a:endParaRPr lang="ru-RU" sz="1200" b="1" dirty="0">
                  <a:solidFill>
                    <a:srgbClr val="FF0000"/>
                  </a:solidFill>
                </a:endParaRPr>
              </a:p>
            </p:txBody>
          </p:sp>
          <p:cxnSp>
            <p:nvCxnSpPr>
              <p:cNvPr id="309" name="Прямая соединительная линия 308"/>
              <p:cNvCxnSpPr/>
              <p:nvPr/>
            </p:nvCxnSpPr>
            <p:spPr>
              <a:xfrm flipH="1">
                <a:off x="5074913" y="1152040"/>
                <a:ext cx="0" cy="886432"/>
              </a:xfrm>
              <a:prstGeom prst="line">
                <a:avLst/>
              </a:prstGeom>
              <a:ln w="158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0" name="Прямая соединительная линия 309"/>
              <p:cNvCxnSpPr/>
              <p:nvPr/>
            </p:nvCxnSpPr>
            <p:spPr>
              <a:xfrm flipH="1">
                <a:off x="5714326" y="1165294"/>
                <a:ext cx="0" cy="886432"/>
              </a:xfrm>
              <a:prstGeom prst="line">
                <a:avLst/>
              </a:prstGeom>
              <a:ln w="158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1" name="Прямая соединительная линия 310"/>
              <p:cNvCxnSpPr/>
              <p:nvPr/>
            </p:nvCxnSpPr>
            <p:spPr>
              <a:xfrm flipH="1">
                <a:off x="5714331" y="495395"/>
                <a:ext cx="0" cy="886432"/>
              </a:xfrm>
              <a:prstGeom prst="line">
                <a:avLst/>
              </a:prstGeom>
              <a:ln w="158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12" name="Группа 311"/>
              <p:cNvGrpSpPr/>
              <p:nvPr/>
            </p:nvGrpSpPr>
            <p:grpSpPr>
              <a:xfrm>
                <a:off x="4440979" y="499472"/>
                <a:ext cx="1951617" cy="723810"/>
                <a:chOff x="4440979" y="2047225"/>
                <a:chExt cx="1951617" cy="723810"/>
              </a:xfrm>
            </p:grpSpPr>
            <p:pic>
              <p:nvPicPr>
                <p:cNvPr id="313" name="Рисунок 312"/>
                <p:cNvPicPr>
                  <a:picLocks noChangeAspect="1"/>
                </p:cNvPicPr>
                <p:nvPr/>
              </p:nvPicPr>
              <p:blipFill rotWithShape="1">
                <a:blip r:embed="rId60">
                  <a:extLst>
                    <a:ext uri="{BEBA8EAE-BF5A-486C-A8C5-ECC9F3942E4B}">
                      <a14:imgProps xmlns:a14="http://schemas.microsoft.com/office/drawing/2010/main">
                        <a14:imgLayer r:embed="rId61">
                          <a14:imgEffect>
                            <a14:brightnessContrast bright="23000" contrast="20000"/>
                          </a14:imgEffect>
                        </a14:imgLayer>
                      </a14:imgProps>
                    </a:ext>
                  </a:extLst>
                </a:blip>
                <a:srcRect l="8223" r="8673"/>
                <a:stretch/>
              </p:blipFill>
              <p:spPr>
                <a:xfrm>
                  <a:off x="4440979" y="2060764"/>
                  <a:ext cx="609601" cy="693517"/>
                </a:xfrm>
                <a:prstGeom prst="rect">
                  <a:avLst/>
                </a:prstGeom>
              </p:spPr>
            </p:pic>
            <p:pic>
              <p:nvPicPr>
                <p:cNvPr id="314" name="Рисунок 313"/>
                <p:cNvPicPr>
                  <a:picLocks noChangeAspect="1"/>
                </p:cNvPicPr>
                <p:nvPr/>
              </p:nvPicPr>
              <p:blipFill rotWithShape="1">
                <a:blip r:embed="rId62">
                  <a:extLst>
                    <a:ext uri="{BEBA8EAE-BF5A-486C-A8C5-ECC9F3942E4B}">
                      <a14:imgProps xmlns:a14="http://schemas.microsoft.com/office/drawing/2010/main">
                        <a14:imgLayer r:embed="rId63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</a:extLst>
                </a:blip>
                <a:srcRect l="7907" r="7429"/>
                <a:stretch/>
              </p:blipFill>
              <p:spPr>
                <a:xfrm>
                  <a:off x="5065820" y="2060764"/>
                  <a:ext cx="621030" cy="693517"/>
                </a:xfrm>
                <a:prstGeom prst="rect">
                  <a:avLst/>
                </a:prstGeom>
              </p:spPr>
            </p:pic>
            <p:pic>
              <p:nvPicPr>
                <p:cNvPr id="315" name="Рисунок 314"/>
                <p:cNvPicPr>
                  <a:picLocks noChangeAspect="1"/>
                </p:cNvPicPr>
                <p:nvPr/>
              </p:nvPicPr>
              <p:blipFill rotWithShape="1">
                <a:blip r:embed="rId64">
                  <a:extLst>
                    <a:ext uri="{BEBA8EAE-BF5A-486C-A8C5-ECC9F3942E4B}">
                      <a14:imgProps xmlns:a14="http://schemas.microsoft.com/office/drawing/2010/main">
                        <a14:imgLayer r:embed="rId65">
                          <a14:imgEffect>
                            <a14:brightnessContrast bright="21000" contrast="17000"/>
                          </a14:imgEffect>
                        </a14:imgLayer>
                      </a14:imgProps>
                    </a:ext>
                  </a:extLst>
                </a:blip>
                <a:srcRect l="6160" r="-5039"/>
                <a:stretch/>
              </p:blipFill>
              <p:spPr>
                <a:xfrm>
                  <a:off x="5702090" y="2060763"/>
                  <a:ext cx="690506" cy="693517"/>
                </a:xfrm>
                <a:prstGeom prst="rect">
                  <a:avLst/>
                </a:prstGeom>
              </p:spPr>
            </p:pic>
            <p:sp>
              <p:nvSpPr>
                <p:cNvPr id="316" name="Овал 315"/>
                <p:cNvSpPr/>
                <p:nvPr/>
              </p:nvSpPr>
              <p:spPr>
                <a:xfrm>
                  <a:off x="4505617" y="2175510"/>
                  <a:ext cx="491946" cy="498940"/>
                </a:xfrm>
                <a:prstGeom prst="ellipse">
                  <a:avLst/>
                </a:prstGeom>
                <a:noFill/>
                <a:ln>
                  <a:solidFill>
                    <a:schemeClr val="bg1"/>
                  </a:solidFill>
                  <a:prstDash val="sys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317" name="Овал 316"/>
                <p:cNvSpPr/>
                <p:nvPr/>
              </p:nvSpPr>
              <p:spPr>
                <a:xfrm>
                  <a:off x="5134531" y="2165671"/>
                  <a:ext cx="491946" cy="498940"/>
                </a:xfrm>
                <a:prstGeom prst="ellipse">
                  <a:avLst/>
                </a:prstGeom>
                <a:noFill/>
                <a:ln>
                  <a:solidFill>
                    <a:schemeClr val="bg1"/>
                  </a:solidFill>
                  <a:prstDash val="sys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318" name="Овал 317"/>
                <p:cNvSpPr/>
                <p:nvPr/>
              </p:nvSpPr>
              <p:spPr>
                <a:xfrm>
                  <a:off x="5774121" y="2165255"/>
                  <a:ext cx="491946" cy="498940"/>
                </a:xfrm>
                <a:prstGeom prst="ellipse">
                  <a:avLst/>
                </a:prstGeom>
                <a:noFill/>
                <a:ln>
                  <a:solidFill>
                    <a:schemeClr val="bg1"/>
                  </a:solidFill>
                  <a:prstDash val="sys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cxnSp>
              <p:nvCxnSpPr>
                <p:cNvPr id="319" name="Прямая соединительная линия 318"/>
                <p:cNvCxnSpPr/>
                <p:nvPr/>
              </p:nvCxnSpPr>
              <p:spPr>
                <a:xfrm>
                  <a:off x="5816977" y="2213584"/>
                  <a:ext cx="480060" cy="225573"/>
                </a:xfrm>
                <a:prstGeom prst="line">
                  <a:avLst/>
                </a:prstGeom>
                <a:ln w="12700">
                  <a:solidFill>
                    <a:srgbClr val="00B0F0"/>
                  </a:solidFill>
                  <a:prstDash val="sysDot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0" name="Прямая соединительная линия 319"/>
                <p:cNvCxnSpPr/>
                <p:nvPr/>
              </p:nvCxnSpPr>
              <p:spPr>
                <a:xfrm>
                  <a:off x="6222867" y="2107239"/>
                  <a:ext cx="972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1" name="Прямая соединительная линия 320"/>
                <p:cNvCxnSpPr/>
                <p:nvPr/>
              </p:nvCxnSpPr>
              <p:spPr>
                <a:xfrm flipH="1">
                  <a:off x="5062844" y="2051035"/>
                  <a:ext cx="0" cy="720000"/>
                </a:xfrm>
                <a:prstGeom prst="line">
                  <a:avLst/>
                </a:prstGeom>
                <a:ln w="1587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2" name="Прямая соединительная линия 321"/>
                <p:cNvCxnSpPr/>
                <p:nvPr/>
              </p:nvCxnSpPr>
              <p:spPr>
                <a:xfrm flipH="1">
                  <a:off x="5695304" y="2047225"/>
                  <a:ext cx="0" cy="720000"/>
                </a:xfrm>
                <a:prstGeom prst="line">
                  <a:avLst/>
                </a:prstGeom>
                <a:ln w="1587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548" name="Группа 547"/>
          <p:cNvGrpSpPr/>
          <p:nvPr/>
        </p:nvGrpSpPr>
        <p:grpSpPr>
          <a:xfrm>
            <a:off x="645096" y="11403863"/>
            <a:ext cx="4378702" cy="2937360"/>
            <a:chOff x="645096" y="11403863"/>
            <a:chExt cx="4378702" cy="2937360"/>
          </a:xfrm>
        </p:grpSpPr>
        <p:sp>
          <p:nvSpPr>
            <p:cNvPr id="590" name="TextBox 589"/>
            <p:cNvSpPr txBox="1"/>
            <p:nvPr/>
          </p:nvSpPr>
          <p:spPr>
            <a:xfrm>
              <a:off x="645096" y="11414674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F</a:t>
              </a:r>
              <a:endParaRPr lang="ru-RU" b="1" dirty="0"/>
            </a:p>
          </p:txBody>
        </p:sp>
        <p:grpSp>
          <p:nvGrpSpPr>
            <p:cNvPr id="540" name="Группа 539"/>
            <p:cNvGrpSpPr/>
            <p:nvPr/>
          </p:nvGrpSpPr>
          <p:grpSpPr>
            <a:xfrm>
              <a:off x="2867780" y="11403863"/>
              <a:ext cx="2156018" cy="2870627"/>
              <a:chOff x="2886570" y="8720164"/>
              <a:chExt cx="2156018" cy="2870627"/>
            </a:xfrm>
          </p:grpSpPr>
          <p:grpSp>
            <p:nvGrpSpPr>
              <p:cNvPr id="521" name="Группа 520"/>
              <p:cNvGrpSpPr/>
              <p:nvPr/>
            </p:nvGrpSpPr>
            <p:grpSpPr>
              <a:xfrm>
                <a:off x="2886570" y="8967590"/>
                <a:ext cx="2156018" cy="2623201"/>
                <a:chOff x="2886570" y="8967590"/>
                <a:chExt cx="2156018" cy="2623201"/>
              </a:xfrm>
            </p:grpSpPr>
            <p:grpSp>
              <p:nvGrpSpPr>
                <p:cNvPr id="187" name="Группа 186"/>
                <p:cNvGrpSpPr/>
                <p:nvPr/>
              </p:nvGrpSpPr>
              <p:grpSpPr>
                <a:xfrm>
                  <a:off x="2959460" y="8996175"/>
                  <a:ext cx="2083128" cy="2594616"/>
                  <a:chOff x="4862561" y="954473"/>
                  <a:chExt cx="2083128" cy="2594616"/>
                </a:xfrm>
              </p:grpSpPr>
              <p:grpSp>
                <p:nvGrpSpPr>
                  <p:cNvPr id="189" name="Группа 188"/>
                  <p:cNvGrpSpPr/>
                  <p:nvPr/>
                </p:nvGrpSpPr>
                <p:grpSpPr>
                  <a:xfrm>
                    <a:off x="4862561" y="954473"/>
                    <a:ext cx="760705" cy="781126"/>
                    <a:chOff x="1390458" y="1932240"/>
                    <a:chExt cx="1135380" cy="1165860"/>
                  </a:xfrm>
                </p:grpSpPr>
                <p:pic>
                  <p:nvPicPr>
                    <p:cNvPr id="208" name="Рисунок 207"/>
                    <p:cNvPicPr>
                      <a:picLocks noChangeAspect="1"/>
                    </p:cNvPicPr>
                    <p:nvPr/>
                  </p:nvPicPr>
                  <p:blipFill>
                    <a:blip r:embed="rId66">
                      <a:extLst>
                        <a:ext uri="{BEBA8EAE-BF5A-486C-A8C5-ECC9F3942E4B}">
                          <a14:imgProps xmlns:a14="http://schemas.microsoft.com/office/drawing/2010/main">
                            <a14:imgLayer r:embed="rId67">
                              <a14:imgEffect>
                                <a14:brightnessContrast bright="20000" contrast="10000"/>
                              </a14:imgEffect>
                            </a14:imgLayer>
                          </a14:imgProps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390458" y="1932240"/>
                      <a:ext cx="1135380" cy="1165860"/>
                    </a:xfrm>
                    <a:prstGeom prst="rect">
                      <a:avLst/>
                    </a:prstGeom>
                  </p:spPr>
                </p:pic>
                <p:cxnSp>
                  <p:nvCxnSpPr>
                    <p:cNvPr id="209" name="Прямая соединительная линия 208"/>
                    <p:cNvCxnSpPr/>
                    <p:nvPr/>
                  </p:nvCxnSpPr>
                  <p:spPr>
                    <a:xfrm>
                      <a:off x="1620078" y="2594113"/>
                      <a:ext cx="636105" cy="99391"/>
                    </a:xfrm>
                    <a:prstGeom prst="line">
                      <a:avLst/>
                    </a:prstGeom>
                    <a:ln w="6350">
                      <a:solidFill>
                        <a:schemeClr val="bg1">
                          <a:alpha val="50000"/>
                        </a:schemeClr>
                      </a:solidFill>
                      <a:prstDash val="sysDash"/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90" name="Группа 189"/>
                  <p:cNvGrpSpPr/>
                  <p:nvPr/>
                </p:nvGrpSpPr>
                <p:grpSpPr>
                  <a:xfrm>
                    <a:off x="4862561" y="1755577"/>
                    <a:ext cx="760705" cy="781126"/>
                    <a:chOff x="1390457" y="3486720"/>
                    <a:chExt cx="1135380" cy="1165860"/>
                  </a:xfrm>
                </p:grpSpPr>
                <p:pic>
                  <p:nvPicPr>
                    <p:cNvPr id="206" name="Рисунок 205"/>
                    <p:cNvPicPr>
                      <a:picLocks noChangeAspect="1"/>
                    </p:cNvPicPr>
                    <p:nvPr/>
                  </p:nvPicPr>
                  <p:blipFill>
                    <a:blip r:embed="rId68">
                      <a:extLst>
                        <a:ext uri="{BEBA8EAE-BF5A-486C-A8C5-ECC9F3942E4B}">
                          <a14:imgProps xmlns:a14="http://schemas.microsoft.com/office/drawing/2010/main">
                            <a14:imgLayer r:embed="rId69">
                              <a14:imgEffect>
                                <a14:brightnessContrast contrast="-5000"/>
                              </a14:imgEffect>
                            </a14:imgLayer>
                          </a14:imgProps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390457" y="3486720"/>
                      <a:ext cx="1135380" cy="1165860"/>
                    </a:xfrm>
                    <a:prstGeom prst="rect">
                      <a:avLst/>
                    </a:prstGeom>
                  </p:spPr>
                </p:pic>
                <p:cxnSp>
                  <p:nvCxnSpPr>
                    <p:cNvPr id="207" name="Прямая соединительная линия 206"/>
                    <p:cNvCxnSpPr/>
                    <p:nvPr/>
                  </p:nvCxnSpPr>
                  <p:spPr>
                    <a:xfrm>
                      <a:off x="1620078" y="3759973"/>
                      <a:ext cx="765313" cy="309677"/>
                    </a:xfrm>
                    <a:prstGeom prst="line">
                      <a:avLst/>
                    </a:prstGeom>
                    <a:ln w="6350">
                      <a:solidFill>
                        <a:schemeClr val="bg1">
                          <a:alpha val="50000"/>
                        </a:schemeClr>
                      </a:solidFill>
                      <a:prstDash val="sysDash"/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91" name="Группа 190"/>
                  <p:cNvGrpSpPr/>
                  <p:nvPr/>
                </p:nvGrpSpPr>
                <p:grpSpPr>
                  <a:xfrm>
                    <a:off x="4862561" y="2548890"/>
                    <a:ext cx="760705" cy="716280"/>
                    <a:chOff x="3008945" y="1920613"/>
                    <a:chExt cx="1135380" cy="1069075"/>
                  </a:xfrm>
                </p:grpSpPr>
                <p:pic>
                  <p:nvPicPr>
                    <p:cNvPr id="204" name="Рисунок 203"/>
                    <p:cNvPicPr>
                      <a:picLocks noChangeAspect="1"/>
                    </p:cNvPicPr>
                    <p:nvPr/>
                  </p:nvPicPr>
                  <p:blipFill rotWithShape="1">
                    <a:blip r:embed="rId70">
                      <a:extLst>
                        <a:ext uri="{BEBA8EAE-BF5A-486C-A8C5-ECC9F3942E4B}">
                          <a14:imgProps xmlns:a14="http://schemas.microsoft.com/office/drawing/2010/main">
                            <a14:imgLayer r:embed="rId71">
                              <a14:imgEffect>
                                <a14:brightnessContrast bright="30000" contrast="10000"/>
                              </a14:imgEffect>
                            </a14:imgLayer>
                          </a14:imgProps>
                        </a:ext>
                      </a:extLst>
                    </a:blip>
                    <a:srcRect t="-997" b="9299"/>
                    <a:stretch/>
                  </p:blipFill>
                  <p:spPr>
                    <a:xfrm>
                      <a:off x="3008945" y="1920613"/>
                      <a:ext cx="1135380" cy="1069075"/>
                    </a:xfrm>
                    <a:prstGeom prst="rect">
                      <a:avLst/>
                    </a:prstGeom>
                  </p:spPr>
                </p:pic>
                <p:cxnSp>
                  <p:nvCxnSpPr>
                    <p:cNvPr id="205" name="Прямая соединительная линия 204"/>
                    <p:cNvCxnSpPr/>
                    <p:nvPr/>
                  </p:nvCxnSpPr>
                  <p:spPr>
                    <a:xfrm flipH="1">
                      <a:off x="3424070" y="2247013"/>
                      <a:ext cx="159025" cy="588198"/>
                    </a:xfrm>
                    <a:prstGeom prst="line">
                      <a:avLst/>
                    </a:prstGeom>
                    <a:ln w="6350">
                      <a:solidFill>
                        <a:schemeClr val="bg1">
                          <a:alpha val="50000"/>
                        </a:schemeClr>
                      </a:solidFill>
                      <a:prstDash val="sysDash"/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aphicFrame>
                <p:nvGraphicFramePr>
                  <p:cNvPr id="193" name="Диаграмма 192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787276398"/>
                      </p:ext>
                    </p:extLst>
                  </p:nvPr>
                </p:nvGraphicFramePr>
                <p:xfrm>
                  <a:off x="5560820" y="996408"/>
                  <a:ext cx="1244059" cy="800709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72"/>
                  </a:graphicData>
                </a:graphic>
              </p:graphicFrame>
              <p:graphicFrame>
                <p:nvGraphicFramePr>
                  <p:cNvPr id="194" name="Диаграмма 193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539216209"/>
                      </p:ext>
                    </p:extLst>
                  </p:nvPr>
                </p:nvGraphicFramePr>
                <p:xfrm>
                  <a:off x="5632605" y="1817666"/>
                  <a:ext cx="1166251" cy="692128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73"/>
                  </a:graphicData>
                </a:graphic>
              </p:graphicFrame>
              <p:graphicFrame>
                <p:nvGraphicFramePr>
                  <p:cNvPr id="195" name="Диаграмма 194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3280114615"/>
                      </p:ext>
                    </p:extLst>
                  </p:nvPr>
                </p:nvGraphicFramePr>
                <p:xfrm>
                  <a:off x="5623266" y="2536703"/>
                  <a:ext cx="1103586" cy="697713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74"/>
                  </a:graphicData>
                </a:graphic>
              </p:graphicFrame>
              <p:sp>
                <p:nvSpPr>
                  <p:cNvPr id="197" name="Овал 196"/>
                  <p:cNvSpPr/>
                  <p:nvPr/>
                </p:nvSpPr>
                <p:spPr>
                  <a:xfrm rot="556594">
                    <a:off x="4974447" y="1087182"/>
                    <a:ext cx="596678" cy="472176"/>
                  </a:xfrm>
                  <a:prstGeom prst="ellipse">
                    <a:avLst/>
                  </a:prstGeom>
                  <a:noFill/>
                  <a:ln w="6350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ru-RU"/>
                  </a:p>
                </p:txBody>
              </p:sp>
              <p:sp>
                <p:nvSpPr>
                  <p:cNvPr id="198" name="Овал 197"/>
                  <p:cNvSpPr/>
                  <p:nvPr/>
                </p:nvSpPr>
                <p:spPr>
                  <a:xfrm rot="18873732">
                    <a:off x="5026374" y="1891511"/>
                    <a:ext cx="466145" cy="562187"/>
                  </a:xfrm>
                  <a:prstGeom prst="ellipse">
                    <a:avLst/>
                  </a:prstGeom>
                  <a:noFill/>
                  <a:ln w="6350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ru-RU"/>
                  </a:p>
                </p:txBody>
              </p:sp>
              <p:sp>
                <p:nvSpPr>
                  <p:cNvPr id="199" name="Овал 198"/>
                  <p:cNvSpPr/>
                  <p:nvPr/>
                </p:nvSpPr>
                <p:spPr>
                  <a:xfrm>
                    <a:off x="5029724" y="2767578"/>
                    <a:ext cx="486123" cy="435389"/>
                  </a:xfrm>
                  <a:prstGeom prst="ellipse">
                    <a:avLst/>
                  </a:prstGeom>
                  <a:noFill/>
                  <a:ln w="6350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ru-RU"/>
                  </a:p>
                </p:txBody>
              </p:sp>
              <p:cxnSp>
                <p:nvCxnSpPr>
                  <p:cNvPr id="200" name="Прямая соединительная линия 199"/>
                  <p:cNvCxnSpPr/>
                  <p:nvPr/>
                </p:nvCxnSpPr>
                <p:spPr>
                  <a:xfrm flipV="1">
                    <a:off x="5463658" y="998620"/>
                    <a:ext cx="115776" cy="0"/>
                  </a:xfrm>
                  <a:prstGeom prst="line">
                    <a:avLst/>
                  </a:prstGeom>
                  <a:ln w="1905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01" name="TextBox 200"/>
                  <p:cNvSpPr txBox="1"/>
                  <p:nvPr/>
                </p:nvSpPr>
                <p:spPr>
                  <a:xfrm>
                    <a:off x="5333458" y="3179757"/>
                    <a:ext cx="147946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 smtClean="0"/>
                      <a:t>Distance along </a:t>
                    </a:r>
                  </a:p>
                  <a:p>
                    <a:pPr algn="ctr"/>
                    <a:r>
                      <a:rPr lang="en-US" sz="900" b="1" dirty="0" smtClean="0"/>
                      <a:t>dotted line (pixels)</a:t>
                    </a:r>
                    <a:endParaRPr lang="ru-RU" sz="900" b="1" dirty="0"/>
                  </a:p>
                </p:txBody>
              </p:sp>
              <p:cxnSp>
                <p:nvCxnSpPr>
                  <p:cNvPr id="202" name="Прямая соединительная линия 201"/>
                  <p:cNvCxnSpPr/>
                  <p:nvPr/>
                </p:nvCxnSpPr>
                <p:spPr>
                  <a:xfrm>
                    <a:off x="6713700" y="1054160"/>
                    <a:ext cx="0" cy="205200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03" name="TextBox 202"/>
                  <p:cNvSpPr txBox="1"/>
                  <p:nvPr/>
                </p:nvSpPr>
                <p:spPr>
                  <a:xfrm rot="5400000">
                    <a:off x="6148676" y="2034179"/>
                    <a:ext cx="1332416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100" b="1" dirty="0" smtClean="0"/>
                      <a:t>GFP intensity (a. u.)</a:t>
                    </a:r>
                    <a:endParaRPr lang="ru-RU" sz="1100" b="1" dirty="0"/>
                  </a:p>
                </p:txBody>
              </p:sp>
            </p:grpSp>
            <p:sp>
              <p:nvSpPr>
                <p:cNvPr id="516" name="Прямоугольник 515"/>
                <p:cNvSpPr/>
                <p:nvPr/>
              </p:nvSpPr>
              <p:spPr>
                <a:xfrm>
                  <a:off x="2886570" y="8967590"/>
                  <a:ext cx="141314" cy="2339282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</p:grpSp>
          <p:cxnSp>
            <p:nvCxnSpPr>
              <p:cNvPr id="523" name="Прямая соединительная линия 522"/>
              <p:cNvCxnSpPr/>
              <p:nvPr/>
            </p:nvCxnSpPr>
            <p:spPr>
              <a:xfrm>
                <a:off x="3037120" y="8946565"/>
                <a:ext cx="17618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4" name="TextBox 523"/>
              <p:cNvSpPr txBox="1"/>
              <p:nvPr/>
            </p:nvSpPr>
            <p:spPr>
              <a:xfrm>
                <a:off x="3481230" y="8720164"/>
                <a:ext cx="94128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 smtClean="0"/>
                  <a:t>Mot3PD-GFP</a:t>
                </a:r>
                <a:endParaRPr lang="ru-RU" sz="1100" b="1" dirty="0"/>
              </a:p>
            </p:txBody>
          </p:sp>
        </p:grpSp>
        <p:grpSp>
          <p:nvGrpSpPr>
            <p:cNvPr id="541" name="Группа 540"/>
            <p:cNvGrpSpPr/>
            <p:nvPr/>
          </p:nvGrpSpPr>
          <p:grpSpPr>
            <a:xfrm>
              <a:off x="769100" y="11408721"/>
              <a:ext cx="2232927" cy="2932502"/>
              <a:chOff x="787890" y="8725022"/>
              <a:chExt cx="2232927" cy="2932502"/>
            </a:xfrm>
          </p:grpSpPr>
          <p:sp>
            <p:nvSpPr>
              <p:cNvPr id="324" name="TextBox 323"/>
              <p:cNvSpPr txBox="1"/>
              <p:nvPr/>
            </p:nvSpPr>
            <p:spPr>
              <a:xfrm>
                <a:off x="905068" y="11288192"/>
                <a:ext cx="147946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b="1" dirty="0" smtClean="0"/>
                  <a:t>Distance along </a:t>
                </a:r>
              </a:p>
              <a:p>
                <a:pPr algn="ctr"/>
                <a:r>
                  <a:rPr lang="en-US" sz="900" b="1" dirty="0" smtClean="0"/>
                  <a:t>dotted line (pixels)</a:t>
                </a:r>
                <a:endParaRPr lang="ru-RU" sz="900" b="1" dirty="0"/>
              </a:p>
            </p:txBody>
          </p:sp>
          <p:cxnSp>
            <p:nvCxnSpPr>
              <p:cNvPr id="325" name="Прямая соединительная линия 324"/>
              <p:cNvCxnSpPr/>
              <p:nvPr/>
            </p:nvCxnSpPr>
            <p:spPr>
              <a:xfrm>
                <a:off x="1109848" y="8944025"/>
                <a:ext cx="17618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6" name="TextBox 325"/>
              <p:cNvSpPr txBox="1"/>
              <p:nvPr/>
            </p:nvSpPr>
            <p:spPr>
              <a:xfrm>
                <a:off x="1588936" y="8725022"/>
                <a:ext cx="76014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 smtClean="0"/>
                  <a:t>GFP-Rnq1</a:t>
                </a:r>
                <a:endParaRPr lang="ru-RU" sz="1100" b="1" dirty="0"/>
              </a:p>
            </p:txBody>
          </p:sp>
          <p:grpSp>
            <p:nvGrpSpPr>
              <p:cNvPr id="538" name="Группа 537"/>
              <p:cNvGrpSpPr/>
              <p:nvPr/>
            </p:nvGrpSpPr>
            <p:grpSpPr>
              <a:xfrm>
                <a:off x="976272" y="9013494"/>
                <a:ext cx="1297763" cy="2413646"/>
                <a:chOff x="1555148" y="9013157"/>
                <a:chExt cx="1297763" cy="2413646"/>
              </a:xfrm>
            </p:grpSpPr>
            <p:graphicFrame>
              <p:nvGraphicFramePr>
                <p:cNvPr id="348" name="Диаграмма 347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890210630"/>
                    </p:ext>
                  </p:extLst>
                </p:nvPr>
              </p:nvGraphicFramePr>
              <p:xfrm>
                <a:off x="1662709" y="9013157"/>
                <a:ext cx="1167545" cy="757413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5"/>
                </a:graphicData>
              </a:graphic>
            </p:graphicFrame>
            <p:graphicFrame>
              <p:nvGraphicFramePr>
                <p:cNvPr id="349" name="Диаграмма 348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397964956"/>
                    </p:ext>
                  </p:extLst>
                </p:nvPr>
              </p:nvGraphicFramePr>
              <p:xfrm>
                <a:off x="1599833" y="9778578"/>
                <a:ext cx="1232336" cy="871455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6"/>
                </a:graphicData>
              </a:graphic>
            </p:graphicFrame>
            <p:graphicFrame>
              <p:nvGraphicFramePr>
                <p:cNvPr id="351" name="Диаграмма 350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092001429"/>
                    </p:ext>
                  </p:extLst>
                </p:nvPr>
              </p:nvGraphicFramePr>
              <p:xfrm>
                <a:off x="1555148" y="10499249"/>
                <a:ext cx="1297763" cy="92755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7"/>
                </a:graphicData>
              </a:graphic>
            </p:graphicFrame>
          </p:grpSp>
          <p:grpSp>
            <p:nvGrpSpPr>
              <p:cNvPr id="537" name="Группа 536"/>
              <p:cNvGrpSpPr/>
              <p:nvPr/>
            </p:nvGrpSpPr>
            <p:grpSpPr>
              <a:xfrm>
                <a:off x="2168266" y="8984044"/>
                <a:ext cx="852551" cy="2339282"/>
                <a:chOff x="765633" y="8975210"/>
                <a:chExt cx="852551" cy="2339282"/>
              </a:xfrm>
            </p:grpSpPr>
            <p:grpSp>
              <p:nvGrpSpPr>
                <p:cNvPr id="517" name="Группа 516"/>
                <p:cNvGrpSpPr/>
                <p:nvPr/>
              </p:nvGrpSpPr>
              <p:grpSpPr>
                <a:xfrm>
                  <a:off x="765633" y="8975210"/>
                  <a:ext cx="852551" cy="2339282"/>
                  <a:chOff x="765633" y="8975210"/>
                  <a:chExt cx="852551" cy="2339282"/>
                </a:xfrm>
              </p:grpSpPr>
              <p:grpSp>
                <p:nvGrpSpPr>
                  <p:cNvPr id="515" name="Группа 514"/>
                  <p:cNvGrpSpPr/>
                  <p:nvPr/>
                </p:nvGrpSpPr>
                <p:grpSpPr>
                  <a:xfrm>
                    <a:off x="765633" y="8990909"/>
                    <a:ext cx="762000" cy="2307514"/>
                    <a:chOff x="1726667" y="9016630"/>
                    <a:chExt cx="762000" cy="2307514"/>
                  </a:xfrm>
                </p:grpSpPr>
                <p:grpSp>
                  <p:nvGrpSpPr>
                    <p:cNvPr id="9" name="Группа 8"/>
                    <p:cNvGrpSpPr/>
                    <p:nvPr/>
                  </p:nvGrpSpPr>
                  <p:grpSpPr>
                    <a:xfrm>
                      <a:off x="1726667" y="10615483"/>
                      <a:ext cx="762000" cy="708661"/>
                      <a:chOff x="5678359" y="13002310"/>
                      <a:chExt cx="762000" cy="708661"/>
                    </a:xfrm>
                  </p:grpSpPr>
                  <p:pic>
                    <p:nvPicPr>
                      <p:cNvPr id="29" name="Рисунок 28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78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79">
                                <a14:imgEffect>
                                  <a14:brightnessContrast bright="35000" contrast="20000"/>
                                </a14:imgEffect>
                              </a14:imgLayer>
                            </a14:imgProps>
                          </a:ext>
                        </a:extLst>
                      </a:blip>
                      <a:srcRect l="16202" t="15769" r="9642" b="12803"/>
                      <a:stretch/>
                    </p:blipFill>
                    <p:spPr>
                      <a:xfrm>
                        <a:off x="5678359" y="13002310"/>
                        <a:ext cx="762000" cy="708661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289" name="Овал 288"/>
                      <p:cNvSpPr/>
                      <p:nvPr/>
                    </p:nvSpPr>
                    <p:spPr>
                      <a:xfrm>
                        <a:off x="5762328" y="13053059"/>
                        <a:ext cx="512417" cy="582085"/>
                      </a:xfrm>
                      <a:prstGeom prst="ellipse">
                        <a:avLst/>
                      </a:prstGeom>
                      <a:noFill/>
                      <a:ln w="6350">
                        <a:solidFill>
                          <a:schemeClr val="bg1"/>
                        </a:solidFill>
                        <a:prstDash val="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ru-RU"/>
                      </a:p>
                    </p:txBody>
                  </p:sp>
                </p:grpSp>
                <p:grpSp>
                  <p:nvGrpSpPr>
                    <p:cNvPr id="512" name="Группа 511"/>
                    <p:cNvGrpSpPr/>
                    <p:nvPr/>
                  </p:nvGrpSpPr>
                  <p:grpSpPr>
                    <a:xfrm>
                      <a:off x="1730657" y="9813932"/>
                      <a:ext cx="755904" cy="779526"/>
                      <a:chOff x="5678359" y="12129193"/>
                      <a:chExt cx="755904" cy="779526"/>
                    </a:xfrm>
                  </p:grpSpPr>
                  <p:pic>
                    <p:nvPicPr>
                      <p:cNvPr id="24" name="Рисунок 23"/>
                      <p:cNvPicPr>
                        <a:picLocks noChangeAspect="1"/>
                      </p:cNvPicPr>
                      <p:nvPr/>
                    </p:nvPicPr>
                    <p:blipFill>
                      <a:blip r:embed="rId80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81">
                                <a14:imgEffect>
                                  <a14:brightnessContrast bright="40000" contrast="30000"/>
                                </a14:imgEffect>
                              </a14:imgLayer>
                            </a14:imgProps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5678359" y="12129193"/>
                        <a:ext cx="755904" cy="779526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290" name="Овал 289"/>
                      <p:cNvSpPr/>
                      <p:nvPr/>
                    </p:nvSpPr>
                    <p:spPr>
                      <a:xfrm rot="1576949">
                        <a:off x="5785626" y="12284492"/>
                        <a:ext cx="512417" cy="582085"/>
                      </a:xfrm>
                      <a:prstGeom prst="ellipse">
                        <a:avLst/>
                      </a:prstGeom>
                      <a:noFill/>
                      <a:ln w="6350">
                        <a:solidFill>
                          <a:schemeClr val="bg1"/>
                        </a:solidFill>
                        <a:prstDash val="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ru-RU"/>
                      </a:p>
                    </p:txBody>
                  </p:sp>
                </p:grpSp>
                <p:grpSp>
                  <p:nvGrpSpPr>
                    <p:cNvPr id="513" name="Группа 512"/>
                    <p:cNvGrpSpPr/>
                    <p:nvPr/>
                  </p:nvGrpSpPr>
                  <p:grpSpPr>
                    <a:xfrm>
                      <a:off x="1729198" y="9016630"/>
                      <a:ext cx="758189" cy="775277"/>
                      <a:chOff x="5676900" y="11339511"/>
                      <a:chExt cx="758189" cy="775277"/>
                    </a:xfrm>
                  </p:grpSpPr>
                  <p:pic>
                    <p:nvPicPr>
                      <p:cNvPr id="59" name="Рисунок 58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82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83">
                                <a14:imgEffect>
                                  <a14:brightnessContrast bright="20000"/>
                                </a14:imgEffect>
                              </a14:imgLayer>
                            </a14:imgProps>
                          </a:ext>
                        </a:extLst>
                      </a:blip>
                      <a:srcRect l="6295" t="11529" r="6367" b="3223"/>
                      <a:stretch/>
                    </p:blipFill>
                    <p:spPr>
                      <a:xfrm>
                        <a:off x="5676900" y="11339511"/>
                        <a:ext cx="758189" cy="775277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288" name="Овал 287"/>
                      <p:cNvSpPr/>
                      <p:nvPr/>
                    </p:nvSpPr>
                    <p:spPr>
                      <a:xfrm>
                        <a:off x="5777115" y="11458617"/>
                        <a:ext cx="551024" cy="468738"/>
                      </a:xfrm>
                      <a:prstGeom prst="ellipse">
                        <a:avLst/>
                      </a:prstGeom>
                      <a:noFill/>
                      <a:ln w="6350">
                        <a:solidFill>
                          <a:schemeClr val="bg1"/>
                        </a:solidFill>
                        <a:prstDash val="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ru-RU"/>
                      </a:p>
                    </p:txBody>
                  </p:sp>
                  <p:cxnSp>
                    <p:nvCxnSpPr>
                      <p:cNvPr id="291" name="Прямая соединительная линия 290"/>
                      <p:cNvCxnSpPr/>
                      <p:nvPr/>
                    </p:nvCxnSpPr>
                    <p:spPr>
                      <a:xfrm flipV="1">
                        <a:off x="5708751" y="11382697"/>
                        <a:ext cx="115776" cy="0"/>
                      </a:xfrm>
                      <a:prstGeom prst="line">
                        <a:avLst/>
                      </a:prstGeom>
                      <a:ln w="19050">
                        <a:solidFill>
                          <a:schemeClr val="bg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sp>
                <p:nvSpPr>
                  <p:cNvPr id="323" name="Прямоугольник 322"/>
                  <p:cNvSpPr/>
                  <p:nvPr/>
                </p:nvSpPr>
                <p:spPr>
                  <a:xfrm>
                    <a:off x="1476870" y="8975210"/>
                    <a:ext cx="141314" cy="233928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ru-RU"/>
                  </a:p>
                </p:txBody>
              </p:sp>
            </p:grpSp>
            <p:cxnSp>
              <p:nvCxnSpPr>
                <p:cNvPr id="518" name="Прямая со стрелкой 517"/>
                <p:cNvCxnSpPr/>
                <p:nvPr/>
              </p:nvCxnSpPr>
              <p:spPr>
                <a:xfrm>
                  <a:off x="1048085" y="9078819"/>
                  <a:ext cx="323603" cy="499739"/>
                </a:xfrm>
                <a:prstGeom prst="straightConnector1">
                  <a:avLst/>
                </a:prstGeom>
                <a:ln w="6350">
                  <a:solidFill>
                    <a:schemeClr val="bg1">
                      <a:alpha val="50000"/>
                    </a:schemeClr>
                  </a:solidFill>
                  <a:prstDash val="sysDash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0" name="Прямая со стрелкой 349"/>
                <p:cNvCxnSpPr/>
                <p:nvPr/>
              </p:nvCxnSpPr>
              <p:spPr>
                <a:xfrm>
                  <a:off x="884072" y="10027381"/>
                  <a:ext cx="556698" cy="135573"/>
                </a:xfrm>
                <a:prstGeom prst="straightConnector1">
                  <a:avLst/>
                </a:prstGeom>
                <a:ln w="6350">
                  <a:solidFill>
                    <a:schemeClr val="bg1">
                      <a:alpha val="50000"/>
                    </a:schemeClr>
                  </a:solidFill>
                  <a:prstDash val="sysDash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4" name="Прямая со стрелкой 353"/>
                <p:cNvCxnSpPr/>
                <p:nvPr/>
              </p:nvCxnSpPr>
              <p:spPr>
                <a:xfrm flipH="1">
                  <a:off x="1001076" y="10624442"/>
                  <a:ext cx="176929" cy="407725"/>
                </a:xfrm>
                <a:prstGeom prst="straightConnector1">
                  <a:avLst/>
                </a:prstGeom>
                <a:ln w="6350">
                  <a:solidFill>
                    <a:schemeClr val="bg1">
                      <a:alpha val="50000"/>
                    </a:schemeClr>
                  </a:solidFill>
                  <a:prstDash val="sysDash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55" name="Прямая соединительная линия 354"/>
              <p:cNvCxnSpPr/>
              <p:nvPr/>
            </p:nvCxnSpPr>
            <p:spPr>
              <a:xfrm>
                <a:off x="1015716" y="9103609"/>
                <a:ext cx="0" cy="205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6" name="TextBox 355"/>
              <p:cNvSpPr txBox="1"/>
              <p:nvPr/>
            </p:nvSpPr>
            <p:spPr>
              <a:xfrm rot="16200000">
                <a:off x="252487" y="10102136"/>
                <a:ext cx="133241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 smtClean="0"/>
                  <a:t>GFP intensity (a. u.)</a:t>
                </a:r>
                <a:endParaRPr lang="ru-RU" sz="1100" b="1" dirty="0"/>
              </a:p>
            </p:txBody>
          </p:sp>
        </p:grpSp>
      </p:grpSp>
      <p:grpSp>
        <p:nvGrpSpPr>
          <p:cNvPr id="554" name="Группа 553"/>
          <p:cNvGrpSpPr/>
          <p:nvPr/>
        </p:nvGrpSpPr>
        <p:grpSpPr>
          <a:xfrm>
            <a:off x="4567307" y="283986"/>
            <a:ext cx="5283664" cy="3732935"/>
            <a:chOff x="4567307" y="283986"/>
            <a:chExt cx="5283664" cy="3732935"/>
          </a:xfrm>
        </p:grpSpPr>
        <p:grpSp>
          <p:nvGrpSpPr>
            <p:cNvPr id="520" name="Группа 519"/>
            <p:cNvGrpSpPr/>
            <p:nvPr/>
          </p:nvGrpSpPr>
          <p:grpSpPr>
            <a:xfrm>
              <a:off x="4567307" y="283986"/>
              <a:ext cx="2372588" cy="2070594"/>
              <a:chOff x="4567307" y="283986"/>
              <a:chExt cx="2372588" cy="2070594"/>
            </a:xfrm>
          </p:grpSpPr>
          <p:grpSp>
            <p:nvGrpSpPr>
              <p:cNvPr id="359" name="Группа 358"/>
              <p:cNvGrpSpPr/>
              <p:nvPr/>
            </p:nvGrpSpPr>
            <p:grpSpPr>
              <a:xfrm>
                <a:off x="4567307" y="283986"/>
                <a:ext cx="2356801" cy="2066001"/>
                <a:chOff x="6674041" y="207538"/>
                <a:chExt cx="2356801" cy="2066001"/>
              </a:xfrm>
            </p:grpSpPr>
            <p:sp>
              <p:nvSpPr>
                <p:cNvPr id="368" name="TextBox 367"/>
                <p:cNvSpPr txBox="1"/>
                <p:nvPr/>
              </p:nvSpPr>
              <p:spPr>
                <a:xfrm>
                  <a:off x="6674041" y="207538"/>
                  <a:ext cx="330540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/>
                    <a:t>D</a:t>
                  </a:r>
                  <a:endParaRPr lang="ru-RU" b="1" dirty="0"/>
                </a:p>
              </p:txBody>
            </p:sp>
            <p:grpSp>
              <p:nvGrpSpPr>
                <p:cNvPr id="369" name="Группа 368"/>
                <p:cNvGrpSpPr/>
                <p:nvPr/>
              </p:nvGrpSpPr>
              <p:grpSpPr>
                <a:xfrm>
                  <a:off x="7401979" y="317497"/>
                  <a:ext cx="1628863" cy="1112816"/>
                  <a:chOff x="5272502" y="436446"/>
                  <a:chExt cx="1628863" cy="1112816"/>
                </a:xfrm>
              </p:grpSpPr>
              <p:pic>
                <p:nvPicPr>
                  <p:cNvPr id="378" name="Рисунок 377"/>
                  <p:cNvPicPr>
                    <a:picLocks noChangeAspect="1"/>
                  </p:cNvPicPr>
                  <p:nvPr/>
                </p:nvPicPr>
                <p:blipFill>
                  <a:blip r:embed="rId84">
                    <a:extLst>
                      <a:ext uri="{BEBA8EAE-BF5A-486C-A8C5-ECC9F3942E4B}">
                        <a14:imgProps xmlns:a14="http://schemas.microsoft.com/office/drawing/2010/main">
                          <a14:imgLayer r:embed="rId85">
                            <a14:imgEffect>
                              <a14:brightnessContrast bright="50000"/>
                            </a14:imgEffect>
                          </a14:imgLayer>
                        </a14:imgProps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104077" y="749162"/>
                    <a:ext cx="788670" cy="800100"/>
                  </a:xfrm>
                  <a:prstGeom prst="rect">
                    <a:avLst/>
                  </a:prstGeom>
                </p:spPr>
              </p:pic>
              <p:pic>
                <p:nvPicPr>
                  <p:cNvPr id="379" name="Рисунок 378"/>
                  <p:cNvPicPr>
                    <a:picLocks noChangeAspect="1"/>
                  </p:cNvPicPr>
                  <p:nvPr/>
                </p:nvPicPr>
                <p:blipFill>
                  <a:blip r:embed="rId86">
                    <a:extLst>
                      <a:ext uri="{BEBA8EAE-BF5A-486C-A8C5-ECC9F3942E4B}">
                        <a14:imgProps xmlns:a14="http://schemas.microsoft.com/office/drawing/2010/main">
                          <a14:imgLayer r:embed="rId87">
                            <a14:imgEffect>
                              <a14:brightnessContrast bright="30000"/>
                            </a14:imgEffect>
                          </a14:imgLayer>
                        </a14:imgProps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272502" y="749162"/>
                    <a:ext cx="788670" cy="800100"/>
                  </a:xfrm>
                  <a:prstGeom prst="rect">
                    <a:avLst/>
                  </a:prstGeom>
                </p:spPr>
              </p:pic>
              <p:sp>
                <p:nvSpPr>
                  <p:cNvPr id="380" name="Овал 379"/>
                  <p:cNvSpPr/>
                  <p:nvPr/>
                </p:nvSpPr>
                <p:spPr>
                  <a:xfrm rot="18904451">
                    <a:off x="6171989" y="949186"/>
                    <a:ext cx="373380" cy="346710"/>
                  </a:xfrm>
                  <a:prstGeom prst="ellipse">
                    <a:avLst/>
                  </a:prstGeom>
                  <a:noFill/>
                  <a:ln w="6350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ru-RU"/>
                  </a:p>
                </p:txBody>
              </p:sp>
              <p:sp>
                <p:nvSpPr>
                  <p:cNvPr id="381" name="Овал 380"/>
                  <p:cNvSpPr/>
                  <p:nvPr/>
                </p:nvSpPr>
                <p:spPr>
                  <a:xfrm rot="18904451">
                    <a:off x="5301320" y="899656"/>
                    <a:ext cx="373380" cy="346710"/>
                  </a:xfrm>
                  <a:prstGeom prst="ellipse">
                    <a:avLst/>
                  </a:prstGeom>
                  <a:noFill/>
                  <a:ln w="6350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ru-RU"/>
                  </a:p>
                </p:txBody>
              </p:sp>
              <p:sp>
                <p:nvSpPr>
                  <p:cNvPr id="382" name="Овал 381"/>
                  <p:cNvSpPr/>
                  <p:nvPr/>
                </p:nvSpPr>
                <p:spPr>
                  <a:xfrm>
                    <a:off x="6564419" y="899160"/>
                    <a:ext cx="288893" cy="282436"/>
                  </a:xfrm>
                  <a:prstGeom prst="ellipse">
                    <a:avLst/>
                  </a:prstGeom>
                  <a:noFill/>
                  <a:ln w="6350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ru-RU"/>
                  </a:p>
                </p:txBody>
              </p:sp>
              <p:sp>
                <p:nvSpPr>
                  <p:cNvPr id="383" name="Овал 382"/>
                  <p:cNvSpPr/>
                  <p:nvPr/>
                </p:nvSpPr>
                <p:spPr>
                  <a:xfrm>
                    <a:off x="5718182" y="840105"/>
                    <a:ext cx="288893" cy="282436"/>
                  </a:xfrm>
                  <a:prstGeom prst="ellipse">
                    <a:avLst/>
                  </a:prstGeom>
                  <a:noFill/>
                  <a:ln w="6350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ru-RU"/>
                  </a:p>
                </p:txBody>
              </p:sp>
              <p:sp>
                <p:nvSpPr>
                  <p:cNvPr id="384" name="TextBox 383"/>
                  <p:cNvSpPr txBox="1"/>
                  <p:nvPr/>
                </p:nvSpPr>
                <p:spPr>
                  <a:xfrm>
                    <a:off x="5295941" y="437131"/>
                    <a:ext cx="769763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100" b="1" dirty="0" smtClean="0"/>
                      <a:t>untreated</a:t>
                    </a:r>
                    <a:endParaRPr lang="ru-RU" sz="1100" b="1" dirty="0"/>
                  </a:p>
                </p:txBody>
              </p:sp>
              <p:sp>
                <p:nvSpPr>
                  <p:cNvPr id="385" name="Прямая соединительная линия 12"/>
                  <p:cNvSpPr/>
                  <p:nvPr/>
                </p:nvSpPr>
                <p:spPr>
                  <a:xfrm>
                    <a:off x="5326362" y="684890"/>
                    <a:ext cx="707493" cy="0"/>
                  </a:xfrm>
                  <a:custGeom>
                    <a:avLst/>
                    <a:gdLst>
                      <a:gd name="f0" fmla="val 10800000"/>
                      <a:gd name="f1" fmla="val 5400000"/>
                      <a:gd name="f2" fmla="val 180"/>
                      <a:gd name="f3" fmla="val w"/>
                      <a:gd name="f4" fmla="val h"/>
                      <a:gd name="f5" fmla="val ss"/>
                      <a:gd name="f6" fmla="val 0"/>
                      <a:gd name="f7" fmla="+- 0 0 -180"/>
                      <a:gd name="f8" fmla="+- 0 0 -360"/>
                      <a:gd name="f9" fmla="abs f3"/>
                      <a:gd name="f10" fmla="abs f4"/>
                      <a:gd name="f11" fmla="abs f5"/>
                      <a:gd name="f12" fmla="val f6"/>
                      <a:gd name="f13" fmla="*/ f7 f0 1"/>
                      <a:gd name="f14" fmla="*/ f8 f0 1"/>
                      <a:gd name="f15" fmla="?: f9 f3 1"/>
                      <a:gd name="f16" fmla="?: f10 f4 1"/>
                      <a:gd name="f17" fmla="?: f11 f5 1"/>
                      <a:gd name="f18" fmla="*/ f13 1 f2"/>
                      <a:gd name="f19" fmla="*/ f14 1 f2"/>
                      <a:gd name="f20" fmla="*/ f15 1 21600"/>
                      <a:gd name="f21" fmla="*/ f16 1 21600"/>
                      <a:gd name="f22" fmla="*/ 21600 f15 1"/>
                      <a:gd name="f23" fmla="*/ 21600 f16 1"/>
                      <a:gd name="f24" fmla="+- f18 0 f1"/>
                      <a:gd name="f25" fmla="+- f19 0 f1"/>
                      <a:gd name="f26" fmla="min f21 f20"/>
                      <a:gd name="f27" fmla="*/ f22 1 f17"/>
                      <a:gd name="f28" fmla="*/ f23 1 f17"/>
                      <a:gd name="f29" fmla="val f27"/>
                      <a:gd name="f30" fmla="val f28"/>
                      <a:gd name="f31" fmla="*/ f6 f26 1"/>
                      <a:gd name="f32" fmla="*/ f27 f26 1"/>
                      <a:gd name="f33" fmla="*/ f28 f26 1"/>
                      <a:gd name="f34" fmla="*/ f12 f26 1"/>
                      <a:gd name="f35" fmla="*/ f29 f26 1"/>
                      <a:gd name="f36" fmla="*/ f30 f26 1"/>
                    </a:gdLst>
                    <a:ahLst/>
                    <a:cxnLst>
                      <a:cxn ang="3cd4">
                        <a:pos x="hc" y="t"/>
                      </a:cxn>
                      <a:cxn ang="0">
                        <a:pos x="r" y="vc"/>
                      </a:cxn>
                      <a:cxn ang="cd4">
                        <a:pos x="hc" y="b"/>
                      </a:cxn>
                      <a:cxn ang="cd2">
                        <a:pos x="l" y="vc"/>
                      </a:cxn>
                      <a:cxn ang="f24">
                        <a:pos x="f34" y="f34"/>
                      </a:cxn>
                      <a:cxn ang="f25">
                        <a:pos x="f35" y="f36"/>
                      </a:cxn>
                    </a:cxnLst>
                    <a:rect l="f31" t="f31" r="f32" b="f33"/>
                    <a:pathLst>
                      <a:path>
                        <a:moveTo>
                          <a:pt x="f34" y="f34"/>
                        </a:moveTo>
                        <a:lnTo>
                          <a:pt x="f35" y="f36"/>
                        </a:lnTo>
                      </a:path>
                    </a:pathLst>
                  </a:custGeom>
                  <a:noFill/>
                  <a:ln w="0" cap="flat">
                    <a:solidFill>
                      <a:srgbClr val="000000"/>
                    </a:solidFill>
                    <a:prstDash val="solid"/>
                    <a:miter/>
                    <a:headEnd type="none" w="med" len="med"/>
                    <a:tailEnd type="triangle" w="med" len="med"/>
                  </a:ln>
                </p:spPr>
                <p:txBody>
                  <a:bodyPr vert="horz" wrap="none" lIns="97964" tIns="48976" rIns="97964" bIns="48976" anchor="ctr" anchorCtr="0" compatLnSpc="1">
                    <a:noAutofit/>
                  </a:bodyPr>
                  <a:lstStyle/>
                  <a:p>
                    <a:pPr defTabSz="995233" hangingPunct="0">
                      <a:lnSpc>
                        <a:spcPct val="93000"/>
                      </a:lnSpc>
                      <a:tabLst>
                        <a:tab pos="0" algn="l"/>
                        <a:tab pos="488599" algn="l"/>
                        <a:tab pos="977597" algn="l"/>
                        <a:tab pos="1466595" algn="l"/>
                        <a:tab pos="1955592" algn="l"/>
                        <a:tab pos="2444590" algn="l"/>
                        <a:tab pos="2933588" algn="l"/>
                        <a:tab pos="3422586" algn="l"/>
                        <a:tab pos="3911574" algn="l"/>
                        <a:tab pos="4400571" algn="l"/>
                        <a:tab pos="4889570" algn="l"/>
                        <a:tab pos="5378567" algn="l"/>
                        <a:tab pos="5867564" algn="l"/>
                        <a:tab pos="6356562" algn="l"/>
                        <a:tab pos="6845560" algn="l"/>
                        <a:tab pos="7334558" algn="l"/>
                        <a:tab pos="7823545" algn="l"/>
                        <a:tab pos="8312543" algn="l"/>
                        <a:tab pos="8801541" algn="l"/>
                        <a:tab pos="9290539" algn="l"/>
                        <a:tab pos="9779536" algn="l"/>
                      </a:tabLst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endParaRPr lang="ru-RU" sz="1959">
                      <a:solidFill>
                        <a:srgbClr val="000000"/>
                      </a:solidFill>
                      <a:latin typeface="Arial" pitchFamily="18"/>
                      <a:ea typeface="Microsoft YaHei" pitchFamily="2"/>
                      <a:cs typeface="Microsoft YaHei" pitchFamily="2"/>
                    </a:endParaRPr>
                  </a:p>
                </p:txBody>
              </p:sp>
              <p:sp>
                <p:nvSpPr>
                  <p:cNvPr id="386" name="Прямая соединительная линия 12"/>
                  <p:cNvSpPr/>
                  <p:nvPr/>
                </p:nvSpPr>
                <p:spPr>
                  <a:xfrm>
                    <a:off x="6152612" y="682565"/>
                    <a:ext cx="707493" cy="0"/>
                  </a:xfrm>
                  <a:custGeom>
                    <a:avLst/>
                    <a:gdLst>
                      <a:gd name="f0" fmla="val 10800000"/>
                      <a:gd name="f1" fmla="val 5400000"/>
                      <a:gd name="f2" fmla="val 180"/>
                      <a:gd name="f3" fmla="val w"/>
                      <a:gd name="f4" fmla="val h"/>
                      <a:gd name="f5" fmla="val ss"/>
                      <a:gd name="f6" fmla="val 0"/>
                      <a:gd name="f7" fmla="+- 0 0 -180"/>
                      <a:gd name="f8" fmla="+- 0 0 -360"/>
                      <a:gd name="f9" fmla="abs f3"/>
                      <a:gd name="f10" fmla="abs f4"/>
                      <a:gd name="f11" fmla="abs f5"/>
                      <a:gd name="f12" fmla="val f6"/>
                      <a:gd name="f13" fmla="*/ f7 f0 1"/>
                      <a:gd name="f14" fmla="*/ f8 f0 1"/>
                      <a:gd name="f15" fmla="?: f9 f3 1"/>
                      <a:gd name="f16" fmla="?: f10 f4 1"/>
                      <a:gd name="f17" fmla="?: f11 f5 1"/>
                      <a:gd name="f18" fmla="*/ f13 1 f2"/>
                      <a:gd name="f19" fmla="*/ f14 1 f2"/>
                      <a:gd name="f20" fmla="*/ f15 1 21600"/>
                      <a:gd name="f21" fmla="*/ f16 1 21600"/>
                      <a:gd name="f22" fmla="*/ 21600 f15 1"/>
                      <a:gd name="f23" fmla="*/ 21600 f16 1"/>
                      <a:gd name="f24" fmla="+- f18 0 f1"/>
                      <a:gd name="f25" fmla="+- f19 0 f1"/>
                      <a:gd name="f26" fmla="min f21 f20"/>
                      <a:gd name="f27" fmla="*/ f22 1 f17"/>
                      <a:gd name="f28" fmla="*/ f23 1 f17"/>
                      <a:gd name="f29" fmla="val f27"/>
                      <a:gd name="f30" fmla="val f28"/>
                      <a:gd name="f31" fmla="*/ f6 f26 1"/>
                      <a:gd name="f32" fmla="*/ f27 f26 1"/>
                      <a:gd name="f33" fmla="*/ f28 f26 1"/>
                      <a:gd name="f34" fmla="*/ f12 f26 1"/>
                      <a:gd name="f35" fmla="*/ f29 f26 1"/>
                      <a:gd name="f36" fmla="*/ f30 f26 1"/>
                    </a:gdLst>
                    <a:ahLst/>
                    <a:cxnLst>
                      <a:cxn ang="3cd4">
                        <a:pos x="hc" y="t"/>
                      </a:cxn>
                      <a:cxn ang="0">
                        <a:pos x="r" y="vc"/>
                      </a:cxn>
                      <a:cxn ang="cd4">
                        <a:pos x="hc" y="b"/>
                      </a:cxn>
                      <a:cxn ang="cd2">
                        <a:pos x="l" y="vc"/>
                      </a:cxn>
                      <a:cxn ang="f24">
                        <a:pos x="f34" y="f34"/>
                      </a:cxn>
                      <a:cxn ang="f25">
                        <a:pos x="f35" y="f36"/>
                      </a:cxn>
                    </a:cxnLst>
                    <a:rect l="f31" t="f31" r="f32" b="f33"/>
                    <a:pathLst>
                      <a:path>
                        <a:moveTo>
                          <a:pt x="f34" y="f34"/>
                        </a:moveTo>
                        <a:lnTo>
                          <a:pt x="f35" y="f36"/>
                        </a:lnTo>
                      </a:path>
                    </a:pathLst>
                  </a:custGeom>
                  <a:noFill/>
                  <a:ln w="0" cap="flat">
                    <a:solidFill>
                      <a:srgbClr val="000000"/>
                    </a:solidFill>
                    <a:prstDash val="solid"/>
                    <a:miter/>
                    <a:headEnd type="none" w="med" len="med"/>
                    <a:tailEnd type="triangle" w="med" len="med"/>
                  </a:ln>
                </p:spPr>
                <p:txBody>
                  <a:bodyPr vert="horz" wrap="none" lIns="97964" tIns="48976" rIns="97964" bIns="48976" anchor="ctr" anchorCtr="0" compatLnSpc="1">
                    <a:noAutofit/>
                  </a:bodyPr>
                  <a:lstStyle/>
                  <a:p>
                    <a:pPr defTabSz="995233" hangingPunct="0">
                      <a:lnSpc>
                        <a:spcPct val="93000"/>
                      </a:lnSpc>
                      <a:tabLst>
                        <a:tab pos="0" algn="l"/>
                        <a:tab pos="488599" algn="l"/>
                        <a:tab pos="977597" algn="l"/>
                        <a:tab pos="1466595" algn="l"/>
                        <a:tab pos="1955592" algn="l"/>
                        <a:tab pos="2444590" algn="l"/>
                        <a:tab pos="2933588" algn="l"/>
                        <a:tab pos="3422586" algn="l"/>
                        <a:tab pos="3911574" algn="l"/>
                        <a:tab pos="4400571" algn="l"/>
                        <a:tab pos="4889570" algn="l"/>
                        <a:tab pos="5378567" algn="l"/>
                        <a:tab pos="5867564" algn="l"/>
                        <a:tab pos="6356562" algn="l"/>
                        <a:tab pos="6845560" algn="l"/>
                        <a:tab pos="7334558" algn="l"/>
                        <a:tab pos="7823545" algn="l"/>
                        <a:tab pos="8312543" algn="l"/>
                        <a:tab pos="8801541" algn="l"/>
                        <a:tab pos="9290539" algn="l"/>
                        <a:tab pos="9779536" algn="l"/>
                      </a:tabLst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endParaRPr lang="ru-RU" sz="1959">
                      <a:solidFill>
                        <a:srgbClr val="000000"/>
                      </a:solidFill>
                      <a:latin typeface="Arial" pitchFamily="18"/>
                      <a:ea typeface="Microsoft YaHei" pitchFamily="2"/>
                      <a:cs typeface="Microsoft YaHei" pitchFamily="2"/>
                    </a:endParaRPr>
                  </a:p>
                </p:txBody>
              </p:sp>
              <p:sp>
                <p:nvSpPr>
                  <p:cNvPr id="387" name="TextBox 386"/>
                  <p:cNvSpPr txBox="1"/>
                  <p:nvPr/>
                </p:nvSpPr>
                <p:spPr>
                  <a:xfrm>
                    <a:off x="6112366" y="436446"/>
                    <a:ext cx="788999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100" b="1" dirty="0" smtClean="0"/>
                      <a:t>+ </a:t>
                    </a:r>
                    <a:r>
                      <a:rPr lang="en-US" sz="1100" b="1" dirty="0" err="1" smtClean="0"/>
                      <a:t>RNAse</a:t>
                    </a:r>
                    <a:r>
                      <a:rPr lang="en-US" sz="1100" b="1" dirty="0" smtClean="0"/>
                      <a:t> A</a:t>
                    </a:r>
                  </a:p>
                </p:txBody>
              </p:sp>
            </p:grpSp>
            <p:sp>
              <p:nvSpPr>
                <p:cNvPr id="370" name="TextBox 369"/>
                <p:cNvSpPr txBox="1"/>
                <p:nvPr/>
              </p:nvSpPr>
              <p:spPr>
                <a:xfrm rot="16200000">
                  <a:off x="6817103" y="789317"/>
                  <a:ext cx="792204" cy="4308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b="1" dirty="0" smtClean="0"/>
                    <a:t>Liquid-like</a:t>
                  </a:r>
                </a:p>
                <a:p>
                  <a:pPr algn="ctr"/>
                  <a:r>
                    <a:rPr lang="en-US" sz="1100" b="1" dirty="0" smtClean="0"/>
                    <a:t> droplets</a:t>
                  </a:r>
                  <a:endParaRPr lang="ru-RU" sz="1100" b="1" dirty="0"/>
                </a:p>
              </p:txBody>
            </p:sp>
            <p:pic>
              <p:nvPicPr>
                <p:cNvPr id="371" name="Рисунок 370"/>
                <p:cNvPicPr>
                  <a:picLocks noChangeAspect="1"/>
                </p:cNvPicPr>
                <p:nvPr/>
              </p:nvPicPr>
              <p:blipFill>
                <a:blip r:embed="rId88">
                  <a:extLst>
                    <a:ext uri="{BEBA8EAE-BF5A-486C-A8C5-ECC9F3942E4B}">
                      <a14:imgProps xmlns:a14="http://schemas.microsoft.com/office/drawing/2010/main">
                        <a14:imgLayer r:embed="rId89">
                          <a14:imgEffect>
                            <a14:brightnessContrast bright="30000" contrast="2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401979" y="1471724"/>
                  <a:ext cx="788670" cy="801815"/>
                </a:xfrm>
                <a:prstGeom prst="rect">
                  <a:avLst/>
                </a:prstGeom>
              </p:spPr>
            </p:pic>
            <p:pic>
              <p:nvPicPr>
                <p:cNvPr id="372" name="Рисунок 371"/>
                <p:cNvPicPr>
                  <a:picLocks noChangeAspect="1"/>
                </p:cNvPicPr>
                <p:nvPr/>
              </p:nvPicPr>
              <p:blipFill>
                <a:blip r:embed="rId90">
                  <a:extLst>
                    <a:ext uri="{BEBA8EAE-BF5A-486C-A8C5-ECC9F3942E4B}">
                      <a14:imgProps xmlns:a14="http://schemas.microsoft.com/office/drawing/2010/main">
                        <a14:imgLayer r:embed="rId91">
                          <a14:imgEffect>
                            <a14:brightnessContrast bright="30000" contrast="2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233553" y="1471724"/>
                  <a:ext cx="788670" cy="801815"/>
                </a:xfrm>
                <a:prstGeom prst="rect">
                  <a:avLst/>
                </a:prstGeom>
              </p:spPr>
            </p:pic>
            <p:sp>
              <p:nvSpPr>
                <p:cNvPr id="373" name="Овал 372"/>
                <p:cNvSpPr/>
                <p:nvPr/>
              </p:nvSpPr>
              <p:spPr>
                <a:xfrm>
                  <a:off x="7628713" y="1681275"/>
                  <a:ext cx="410074" cy="356235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374" name="Овал 373"/>
                <p:cNvSpPr/>
                <p:nvPr/>
              </p:nvSpPr>
              <p:spPr>
                <a:xfrm>
                  <a:off x="8467811" y="1659107"/>
                  <a:ext cx="410074" cy="356235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375" name="TextBox 374"/>
                <p:cNvSpPr txBox="1"/>
                <p:nvPr/>
              </p:nvSpPr>
              <p:spPr>
                <a:xfrm rot="16200000">
                  <a:off x="6802676" y="1588607"/>
                  <a:ext cx="821059" cy="4308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b="1" dirty="0" smtClean="0"/>
                    <a:t>Solid-like </a:t>
                  </a:r>
                </a:p>
                <a:p>
                  <a:pPr algn="ctr"/>
                  <a:r>
                    <a:rPr lang="en-US" sz="1100" b="1" dirty="0" err="1" smtClean="0"/>
                    <a:t>aggregares</a:t>
                  </a:r>
                  <a:endParaRPr lang="ru-RU" sz="1100" b="1" dirty="0"/>
                </a:p>
              </p:txBody>
            </p:sp>
            <p:cxnSp>
              <p:nvCxnSpPr>
                <p:cNvPr id="376" name="Прямая соединительная линия 375"/>
                <p:cNvCxnSpPr/>
                <p:nvPr/>
              </p:nvCxnSpPr>
              <p:spPr>
                <a:xfrm>
                  <a:off x="7013001" y="626200"/>
                  <a:ext cx="0" cy="1512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77" name="TextBox 376"/>
                <p:cNvSpPr txBox="1"/>
                <p:nvPr/>
              </p:nvSpPr>
              <p:spPr>
                <a:xfrm rot="16200000">
                  <a:off x="6116839" y="1240391"/>
                  <a:ext cx="161294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 smtClean="0"/>
                    <a:t>Mot3PD-GFP assemblies</a:t>
                  </a:r>
                  <a:endParaRPr lang="ru-RU" sz="1100" b="1" dirty="0"/>
                </a:p>
              </p:txBody>
            </p:sp>
          </p:grpSp>
          <p:cxnSp>
            <p:nvCxnSpPr>
              <p:cNvPr id="529" name="Прямая соединительная линия 528"/>
              <p:cNvCxnSpPr/>
              <p:nvPr/>
            </p:nvCxnSpPr>
            <p:spPr>
              <a:xfrm>
                <a:off x="5321915" y="745452"/>
                <a:ext cx="72000" cy="0"/>
              </a:xfrm>
              <a:prstGeom prst="line">
                <a:avLst/>
              </a:prstGeom>
              <a:ln w="158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4" name="Прямоугольник 513"/>
              <p:cNvSpPr/>
              <p:nvPr/>
            </p:nvSpPr>
            <p:spPr>
              <a:xfrm>
                <a:off x="5261423" y="2217420"/>
                <a:ext cx="1678472" cy="13716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</p:grpSp>
        <p:grpSp>
          <p:nvGrpSpPr>
            <p:cNvPr id="519" name="Группа 518"/>
            <p:cNvGrpSpPr/>
            <p:nvPr/>
          </p:nvGrpSpPr>
          <p:grpSpPr>
            <a:xfrm>
              <a:off x="4685772" y="2221758"/>
              <a:ext cx="2231717" cy="1368501"/>
              <a:chOff x="4685772" y="2435118"/>
              <a:chExt cx="2231717" cy="1368501"/>
            </a:xfrm>
          </p:grpSpPr>
          <p:grpSp>
            <p:nvGrpSpPr>
              <p:cNvPr id="532" name="Группа 531"/>
              <p:cNvGrpSpPr/>
              <p:nvPr/>
            </p:nvGrpSpPr>
            <p:grpSpPr>
              <a:xfrm>
                <a:off x="4685772" y="2435118"/>
                <a:ext cx="2231717" cy="1368501"/>
                <a:chOff x="782351" y="14239594"/>
                <a:chExt cx="2231717" cy="1368501"/>
              </a:xfrm>
            </p:grpSpPr>
            <p:grpSp>
              <p:nvGrpSpPr>
                <p:cNvPr id="360" name="Группа 359"/>
                <p:cNvGrpSpPr>
                  <a:grpSpLocks noChangeAspect="1"/>
                </p:cNvGrpSpPr>
                <p:nvPr/>
              </p:nvGrpSpPr>
              <p:grpSpPr>
                <a:xfrm>
                  <a:off x="2223582" y="14319335"/>
                  <a:ext cx="788956" cy="584645"/>
                  <a:chOff x="4391881" y="13127496"/>
                  <a:chExt cx="2390775" cy="1771650"/>
                </a:xfrm>
              </p:grpSpPr>
              <p:pic>
                <p:nvPicPr>
                  <p:cNvPr id="365" name="Рисунок 364"/>
                  <p:cNvPicPr>
                    <a:picLocks noChangeAspect="1"/>
                  </p:cNvPicPr>
                  <p:nvPr/>
                </p:nvPicPr>
                <p:blipFill>
                  <a:blip r:embed="rId92">
                    <a:extLst>
                      <a:ext uri="{BEBA8EAE-BF5A-486C-A8C5-ECC9F3942E4B}">
                        <a14:imgProps xmlns:a14="http://schemas.microsoft.com/office/drawing/2010/main">
                          <a14:imgLayer r:embed="rId93"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391881" y="13127496"/>
                    <a:ext cx="2390775" cy="1771650"/>
                  </a:xfrm>
                  <a:prstGeom prst="rect">
                    <a:avLst/>
                  </a:prstGeom>
                </p:spPr>
              </p:pic>
              <p:sp>
                <p:nvSpPr>
                  <p:cNvPr id="366" name="Овал 365"/>
                  <p:cNvSpPr/>
                  <p:nvPr/>
                </p:nvSpPr>
                <p:spPr>
                  <a:xfrm rot="17135058">
                    <a:off x="5574505" y="13644892"/>
                    <a:ext cx="891581" cy="1076428"/>
                  </a:xfrm>
                  <a:prstGeom prst="ellipse">
                    <a:avLst/>
                  </a:prstGeom>
                  <a:noFill/>
                  <a:ln w="6350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ru-RU"/>
                  </a:p>
                </p:txBody>
              </p:sp>
              <p:sp>
                <p:nvSpPr>
                  <p:cNvPr id="367" name="Овал 366"/>
                  <p:cNvSpPr/>
                  <p:nvPr/>
                </p:nvSpPr>
                <p:spPr>
                  <a:xfrm rot="209877">
                    <a:off x="4751803" y="13459926"/>
                    <a:ext cx="781624" cy="795942"/>
                  </a:xfrm>
                  <a:prstGeom prst="ellipse">
                    <a:avLst/>
                  </a:prstGeom>
                  <a:noFill/>
                  <a:ln w="6350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ru-RU"/>
                  </a:p>
                </p:txBody>
              </p:sp>
            </p:grpSp>
            <p:grpSp>
              <p:nvGrpSpPr>
                <p:cNvPr id="361" name="Группа 360"/>
                <p:cNvGrpSpPr>
                  <a:grpSpLocks noChangeAspect="1"/>
                </p:cNvGrpSpPr>
                <p:nvPr/>
              </p:nvGrpSpPr>
              <p:grpSpPr>
                <a:xfrm>
                  <a:off x="1394479" y="14318683"/>
                  <a:ext cx="788956" cy="584645"/>
                  <a:chOff x="1881183" y="13127496"/>
                  <a:chExt cx="2390775" cy="1771650"/>
                </a:xfrm>
              </p:grpSpPr>
              <p:pic>
                <p:nvPicPr>
                  <p:cNvPr id="362" name="Рисунок 361"/>
                  <p:cNvPicPr>
                    <a:picLocks noChangeAspect="1"/>
                  </p:cNvPicPr>
                  <p:nvPr/>
                </p:nvPicPr>
                <p:blipFill>
                  <a:blip r:embed="rId94">
                    <a:extLst>
                      <a:ext uri="{BEBA8EAE-BF5A-486C-A8C5-ECC9F3942E4B}">
                        <a14:imgProps xmlns:a14="http://schemas.microsoft.com/office/drawing/2010/main">
                          <a14:imgLayer r:embed="rId95"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881183" y="13127496"/>
                    <a:ext cx="2390775" cy="1771650"/>
                  </a:xfrm>
                  <a:prstGeom prst="rect">
                    <a:avLst/>
                  </a:prstGeom>
                </p:spPr>
              </p:pic>
              <p:sp>
                <p:nvSpPr>
                  <p:cNvPr id="363" name="Овал 362"/>
                  <p:cNvSpPr/>
                  <p:nvPr/>
                </p:nvSpPr>
                <p:spPr>
                  <a:xfrm rot="17491419">
                    <a:off x="2998520" y="13629215"/>
                    <a:ext cx="932587" cy="1107250"/>
                  </a:xfrm>
                  <a:prstGeom prst="ellipse">
                    <a:avLst/>
                  </a:prstGeom>
                  <a:noFill/>
                  <a:ln w="6350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ru-RU"/>
                  </a:p>
                </p:txBody>
              </p:sp>
              <p:sp>
                <p:nvSpPr>
                  <p:cNvPr id="364" name="Овал 363"/>
                  <p:cNvSpPr/>
                  <p:nvPr/>
                </p:nvSpPr>
                <p:spPr>
                  <a:xfrm rot="209877">
                    <a:off x="2191819" y="13459925"/>
                    <a:ext cx="781624" cy="795942"/>
                  </a:xfrm>
                  <a:prstGeom prst="ellipse">
                    <a:avLst/>
                  </a:prstGeom>
                  <a:noFill/>
                  <a:ln w="6350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ru-RU"/>
                  </a:p>
                </p:txBody>
              </p:sp>
            </p:grpSp>
            <p:sp>
              <p:nvSpPr>
                <p:cNvPr id="388" name="TextBox 387"/>
                <p:cNvSpPr txBox="1"/>
                <p:nvPr/>
              </p:nvSpPr>
              <p:spPr>
                <a:xfrm rot="16200000">
                  <a:off x="845693" y="14393963"/>
                  <a:ext cx="708848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000" b="1" dirty="0" smtClean="0"/>
                    <a:t>Fresh </a:t>
                  </a:r>
                </a:p>
                <a:p>
                  <a:pPr algn="ctr"/>
                  <a:r>
                    <a:rPr lang="en-US" sz="1000" b="1" dirty="0" smtClean="0"/>
                    <a:t>(5 </a:t>
                  </a:r>
                  <a:r>
                    <a:rPr lang="en-US" sz="1000" b="1" dirty="0" err="1" smtClean="0"/>
                    <a:t>hrs</a:t>
                  </a:r>
                  <a:r>
                    <a:rPr lang="en-US" sz="1000" b="1" dirty="0" smtClean="0"/>
                    <a:t> OP)</a:t>
                  </a:r>
                </a:p>
              </p:txBody>
            </p:sp>
            <p:cxnSp>
              <p:nvCxnSpPr>
                <p:cNvPr id="389" name="Прямая соединительная линия 388"/>
                <p:cNvCxnSpPr/>
                <p:nvPr/>
              </p:nvCxnSpPr>
              <p:spPr>
                <a:xfrm>
                  <a:off x="1002169" y="14320684"/>
                  <a:ext cx="0" cy="118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90" name="TextBox 389"/>
                <p:cNvSpPr txBox="1"/>
                <p:nvPr/>
              </p:nvSpPr>
              <p:spPr>
                <a:xfrm rot="16200000">
                  <a:off x="273397" y="14771809"/>
                  <a:ext cx="127951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 smtClean="0"/>
                    <a:t>GFP-Rnq1 droplets</a:t>
                  </a:r>
                  <a:endParaRPr lang="ru-RU" sz="1100" b="1" dirty="0"/>
                </a:p>
              </p:txBody>
            </p:sp>
            <p:pic>
              <p:nvPicPr>
                <p:cNvPr id="530" name="Рисунок 529"/>
                <p:cNvPicPr>
                  <a:picLocks noChangeAspect="1"/>
                </p:cNvPicPr>
                <p:nvPr/>
              </p:nvPicPr>
              <p:blipFill>
                <a:blip r:embed="rId96">
                  <a:extLst>
                    <a:ext uri="{BEBA8EAE-BF5A-486C-A8C5-ECC9F3942E4B}">
                      <a14:imgProps xmlns:a14="http://schemas.microsoft.com/office/drawing/2010/main">
                        <a14:imgLayer r:embed="rId97">
                          <a14:imgEffect>
                            <a14:brightnessContrast bright="40000" contrast="5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394149" y="14952143"/>
                  <a:ext cx="792671" cy="499491"/>
                </a:xfrm>
                <a:prstGeom prst="rect">
                  <a:avLst/>
                </a:prstGeom>
              </p:spPr>
            </p:pic>
            <p:pic>
              <p:nvPicPr>
                <p:cNvPr id="531" name="Рисунок 530"/>
                <p:cNvPicPr>
                  <a:picLocks noChangeAspect="1"/>
                </p:cNvPicPr>
                <p:nvPr/>
              </p:nvPicPr>
              <p:blipFill>
                <a:blip r:embed="rId98">
                  <a:extLst>
                    <a:ext uri="{BEBA8EAE-BF5A-486C-A8C5-ECC9F3942E4B}">
                      <a14:imgProps xmlns:a14="http://schemas.microsoft.com/office/drawing/2010/main">
                        <a14:imgLayer r:embed="rId99">
                          <a14:imgEffect>
                            <a14:brightnessContrast bright="40000" contrast="3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221397" y="14951275"/>
                  <a:ext cx="792671" cy="499491"/>
                </a:xfrm>
                <a:prstGeom prst="rect">
                  <a:avLst/>
                </a:prstGeom>
              </p:spPr>
            </p:pic>
            <p:sp>
              <p:nvSpPr>
                <p:cNvPr id="391" name="Овал 390"/>
                <p:cNvSpPr/>
                <p:nvPr/>
              </p:nvSpPr>
              <p:spPr>
                <a:xfrm rot="209877">
                  <a:off x="1479273" y="14991910"/>
                  <a:ext cx="282814" cy="278439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392" name="Овал 391"/>
                <p:cNvSpPr/>
                <p:nvPr/>
              </p:nvSpPr>
              <p:spPr>
                <a:xfrm rot="209877">
                  <a:off x="2336979" y="14997786"/>
                  <a:ext cx="282814" cy="286305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393" name="Овал 392"/>
                <p:cNvSpPr/>
                <p:nvPr/>
              </p:nvSpPr>
              <p:spPr>
                <a:xfrm rot="17491419">
                  <a:off x="1793038" y="15049357"/>
                  <a:ext cx="307754" cy="365393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394" name="Овал 393"/>
                <p:cNvSpPr/>
                <p:nvPr/>
              </p:nvSpPr>
              <p:spPr>
                <a:xfrm rot="17491419">
                  <a:off x="2652144" y="15056649"/>
                  <a:ext cx="307754" cy="365393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395" name="TextBox 394"/>
                <p:cNvSpPr txBox="1"/>
                <p:nvPr/>
              </p:nvSpPr>
              <p:spPr>
                <a:xfrm rot="16200000">
                  <a:off x="815765" y="15020755"/>
                  <a:ext cx="774571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000" b="1" dirty="0" smtClean="0"/>
                    <a:t>Aged</a:t>
                  </a:r>
                </a:p>
                <a:p>
                  <a:pPr algn="ctr"/>
                  <a:r>
                    <a:rPr lang="en-US" sz="1000" b="1" dirty="0" smtClean="0"/>
                    <a:t>(30 </a:t>
                  </a:r>
                  <a:r>
                    <a:rPr lang="en-US" sz="1000" b="1" dirty="0" err="1" smtClean="0"/>
                    <a:t>hrs</a:t>
                  </a:r>
                  <a:r>
                    <a:rPr lang="en-US" sz="1000" b="1" dirty="0" smtClean="0"/>
                    <a:t> OP)</a:t>
                  </a:r>
                </a:p>
              </p:txBody>
            </p:sp>
          </p:grpSp>
          <p:cxnSp>
            <p:nvCxnSpPr>
              <p:cNvPr id="547" name="Прямая соединительная линия 546"/>
              <p:cNvCxnSpPr/>
              <p:nvPr/>
            </p:nvCxnSpPr>
            <p:spPr>
              <a:xfrm>
                <a:off x="5338635" y="2562944"/>
                <a:ext cx="72000" cy="0"/>
              </a:xfrm>
              <a:prstGeom prst="line">
                <a:avLst/>
              </a:prstGeom>
              <a:ln w="158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53" name="Группа 552"/>
            <p:cNvGrpSpPr/>
            <p:nvPr/>
          </p:nvGrpSpPr>
          <p:grpSpPr>
            <a:xfrm>
              <a:off x="7049396" y="318341"/>
              <a:ext cx="1804433" cy="1769025"/>
              <a:chOff x="7049396" y="402161"/>
              <a:chExt cx="1804433" cy="1769025"/>
            </a:xfrm>
          </p:grpSpPr>
          <p:grpSp>
            <p:nvGrpSpPr>
              <p:cNvPr id="536" name="Группа 535"/>
              <p:cNvGrpSpPr/>
              <p:nvPr/>
            </p:nvGrpSpPr>
            <p:grpSpPr>
              <a:xfrm>
                <a:off x="7049396" y="402161"/>
                <a:ext cx="1804433" cy="1545787"/>
                <a:chOff x="7163696" y="668861"/>
                <a:chExt cx="1804433" cy="1545787"/>
              </a:xfrm>
            </p:grpSpPr>
            <p:graphicFrame>
              <p:nvGraphicFramePr>
                <p:cNvPr id="396" name="Диаграмма 395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673015162"/>
                    </p:ext>
                  </p:extLst>
                </p:nvPr>
              </p:nvGraphicFramePr>
              <p:xfrm>
                <a:off x="7290413" y="775932"/>
                <a:ext cx="1677716" cy="1438716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00"/>
                </a:graphicData>
              </a:graphic>
            </p:graphicFrame>
            <p:cxnSp>
              <p:nvCxnSpPr>
                <p:cNvPr id="525" name="Прямая соединительная линия 524"/>
                <p:cNvCxnSpPr/>
                <p:nvPr/>
              </p:nvCxnSpPr>
              <p:spPr>
                <a:xfrm>
                  <a:off x="7800379" y="1066800"/>
                  <a:ext cx="817841" cy="0"/>
                </a:xfrm>
                <a:prstGeom prst="line">
                  <a:avLst/>
                </a:prstGeom>
                <a:ln>
                  <a:solidFill>
                    <a:schemeClr val="bg2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26" name="TextBox 525"/>
                <p:cNvSpPr txBox="1"/>
                <p:nvPr/>
              </p:nvSpPr>
              <p:spPr>
                <a:xfrm>
                  <a:off x="7977250" y="873461"/>
                  <a:ext cx="556563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</a:rPr>
                    <a:t>p = 0.03</a:t>
                  </a:r>
                  <a:endParaRPr lang="ru-RU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endParaRPr>
                </a:p>
              </p:txBody>
            </p:sp>
            <p:sp>
              <p:nvSpPr>
                <p:cNvPr id="527" name="TextBox 526"/>
                <p:cNvSpPr txBox="1"/>
                <p:nvPr/>
              </p:nvSpPr>
              <p:spPr>
                <a:xfrm>
                  <a:off x="7553858" y="668861"/>
                  <a:ext cx="134684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Mot3PD-GFP OP 6 </a:t>
                  </a:r>
                  <a:r>
                    <a:rPr lang="en-US" sz="1000" b="1" dirty="0" err="1" smtClean="0"/>
                    <a:t>hrs</a:t>
                  </a:r>
                  <a:endParaRPr lang="ru-RU" sz="1000" dirty="0"/>
                </a:p>
              </p:txBody>
            </p:sp>
            <p:sp>
              <p:nvSpPr>
                <p:cNvPr id="528" name="TextBox 527"/>
                <p:cNvSpPr txBox="1"/>
                <p:nvPr/>
              </p:nvSpPr>
              <p:spPr>
                <a:xfrm rot="16200000">
                  <a:off x="6657948" y="1303351"/>
                  <a:ext cx="127310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 smtClean="0"/>
                    <a:t>% of cells with foci</a:t>
                  </a:r>
                  <a:endParaRPr lang="ru-RU" sz="1100" b="1" dirty="0"/>
                </a:p>
              </p:txBody>
            </p:sp>
          </p:grpSp>
          <p:sp>
            <p:nvSpPr>
              <p:cNvPr id="522" name="TextBox 521"/>
              <p:cNvSpPr txBox="1"/>
              <p:nvPr/>
            </p:nvSpPr>
            <p:spPr>
              <a:xfrm rot="19500000">
                <a:off x="7201395" y="1915724"/>
                <a:ext cx="7168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untreated</a:t>
                </a:r>
                <a:endParaRPr lang="ru-RU" sz="1000" b="1" dirty="0"/>
              </a:p>
            </p:txBody>
          </p:sp>
          <p:sp>
            <p:nvSpPr>
              <p:cNvPr id="407" name="TextBox 406"/>
              <p:cNvSpPr txBox="1"/>
              <p:nvPr/>
            </p:nvSpPr>
            <p:spPr>
              <a:xfrm rot="19500000">
                <a:off x="7784382" y="1909576"/>
                <a:ext cx="78899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 smtClean="0"/>
                  <a:t>+ </a:t>
                </a:r>
                <a:r>
                  <a:rPr lang="en-US" sz="1100" b="1" dirty="0" err="1" smtClean="0"/>
                  <a:t>RNAse</a:t>
                </a:r>
                <a:r>
                  <a:rPr lang="en-US" sz="1100" b="1" dirty="0" smtClean="0"/>
                  <a:t> A</a:t>
                </a:r>
              </a:p>
            </p:txBody>
          </p:sp>
        </p:grpSp>
        <p:grpSp>
          <p:nvGrpSpPr>
            <p:cNvPr id="552" name="Группа 551"/>
            <p:cNvGrpSpPr/>
            <p:nvPr/>
          </p:nvGrpSpPr>
          <p:grpSpPr>
            <a:xfrm>
              <a:off x="6988054" y="2169132"/>
              <a:ext cx="2862917" cy="1847789"/>
              <a:chOff x="7042012" y="2123387"/>
              <a:chExt cx="2862917" cy="1847789"/>
            </a:xfrm>
          </p:grpSpPr>
          <p:grpSp>
            <p:nvGrpSpPr>
              <p:cNvPr id="550" name="Группа 549"/>
              <p:cNvGrpSpPr/>
              <p:nvPr/>
            </p:nvGrpSpPr>
            <p:grpSpPr>
              <a:xfrm>
                <a:off x="7042012" y="2123387"/>
                <a:ext cx="2862917" cy="1617124"/>
                <a:chOff x="7126085" y="2214889"/>
                <a:chExt cx="2862917" cy="1617124"/>
              </a:xfrm>
            </p:grpSpPr>
            <p:graphicFrame>
              <p:nvGraphicFramePr>
                <p:cNvPr id="397" name="Диаграмма 396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95189972"/>
                    </p:ext>
                  </p:extLst>
                </p:nvPr>
              </p:nvGraphicFramePr>
              <p:xfrm>
                <a:off x="7303167" y="2463315"/>
                <a:ext cx="2685835" cy="136869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01"/>
                </a:graphicData>
              </a:graphic>
            </p:graphicFrame>
            <p:sp>
              <p:nvSpPr>
                <p:cNvPr id="398" name="TextBox 397"/>
                <p:cNvSpPr txBox="1"/>
                <p:nvPr/>
              </p:nvSpPr>
              <p:spPr>
                <a:xfrm>
                  <a:off x="8311963" y="2214889"/>
                  <a:ext cx="89319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GFP-Rnq1 OP</a:t>
                  </a:r>
                  <a:endParaRPr lang="ru-RU" sz="1000" dirty="0"/>
                </a:p>
              </p:txBody>
            </p:sp>
            <p:cxnSp>
              <p:nvCxnSpPr>
                <p:cNvPr id="539" name="Прямая соединительная линия 538"/>
                <p:cNvCxnSpPr/>
                <p:nvPr/>
              </p:nvCxnSpPr>
              <p:spPr>
                <a:xfrm>
                  <a:off x="7723499" y="2553322"/>
                  <a:ext cx="900697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9" name="Прямая соединительная линия 398"/>
                <p:cNvCxnSpPr/>
                <p:nvPr/>
              </p:nvCxnSpPr>
              <p:spPr>
                <a:xfrm>
                  <a:off x="8836019" y="2553322"/>
                  <a:ext cx="900697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46" name="Прямоугольник 545"/>
                <p:cNvSpPr/>
                <p:nvPr/>
              </p:nvSpPr>
              <p:spPr>
                <a:xfrm>
                  <a:off x="7946378" y="2344871"/>
                  <a:ext cx="502061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b="1" dirty="0" smtClean="0"/>
                    <a:t>5 </a:t>
                  </a:r>
                  <a:r>
                    <a:rPr lang="en-US" sz="1100" b="1" dirty="0" err="1" smtClean="0"/>
                    <a:t>hrs</a:t>
                  </a:r>
                  <a:r>
                    <a:rPr lang="en-US" sz="1100" b="1" dirty="0" smtClean="0"/>
                    <a:t> </a:t>
                  </a:r>
                  <a:endParaRPr lang="ru-RU" sz="1100" dirty="0"/>
                </a:p>
              </p:txBody>
            </p:sp>
            <p:sp>
              <p:nvSpPr>
                <p:cNvPr id="400" name="Прямоугольник 399"/>
                <p:cNvSpPr/>
                <p:nvPr/>
              </p:nvSpPr>
              <p:spPr>
                <a:xfrm>
                  <a:off x="9066518" y="2344871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b="1" dirty="0" smtClean="0"/>
                    <a:t>30 </a:t>
                  </a:r>
                  <a:r>
                    <a:rPr lang="en-US" sz="1100" b="1" dirty="0" err="1" smtClean="0"/>
                    <a:t>hrs</a:t>
                  </a:r>
                  <a:endParaRPr lang="ru-RU" sz="1100" dirty="0"/>
                </a:p>
              </p:txBody>
            </p:sp>
            <p:cxnSp>
              <p:nvCxnSpPr>
                <p:cNvPr id="401" name="Прямая соединительная линия 400"/>
                <p:cNvCxnSpPr/>
                <p:nvPr/>
              </p:nvCxnSpPr>
              <p:spPr>
                <a:xfrm>
                  <a:off x="8927459" y="2759062"/>
                  <a:ext cx="720000" cy="0"/>
                </a:xfrm>
                <a:prstGeom prst="line">
                  <a:avLst/>
                </a:prstGeom>
                <a:ln w="9525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2" name="Прямая соединительная линия 401"/>
                <p:cNvCxnSpPr/>
                <p:nvPr/>
              </p:nvCxnSpPr>
              <p:spPr>
                <a:xfrm>
                  <a:off x="7800118" y="3188212"/>
                  <a:ext cx="720000" cy="0"/>
                </a:xfrm>
                <a:prstGeom prst="line">
                  <a:avLst/>
                </a:prstGeom>
                <a:ln w="9525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49" name="TextBox 548"/>
                <p:cNvSpPr txBox="1"/>
                <p:nvPr/>
              </p:nvSpPr>
              <p:spPr>
                <a:xfrm>
                  <a:off x="7901587" y="2996224"/>
                  <a:ext cx="556563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</a:rPr>
                    <a:t>p = 0.02</a:t>
                  </a:r>
                  <a:endParaRPr lang="ru-RU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endParaRPr>
                </a:p>
              </p:txBody>
            </p:sp>
            <p:sp>
              <p:nvSpPr>
                <p:cNvPr id="403" name="TextBox 402"/>
                <p:cNvSpPr txBox="1"/>
                <p:nvPr/>
              </p:nvSpPr>
              <p:spPr>
                <a:xfrm>
                  <a:off x="9031654" y="2570027"/>
                  <a:ext cx="556563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</a:rPr>
                    <a:t>p = 0.54</a:t>
                  </a:r>
                  <a:endParaRPr lang="ru-RU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endParaRPr>
                </a:p>
              </p:txBody>
            </p:sp>
            <p:sp>
              <p:nvSpPr>
                <p:cNvPr id="404" name="TextBox 403"/>
                <p:cNvSpPr txBox="1"/>
                <p:nvPr/>
              </p:nvSpPr>
              <p:spPr>
                <a:xfrm rot="16200000">
                  <a:off x="6620337" y="3032297"/>
                  <a:ext cx="127310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 smtClean="0"/>
                    <a:t>% of cells with foci</a:t>
                  </a:r>
                  <a:endParaRPr lang="ru-RU" sz="1100" b="1" dirty="0"/>
                </a:p>
              </p:txBody>
            </p:sp>
          </p:grpSp>
          <p:sp>
            <p:nvSpPr>
              <p:cNvPr id="405" name="TextBox 404"/>
              <p:cNvSpPr txBox="1"/>
              <p:nvPr/>
            </p:nvSpPr>
            <p:spPr>
              <a:xfrm rot="19680000">
                <a:off x="7217962" y="3708097"/>
                <a:ext cx="7168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untreated</a:t>
                </a:r>
                <a:endParaRPr lang="ru-RU" sz="1000" b="1" dirty="0"/>
              </a:p>
            </p:txBody>
          </p:sp>
          <p:sp>
            <p:nvSpPr>
              <p:cNvPr id="406" name="TextBox 405"/>
              <p:cNvSpPr txBox="1"/>
              <p:nvPr/>
            </p:nvSpPr>
            <p:spPr>
              <a:xfrm rot="19680000">
                <a:off x="8346189" y="3708097"/>
                <a:ext cx="7168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untreated</a:t>
                </a:r>
                <a:endParaRPr lang="ru-RU" sz="1000" b="1" dirty="0"/>
              </a:p>
            </p:txBody>
          </p:sp>
          <p:sp>
            <p:nvSpPr>
              <p:cNvPr id="408" name="TextBox 407"/>
              <p:cNvSpPr txBox="1"/>
              <p:nvPr/>
            </p:nvSpPr>
            <p:spPr>
              <a:xfrm rot="19680000">
                <a:off x="7699480" y="3709566"/>
                <a:ext cx="78899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 smtClean="0"/>
                  <a:t>+ </a:t>
                </a:r>
                <a:r>
                  <a:rPr lang="en-US" sz="1100" b="1" dirty="0" err="1" smtClean="0"/>
                  <a:t>RNAse</a:t>
                </a:r>
                <a:r>
                  <a:rPr lang="en-US" sz="1100" b="1" dirty="0" smtClean="0"/>
                  <a:t> A</a:t>
                </a:r>
              </a:p>
            </p:txBody>
          </p:sp>
          <p:sp>
            <p:nvSpPr>
              <p:cNvPr id="409" name="TextBox 408"/>
              <p:cNvSpPr txBox="1"/>
              <p:nvPr/>
            </p:nvSpPr>
            <p:spPr>
              <a:xfrm rot="19680000">
                <a:off x="8854540" y="3707701"/>
                <a:ext cx="78899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 smtClean="0"/>
                  <a:t>+ </a:t>
                </a:r>
                <a:r>
                  <a:rPr lang="en-US" sz="1100" b="1" dirty="0" err="1" smtClean="0"/>
                  <a:t>RNAse</a:t>
                </a:r>
                <a:r>
                  <a:rPr lang="en-US" sz="1100" b="1" dirty="0" smtClean="0"/>
                  <a:t> A</a:t>
                </a:r>
              </a:p>
            </p:txBody>
          </p:sp>
        </p:grpSp>
      </p:grpSp>
      <p:grpSp>
        <p:nvGrpSpPr>
          <p:cNvPr id="555" name="Группа 554"/>
          <p:cNvGrpSpPr/>
          <p:nvPr/>
        </p:nvGrpSpPr>
        <p:grpSpPr>
          <a:xfrm>
            <a:off x="819659" y="226074"/>
            <a:ext cx="2911085" cy="2438976"/>
            <a:chOff x="819659" y="226074"/>
            <a:chExt cx="2911085" cy="2438976"/>
          </a:xfrm>
        </p:grpSpPr>
        <p:grpSp>
          <p:nvGrpSpPr>
            <p:cNvPr id="542" name="Группа 541"/>
            <p:cNvGrpSpPr/>
            <p:nvPr/>
          </p:nvGrpSpPr>
          <p:grpSpPr>
            <a:xfrm>
              <a:off x="819659" y="226074"/>
              <a:ext cx="2470372" cy="2438976"/>
              <a:chOff x="819659" y="226074"/>
              <a:chExt cx="2470372" cy="2438976"/>
            </a:xfrm>
          </p:grpSpPr>
          <p:sp>
            <p:nvSpPr>
              <p:cNvPr id="533" name="TextBox 532"/>
              <p:cNvSpPr txBox="1"/>
              <p:nvPr/>
            </p:nvSpPr>
            <p:spPr>
              <a:xfrm>
                <a:off x="914764" y="226074"/>
                <a:ext cx="32412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A</a:t>
                </a:r>
                <a:endParaRPr lang="ru-RU" b="1" dirty="0"/>
              </a:p>
            </p:txBody>
          </p:sp>
          <p:grpSp>
            <p:nvGrpSpPr>
              <p:cNvPr id="11" name="Группа 10"/>
              <p:cNvGrpSpPr/>
              <p:nvPr/>
            </p:nvGrpSpPr>
            <p:grpSpPr>
              <a:xfrm>
                <a:off x="819659" y="252462"/>
                <a:ext cx="2470372" cy="2412588"/>
                <a:chOff x="4740965" y="-87772"/>
                <a:chExt cx="2470372" cy="2412588"/>
              </a:xfrm>
            </p:grpSpPr>
            <p:sp>
              <p:nvSpPr>
                <p:cNvPr id="12" name="TextBox 11"/>
                <p:cNvSpPr txBox="1"/>
                <p:nvPr/>
              </p:nvSpPr>
              <p:spPr>
                <a:xfrm>
                  <a:off x="5765491" y="2047817"/>
                  <a:ext cx="83644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/>
                    <a:t>Residue %</a:t>
                  </a:r>
                  <a:endParaRPr lang="ru-RU" sz="1200" b="1" dirty="0"/>
                </a:p>
              </p:txBody>
            </p:sp>
            <p:graphicFrame>
              <p:nvGraphicFramePr>
                <p:cNvPr id="13" name="Диаграмма 12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190253745"/>
                    </p:ext>
                  </p:extLst>
                </p:nvPr>
              </p:nvGraphicFramePr>
              <p:xfrm>
                <a:off x="4740965" y="-87772"/>
                <a:ext cx="2470372" cy="222504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02"/>
                </a:graphicData>
              </a:graphic>
            </p:graphicFrame>
          </p:grpSp>
        </p:grpSp>
        <p:sp>
          <p:nvSpPr>
            <p:cNvPr id="6" name="TextBox 5"/>
            <p:cNvSpPr txBox="1"/>
            <p:nvPr/>
          </p:nvSpPr>
          <p:spPr>
            <a:xfrm>
              <a:off x="2965791" y="789756"/>
              <a:ext cx="7649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/>
                <a:t>Q/N = 1.54</a:t>
              </a:r>
              <a:endParaRPr lang="ru-RU" sz="1000" b="1" dirty="0"/>
            </a:p>
          </p:txBody>
        </p:sp>
        <p:sp>
          <p:nvSpPr>
            <p:cNvPr id="410" name="TextBox 409"/>
            <p:cNvSpPr txBox="1"/>
            <p:nvPr/>
          </p:nvSpPr>
          <p:spPr>
            <a:xfrm>
              <a:off x="2958291" y="1148324"/>
              <a:ext cx="7649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/>
                <a:t>Q/N = 0.58</a:t>
              </a:r>
              <a:endParaRPr lang="ru-RU" sz="1000" b="1" dirty="0"/>
            </a:p>
          </p:txBody>
        </p:sp>
        <p:sp>
          <p:nvSpPr>
            <p:cNvPr id="411" name="TextBox 410"/>
            <p:cNvSpPr txBox="1"/>
            <p:nvPr/>
          </p:nvSpPr>
          <p:spPr>
            <a:xfrm>
              <a:off x="2958291" y="1529324"/>
              <a:ext cx="7649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/>
                <a:t>Q/N = 0.30</a:t>
              </a:r>
              <a:endParaRPr lang="ru-RU" sz="1000" b="1" dirty="0"/>
            </a:p>
          </p:txBody>
        </p:sp>
        <p:sp>
          <p:nvSpPr>
            <p:cNvPr id="412" name="TextBox 411"/>
            <p:cNvSpPr txBox="1"/>
            <p:nvPr/>
          </p:nvSpPr>
          <p:spPr>
            <a:xfrm>
              <a:off x="2958291" y="1925564"/>
              <a:ext cx="7649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/>
                <a:t>Q/N = 0.16</a:t>
              </a:r>
              <a:endParaRPr lang="ru-RU" sz="1000" b="1" dirty="0"/>
            </a:p>
          </p:txBody>
        </p:sp>
      </p:grpSp>
      <p:grpSp>
        <p:nvGrpSpPr>
          <p:cNvPr id="413" name="Группа 412"/>
          <p:cNvGrpSpPr/>
          <p:nvPr/>
        </p:nvGrpSpPr>
        <p:grpSpPr>
          <a:xfrm>
            <a:off x="8213084" y="8669003"/>
            <a:ext cx="2813096" cy="2063391"/>
            <a:chOff x="8212390" y="8676697"/>
            <a:chExt cx="2813096" cy="2063391"/>
          </a:xfrm>
        </p:grpSpPr>
        <p:grpSp>
          <p:nvGrpSpPr>
            <p:cNvPr id="414" name="Группа 413"/>
            <p:cNvGrpSpPr/>
            <p:nvPr/>
          </p:nvGrpSpPr>
          <p:grpSpPr>
            <a:xfrm>
              <a:off x="8212390" y="8676697"/>
              <a:ext cx="2813096" cy="2063391"/>
              <a:chOff x="3823389" y="6172875"/>
              <a:chExt cx="2813096" cy="2063391"/>
            </a:xfrm>
          </p:grpSpPr>
          <p:sp>
            <p:nvSpPr>
              <p:cNvPr id="416" name="TextBox 415"/>
              <p:cNvSpPr txBox="1"/>
              <p:nvPr/>
            </p:nvSpPr>
            <p:spPr>
              <a:xfrm>
                <a:off x="3823389" y="6172875"/>
                <a:ext cx="24558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I</a:t>
                </a:r>
                <a:endParaRPr lang="ru-RU" b="1" dirty="0"/>
              </a:p>
            </p:txBody>
          </p:sp>
          <p:grpSp>
            <p:nvGrpSpPr>
              <p:cNvPr id="417" name="Группа 416"/>
              <p:cNvGrpSpPr/>
              <p:nvPr/>
            </p:nvGrpSpPr>
            <p:grpSpPr>
              <a:xfrm>
                <a:off x="4017142" y="6209556"/>
                <a:ext cx="2619343" cy="2026710"/>
                <a:chOff x="4239802" y="1084293"/>
                <a:chExt cx="2619343" cy="2026710"/>
              </a:xfrm>
            </p:grpSpPr>
            <p:graphicFrame>
              <p:nvGraphicFramePr>
                <p:cNvPr id="418" name="Диаграмма 417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473374061"/>
                    </p:ext>
                  </p:extLst>
                </p:nvPr>
              </p:nvGraphicFramePr>
              <p:xfrm>
                <a:off x="4653794" y="1282148"/>
                <a:ext cx="2205351" cy="166977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03"/>
                </a:graphicData>
              </a:graphic>
            </p:graphicFrame>
            <p:sp>
              <p:nvSpPr>
                <p:cNvPr id="419" name="TextBox 418"/>
                <p:cNvSpPr txBox="1"/>
                <p:nvPr/>
              </p:nvSpPr>
              <p:spPr>
                <a:xfrm>
                  <a:off x="5266259" y="2834004"/>
                  <a:ext cx="94102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>
                      <a:cs typeface="Arial" panose="020B0604020202020204" pitchFamily="34" charset="0"/>
                    </a:rPr>
                    <a:t>Time, hours</a:t>
                  </a:r>
                  <a:endParaRPr lang="ru-RU" sz="1200" b="1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0" name="TextBox 419"/>
                <p:cNvSpPr txBox="1"/>
                <p:nvPr/>
              </p:nvSpPr>
              <p:spPr>
                <a:xfrm rot="16200000">
                  <a:off x="3538516" y="1785579"/>
                  <a:ext cx="1864238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 smtClean="0">
                      <a:cs typeface="Arial" panose="020B0604020202020204" pitchFamily="34" charset="0"/>
                    </a:rPr>
                    <a:t>% of cells with certain type of assemblies</a:t>
                  </a:r>
                  <a:endParaRPr lang="ru-RU" sz="1200" b="1" dirty="0"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415" name="Прямоугольник 414"/>
            <p:cNvSpPr/>
            <p:nvPr/>
          </p:nvSpPr>
          <p:spPr>
            <a:xfrm>
              <a:off x="8835375" y="10174753"/>
              <a:ext cx="198874" cy="1655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</p:grpSp>
    </p:spTree>
    <p:extLst>
      <p:ext uri="{BB962C8B-B14F-4D97-AF65-F5344CB8AC3E}">
        <p14:creationId xmlns:p14="http://schemas.microsoft.com/office/powerpoint/2010/main" val="10844817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323850" y="316765"/>
            <a:ext cx="10515600" cy="10290109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400" b="1" dirty="0"/>
              <a:t>A. </a:t>
            </a:r>
            <a:r>
              <a:rPr lang="en-US" sz="1400" dirty="0"/>
              <a:t>Comparison of the content of glutamine (Q) and asparagine (N) residues in the studied </a:t>
            </a:r>
            <a:r>
              <a:rPr lang="en-US" sz="1400" dirty="0" err="1"/>
              <a:t>prionogenic</a:t>
            </a:r>
            <a:r>
              <a:rPr lang="en-US" sz="1400" dirty="0"/>
              <a:t> polypeptides (w/o GFP</a:t>
            </a:r>
            <a:r>
              <a:rPr lang="ru-RU" sz="1400" dirty="0"/>
              <a:t> </a:t>
            </a:r>
            <a:r>
              <a:rPr lang="en-US" sz="1400" dirty="0" smtClean="0"/>
              <a:t>tag and linker sequence (Sup35 M domain fragment)).</a:t>
            </a:r>
          </a:p>
          <a:p>
            <a:pPr marL="0" indent="0">
              <a:buNone/>
            </a:pPr>
            <a:r>
              <a:rPr lang="en-US" sz="1400" b="1" dirty="0" smtClean="0"/>
              <a:t>B. </a:t>
            </a:r>
            <a:r>
              <a:rPr lang="en-US" sz="1400" dirty="0"/>
              <a:t>The distribution of [Inside/Outside] GFP Intensity Ratio (IR), as a measure of protein enrichment, for freshly-formed protein condensates of Sup35PD-GFP (</a:t>
            </a:r>
            <a:r>
              <a:rPr lang="en-US" sz="1400" dirty="0" smtClean="0"/>
              <a:t>12 </a:t>
            </a:r>
            <a:r>
              <a:rPr lang="en-US" sz="1400" dirty="0" err="1" smtClean="0"/>
              <a:t>hrs</a:t>
            </a:r>
            <a:r>
              <a:rPr lang="en-US" sz="1400" dirty="0" smtClean="0"/>
              <a:t> </a:t>
            </a:r>
            <a:r>
              <a:rPr lang="en-US" sz="1400" dirty="0"/>
              <a:t>overproduction, n = 196 condensates), GFP-Rnq1 (</a:t>
            </a:r>
            <a:r>
              <a:rPr lang="en-US" sz="1400" dirty="0" smtClean="0"/>
              <a:t>8 </a:t>
            </a:r>
            <a:r>
              <a:rPr lang="en-US" sz="1400" dirty="0" err="1" smtClean="0"/>
              <a:t>hrs</a:t>
            </a:r>
            <a:r>
              <a:rPr lang="en-US" sz="1400" dirty="0" smtClean="0"/>
              <a:t> </a:t>
            </a:r>
            <a:r>
              <a:rPr lang="en-US" sz="1400" dirty="0"/>
              <a:t>overproduction, n = 132 condensates), and Mot3PD-GFP (</a:t>
            </a:r>
            <a:r>
              <a:rPr lang="en-US" sz="1400" dirty="0" smtClean="0"/>
              <a:t>4 </a:t>
            </a:r>
            <a:r>
              <a:rPr lang="en-US" sz="1400" dirty="0" err="1" smtClean="0"/>
              <a:t>hrs</a:t>
            </a:r>
            <a:r>
              <a:rPr lang="en-US" sz="1400" dirty="0" smtClean="0"/>
              <a:t> </a:t>
            </a:r>
            <a:r>
              <a:rPr lang="en-US" sz="1400" dirty="0"/>
              <a:t>overproduction, n = 163 condensates</a:t>
            </a:r>
            <a:r>
              <a:rPr lang="en-US" sz="1400" dirty="0" smtClean="0"/>
              <a:t>).</a:t>
            </a:r>
          </a:p>
          <a:p>
            <a:pPr marL="0" indent="0">
              <a:buNone/>
            </a:pPr>
            <a:r>
              <a:rPr lang="en-US" sz="1400" b="1" dirty="0" smtClean="0"/>
              <a:t>C. </a:t>
            </a:r>
            <a:r>
              <a:rPr lang="en-US" sz="1400" dirty="0" err="1" smtClean="0">
                <a:cs typeface="Arial" panose="020B0604020202020204" pitchFamily="34" charset="0"/>
              </a:rPr>
              <a:t>Colocalization</a:t>
            </a:r>
            <a:r>
              <a:rPr lang="en-US" sz="1400" dirty="0" smtClean="0">
                <a:cs typeface="Arial" panose="020B0604020202020204" pitchFamily="34" charset="0"/>
              </a:rPr>
              <a:t> </a:t>
            </a:r>
            <a:r>
              <a:rPr lang="en-US" sz="1400" dirty="0">
                <a:cs typeface="Arial" panose="020B0604020202020204" pitchFamily="34" charset="0"/>
              </a:rPr>
              <a:t>of GFP-Rnq1 (24 </a:t>
            </a:r>
            <a:r>
              <a:rPr lang="en-US" sz="1400" dirty="0" err="1" smtClean="0">
                <a:cs typeface="Arial" panose="020B0604020202020204" pitchFamily="34" charset="0"/>
              </a:rPr>
              <a:t>hrs</a:t>
            </a:r>
            <a:r>
              <a:rPr lang="en-US" sz="1400" dirty="0" smtClean="0">
                <a:cs typeface="Arial" panose="020B0604020202020204" pitchFamily="34" charset="0"/>
              </a:rPr>
              <a:t> </a:t>
            </a:r>
            <a:r>
              <a:rPr lang="en-US" sz="1400" dirty="0">
                <a:cs typeface="Arial" panose="020B0604020202020204" pitchFamily="34" charset="0"/>
              </a:rPr>
              <a:t>overproduction) and Mot3PD-GFP (8 </a:t>
            </a:r>
            <a:r>
              <a:rPr lang="en-US" sz="1400" dirty="0" err="1" smtClean="0">
                <a:cs typeface="Arial" panose="020B0604020202020204" pitchFamily="34" charset="0"/>
              </a:rPr>
              <a:t>hrs</a:t>
            </a:r>
            <a:r>
              <a:rPr lang="en-US" sz="1400" dirty="0" smtClean="0">
                <a:cs typeface="Arial" panose="020B0604020202020204" pitchFamily="34" charset="0"/>
              </a:rPr>
              <a:t> </a:t>
            </a:r>
            <a:r>
              <a:rPr lang="en-US" sz="1400" dirty="0">
                <a:cs typeface="Arial" panose="020B0604020202020204" pitchFamily="34" charset="0"/>
              </a:rPr>
              <a:t>overproduction) condensates with the stress granule marker Pab1-RFP, the P-body marker Dcp2-RFP and the IPOD marker Hsp42-RFP. Pab1-RFP forms co-aggregates with both constructs, whereas Dcp2-RFP partially </a:t>
            </a:r>
            <a:r>
              <a:rPr lang="en-US" sz="1400" dirty="0" err="1" smtClean="0">
                <a:cs typeface="Arial" panose="020B0604020202020204" pitchFamily="34" charset="0"/>
              </a:rPr>
              <a:t>colocalizes</a:t>
            </a:r>
            <a:r>
              <a:rPr lang="en-US" sz="1400" dirty="0" smtClean="0">
                <a:cs typeface="Arial" panose="020B0604020202020204" pitchFamily="34" charset="0"/>
              </a:rPr>
              <a:t> </a:t>
            </a:r>
            <a:r>
              <a:rPr lang="en-US" sz="1400" dirty="0">
                <a:cs typeface="Arial" panose="020B0604020202020204" pitchFamily="34" charset="0"/>
              </a:rPr>
              <a:t>with GFP-Rnq1 and Mot3PD-GFP condensates (white arrowheads), but also forms separate aggregates that could be attributed to the native P-bodies (blue arrowheads). Hsp42-RFP does not </a:t>
            </a:r>
            <a:r>
              <a:rPr lang="en-US" sz="1400" dirty="0" err="1" smtClean="0">
                <a:cs typeface="Arial" panose="020B0604020202020204" pitchFamily="34" charset="0"/>
              </a:rPr>
              <a:t>colocalize</a:t>
            </a:r>
            <a:r>
              <a:rPr lang="en-US" sz="1400" dirty="0" smtClean="0">
                <a:cs typeface="Arial" panose="020B0604020202020204" pitchFamily="34" charset="0"/>
              </a:rPr>
              <a:t> </a:t>
            </a:r>
            <a:r>
              <a:rPr lang="en-US" sz="1400" dirty="0">
                <a:cs typeface="Arial" panose="020B0604020202020204" pitchFamily="34" charset="0"/>
              </a:rPr>
              <a:t>with either GFP-Rnq1 or Mot3PD-GFP condensates. Scale bar is 1</a:t>
            </a:r>
            <a:r>
              <a:rPr lang="el-GR" sz="1400" dirty="0">
                <a:cs typeface="Arial" panose="020B0604020202020204" pitchFamily="34" charset="0"/>
              </a:rPr>
              <a:t>μ</a:t>
            </a:r>
            <a:r>
              <a:rPr lang="en-US" sz="1400" dirty="0">
                <a:cs typeface="Arial" panose="020B0604020202020204" pitchFamily="34" charset="0"/>
              </a:rPr>
              <a:t>M</a:t>
            </a:r>
            <a:r>
              <a:rPr lang="en-US" sz="1400" dirty="0" smtClean="0">
                <a:cs typeface="Arial" panose="020B0604020202020204" pitchFamily="34" charset="0"/>
              </a:rPr>
              <a:t>.</a:t>
            </a:r>
          </a:p>
          <a:p>
            <a:pPr marL="0" indent="0">
              <a:buNone/>
            </a:pPr>
            <a:r>
              <a:rPr lang="en-US" sz="1400" b="1" dirty="0" smtClean="0">
                <a:cs typeface="Arial" panose="020B0604020202020204" pitchFamily="34" charset="0"/>
              </a:rPr>
              <a:t>D. </a:t>
            </a:r>
            <a:r>
              <a:rPr lang="en-US" sz="1400" dirty="0" smtClean="0">
                <a:cs typeface="Arial" panose="020B0604020202020204" pitchFamily="34" charset="0"/>
              </a:rPr>
              <a:t>Fresh liquid-like condensates of GFP-Rnq1 and Mot3PD-GFP constructs are sensitive to </a:t>
            </a:r>
            <a:r>
              <a:rPr lang="en-US" sz="1400" dirty="0" err="1" smtClean="0">
                <a:cs typeface="Arial" panose="020B0604020202020204" pitchFamily="34" charset="0"/>
              </a:rPr>
              <a:t>RNAse</a:t>
            </a:r>
            <a:r>
              <a:rPr lang="en-US" sz="1400" dirty="0" smtClean="0">
                <a:cs typeface="Arial" panose="020B0604020202020204" pitchFamily="34" charset="0"/>
              </a:rPr>
              <a:t> A treatment, while more aged condensates or solid-like aggregates are </a:t>
            </a:r>
            <a:r>
              <a:rPr lang="en-US" sz="1400" dirty="0" err="1" smtClean="0">
                <a:cs typeface="Arial" panose="020B0604020202020204" pitchFamily="34" charset="0"/>
              </a:rPr>
              <a:t>RNAse</a:t>
            </a:r>
            <a:r>
              <a:rPr lang="en-US" sz="1400" dirty="0" smtClean="0">
                <a:cs typeface="Arial" panose="020B0604020202020204" pitchFamily="34" charset="0"/>
              </a:rPr>
              <a:t>-resistant. Mot3PD-GFP was overproduced over 8 </a:t>
            </a:r>
            <a:r>
              <a:rPr lang="en-US" sz="1400" dirty="0" err="1" smtClean="0">
                <a:cs typeface="Arial" panose="020B0604020202020204" pitchFamily="34" charset="0"/>
              </a:rPr>
              <a:t>hrs</a:t>
            </a:r>
            <a:r>
              <a:rPr lang="en-US" sz="1400" dirty="0" smtClean="0">
                <a:cs typeface="Arial" panose="020B0604020202020204" pitchFamily="34" charset="0"/>
              </a:rPr>
              <a:t>, GFP-Rnq1 was overproduced over 4 </a:t>
            </a:r>
            <a:r>
              <a:rPr lang="en-US" sz="1400" dirty="0" err="1" smtClean="0">
                <a:cs typeface="Arial" panose="020B0604020202020204" pitchFamily="34" charset="0"/>
              </a:rPr>
              <a:t>hrs</a:t>
            </a:r>
            <a:r>
              <a:rPr lang="en-US" sz="1400" dirty="0" smtClean="0">
                <a:cs typeface="Arial" panose="020B0604020202020204" pitchFamily="34" charset="0"/>
              </a:rPr>
              <a:t> (fresh condensates) or 24 </a:t>
            </a:r>
            <a:r>
              <a:rPr lang="en-US" sz="1400" dirty="0" err="1" smtClean="0">
                <a:cs typeface="Arial" panose="020B0604020202020204" pitchFamily="34" charset="0"/>
              </a:rPr>
              <a:t>hrs</a:t>
            </a:r>
            <a:r>
              <a:rPr lang="en-US" sz="1400" dirty="0" smtClean="0">
                <a:cs typeface="Arial" panose="020B0604020202020204" pitchFamily="34" charset="0"/>
              </a:rPr>
              <a:t> (aged condensates). Maximum intensity projections on the left show the live single cells before and after 1 </a:t>
            </a:r>
            <a:r>
              <a:rPr lang="en-US" sz="1400" dirty="0" err="1" smtClean="0">
                <a:cs typeface="Arial" panose="020B0604020202020204" pitchFamily="34" charset="0"/>
              </a:rPr>
              <a:t>hr</a:t>
            </a:r>
            <a:r>
              <a:rPr lang="en-US" sz="1400" dirty="0" smtClean="0">
                <a:cs typeface="Arial" panose="020B0604020202020204" pitchFamily="34" charset="0"/>
              </a:rPr>
              <a:t>-long treatment with </a:t>
            </a:r>
            <a:r>
              <a:rPr lang="en-US" sz="1400" dirty="0" err="1" smtClean="0">
                <a:cs typeface="Arial" panose="020B0604020202020204" pitchFamily="34" charset="0"/>
              </a:rPr>
              <a:t>RNAse</a:t>
            </a:r>
            <a:r>
              <a:rPr lang="en-US" sz="1400" dirty="0" smtClean="0">
                <a:cs typeface="Arial" panose="020B0604020202020204" pitchFamily="34" charset="0"/>
              </a:rPr>
              <a:t> A solution (1 mg/ml</a:t>
            </a:r>
            <a:r>
              <a:rPr lang="en-US" sz="1400" dirty="0">
                <a:cs typeface="Arial" panose="020B0604020202020204" pitchFamily="34" charset="0"/>
              </a:rPr>
              <a:t>). Scale bar is 1 </a:t>
            </a:r>
            <a:r>
              <a:rPr lang="el-GR" sz="1400" dirty="0">
                <a:cs typeface="Arial" panose="020B0604020202020204" pitchFamily="34" charset="0"/>
              </a:rPr>
              <a:t>μ</a:t>
            </a:r>
            <a:r>
              <a:rPr lang="en-US" sz="1400" dirty="0">
                <a:cs typeface="Arial" panose="020B0604020202020204" pitchFamily="34" charset="0"/>
              </a:rPr>
              <a:t>M. Graphs </a:t>
            </a:r>
            <a:r>
              <a:rPr lang="en-US" sz="1400" dirty="0" smtClean="0">
                <a:cs typeface="Arial" panose="020B0604020202020204" pitchFamily="34" charset="0"/>
              </a:rPr>
              <a:t>on the right show quantification of proportions of cells with foci in indicated conditions. The values represent mean + SEM (n = 3, 150-200 cells counted per condition).</a:t>
            </a:r>
          </a:p>
          <a:p>
            <a:pPr marL="0" indent="0">
              <a:buNone/>
            </a:pPr>
            <a:r>
              <a:rPr lang="en-US" sz="1400" b="1" dirty="0">
                <a:cs typeface="Arial" panose="020B0604020202020204" pitchFamily="34" charset="0"/>
              </a:rPr>
              <a:t>E</a:t>
            </a:r>
            <a:r>
              <a:rPr lang="en-US" sz="1400" b="1" dirty="0" smtClean="0">
                <a:cs typeface="Arial" panose="020B0604020202020204" pitchFamily="34" charset="0"/>
              </a:rPr>
              <a:t>. </a:t>
            </a:r>
            <a:r>
              <a:rPr lang="en-US" sz="1400" dirty="0">
                <a:cs typeface="Arial" panose="020B0604020202020204" pitchFamily="34" charset="0"/>
              </a:rPr>
              <a:t>Formation of an amyloid layer on the surface of GFP-Rnq1 hydrogel particles emerged in Δrnq1 cells via LLPS and </a:t>
            </a:r>
            <a:r>
              <a:rPr lang="en-US" sz="1400" dirty="0" smtClean="0">
                <a:cs typeface="Arial" panose="020B0604020202020204" pitchFamily="34" charset="0"/>
              </a:rPr>
              <a:t>LSPT </a:t>
            </a:r>
            <a:r>
              <a:rPr lang="en-US" sz="1400" dirty="0">
                <a:cs typeface="Arial" panose="020B0604020202020204" pitchFamily="34" charset="0"/>
              </a:rPr>
              <a:t>of GFP-Rnq1 protein. {Left} Fluorescent images of cell stained with </a:t>
            </a:r>
            <a:r>
              <a:rPr lang="en-US" sz="1400" dirty="0" err="1">
                <a:cs typeface="Arial" panose="020B0604020202020204" pitchFamily="34" charset="0"/>
              </a:rPr>
              <a:t>proteostat</a:t>
            </a:r>
            <a:r>
              <a:rPr lang="en-US" sz="1400" dirty="0">
                <a:cs typeface="Arial" panose="020B0604020202020204" pitchFamily="34" charset="0"/>
              </a:rPr>
              <a:t>. {Right} Plot profiles of pixel intensities in </a:t>
            </a:r>
            <a:r>
              <a:rPr lang="en-US" sz="1400" dirty="0" smtClean="0">
                <a:cs typeface="Arial" panose="020B0604020202020204" pitchFamily="34" charset="0"/>
              </a:rPr>
              <a:t>cross-sections </a:t>
            </a:r>
            <a:r>
              <a:rPr lang="en-US" sz="1400" dirty="0">
                <a:cs typeface="Arial" panose="020B0604020202020204" pitchFamily="34" charset="0"/>
              </a:rPr>
              <a:t>of </a:t>
            </a:r>
            <a:r>
              <a:rPr lang="en-US" sz="1400" dirty="0" smtClean="0">
                <a:cs typeface="Arial" panose="020B0604020202020204" pitchFamily="34" charset="0"/>
              </a:rPr>
              <a:t>the hydrogel particles </a:t>
            </a:r>
            <a:r>
              <a:rPr lang="en-US" sz="1400" dirty="0">
                <a:cs typeface="Arial" panose="020B0604020202020204" pitchFamily="34" charset="0"/>
              </a:rPr>
              <a:t>(along dotted </a:t>
            </a:r>
            <a:r>
              <a:rPr lang="en-US" sz="1400" dirty="0" smtClean="0">
                <a:cs typeface="Arial" panose="020B0604020202020204" pitchFamily="34" charset="0"/>
              </a:rPr>
              <a:t>lines). </a:t>
            </a:r>
            <a:r>
              <a:rPr lang="en-US" sz="1400" dirty="0">
                <a:cs typeface="Arial" panose="020B0604020202020204" pitchFamily="34" charset="0"/>
              </a:rPr>
              <a:t>Note that </a:t>
            </a:r>
            <a:r>
              <a:rPr lang="en-US" sz="1400" dirty="0" err="1">
                <a:cs typeface="Arial" panose="020B0604020202020204" pitchFamily="34" charset="0"/>
              </a:rPr>
              <a:t>proteostat</a:t>
            </a:r>
            <a:r>
              <a:rPr lang="en-US" sz="1400" dirty="0">
                <a:cs typeface="Arial" panose="020B0604020202020204" pitchFamily="34" charset="0"/>
              </a:rPr>
              <a:t> signal is of high intensity only at the margins of </a:t>
            </a:r>
            <a:r>
              <a:rPr lang="en-US" sz="1400" dirty="0" smtClean="0">
                <a:cs typeface="Arial" panose="020B0604020202020204" pitchFamily="34" charset="0"/>
              </a:rPr>
              <a:t>particles. </a:t>
            </a:r>
            <a:r>
              <a:rPr lang="en-US" sz="1400" dirty="0">
                <a:cs typeface="Arial" panose="020B0604020202020204" pitchFamily="34" charset="0"/>
              </a:rPr>
              <a:t>Scale bar is </a:t>
            </a:r>
            <a:r>
              <a:rPr lang="ru-RU" sz="1400" dirty="0">
                <a:ea typeface="Microsoft YaHei" pitchFamily="2"/>
                <a:cs typeface="Arial" panose="020B0604020202020204" pitchFamily="34" charset="0"/>
              </a:rPr>
              <a:t>1</a:t>
            </a:r>
            <a:r>
              <a:rPr lang="ru-RU" sz="1400" dirty="0">
                <a:ea typeface="Arial" pitchFamily="18"/>
                <a:cs typeface="Arial" panose="020B0604020202020204" pitchFamily="34" charset="0"/>
              </a:rPr>
              <a:t>μM</a:t>
            </a:r>
            <a:r>
              <a:rPr lang="en-US" sz="1400" dirty="0">
                <a:ea typeface="Arial" pitchFamily="18"/>
                <a:cs typeface="Arial" panose="020B0604020202020204" pitchFamily="34" charset="0"/>
              </a:rPr>
              <a:t>.</a:t>
            </a:r>
            <a:endParaRPr lang="ru-RU" sz="1400" dirty="0">
              <a:ea typeface="Arial" pitchFamily="18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sz="1400" b="1" dirty="0" smtClean="0"/>
              <a:t>F. </a:t>
            </a:r>
            <a:r>
              <a:rPr lang="en-US" sz="1400" dirty="0">
                <a:cs typeface="Arial" panose="020B0604020202020204" pitchFamily="34" charset="0"/>
              </a:rPr>
              <a:t>Fluorescent images of the cells bearing </a:t>
            </a:r>
            <a:r>
              <a:rPr lang="en-US" sz="1400" dirty="0" smtClean="0">
                <a:cs typeface="Arial" panose="020B0604020202020204" pitchFamily="34" charset="0"/>
              </a:rPr>
              <a:t>GFP-Rnq1 or Mot3PD-GFP </a:t>
            </a:r>
            <a:r>
              <a:rPr lang="en-US" sz="1400" dirty="0">
                <a:cs typeface="Arial" panose="020B0604020202020204" pitchFamily="34" charset="0"/>
              </a:rPr>
              <a:t>solid-like bodies with cavities. Scale bar is 1 </a:t>
            </a:r>
            <a:r>
              <a:rPr lang="en-US" sz="1400" dirty="0" err="1">
                <a:cs typeface="Arial" panose="020B0604020202020204" pitchFamily="34" charset="0"/>
              </a:rPr>
              <a:t>μM</a:t>
            </a:r>
            <a:r>
              <a:rPr lang="en-US" sz="1400" dirty="0" smtClean="0">
                <a:cs typeface="Arial" panose="020B0604020202020204" pitchFamily="34" charset="0"/>
              </a:rPr>
              <a:t>. Graphs are plot </a:t>
            </a:r>
            <a:r>
              <a:rPr lang="en-US" sz="1400" dirty="0">
                <a:cs typeface="Arial" panose="020B0604020202020204" pitchFamily="34" charset="0"/>
              </a:rPr>
              <a:t>profiles of pixel intensities in cross-sections of </a:t>
            </a:r>
            <a:r>
              <a:rPr lang="en-US" sz="1400" dirty="0" smtClean="0">
                <a:cs typeface="Arial" panose="020B0604020202020204" pitchFamily="34" charset="0"/>
              </a:rPr>
              <a:t>the particles (along dotted lines).</a:t>
            </a:r>
            <a:endParaRPr lang="en-US" sz="1400" dirty="0"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sz="1400" b="1" dirty="0" smtClean="0"/>
              <a:t>G. </a:t>
            </a:r>
            <a:r>
              <a:rPr lang="en-US" sz="1400" dirty="0">
                <a:cs typeface="Arial" panose="020B0604020202020204" pitchFamily="34" charset="0"/>
              </a:rPr>
              <a:t>Solid-like amyloid aggregates of </a:t>
            </a:r>
            <a:r>
              <a:rPr lang="en-US" sz="1400" dirty="0" smtClean="0">
                <a:cs typeface="Arial" panose="020B0604020202020204" pitchFamily="34" charset="0"/>
              </a:rPr>
              <a:t>GFP-Rnq1 </a:t>
            </a:r>
            <a:r>
              <a:rPr lang="en-US" sz="1400" dirty="0">
                <a:cs typeface="Arial" panose="020B0604020202020204" pitchFamily="34" charset="0"/>
              </a:rPr>
              <a:t>(72 </a:t>
            </a:r>
            <a:r>
              <a:rPr lang="en-US" sz="1400" dirty="0" err="1" smtClean="0">
                <a:cs typeface="Arial" panose="020B0604020202020204" pitchFamily="34" charset="0"/>
              </a:rPr>
              <a:t>hrs</a:t>
            </a:r>
            <a:r>
              <a:rPr lang="en-US" sz="1400" dirty="0" smtClean="0">
                <a:cs typeface="Arial" panose="020B0604020202020204" pitchFamily="34" charset="0"/>
              </a:rPr>
              <a:t> </a:t>
            </a:r>
            <a:r>
              <a:rPr lang="en-US" sz="1400" dirty="0">
                <a:cs typeface="Arial" panose="020B0604020202020204" pitchFamily="34" charset="0"/>
              </a:rPr>
              <a:t>overproduction) and Mot3PD-GFP (24 </a:t>
            </a:r>
            <a:r>
              <a:rPr lang="en-US" sz="1400" dirty="0" err="1" smtClean="0">
                <a:cs typeface="Arial" panose="020B0604020202020204" pitchFamily="34" charset="0"/>
              </a:rPr>
              <a:t>hrs</a:t>
            </a:r>
            <a:r>
              <a:rPr lang="en-US" sz="1400" dirty="0" smtClean="0">
                <a:cs typeface="Arial" panose="020B0604020202020204" pitchFamily="34" charset="0"/>
              </a:rPr>
              <a:t> </a:t>
            </a:r>
            <a:r>
              <a:rPr lang="en-US" sz="1400" dirty="0">
                <a:cs typeface="Arial" panose="020B0604020202020204" pitchFamily="34" charset="0"/>
              </a:rPr>
              <a:t>overproduction) formed in </a:t>
            </a: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US" sz="1400" dirty="0">
                <a:cs typeface="Arial" panose="020B0604020202020204" pitchFamily="34" charset="0"/>
              </a:rPr>
              <a:t>rnq1 cells have no physical </a:t>
            </a:r>
            <a:r>
              <a:rPr lang="en-US" sz="1400" dirty="0" smtClean="0">
                <a:cs typeface="Arial" panose="020B0604020202020204" pitchFamily="34" charset="0"/>
              </a:rPr>
              <a:t>connection </a:t>
            </a:r>
            <a:r>
              <a:rPr lang="en-US" sz="1400" dirty="0">
                <a:cs typeface="Arial" panose="020B0604020202020204" pitchFamily="34" charset="0"/>
              </a:rPr>
              <a:t>with IPOD (marked by Hsp42-RFP protein). Scale bar is </a:t>
            </a:r>
            <a:r>
              <a:rPr lang="en-US" sz="1400" dirty="0" smtClean="0">
                <a:cs typeface="Arial" panose="020B0604020202020204" pitchFamily="34" charset="0"/>
              </a:rPr>
              <a:t>1 </a:t>
            </a:r>
            <a:r>
              <a:rPr lang="el-GR" sz="1400" dirty="0" smtClean="0">
                <a:cs typeface="Arial" panose="020B0604020202020204" pitchFamily="34" charset="0"/>
              </a:rPr>
              <a:t>μ</a:t>
            </a:r>
            <a:r>
              <a:rPr lang="en-US" sz="1400" dirty="0">
                <a:cs typeface="Arial" panose="020B0604020202020204" pitchFamily="34" charset="0"/>
              </a:rPr>
              <a:t>M</a:t>
            </a:r>
            <a:r>
              <a:rPr lang="en-US" sz="1400" dirty="0" smtClean="0">
                <a:cs typeface="Arial" panose="020B0604020202020204" pitchFamily="34" charset="0"/>
              </a:rPr>
              <a:t>.</a:t>
            </a:r>
          </a:p>
          <a:p>
            <a:pPr marL="0" indent="0">
              <a:buNone/>
            </a:pPr>
            <a:r>
              <a:rPr lang="en-US" sz="1400" b="1" dirty="0" smtClean="0">
                <a:cs typeface="Arial" panose="020B0604020202020204" pitchFamily="34" charset="0"/>
              </a:rPr>
              <a:t>H. </a:t>
            </a:r>
            <a:r>
              <a:rPr lang="en-US" sz="1400" dirty="0" smtClean="0">
                <a:cs typeface="Arial" panose="020B0604020202020204" pitchFamily="34" charset="0"/>
              </a:rPr>
              <a:t>Life-cell </a:t>
            </a:r>
            <a:r>
              <a:rPr lang="en-US" sz="1400" dirty="0">
                <a:cs typeface="Arial" panose="020B0604020202020204" pitchFamily="34" charset="0"/>
              </a:rPr>
              <a:t>imaging of Δrnq1 cells with Ure2PD-GFP aggregates. Elongates </a:t>
            </a:r>
            <a:r>
              <a:rPr lang="en-US" sz="1400" dirty="0" smtClean="0">
                <a:cs typeface="Arial" panose="020B0604020202020204" pitchFamily="34" charset="0"/>
              </a:rPr>
              <a:t>Ure2PrD-GFP </a:t>
            </a:r>
            <a:r>
              <a:rPr lang="en-US" sz="1400" dirty="0">
                <a:cs typeface="Arial" panose="020B0604020202020204" pitchFamily="34" charset="0"/>
              </a:rPr>
              <a:t>aggregates, formed upon long-term incubation of Δrnq1 cells with </a:t>
            </a:r>
            <a:r>
              <a:rPr lang="en-US" sz="1400" dirty="0" smtClean="0">
                <a:cs typeface="Arial" panose="020B0604020202020204" pitchFamily="34" charset="0"/>
              </a:rPr>
              <a:t>Ure2PrD-GFP </a:t>
            </a:r>
            <a:r>
              <a:rPr lang="en-US" sz="1400" dirty="0" smtClean="0">
                <a:cs typeface="Arial" panose="020B0604020202020204" pitchFamily="34" charset="0"/>
              </a:rPr>
              <a:t>overproduction</a:t>
            </a:r>
            <a:r>
              <a:rPr lang="en-US" sz="1400" dirty="0">
                <a:cs typeface="Arial" panose="020B0604020202020204" pitchFamily="34" charset="0"/>
              </a:rPr>
              <a:t>, </a:t>
            </a:r>
            <a:r>
              <a:rPr lang="en-US" sz="1400" dirty="0" smtClean="0">
                <a:cs typeface="Arial" panose="020B0604020202020204" pitchFamily="34" charset="0"/>
              </a:rPr>
              <a:t>are </a:t>
            </a:r>
            <a:r>
              <a:rPr lang="en-US" sz="1400" dirty="0" err="1" smtClean="0">
                <a:cs typeface="Arial" panose="020B0604020202020204" pitchFamily="34" charset="0"/>
              </a:rPr>
              <a:t>proteostat</a:t>
            </a:r>
            <a:r>
              <a:rPr lang="en-US" sz="1400" dirty="0" smtClean="0">
                <a:cs typeface="Arial" panose="020B0604020202020204" pitchFamily="34" charset="0"/>
              </a:rPr>
              <a:t>-positive </a:t>
            </a:r>
            <a:r>
              <a:rPr lang="en-US" sz="1400" dirty="0">
                <a:cs typeface="Arial" panose="020B0604020202020204" pitchFamily="34" charset="0"/>
              </a:rPr>
              <a:t>and insoluble in 10% 1,6-hexanedion, supposing that they are likely constituted by </a:t>
            </a:r>
            <a:r>
              <a:rPr lang="en-US" sz="1400" dirty="0" smtClean="0">
                <a:cs typeface="Arial" panose="020B0604020202020204" pitchFamily="34" charset="0"/>
              </a:rPr>
              <a:t>Ure2PrD-GFP </a:t>
            </a:r>
            <a:r>
              <a:rPr lang="en-US" sz="1400" dirty="0">
                <a:cs typeface="Arial" panose="020B0604020202020204" pitchFamily="34" charset="0"/>
              </a:rPr>
              <a:t>amyloid form. Scale bar is 1 </a:t>
            </a:r>
            <a:r>
              <a:rPr lang="en-US" sz="1400" dirty="0" err="1">
                <a:cs typeface="Arial" panose="020B0604020202020204" pitchFamily="34" charset="0"/>
              </a:rPr>
              <a:t>μM</a:t>
            </a:r>
            <a:r>
              <a:rPr lang="en-US" sz="1400" dirty="0">
                <a:cs typeface="Arial" panose="020B0604020202020204" pitchFamily="34" charset="0"/>
              </a:rPr>
              <a:t>.</a:t>
            </a:r>
          </a:p>
          <a:p>
            <a:pPr marL="0" indent="0">
              <a:buNone/>
            </a:pPr>
            <a:r>
              <a:rPr lang="en-US" sz="1400" b="1" dirty="0" smtClean="0">
                <a:cs typeface="Arial" panose="020B0604020202020204" pitchFamily="34" charset="0"/>
              </a:rPr>
              <a:t>I</a:t>
            </a:r>
            <a:r>
              <a:rPr lang="en-US" sz="1400" b="1" dirty="0" smtClean="0">
                <a:cs typeface="Arial" panose="020B0604020202020204" pitchFamily="34" charset="0"/>
              </a:rPr>
              <a:t>. </a:t>
            </a:r>
            <a:r>
              <a:rPr lang="en-US" sz="1400" dirty="0"/>
              <a:t>Time-lapse dynamics of liquid- and solid-like assemblies formed in Δrnq1 cells by </a:t>
            </a:r>
            <a:r>
              <a:rPr lang="en-US" sz="1400" dirty="0" smtClean="0"/>
              <a:t>Ure2PD-GFP </a:t>
            </a:r>
            <a:r>
              <a:rPr lang="en-US" sz="1400" dirty="0"/>
              <a:t>and </a:t>
            </a:r>
            <a:r>
              <a:rPr lang="en-US" sz="1400" dirty="0" smtClean="0"/>
              <a:t>Sap30PD-GFP </a:t>
            </a:r>
            <a:r>
              <a:rPr lang="en-US" sz="1400" dirty="0"/>
              <a:t>proteins. </a:t>
            </a:r>
            <a:r>
              <a:rPr lang="en-US" sz="1400" dirty="0" smtClean="0"/>
              <a:t>The </a:t>
            </a:r>
            <a:r>
              <a:rPr lang="en-US" sz="1400" dirty="0" err="1" smtClean="0"/>
              <a:t>metodics</a:t>
            </a:r>
            <a:r>
              <a:rPr lang="en-US" sz="1400" dirty="0" smtClean="0"/>
              <a:t> of calculation of cell with either liquid-</a:t>
            </a:r>
            <a:r>
              <a:rPr lang="en-US" sz="1400" dirty="0"/>
              <a:t> </a:t>
            </a:r>
            <a:r>
              <a:rPr lang="en-US" sz="1400" dirty="0" smtClean="0"/>
              <a:t>or solid-like assemblies is described in the Figure 6E capture.</a:t>
            </a:r>
            <a:endParaRPr lang="en-US" sz="1400" dirty="0" smtClean="0"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sz="1400" b="1" dirty="0" smtClean="0">
                <a:cs typeface="Arial" panose="020B0604020202020204" pitchFamily="34" charset="0"/>
              </a:rPr>
              <a:t>J.</a:t>
            </a:r>
            <a:r>
              <a:rPr lang="en-US" sz="1400" b="1" dirty="0">
                <a:solidFill>
                  <a:srgbClr val="000000"/>
                </a:solidFill>
                <a:ea typeface="Microsoft YaHei" pitchFamily="2"/>
                <a:cs typeface="Microsoft YaHei" pitchFamily="2"/>
              </a:rPr>
              <a:t> </a:t>
            </a:r>
            <a:r>
              <a:rPr lang="en-US" sz="1400" dirty="0">
                <a:solidFill>
                  <a:srgbClr val="000000"/>
                </a:solidFill>
                <a:ea typeface="Microsoft YaHei" pitchFamily="2"/>
                <a:cs typeface="Microsoft YaHei" pitchFamily="2"/>
              </a:rPr>
              <a:t>The effect of sample preparation on the mobility of GFP-Rnq1 </a:t>
            </a:r>
            <a:r>
              <a:rPr lang="en-US" sz="1400" dirty="0" smtClean="0">
                <a:solidFill>
                  <a:srgbClr val="000000"/>
                </a:solidFill>
                <a:ea typeface="Microsoft YaHei" pitchFamily="2"/>
                <a:cs typeface="Microsoft YaHei" pitchFamily="2"/>
              </a:rPr>
              <a:t>amyloids, </a:t>
            </a:r>
            <a:r>
              <a:rPr lang="en-US" sz="1400" dirty="0">
                <a:solidFill>
                  <a:srgbClr val="000000"/>
                </a:solidFill>
                <a:ea typeface="Microsoft YaHei" pitchFamily="2"/>
                <a:cs typeface="Microsoft YaHei" pitchFamily="2"/>
              </a:rPr>
              <a:t>formed </a:t>
            </a:r>
            <a:r>
              <a:rPr lang="en-US" sz="1400" dirty="0" smtClean="0">
                <a:solidFill>
                  <a:srgbClr val="000000"/>
                </a:solidFill>
                <a:ea typeface="Microsoft YaHei" pitchFamily="2"/>
                <a:cs typeface="Microsoft YaHei" pitchFamily="2"/>
              </a:rPr>
              <a:t>through the </a:t>
            </a:r>
            <a:r>
              <a:rPr lang="en-US" sz="1400" dirty="0">
                <a:solidFill>
                  <a:srgbClr val="000000"/>
                </a:solidFill>
                <a:ea typeface="Microsoft YaHei" pitchFamily="2"/>
                <a:cs typeface="Microsoft YaHei" pitchFamily="2"/>
              </a:rPr>
              <a:t>maturation of GFP-Rnq1 condensates, in 1.8% agarose </a:t>
            </a:r>
            <a:r>
              <a:rPr lang="en-US" sz="1400" dirty="0" smtClean="0">
                <a:solidFill>
                  <a:srgbClr val="000000"/>
                </a:solidFill>
                <a:ea typeface="Microsoft YaHei" pitchFamily="2"/>
                <a:cs typeface="Microsoft YaHei" pitchFamily="2"/>
              </a:rPr>
              <a:t>gel electrophoresis. </a:t>
            </a:r>
            <a:r>
              <a:rPr lang="en-US" sz="1400" dirty="0">
                <a:solidFill>
                  <a:srgbClr val="000000"/>
                </a:solidFill>
                <a:ea typeface="Microsoft YaHei" pitchFamily="2"/>
                <a:cs typeface="Microsoft YaHei" pitchFamily="2"/>
              </a:rPr>
              <a:t>SDD-AGE analysis was performed on lysates from ∆rnq1 cells incubated with overproduced GFP-Rnq1 protein </a:t>
            </a:r>
            <a:r>
              <a:rPr lang="en-US" sz="1400" dirty="0" smtClean="0">
                <a:solidFill>
                  <a:srgbClr val="000000"/>
                </a:solidFill>
                <a:ea typeface="Microsoft YaHei" pitchFamily="2"/>
                <a:cs typeface="Microsoft YaHei" pitchFamily="2"/>
              </a:rPr>
              <a:t>for up to </a:t>
            </a:r>
            <a:r>
              <a:rPr lang="en-US" sz="1400" dirty="0">
                <a:solidFill>
                  <a:srgbClr val="000000"/>
                </a:solidFill>
                <a:ea typeface="Microsoft YaHei" pitchFamily="2"/>
                <a:cs typeface="Microsoft YaHei" pitchFamily="2"/>
              </a:rPr>
              <a:t>7 days, with or without sonication (30 s, 50% amplitude).</a:t>
            </a:r>
            <a:endParaRPr lang="ru-RU" sz="1400" dirty="0"/>
          </a:p>
          <a:p>
            <a:pPr marL="0" indent="0">
              <a:buNone/>
            </a:pPr>
            <a:endParaRPr lang="ru-RU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endParaRPr lang="ru-RU" sz="1400" dirty="0"/>
          </a:p>
          <a:p>
            <a:pPr marL="0" indent="0">
              <a:buNone/>
            </a:pPr>
            <a:r>
              <a:rPr lang="en-US" sz="1400" dirty="0" smtClean="0"/>
              <a:t>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08475083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Тема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Тема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Тема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55</TotalTime>
  <Words>810</Words>
  <Application>Microsoft Office PowerPoint</Application>
  <PresentationFormat>Произвольный</PresentationFormat>
  <Paragraphs>109</Paragraphs>
  <Slides>2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4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2</vt:i4>
      </vt:variant>
    </vt:vector>
  </HeadingPairs>
  <TitlesOfParts>
    <vt:vector size="7" baseType="lpstr">
      <vt:lpstr>Microsoft YaHei</vt:lpstr>
      <vt:lpstr>Arial</vt:lpstr>
      <vt:lpstr>Calibri</vt:lpstr>
      <vt:lpstr>Calibri Light</vt:lpstr>
      <vt:lpstr>Тема Office</vt:lpstr>
      <vt:lpstr>Презентация PowerPoint</vt:lpstr>
      <vt:lpstr>Презентация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Александр Дергалёв</dc:creator>
  <cp:lastModifiedBy>Александр Дергалёв</cp:lastModifiedBy>
  <cp:revision>88</cp:revision>
  <dcterms:created xsi:type="dcterms:W3CDTF">2023-08-09T20:22:04Z</dcterms:created>
  <dcterms:modified xsi:type="dcterms:W3CDTF">2023-11-12T16:11:10Z</dcterms:modified>
</cp:coreProperties>
</file>